
<file path=[Content_Types].xml><?xml version="1.0" encoding="utf-8"?>
<Types xmlns="http://schemas.openxmlformats.org/package/2006/content-types">
  <Default Extension="emf" ContentType="image/x-emf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5"/>
  </p:notesMasterIdLst>
  <p:sldIdLst>
    <p:sldId id="403" r:id="rId2"/>
    <p:sldId id="405" r:id="rId3"/>
    <p:sldId id="404" r:id="rId4"/>
  </p:sldIdLst>
  <p:sldSz cx="6858000" cy="9906000" type="A4"/>
  <p:notesSz cx="6797675" cy="98742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figure (main )" id="{7011CEB8-AC9A-4F01-993F-094B46AB4451}">
          <p14:sldIdLst>
            <p14:sldId id="403"/>
            <p14:sldId id="405"/>
            <p14:sldId id="404"/>
          </p14:sldIdLst>
        </p14:section>
        <p14:section name="EXTRA" id="{C75BE503-C125-4A8A-96A0-F221A7A9E10A}">
          <p14:sldIdLst/>
        </p14:section>
      </p14:sectionLst>
    </p:ext>
    <p:ext uri="{EFAFB233-063F-42B5-8137-9DF3F51BA10A}">
      <p15:sldGuideLst xmlns:p15="http://schemas.microsoft.com/office/powerpoint/2012/main">
        <p15:guide id="1" orient="horz" pos="761" userDrawn="1">
          <p15:clr>
            <a:srgbClr val="A4A3A4"/>
          </p15:clr>
        </p15:guide>
        <p15:guide id="2" pos="1389" userDrawn="1">
          <p15:clr>
            <a:srgbClr val="A4A3A4"/>
          </p15:clr>
        </p15:guide>
        <p15:guide id="3" orient="horz" pos="4005" userDrawn="1">
          <p15:clr>
            <a:srgbClr val="A4A3A4"/>
          </p15:clr>
        </p15:guide>
        <p15:guide id="4" pos="2772" userDrawn="1">
          <p15:clr>
            <a:srgbClr val="A4A3A4"/>
          </p15:clr>
        </p15:guide>
        <p15:guide id="5" orient="horz" pos="943" userDrawn="1">
          <p15:clr>
            <a:srgbClr val="A4A3A4"/>
          </p15:clr>
        </p15:guide>
        <p15:guide id="6" orient="horz" pos="3211" userDrawn="1">
          <p15:clr>
            <a:srgbClr val="A4A3A4"/>
          </p15:clr>
        </p15:guide>
        <p15:guide id="8" pos="300" userDrawn="1">
          <p15:clr>
            <a:srgbClr val="A4A3A4"/>
          </p15:clr>
        </p15:guide>
        <p15:guide id="9" pos="210" userDrawn="1">
          <p15:clr>
            <a:srgbClr val="A4A3A4"/>
          </p15:clr>
        </p15:guide>
        <p15:guide id="10" pos="2795" userDrawn="1">
          <p15:clr>
            <a:srgbClr val="A4A3A4"/>
          </p15:clr>
        </p15:guide>
        <p15:guide id="11" orient="horz" pos="285" userDrawn="1">
          <p15:clr>
            <a:srgbClr val="A4A3A4"/>
          </p15:clr>
        </p15:guide>
        <p15:guide id="12" orient="horz" pos="603" userDrawn="1">
          <p15:clr>
            <a:srgbClr val="A4A3A4"/>
          </p15:clr>
        </p15:guide>
        <p15:guide id="14" orient="horz" pos="784" userDrawn="1">
          <p15:clr>
            <a:srgbClr val="A4A3A4"/>
          </p15:clr>
        </p15:guide>
        <p15:guide id="16" pos="1616" userDrawn="1">
          <p15:clr>
            <a:srgbClr val="A4A3A4"/>
          </p15:clr>
        </p15:guide>
        <p15:guide id="17" pos="232" userDrawn="1">
          <p15:clr>
            <a:srgbClr val="A4A3A4"/>
          </p15:clr>
        </p15:guide>
        <p15:guide id="18" pos="3090" userDrawn="1">
          <p15:clr>
            <a:srgbClr val="A4A3A4"/>
          </p15:clr>
        </p15:guide>
        <p15:guide id="19" pos="731" userDrawn="1">
          <p15:clr>
            <a:srgbClr val="A4A3A4"/>
          </p15:clr>
        </p15:guide>
        <p15:guide id="20" orient="horz" pos="6204" userDrawn="1">
          <p15:clr>
            <a:srgbClr val="A4A3A4"/>
          </p15:clr>
        </p15:guide>
        <p15:guide id="21" orient="horz" pos="3279" userDrawn="1">
          <p15:clr>
            <a:srgbClr val="A4A3A4"/>
          </p15:clr>
        </p15:guide>
        <p15:guide id="22" orient="horz" pos="5660" userDrawn="1">
          <p15:clr>
            <a:srgbClr val="A4A3A4"/>
          </p15:clr>
        </p15:guide>
        <p15:guide id="23" pos="164" userDrawn="1">
          <p15:clr>
            <a:srgbClr val="A4A3A4"/>
          </p15:clr>
        </p15:guide>
        <p15:guide id="24" orient="horz" pos="1963" userDrawn="1">
          <p15:clr>
            <a:srgbClr val="A4A3A4"/>
          </p15:clr>
        </p15:guide>
        <p15:guide id="25" orient="horz" pos="1396" userDrawn="1">
          <p15:clr>
            <a:srgbClr val="A4A3A4"/>
          </p15:clr>
        </p15:guide>
        <p15:guide id="26" pos="2205" userDrawn="1">
          <p15:clr>
            <a:srgbClr val="A4A3A4"/>
          </p15:clr>
        </p15:guide>
        <p15:guide id="27" orient="horz" pos="4503" userDrawn="1">
          <p15:clr>
            <a:srgbClr val="A4A3A4"/>
          </p15:clr>
        </p15:guide>
        <p15:guide id="29" orient="horz" pos="1827" userDrawn="1">
          <p15:clr>
            <a:srgbClr val="A4A3A4"/>
          </p15:clr>
        </p15:guide>
        <p15:guide id="30" pos="754" userDrawn="1">
          <p15:clr>
            <a:srgbClr val="A4A3A4"/>
          </p15:clr>
        </p15:guide>
        <p15:guide id="32" orient="horz" pos="5184" userDrawn="1">
          <p15:clr>
            <a:srgbClr val="A4A3A4"/>
          </p15:clr>
        </p15:guide>
        <p15:guide id="35" pos="119" userDrawn="1">
          <p15:clr>
            <a:srgbClr val="A4A3A4"/>
          </p15:clr>
        </p15:guide>
        <p15:guide id="36" orient="horz" pos="217" userDrawn="1">
          <p15:clr>
            <a:srgbClr val="A4A3A4"/>
          </p15:clr>
        </p15:guide>
        <p15:guide id="38" pos="142" userDrawn="1">
          <p15:clr>
            <a:srgbClr val="A4A3A4"/>
          </p15:clr>
        </p15:guide>
        <p15:guide id="39" orient="horz" pos="739" userDrawn="1">
          <p15:clr>
            <a:srgbClr val="A4A3A4"/>
          </p15:clr>
        </p15:guide>
        <p15:guide id="40" orient="horz" pos="240" userDrawn="1">
          <p15:clr>
            <a:srgbClr val="A4A3A4"/>
          </p15:clr>
        </p15:guide>
        <p15:guide id="41" pos="1593" userDrawn="1">
          <p15:clr>
            <a:srgbClr val="A4A3A4"/>
          </p15:clr>
        </p15:guide>
        <p15:guide id="44" orient="horz" pos="81" userDrawn="1">
          <p15:clr>
            <a:srgbClr val="A4A3A4"/>
          </p15:clr>
        </p15:guide>
        <p15:guide id="45" pos="2115" userDrawn="1">
          <p15:clr>
            <a:srgbClr val="A4A3A4"/>
          </p15:clr>
        </p15:guide>
        <p15:guide id="46" orient="horz" pos="580" userDrawn="1">
          <p15:clr>
            <a:srgbClr val="A4A3A4"/>
          </p15:clr>
        </p15:guide>
        <p15:guide id="47" orient="horz" pos="512" userDrawn="1">
          <p15:clr>
            <a:srgbClr val="A4A3A4"/>
          </p15:clr>
        </p15:guide>
        <p15:guide id="48" pos="96" userDrawn="1">
          <p15:clr>
            <a:srgbClr val="A4A3A4"/>
          </p15:clr>
        </p15:guide>
        <p15:guide id="49" orient="horz" pos="1918" userDrawn="1">
          <p15:clr>
            <a:srgbClr val="A4A3A4"/>
          </p15:clr>
        </p15:guide>
        <p15:guide id="50" orient="horz" pos="2190" userDrawn="1">
          <p15:clr>
            <a:srgbClr val="A4A3A4"/>
          </p15:clr>
        </p15:guide>
        <p15:guide id="51" orient="horz" pos="2553" userDrawn="1">
          <p15:clr>
            <a:srgbClr val="A4A3A4"/>
          </p15:clr>
        </p15:guide>
        <p15:guide id="52" orient="horz" pos="2099" userDrawn="1">
          <p15:clr>
            <a:srgbClr val="A4A3A4"/>
          </p15:clr>
        </p15:guide>
        <p15:guide id="53" orient="horz" pos="2734" userDrawn="1">
          <p15:clr>
            <a:srgbClr val="A4A3A4"/>
          </p15:clr>
        </p15:guide>
        <p15:guide id="54" orient="horz" pos="4481" userDrawn="1">
          <p15:clr>
            <a:srgbClr val="A4A3A4"/>
          </p15:clr>
        </p15:guide>
        <p15:guide id="55" orient="horz" pos="3347" userDrawn="1">
          <p15:clr>
            <a:srgbClr val="A4A3A4"/>
          </p15:clr>
        </p15:guide>
        <p15:guide id="56" pos="1865" userDrawn="1">
          <p15:clr>
            <a:srgbClr val="A4A3A4"/>
          </p15:clr>
        </p15:guide>
        <p15:guide id="57" orient="horz" pos="3483" userDrawn="1">
          <p15:clr>
            <a:srgbClr val="A4A3A4"/>
          </p15:clr>
        </p15:guide>
        <p15:guide id="58" orient="horz" pos="6023" userDrawn="1">
          <p15:clr>
            <a:srgbClr val="A4A3A4"/>
          </p15:clr>
        </p15:guide>
        <p15:guide id="59" orient="horz" pos="6091" userDrawn="1">
          <p15:clr>
            <a:srgbClr val="A4A3A4"/>
          </p15:clr>
        </p15:guide>
        <p15:guide id="62" pos="3974" userDrawn="1">
          <p15:clr>
            <a:srgbClr val="A4A3A4"/>
          </p15:clr>
        </p15:guide>
        <p15:guide id="63" pos="3181" userDrawn="1">
          <p15:clr>
            <a:srgbClr val="A4A3A4"/>
          </p15:clr>
        </p15:guide>
        <p15:guide id="64" pos="3158" userDrawn="1">
          <p15:clr>
            <a:srgbClr val="A4A3A4"/>
          </p15:clr>
        </p15:guide>
        <p15:guide id="66" pos="3135" userDrawn="1">
          <p15:clr>
            <a:srgbClr val="A4A3A4"/>
          </p15:clr>
        </p15:guide>
        <p15:guide id="67" pos="3271" userDrawn="1">
          <p15:clr>
            <a:srgbClr val="A4A3A4"/>
          </p15:clr>
        </p15:guide>
        <p15:guide id="68" pos="3226" userDrawn="1">
          <p15:clr>
            <a:srgbClr val="A4A3A4"/>
          </p15:clr>
        </p15:guide>
        <p15:guide id="69" pos="3997" userDrawn="1">
          <p15:clr>
            <a:srgbClr val="A4A3A4"/>
          </p15:clr>
        </p15:guide>
        <p15:guide id="71" pos="2251" userDrawn="1">
          <p15:clr>
            <a:srgbClr val="A4A3A4"/>
          </p15:clr>
        </p15:guide>
        <p15:guide id="72" orient="horz" pos="5048" userDrawn="1">
          <p15:clr>
            <a:srgbClr val="A4A3A4"/>
          </p15:clr>
        </p15:guide>
        <p15:guide id="73" orient="horz" pos="5637" userDrawn="1">
          <p15:clr>
            <a:srgbClr val="A4A3A4"/>
          </p15:clr>
        </p15:guide>
        <p15:guide id="74" pos="777" userDrawn="1">
          <p15:clr>
            <a:srgbClr val="A4A3A4"/>
          </p15:clr>
        </p15:guide>
        <p15:guide id="76" orient="horz" pos="6227" userDrawn="1">
          <p15:clr>
            <a:srgbClr val="A4A3A4"/>
          </p15:clr>
        </p15:guide>
        <p15:guide id="77" orient="horz" pos="3891" userDrawn="1">
          <p15:clr>
            <a:srgbClr val="A4A3A4"/>
          </p15:clr>
        </p15:guide>
        <p15:guide id="78" pos="799" userDrawn="1">
          <p15:clr>
            <a:srgbClr val="A4A3A4"/>
          </p15:clr>
        </p15:guide>
        <p15:guide id="79" orient="horz" pos="4458" userDrawn="1">
          <p15:clr>
            <a:srgbClr val="A4A3A4"/>
          </p15:clr>
        </p15:guide>
        <p15:guide id="80" pos="2228" userDrawn="1">
          <p15:clr>
            <a:srgbClr val="A4A3A4"/>
          </p15:clr>
        </p15:guide>
        <p15:guide id="81" orient="horz" pos="4299" userDrawn="1">
          <p15:clr>
            <a:srgbClr val="A4A3A4"/>
          </p15:clr>
        </p15:guide>
        <p15:guide id="83" orient="horz" pos="4345" userDrawn="1">
          <p15:clr>
            <a:srgbClr val="A4A3A4"/>
          </p15:clr>
        </p15:guide>
        <p15:guide id="84" orient="horz" pos="4413" userDrawn="1">
          <p15:clr>
            <a:srgbClr val="A4A3A4"/>
          </p15:clr>
        </p15:guide>
        <p15:guide id="85" orient="horz" pos="4322" userDrawn="1">
          <p15:clr>
            <a:srgbClr val="A4A3A4"/>
          </p15:clr>
        </p15:guide>
        <p15:guide id="86" orient="horz" pos="4367" userDrawn="1">
          <p15:clr>
            <a:srgbClr val="A4A3A4"/>
          </p15:clr>
        </p15:guide>
        <p15:guide id="87" orient="horz" pos="5025" userDrawn="1">
          <p15:clr>
            <a:srgbClr val="A4A3A4"/>
          </p15:clr>
        </p15:guide>
        <p15:guide id="88" orient="horz" pos="5547" userDrawn="1">
          <p15:clr>
            <a:srgbClr val="A4A3A4"/>
          </p15:clr>
        </p15:guide>
        <p15:guide id="89" orient="horz" pos="3846" userDrawn="1">
          <p15:clr>
            <a:srgbClr val="A4A3A4"/>
          </p15:clr>
        </p15:guide>
        <p15:guide id="90" pos="1321" userDrawn="1">
          <p15:clr>
            <a:srgbClr val="A4A3A4"/>
          </p15:clr>
        </p15:guide>
        <p15:guide id="91" pos="1548" userDrawn="1">
          <p15:clr>
            <a:srgbClr val="A4A3A4"/>
          </p15:clr>
        </p15:guide>
        <p15:guide id="92" orient="horz" pos="1351" userDrawn="1">
          <p15:clr>
            <a:srgbClr val="A4A3A4"/>
          </p15:clr>
        </p15:guide>
        <p15:guide id="93" orient="horz" pos="1192" userDrawn="1">
          <p15:clr>
            <a:srgbClr val="A4A3A4"/>
          </p15:clr>
        </p15:guide>
        <p15:guide id="94" pos="3407" userDrawn="1">
          <p15:clr>
            <a:srgbClr val="A4A3A4"/>
          </p15:clr>
        </p15:guide>
        <p15:guide id="95" orient="horz" pos="1260" userDrawn="1">
          <p15:clr>
            <a:srgbClr val="A4A3A4"/>
          </p15:clr>
        </p15:guide>
        <p15:guide id="96" orient="horz" pos="2530" userDrawn="1">
          <p15:clr>
            <a:srgbClr val="A4A3A4"/>
          </p15:clr>
        </p15:guide>
        <p15:guide id="97" pos="2818" userDrawn="1">
          <p15:clr>
            <a:srgbClr val="A4A3A4"/>
          </p15:clr>
        </p15:guide>
        <p15:guide id="98" pos="3249" userDrawn="1">
          <p15:clr>
            <a:srgbClr val="A4A3A4"/>
          </p15:clr>
        </p15:guide>
        <p15:guide id="99" orient="horz" pos="1986" userDrawn="1">
          <p15:clr>
            <a:srgbClr val="A4A3A4"/>
          </p15:clr>
        </p15:guide>
        <p15:guide id="100" orient="horz" pos="2689" userDrawn="1">
          <p15:clr>
            <a:srgbClr val="A4A3A4"/>
          </p15:clr>
        </p15:guide>
        <p15:guide id="102" pos="1842" userDrawn="1">
          <p15:clr>
            <a:srgbClr val="A4A3A4"/>
          </p15:clr>
        </p15:guide>
        <p15:guide id="104" pos="1706" userDrawn="1">
          <p15:clr>
            <a:srgbClr val="A4A3A4"/>
          </p15:clr>
        </p15:guide>
        <p15:guide id="105" pos="3045" userDrawn="1">
          <p15:clr>
            <a:srgbClr val="A4A3A4"/>
          </p15:clr>
        </p15:guide>
        <p15:guide id="107" pos="1911" userDrawn="1">
          <p15:clr>
            <a:srgbClr val="A4A3A4"/>
          </p15:clr>
        </p15:guide>
        <p15:guide id="108" pos="1684" userDrawn="1">
          <p15:clr>
            <a:srgbClr val="A4A3A4"/>
          </p15:clr>
        </p15:guide>
        <p15:guide id="109" pos="1661" userDrawn="1">
          <p15:clr>
            <a:srgbClr val="A4A3A4"/>
          </p15:clr>
        </p15:guide>
        <p15:guide id="111" pos="2455" userDrawn="1">
          <p15:clr>
            <a:srgbClr val="A4A3A4"/>
          </p15:clr>
        </p15:guide>
        <p15:guide id="112" pos="2296" userDrawn="1">
          <p15:clr>
            <a:srgbClr val="A4A3A4"/>
          </p15:clr>
        </p15:guide>
        <p15:guide id="113" pos="2387" userDrawn="1">
          <p15:clr>
            <a:srgbClr val="A4A3A4"/>
          </p15:clr>
        </p15:guide>
        <p15:guide id="114" pos="2682" userDrawn="1">
          <p15:clr>
            <a:srgbClr val="A4A3A4"/>
          </p15:clr>
        </p15:guide>
        <p15:guide id="115" pos="2614" userDrawn="1">
          <p15:clr>
            <a:srgbClr val="A4A3A4"/>
          </p15:clr>
        </p15:guide>
        <p15:guide id="116" pos="2591" userDrawn="1">
          <p15:clr>
            <a:srgbClr val="A4A3A4"/>
          </p15:clr>
        </p15:guide>
        <p15:guide id="117" orient="horz" pos="2712" userDrawn="1">
          <p15:clr>
            <a:srgbClr val="A4A3A4"/>
          </p15:clr>
        </p15:guide>
        <p15:guide id="118" orient="horz" pos="2576" userDrawn="1">
          <p15:clr>
            <a:srgbClr val="A4A3A4"/>
          </p15:clr>
        </p15:guide>
        <p15:guide id="119" orient="horz" pos="2054" userDrawn="1">
          <p15:clr>
            <a:srgbClr val="A4A3A4"/>
          </p15:clr>
        </p15:guide>
        <p15:guide id="120" orient="horz" pos="2031" userDrawn="1">
          <p15:clr>
            <a:srgbClr val="A4A3A4"/>
          </p15:clr>
        </p15:guide>
        <p15:guide id="121" pos="3317" userDrawn="1">
          <p15:clr>
            <a:srgbClr val="A4A3A4"/>
          </p15:clr>
        </p15:guide>
        <p15:guide id="122" pos="3430" userDrawn="1">
          <p15:clr>
            <a:srgbClr val="A4A3A4"/>
          </p15:clr>
        </p15:guide>
        <p15:guide id="123" pos="3362" userDrawn="1">
          <p15:clr>
            <a:srgbClr val="A4A3A4"/>
          </p15:clr>
        </p15:guide>
        <p15:guide id="124" pos="3884" userDrawn="1">
          <p15:clr>
            <a:srgbClr val="A4A3A4"/>
          </p15:clr>
        </p15:guide>
        <p15:guide id="125" pos="3339" userDrawn="1">
          <p15:clr>
            <a:srgbClr val="A4A3A4"/>
          </p15:clr>
        </p15:guide>
        <p15:guide id="126" pos="3453" userDrawn="1">
          <p15:clr>
            <a:srgbClr val="A4A3A4"/>
          </p15:clr>
        </p15:guide>
        <p15:guide id="127" pos="2568" userDrawn="1">
          <p15:clr>
            <a:srgbClr val="A4A3A4"/>
          </p15:clr>
        </p15:guide>
        <p15:guide id="129" pos="3498" userDrawn="1">
          <p15:clr>
            <a:srgbClr val="A4A3A4"/>
          </p15:clr>
        </p15:guide>
        <p15:guide id="130" pos="3543" userDrawn="1">
          <p15:clr>
            <a:srgbClr val="A4A3A4"/>
          </p15:clr>
        </p15:guide>
        <p15:guide id="131" pos="3521" userDrawn="1">
          <p15:clr>
            <a:srgbClr val="A4A3A4"/>
          </p15:clr>
        </p15:guide>
        <p15:guide id="132" pos="3566" userDrawn="1">
          <p15:clr>
            <a:srgbClr val="A4A3A4"/>
          </p15:clr>
        </p15:guide>
        <p15:guide id="133" pos="3589" userDrawn="1">
          <p15:clr>
            <a:srgbClr val="A4A3A4"/>
          </p15:clr>
        </p15:guide>
        <p15:guide id="134" pos="2999" userDrawn="1">
          <p15:clr>
            <a:srgbClr val="A4A3A4"/>
          </p15:clr>
        </p15:guide>
        <p15:guide id="135" pos="3022" userDrawn="1">
          <p15:clr>
            <a:srgbClr val="A4A3A4"/>
          </p15:clr>
        </p15:guide>
        <p15:guide id="136" pos="2954" userDrawn="1">
          <p15:clr>
            <a:srgbClr val="A4A3A4"/>
          </p15:clr>
        </p15:guide>
        <p15:guide id="137" pos="3067" userDrawn="1">
          <p15:clr>
            <a:srgbClr val="A4A3A4"/>
          </p15:clr>
        </p15:guide>
        <p15:guide id="138" pos="2931" userDrawn="1">
          <p15:clr>
            <a:srgbClr val="A4A3A4"/>
          </p15:clr>
        </p15:guide>
        <p15:guide id="139" orient="horz" pos="2009" userDrawn="1">
          <p15:clr>
            <a:srgbClr val="A4A3A4"/>
          </p15:clr>
        </p15:guide>
        <p15:guide id="140" orient="horz" pos="2666" userDrawn="1">
          <p15:clr>
            <a:srgbClr val="A4A3A4"/>
          </p15:clr>
        </p15:guide>
        <p15:guide id="141" orient="horz" pos="2644" userDrawn="1">
          <p15:clr>
            <a:srgbClr val="A4A3A4"/>
          </p15:clr>
        </p15:guide>
        <p15:guide id="142" pos="1344" userDrawn="1">
          <p15:clr>
            <a:srgbClr val="A4A3A4"/>
          </p15:clr>
        </p15:guide>
        <p15:guide id="143" pos="1366" userDrawn="1">
          <p15:clr>
            <a:srgbClr val="A4A3A4"/>
          </p15:clr>
        </p15:guide>
        <p15:guide id="144" pos="1412" userDrawn="1">
          <p15:clr>
            <a:srgbClr val="A4A3A4"/>
          </p15:clr>
        </p15:guide>
        <p15:guide id="146" pos="2840" userDrawn="1">
          <p15:clr>
            <a:srgbClr val="A4A3A4"/>
          </p15:clr>
        </p15:guide>
        <p15:guide id="147" pos="4292" userDrawn="1">
          <p15:clr>
            <a:srgbClr val="A4A3A4"/>
          </p15:clr>
        </p15:guide>
        <p15:guide id="148" pos="3612" userDrawn="1">
          <p15:clr>
            <a:srgbClr val="A4A3A4"/>
          </p15:clr>
        </p15:guide>
        <p15:guide id="149" pos="4269" userDrawn="1">
          <p15:clr>
            <a:srgbClr val="A4A3A4"/>
          </p15:clr>
        </p15:guide>
        <p15:guide id="151" pos="4201" userDrawn="1">
          <p15:clr>
            <a:srgbClr val="A4A3A4"/>
          </p15:clr>
        </p15:guide>
        <p15:guide id="152" pos="3634" userDrawn="1">
          <p15:clr>
            <a:srgbClr val="A4A3A4"/>
          </p15:clr>
        </p15:guide>
        <p15:guide id="153" pos="3657" userDrawn="1">
          <p15:clr>
            <a:srgbClr val="A4A3A4"/>
          </p15:clr>
        </p15:guide>
        <p15:guide id="154" pos="3680" userDrawn="1">
          <p15:clr>
            <a:srgbClr val="A4A3A4"/>
          </p15:clr>
        </p15:guide>
        <p15:guide id="155" pos="1797" userDrawn="1">
          <p15:clr>
            <a:srgbClr val="A4A3A4"/>
          </p15:clr>
        </p15:guide>
        <p15:guide id="156" pos="1774" userDrawn="1">
          <p15:clr>
            <a:srgbClr val="A4A3A4"/>
          </p15:clr>
        </p15:guide>
        <p15:guide id="157" pos="1570" userDrawn="1">
          <p15:clr>
            <a:srgbClr val="A4A3A4"/>
          </p15:clr>
        </p15:guide>
        <p15:guide id="158" pos="1480" userDrawn="1">
          <p15:clr>
            <a:srgbClr val="A4A3A4"/>
          </p15:clr>
        </p15:guide>
        <p15:guide id="159" orient="horz" pos="4980" userDrawn="1">
          <p15:clr>
            <a:srgbClr val="A4A3A4"/>
          </p15:clr>
        </p15:guide>
        <p15:guide id="161" orient="horz" pos="5002" userDrawn="1">
          <p15:clr>
            <a:srgbClr val="A4A3A4"/>
          </p15:clr>
        </p15:guide>
        <p15:guide id="162" orient="horz" pos="5070" userDrawn="1">
          <p15:clr>
            <a:srgbClr val="A4A3A4"/>
          </p15:clr>
        </p15:guide>
        <p15:guide id="163" orient="horz" pos="5592" userDrawn="1">
          <p15:clr>
            <a:srgbClr val="A4A3A4"/>
          </p15:clr>
        </p15:guide>
        <p15:guide id="164" orient="horz" pos="5615" userDrawn="1">
          <p15:clr>
            <a:srgbClr val="A4A3A4"/>
          </p15:clr>
        </p15:guide>
        <p15:guide id="165" orient="horz" pos="5569" userDrawn="1">
          <p15:clr>
            <a:srgbClr val="A4A3A4"/>
          </p15:clr>
        </p15:guide>
        <p15:guide id="166" orient="horz" pos="5751" userDrawn="1">
          <p15:clr>
            <a:srgbClr val="A4A3A4"/>
          </p15:clr>
        </p15:guide>
        <p15:guide id="167" orient="horz" pos="5819" userDrawn="1">
          <p15:clr>
            <a:srgbClr val="A4A3A4"/>
          </p15:clr>
        </p15:guide>
        <p15:guide id="168" orient="horz" pos="6182" userDrawn="1">
          <p15:clr>
            <a:srgbClr val="A4A3A4"/>
          </p15:clr>
        </p15:guide>
        <p15:guide id="169" orient="horz" pos="4277" userDrawn="1">
          <p15:clr>
            <a:srgbClr val="A4A3A4"/>
          </p15:clr>
        </p15:guide>
        <p15:guide id="171" pos="3929" userDrawn="1">
          <p15:clr>
            <a:srgbClr val="A4A3A4"/>
          </p15:clr>
        </p15:guide>
        <p15:guide id="172" pos="3906" userDrawn="1">
          <p15:clr>
            <a:srgbClr val="A4A3A4"/>
          </p15:clr>
        </p15:guide>
        <p15:guide id="173" pos="3952" userDrawn="1">
          <p15:clr>
            <a:srgbClr val="A4A3A4"/>
          </p15:clr>
        </p15:guide>
        <p15:guide id="174" pos="3861" userDrawn="1">
          <p15:clr>
            <a:srgbClr val="A4A3A4"/>
          </p15:clr>
        </p15:guide>
        <p15:guide id="175" pos="3838" userDrawn="1">
          <p15:clr>
            <a:srgbClr val="A4A3A4"/>
          </p15:clr>
        </p15:guide>
        <p15:guide id="176" pos="3816" userDrawn="1">
          <p15:clr>
            <a:srgbClr val="A4A3A4"/>
          </p15:clr>
        </p15:guide>
        <p15:guide id="177" pos="3793" userDrawn="1">
          <p15:clr>
            <a:srgbClr val="A4A3A4"/>
          </p15:clr>
        </p15:guide>
        <p15:guide id="178" pos="3770" userDrawn="1">
          <p15:clr>
            <a:srgbClr val="A4A3A4"/>
          </p15:clr>
        </p15:guide>
        <p15:guide id="179" pos="3748" userDrawn="1">
          <p15:clr>
            <a:srgbClr val="A4A3A4"/>
          </p15:clr>
        </p15:guide>
        <p15:guide id="180" pos="3702" userDrawn="1">
          <p15:clr>
            <a:srgbClr val="A4A3A4"/>
          </p15:clr>
        </p15:guide>
        <p15:guide id="181" pos="3725" userDrawn="1">
          <p15:clr>
            <a:srgbClr val="A4A3A4"/>
          </p15:clr>
        </p15:guide>
        <p15:guide id="182" pos="3475" userDrawn="1">
          <p15:clr>
            <a:srgbClr val="A4A3A4"/>
          </p15:clr>
        </p15:guide>
        <p15:guide id="183" orient="horz" pos="3800" userDrawn="1">
          <p15:clr>
            <a:srgbClr val="A4A3A4"/>
          </p15:clr>
        </p15:guide>
        <p15:guide id="184" orient="horz" pos="3823" userDrawn="1">
          <p15:clr>
            <a:srgbClr val="A4A3A4"/>
          </p15:clr>
        </p15:guide>
        <p15:guide id="185" pos="1729" userDrawn="1">
          <p15:clr>
            <a:srgbClr val="A4A3A4"/>
          </p15:clr>
        </p15:guide>
        <p15:guide id="186" pos="1434" userDrawn="1">
          <p15:clr>
            <a:srgbClr val="A4A3A4"/>
          </p15:clr>
        </p15:guide>
        <p15:guide id="187" pos="890" userDrawn="1">
          <p15:clr>
            <a:srgbClr val="A4A3A4"/>
          </p15:clr>
        </p15:guide>
        <p15:guide id="188" pos="255" userDrawn="1">
          <p15:clr>
            <a:srgbClr val="A4A3A4"/>
          </p15:clr>
        </p15:guide>
        <p15:guide id="189" pos="1638" userDrawn="1">
          <p15:clr>
            <a:srgbClr val="A4A3A4"/>
          </p15:clr>
        </p15:guide>
        <p15:guide id="190" orient="horz" pos="6159" userDrawn="1">
          <p15:clr>
            <a:srgbClr val="A4A3A4"/>
          </p15:clr>
        </p15:guide>
        <p15:guide id="191" pos="2432" userDrawn="1">
          <p15:clr>
            <a:srgbClr val="A4A3A4"/>
          </p15:clr>
        </p15:guide>
        <p15:guide id="193" orient="horz" pos="5093" userDrawn="1">
          <p15:clr>
            <a:srgbClr val="A4A3A4"/>
          </p15:clr>
        </p15:guide>
        <p15:guide id="194" orient="horz" pos="5116" userDrawn="1">
          <p15:clr>
            <a:srgbClr val="A4A3A4"/>
          </p15:clr>
        </p15:guide>
        <p15:guide id="195" pos="2001" userDrawn="1">
          <p15:clr>
            <a:srgbClr val="A4A3A4"/>
          </p15:clr>
        </p15:guide>
        <p15:guide id="196" orient="horz" pos="308" userDrawn="1">
          <p15:clr>
            <a:srgbClr val="A4A3A4"/>
          </p15:clr>
        </p15:guide>
        <p15:guide id="197" orient="horz" pos="330" userDrawn="1">
          <p15:clr>
            <a:srgbClr val="A4A3A4"/>
          </p15:clr>
        </p15:guide>
        <p15:guide id="198" orient="horz" pos="353" userDrawn="1">
          <p15:clr>
            <a:srgbClr val="A4A3A4"/>
          </p15:clr>
        </p15:guide>
        <p15:guide id="199" pos="73" userDrawn="1">
          <p15:clr>
            <a:srgbClr val="A4A3A4"/>
          </p15:clr>
        </p15:guide>
        <p15:guide id="200" orient="horz" pos="2916" userDrawn="1">
          <p15:clr>
            <a:srgbClr val="A4A3A4"/>
          </p15:clr>
        </p15:guide>
        <p15:guide id="201" orient="horz" pos="1011" userDrawn="1">
          <p15:clr>
            <a:srgbClr val="A4A3A4"/>
          </p15:clr>
        </p15:guide>
        <p15:guide id="202" orient="horz" pos="920" userDrawn="1">
          <p15:clr>
            <a:srgbClr val="A4A3A4"/>
          </p15:clr>
        </p15:guide>
        <p15:guide id="203" pos="1525" userDrawn="1">
          <p15:clr>
            <a:srgbClr val="A4A3A4"/>
          </p15:clr>
        </p15:guide>
        <p15:guide id="204" pos="1752" userDrawn="1">
          <p15:clr>
            <a:srgbClr val="A4A3A4"/>
          </p15:clr>
        </p15:guide>
        <p15:guide id="206" orient="horz" pos="2077" userDrawn="1">
          <p15:clr>
            <a:srgbClr val="A4A3A4"/>
          </p15:clr>
        </p15:guide>
        <p15:guide id="207" orient="horz" pos="3392" userDrawn="1">
          <p15:clr>
            <a:srgbClr val="A4A3A4"/>
          </p15:clr>
        </p15:guide>
        <p15:guide id="209" orient="horz" pos="2757" userDrawn="1">
          <p15:clr>
            <a:srgbClr val="A4A3A4"/>
          </p15:clr>
        </p15:guide>
        <p15:guide id="210" orient="horz" pos="2780" userDrawn="1">
          <p15:clr>
            <a:srgbClr val="A4A3A4"/>
          </p15:clr>
        </p15:guide>
        <p15:guide id="211" pos="278" userDrawn="1">
          <p15:clr>
            <a:srgbClr val="A4A3A4"/>
          </p15:clr>
        </p15:guide>
        <p15:guide id="212" pos="663" userDrawn="1">
          <p15:clr>
            <a:srgbClr val="A4A3A4"/>
          </p15:clr>
        </p15:guide>
        <p15:guide id="213" pos="709" userDrawn="1">
          <p15:clr>
            <a:srgbClr val="A4A3A4"/>
          </p15:clr>
        </p15:guide>
        <p15:guide id="214" pos="640" userDrawn="1">
          <p15:clr>
            <a:srgbClr val="A4A3A4"/>
          </p15:clr>
        </p15:guide>
        <p15:guide id="215" pos="618" userDrawn="1">
          <p15:clr>
            <a:srgbClr val="A4A3A4"/>
          </p15:clr>
        </p15:guide>
        <p15:guide id="216" pos="595" userDrawn="1">
          <p15:clr>
            <a:srgbClr val="A4A3A4"/>
          </p15:clr>
        </p15:guide>
        <p15:guide id="217" pos="572" userDrawn="1">
          <p15:clr>
            <a:srgbClr val="A4A3A4"/>
          </p15:clr>
        </p15:guide>
        <p15:guide id="218" pos="550" userDrawn="1">
          <p15:clr>
            <a:srgbClr val="A4A3A4"/>
          </p15:clr>
        </p15:guide>
        <p15:guide id="219" pos="527" userDrawn="1">
          <p15:clr>
            <a:srgbClr val="A4A3A4"/>
          </p15:clr>
        </p15:guide>
        <p15:guide id="220" pos="504" userDrawn="1">
          <p15:clr>
            <a:srgbClr val="A4A3A4"/>
          </p15:clr>
        </p15:guide>
        <p15:guide id="221" pos="482" userDrawn="1">
          <p15:clr>
            <a:srgbClr val="A4A3A4"/>
          </p15:clr>
        </p15:guide>
        <p15:guide id="222" pos="459" userDrawn="1">
          <p15:clr>
            <a:srgbClr val="A4A3A4"/>
          </p15:clr>
        </p15:guide>
        <p15:guide id="223" pos="436" userDrawn="1">
          <p15:clr>
            <a:srgbClr val="A4A3A4"/>
          </p15:clr>
        </p15:guide>
        <p15:guide id="224" pos="414" userDrawn="1">
          <p15:clr>
            <a:srgbClr val="A4A3A4"/>
          </p15:clr>
        </p15:guide>
        <p15:guide id="225" pos="391" userDrawn="1">
          <p15:clr>
            <a:srgbClr val="A4A3A4"/>
          </p15:clr>
        </p15:guide>
        <p15:guide id="226" pos="368" userDrawn="1">
          <p15:clr>
            <a:srgbClr val="A4A3A4"/>
          </p15:clr>
        </p15:guide>
        <p15:guide id="227" pos="323" userDrawn="1">
          <p15:clr>
            <a:srgbClr val="A4A3A4"/>
          </p15:clr>
        </p15:guide>
        <p15:guide id="228" pos="346" userDrawn="1">
          <p15:clr>
            <a:srgbClr val="A4A3A4"/>
          </p15:clr>
        </p15:guide>
        <p15:guide id="229" pos="2727" userDrawn="1">
          <p15:clr>
            <a:srgbClr val="A4A3A4"/>
          </p15:clr>
        </p15:guide>
        <p15:guide id="231" pos="2704" userDrawn="1">
          <p15:clr>
            <a:srgbClr val="A4A3A4"/>
          </p15:clr>
        </p15:guide>
        <p15:guide id="232" pos="2636" userDrawn="1">
          <p15:clr>
            <a:srgbClr val="A4A3A4"/>
          </p15:clr>
        </p15:guide>
        <p15:guide id="233" pos="2523" userDrawn="1">
          <p15:clr>
            <a:srgbClr val="A4A3A4"/>
          </p15:clr>
        </p15:guide>
        <p15:guide id="234" pos="2500" userDrawn="1">
          <p15:clr>
            <a:srgbClr val="A4A3A4"/>
          </p15:clr>
        </p15:guide>
        <p15:guide id="235" pos="2478" userDrawn="1">
          <p15:clr>
            <a:srgbClr val="A4A3A4"/>
          </p15:clr>
        </p15:guide>
        <p15:guide id="237" orient="horz" pos="3732" userDrawn="1">
          <p15:clr>
            <a:srgbClr val="A4A3A4"/>
          </p15:clr>
        </p15:guide>
        <p15:guide id="238" orient="horz" pos="3778" userDrawn="1">
          <p15:clr>
            <a:srgbClr val="A4A3A4"/>
          </p15:clr>
        </p15:guide>
        <p15:guide id="241" orient="horz" pos="4254" userDrawn="1">
          <p15:clr>
            <a:srgbClr val="A4A3A4"/>
          </p15:clr>
        </p15:guide>
        <p15:guide id="242" orient="horz" pos="4209" userDrawn="1">
          <p15:clr>
            <a:srgbClr val="A4A3A4"/>
          </p15:clr>
        </p15:guide>
        <p15:guide id="243" pos="822" userDrawn="1">
          <p15:clr>
            <a:srgbClr val="A4A3A4"/>
          </p15:clr>
        </p15:guide>
        <p15:guide id="244" pos="845" userDrawn="1">
          <p15:clr>
            <a:srgbClr val="A4A3A4"/>
          </p15:clr>
        </p15:guide>
        <p15:guide id="245" orient="horz" pos="4594" userDrawn="1">
          <p15:clr>
            <a:srgbClr val="A4A3A4"/>
          </p15:clr>
        </p15:guide>
        <p15:guide id="246" pos="2273" userDrawn="1">
          <p15:clr>
            <a:srgbClr val="A4A3A4"/>
          </p15:clr>
        </p15:guide>
        <p15:guide id="248" pos="1956" userDrawn="1">
          <p15:clr>
            <a:srgbClr val="A4A3A4"/>
          </p15:clr>
        </p15:guide>
        <p15:guide id="250" pos="2137" userDrawn="1">
          <p15:clr>
            <a:srgbClr val="A4A3A4"/>
          </p15:clr>
        </p15:guide>
        <p15:guide id="253" orient="horz" pos="1056" userDrawn="1">
          <p15:clr>
            <a:srgbClr val="A4A3A4"/>
          </p15:clr>
        </p15:guide>
        <p15:guide id="255" orient="horz" pos="1805" userDrawn="1">
          <p15:clr>
            <a:srgbClr val="A4A3A4"/>
          </p15:clr>
        </p15:guide>
        <p15:guide id="256" orient="horz" pos="376" userDrawn="1">
          <p15:clr>
            <a:srgbClr val="A4A3A4"/>
          </p15:clr>
        </p15:guide>
        <p15:guide id="257" orient="horz" pos="965" userDrawn="1">
          <p15:clr>
            <a:srgbClr val="A4A3A4"/>
          </p15:clr>
        </p15:guide>
        <p15:guide id="258" orient="horz" pos="1714" userDrawn="1">
          <p15:clr>
            <a:srgbClr val="A4A3A4"/>
          </p15:clr>
        </p15:guide>
        <p15:guide id="260" pos="2024" userDrawn="1">
          <p15:clr>
            <a:srgbClr val="A4A3A4"/>
          </p15:clr>
        </p15:guide>
        <p15:guide id="261" pos="2183" userDrawn="1">
          <p15:clr>
            <a:srgbClr val="A4A3A4"/>
          </p15:clr>
        </p15:guide>
        <p15:guide id="262" pos="2319" userDrawn="1">
          <p15:clr>
            <a:srgbClr val="A4A3A4"/>
          </p15:clr>
        </p15:guide>
        <p15:guide id="263" pos="2341" userDrawn="1">
          <p15:clr>
            <a:srgbClr val="A4A3A4"/>
          </p15:clr>
        </p15:guide>
        <p15:guide id="264" pos="2364" userDrawn="1">
          <p15:clr>
            <a:srgbClr val="A4A3A4"/>
          </p15:clr>
        </p15:guide>
        <p15:guide id="265" orient="horz" pos="2440" userDrawn="1">
          <p15:clr>
            <a:srgbClr val="A4A3A4"/>
          </p15:clr>
        </p15:guide>
        <p15:guide id="266" pos="2750" userDrawn="1">
          <p15:clr>
            <a:srgbClr val="A4A3A4"/>
          </p15:clr>
        </p15:guide>
        <p15:guide id="268" pos="2546" userDrawn="1">
          <p15:clr>
            <a:srgbClr val="A4A3A4"/>
          </p15:clr>
        </p15:guide>
        <p15:guide id="269" pos="3113" userDrawn="1">
          <p15:clr>
            <a:srgbClr val="A4A3A4"/>
          </p15:clr>
        </p15:guide>
        <p15:guide id="270" orient="horz" pos="557" userDrawn="1">
          <p15:clr>
            <a:srgbClr val="A4A3A4"/>
          </p15:clr>
        </p15:guide>
        <p15:guide id="271" orient="horz" pos="535" userDrawn="1">
          <p15:clr>
            <a:srgbClr val="A4A3A4"/>
          </p15:clr>
        </p15:guide>
        <p15:guide id="272" orient="horz" pos="466" userDrawn="1">
          <p15:clr>
            <a:srgbClr val="A4A3A4"/>
          </p15:clr>
        </p15:guide>
        <p15:guide id="273" orient="horz" pos="444" userDrawn="1">
          <p15:clr>
            <a:srgbClr val="A4A3A4"/>
          </p15:clr>
        </p15:guide>
        <p15:guide id="274" orient="horz" pos="421" userDrawn="1">
          <p15:clr>
            <a:srgbClr val="A4A3A4"/>
          </p15:clr>
        </p15:guide>
        <p15:guide id="275" pos="2160" userDrawn="1">
          <p15:clr>
            <a:srgbClr val="A4A3A4"/>
          </p15:clr>
        </p15:guide>
        <p15:guide id="276" pos="1049" userDrawn="1">
          <p15:clr>
            <a:srgbClr val="A4A3A4"/>
          </p15:clr>
        </p15:guide>
        <p15:guide id="277" pos="1071" userDrawn="1">
          <p15:clr>
            <a:srgbClr val="A4A3A4"/>
          </p15:clr>
        </p15:guide>
        <p15:guide id="278" orient="horz" pos="1464" userDrawn="1">
          <p15:clr>
            <a:srgbClr val="A4A3A4"/>
          </p15:clr>
        </p15:guide>
        <p15:guide id="279" pos="1979" userDrawn="1">
          <p15:clr>
            <a:srgbClr val="A4A3A4"/>
          </p15:clr>
        </p15:guide>
        <p15:guide id="280" orient="horz" pos="1442" userDrawn="1">
          <p15:clr>
            <a:srgbClr val="A4A3A4"/>
          </p15:clr>
        </p15:guide>
        <p15:guide id="281" orient="horz" pos="1510" userDrawn="1">
          <p15:clr>
            <a:srgbClr val="A4A3A4"/>
          </p15:clr>
        </p15:guide>
        <p15:guide id="282" pos="1026" userDrawn="1">
          <p15:clr>
            <a:srgbClr val="A4A3A4"/>
          </p15:clr>
        </p15:guide>
        <p15:guide id="284" pos="3203" userDrawn="1">
          <p15:clr>
            <a:srgbClr val="A4A3A4"/>
          </p15:clr>
        </p15:guide>
        <p15:guide id="285" orient="horz" pos="1102" userDrawn="1">
          <p15:clr>
            <a:srgbClr val="A4A3A4"/>
          </p15:clr>
        </p15:guide>
        <p15:guide id="286" orient="horz" pos="1850" userDrawn="1">
          <p15:clr>
            <a:srgbClr val="A4A3A4"/>
          </p15:clr>
        </p15:guide>
        <p15:guide id="287" pos="28" userDrawn="1">
          <p15:clr>
            <a:srgbClr val="A4A3A4"/>
          </p15:clr>
        </p15:guide>
        <p15:guide id="288" pos="51" userDrawn="1">
          <p15:clr>
            <a:srgbClr val="A4A3A4"/>
          </p15:clr>
        </p15:guide>
        <p15:guide id="290" pos="187" userDrawn="1">
          <p15:clr>
            <a:srgbClr val="A4A3A4"/>
          </p15:clr>
        </p15:guide>
        <p15:guide id="291" orient="horz" pos="2802" userDrawn="1">
          <p15:clr>
            <a:srgbClr val="A4A3A4"/>
          </p15:clr>
        </p15:guide>
        <p15:guide id="292" orient="horz" pos="2825" userDrawn="1">
          <p15:clr>
            <a:srgbClr val="A4A3A4"/>
          </p15:clr>
        </p15:guide>
        <p15:guide id="293" orient="horz" pos="2939" userDrawn="1">
          <p15:clr>
            <a:srgbClr val="A4A3A4"/>
          </p15:clr>
        </p15:guide>
        <p15:guide id="294" pos="981" userDrawn="1">
          <p15:clr>
            <a:srgbClr val="A4A3A4"/>
          </p15:clr>
        </p15:guide>
        <p15:guide id="295" pos="958" userDrawn="1">
          <p15:clr>
            <a:srgbClr val="A4A3A4"/>
          </p15:clr>
        </p15:guide>
        <p15:guide id="296" pos="935" userDrawn="1">
          <p15:clr>
            <a:srgbClr val="A4A3A4"/>
          </p15:clr>
        </p15:guide>
        <p15:guide id="297" pos="913" userDrawn="1">
          <p15:clr>
            <a:srgbClr val="A4A3A4"/>
          </p15:clr>
        </p15:guide>
        <p15:guide id="298" pos="867" userDrawn="1">
          <p15:clr>
            <a:srgbClr val="A4A3A4"/>
          </p15:clr>
        </p15:guide>
        <p15:guide id="299" orient="horz" pos="3528" userDrawn="1">
          <p15:clr>
            <a:srgbClr val="A4A3A4"/>
          </p15:clr>
        </p15:guide>
        <p15:guide id="300" orient="horz" pos="3551" userDrawn="1">
          <p15:clr>
            <a:srgbClr val="A4A3A4"/>
          </p15:clr>
        </p15:guide>
        <p15:guide id="301" orient="horz" pos="3574" userDrawn="1">
          <p15:clr>
            <a:srgbClr val="A4A3A4"/>
          </p15:clr>
        </p15:guide>
        <p15:guide id="302" orient="horz" pos="3596" userDrawn="1">
          <p15:clr>
            <a:srgbClr val="A4A3A4"/>
          </p15:clr>
        </p15:guide>
        <p15:guide id="303" pos="2092" userDrawn="1">
          <p15:clr>
            <a:srgbClr val="A4A3A4"/>
          </p15:clr>
        </p15:guide>
        <p15:guide id="304" pos="2069" userDrawn="1">
          <p15:clr>
            <a:srgbClr val="A4A3A4"/>
          </p15:clr>
        </p15:guide>
        <p15:guide id="305" pos="2047" userDrawn="1">
          <p15:clr>
            <a:srgbClr val="A4A3A4"/>
          </p15:clr>
        </p15:guide>
        <p15:guide id="306" pos="1933" userDrawn="1">
          <p15:clr>
            <a:srgbClr val="A4A3A4"/>
          </p15:clr>
        </p15:guide>
        <p15:guide id="308" pos="1888" userDrawn="1">
          <p15:clr>
            <a:srgbClr val="A4A3A4"/>
          </p15:clr>
        </p15:guide>
        <p15:guide id="309" orient="horz" pos="2893" userDrawn="1">
          <p15:clr>
            <a:srgbClr val="A4A3A4"/>
          </p15:clr>
        </p15:guide>
        <p15:guide id="310" orient="horz" pos="2871" userDrawn="1">
          <p15:clr>
            <a:srgbClr val="A4A3A4"/>
          </p15:clr>
        </p15:guide>
        <p15:guide id="311" orient="horz" pos="3664" userDrawn="1">
          <p15:clr>
            <a:srgbClr val="A4A3A4"/>
          </p15:clr>
        </p15:guide>
        <p15:guide id="312" orient="horz" pos="3642" userDrawn="1">
          <p15:clr>
            <a:srgbClr val="A4A3A4"/>
          </p15:clr>
        </p15:guide>
        <p15:guide id="313" orient="horz" pos="4050" userDrawn="1">
          <p15:clr>
            <a:srgbClr val="A4A3A4"/>
          </p15:clr>
        </p15:guide>
        <p15:guide id="314" orient="horz" pos="4572" userDrawn="1">
          <p15:clr>
            <a:srgbClr val="A4A3A4"/>
          </p15:clr>
        </p15:guide>
        <p15:guide id="315" orient="horz" pos="4617" userDrawn="1">
          <p15:clr>
            <a:srgbClr val="A4A3A4"/>
          </p15:clr>
        </p15:guide>
        <p15:guide id="316" orient="horz" pos="4640" userDrawn="1">
          <p15:clr>
            <a:srgbClr val="A4A3A4"/>
          </p15:clr>
        </p15:guide>
        <p15:guide id="317" orient="horz" pos="4662" userDrawn="1">
          <p15:clr>
            <a:srgbClr val="A4A3A4"/>
          </p15:clr>
        </p15:guide>
        <p15:guide id="318" orient="horz" pos="4685" userDrawn="1">
          <p15:clr>
            <a:srgbClr val="A4A3A4"/>
          </p15:clr>
        </p15:guide>
        <p15:guide id="319" orient="horz" pos="4708" userDrawn="1">
          <p15:clr>
            <a:srgbClr val="A4A3A4"/>
          </p15:clr>
        </p15:guide>
        <p15:guide id="320" orient="horz" pos="4730" userDrawn="1">
          <p15:clr>
            <a:srgbClr val="A4A3A4"/>
          </p15:clr>
        </p15:guide>
        <p15:guide id="321" orient="horz" pos="4753" userDrawn="1">
          <p15:clr>
            <a:srgbClr val="A4A3A4"/>
          </p15:clr>
        </p15:guide>
        <p15:guide id="322" orient="horz" pos="3438" userDrawn="1">
          <p15:clr>
            <a:srgbClr val="A4A3A4"/>
          </p15:clr>
        </p15:guide>
        <p15:guide id="323" orient="horz" pos="3460" userDrawn="1">
          <p15:clr>
            <a:srgbClr val="A4A3A4"/>
          </p15:clr>
        </p15:guide>
        <p15:guide id="324" pos="2886" userDrawn="1">
          <p15:clr>
            <a:srgbClr val="A4A3A4"/>
          </p15:clr>
        </p15:guide>
        <p15:guide id="325" pos="4065" userDrawn="1">
          <p15:clr>
            <a:srgbClr val="A4A3A4"/>
          </p15:clr>
        </p15:guide>
        <p15:guide id="326" orient="horz" pos="5252" userDrawn="1">
          <p15:clr>
            <a:srgbClr val="A4A3A4"/>
          </p15:clr>
        </p15:guide>
        <p15:guide id="327" orient="horz" pos="6136" userDrawn="1">
          <p15:clr>
            <a:srgbClr val="A4A3A4"/>
          </p15:clr>
        </p15:guide>
        <p15:guide id="328" orient="horz" pos="6114" userDrawn="1">
          <p15:clr>
            <a:srgbClr val="A4A3A4"/>
          </p15:clr>
        </p15:guide>
        <p15:guide id="329" pos="2976" userDrawn="1">
          <p15:clr>
            <a:srgbClr val="A4A3A4"/>
          </p15:clr>
        </p15:guide>
        <p15:guide id="330" orient="horz" pos="875" userDrawn="1">
          <p15:clr>
            <a:srgbClr val="A4A3A4"/>
          </p15:clr>
        </p15:guide>
        <p15:guide id="331" orient="horz" pos="829" userDrawn="1">
          <p15:clr>
            <a:srgbClr val="A4A3A4"/>
          </p15:clr>
        </p15:guide>
        <p15:guide id="332" orient="horz" pos="807" userDrawn="1">
          <p15:clr>
            <a:srgbClr val="A4A3A4"/>
          </p15:clr>
        </p15:guide>
        <p15:guide id="333" orient="horz" pos="1419" userDrawn="1">
          <p15:clr>
            <a:srgbClr val="A4A3A4"/>
          </p15:clr>
        </p15:guide>
        <p15:guide id="335" orient="horz" pos="1578" userDrawn="1">
          <p15:clr>
            <a:srgbClr val="A4A3A4"/>
          </p15:clr>
        </p15:guide>
        <p15:guide id="336" orient="horz" pos="1623" userDrawn="1">
          <p15:clr>
            <a:srgbClr val="A4A3A4"/>
          </p15:clr>
        </p15:guide>
        <p15:guide id="337" orient="horz" pos="1532" userDrawn="1">
          <p15:clr>
            <a:srgbClr val="A4A3A4"/>
          </p15:clr>
        </p15:guide>
        <p15:guide id="338" pos="686" userDrawn="1">
          <p15:clr>
            <a:srgbClr val="A4A3A4"/>
          </p15:clr>
        </p15:guide>
        <p15:guide id="339" orient="horz" pos="2235" userDrawn="1">
          <p15:clr>
            <a:srgbClr val="A4A3A4"/>
          </p15:clr>
        </p15:guide>
        <p15:guide id="341" orient="horz" pos="2417" userDrawn="1">
          <p15:clr>
            <a:srgbClr val="A4A3A4"/>
          </p15:clr>
        </p15:guide>
        <p15:guide id="342" orient="horz" pos="3029" userDrawn="1">
          <p15:clr>
            <a:srgbClr val="A4A3A4"/>
          </p15:clr>
        </p15:guide>
        <p15:guide id="343" orient="horz" pos="3052" userDrawn="1">
          <p15:clr>
            <a:srgbClr val="A4A3A4"/>
          </p15:clr>
        </p15:guide>
        <p15:guide id="344" orient="horz" pos="3007" userDrawn="1">
          <p15:clr>
            <a:srgbClr val="A4A3A4"/>
          </p15:clr>
        </p15:guide>
        <p15:guide id="345" orient="horz" pos="2394" userDrawn="1">
          <p15:clr>
            <a:srgbClr val="A4A3A4"/>
          </p15:clr>
        </p15:guide>
        <p15:guide id="346" orient="horz" pos="1555" userDrawn="1">
          <p15:clr>
            <a:srgbClr val="A4A3A4"/>
          </p15:clr>
        </p15:guide>
        <p15:guide id="347" orient="horz" pos="3710" userDrawn="1">
          <p15:clr>
            <a:srgbClr val="A4A3A4"/>
          </p15:clr>
        </p15:guide>
        <p15:guide id="348" orient="horz" pos="3687" userDrawn="1">
          <p15:clr>
            <a:srgbClr val="A4A3A4"/>
          </p15:clr>
        </p15:guide>
        <p15:guide id="349" orient="horz" pos="4934" userDrawn="1">
          <p15:clr>
            <a:srgbClr val="A4A3A4"/>
          </p15:clr>
        </p15:guide>
        <p15:guide id="350" orient="horz" pos="4912" userDrawn="1">
          <p15:clr>
            <a:srgbClr val="A4A3A4"/>
          </p15:clr>
        </p15:guide>
        <p15:guide id="351" orient="horz" pos="4957" userDrawn="1">
          <p15:clr>
            <a:srgbClr val="A4A3A4"/>
          </p15:clr>
        </p15:guide>
        <p15:guide id="352" orient="horz" pos="4889" userDrawn="1">
          <p15:clr>
            <a:srgbClr val="A4A3A4"/>
          </p15:clr>
        </p15:guide>
        <p15:guide id="353" orient="horz" pos="4231" userDrawn="1">
          <p15:clr>
            <a:srgbClr val="A4A3A4"/>
          </p15:clr>
        </p15:guide>
        <p15:guide id="354" orient="horz" pos="648" userDrawn="1">
          <p15:clr>
            <a:srgbClr val="A4A3A4"/>
          </p15:clr>
        </p15:guide>
        <p15:guide id="355" orient="horz" pos="625" userDrawn="1">
          <p15:clr>
            <a:srgbClr val="A4A3A4"/>
          </p15:clr>
        </p15:guide>
        <p15:guide id="356" pos="2908" userDrawn="1">
          <p15:clr>
            <a:srgbClr val="A4A3A4"/>
          </p15:clr>
        </p15:guide>
        <p15:guide id="357" orient="horz" pos="3369" userDrawn="1">
          <p15:clr>
            <a:srgbClr val="A4A3A4"/>
          </p15:clr>
        </p15:guide>
        <p15:guide id="358" orient="horz" pos="2167" userDrawn="1">
          <p15:clr>
            <a:srgbClr val="A4A3A4"/>
          </p15:clr>
        </p15:guide>
        <p15:guide id="359" orient="horz" pos="172" userDrawn="1">
          <p15:clr>
            <a:srgbClr val="A4A3A4"/>
          </p15:clr>
        </p15:guide>
        <p15:guide id="360" orient="horz" pos="149" userDrawn="1">
          <p15:clr>
            <a:srgbClr val="A4A3A4"/>
          </p15:clr>
        </p15:guide>
        <p15:guide id="361" orient="horz" pos="126" userDrawn="1">
          <p15:clr>
            <a:srgbClr val="A4A3A4"/>
          </p15:clr>
        </p15:guide>
        <p15:guide id="362" userDrawn="1">
          <p15:clr>
            <a:srgbClr val="A4A3A4"/>
          </p15:clr>
        </p15:guide>
        <p15:guide id="363" orient="horz" pos="104" userDrawn="1">
          <p15:clr>
            <a:srgbClr val="A4A3A4"/>
          </p15:clr>
        </p15:guide>
        <p15:guide id="364" orient="horz" pos="2145" userDrawn="1">
          <p15:clr>
            <a:srgbClr val="A4A3A4"/>
          </p15:clr>
        </p15:guide>
        <p15:guide id="365" orient="horz" pos="2961" userDrawn="1">
          <p15:clr>
            <a:srgbClr val="A4A3A4"/>
          </p15:clr>
        </p15:guide>
        <p15:guide id="367" orient="horz" pos="716" userDrawn="1">
          <p15:clr>
            <a:srgbClr val="A4A3A4"/>
          </p15:clr>
        </p15:guide>
        <p15:guide id="368" orient="horz" pos="693" userDrawn="1">
          <p15:clr>
            <a:srgbClr val="A4A3A4"/>
          </p15:clr>
        </p15:guide>
        <p15:guide id="369" orient="horz" pos="58" userDrawn="1">
          <p15:clr>
            <a:srgbClr val="A4A3A4"/>
          </p15:clr>
        </p15:guide>
        <p15:guide id="370" orient="horz" pos="36" userDrawn="1">
          <p15:clr>
            <a:srgbClr val="A4A3A4"/>
          </p15:clr>
        </p15:guide>
        <p15:guide id="371" orient="horz" pos="262" userDrawn="1">
          <p15:clr>
            <a:srgbClr val="A4A3A4"/>
          </p15:clr>
        </p15:guide>
        <p15:guide id="372" orient="horz" pos="4549" userDrawn="1">
          <p15:clr>
            <a:srgbClr val="A4A3A4"/>
          </p15:clr>
        </p15:guide>
        <p15:guide id="373" orient="horz" pos="3619" userDrawn="1">
          <p15:clr>
            <a:srgbClr val="A4A3A4"/>
          </p15:clr>
        </p15:guide>
        <p15:guide id="374" orient="horz" pos="3165" userDrawn="1">
          <p15:clr>
            <a:srgbClr val="A4A3A4"/>
          </p15:clr>
        </p15:guide>
        <p15:guide id="375" orient="horz" pos="489" userDrawn="1">
          <p15:clr>
            <a:srgbClr val="A4A3A4"/>
          </p15:clr>
        </p15:guide>
        <p15:guide id="376" orient="horz" pos="3914" userDrawn="1">
          <p15:clr>
            <a:srgbClr val="A4A3A4"/>
          </p15:clr>
        </p15:guide>
        <p15:guide id="377" orient="horz" pos="1737" userDrawn="1">
          <p15:clr>
            <a:srgbClr val="A4A3A4"/>
          </p15:clr>
        </p15:guide>
        <p15:guide id="378" orient="horz" pos="1691" userDrawn="1">
          <p15:clr>
            <a:srgbClr val="A4A3A4"/>
          </p15:clr>
        </p15:guide>
        <p15:guide id="379" orient="horz" pos="3256" userDrawn="1">
          <p15:clr>
            <a:srgbClr val="A4A3A4"/>
          </p15:clr>
        </p15:guide>
        <p15:guide id="380" orient="horz" pos="3868" userDrawn="1">
          <p15:clr>
            <a:srgbClr val="A4A3A4"/>
          </p15:clr>
        </p15:guide>
        <p15:guide id="381" pos="3294" userDrawn="1">
          <p15:clr>
            <a:srgbClr val="A4A3A4"/>
          </p15:clr>
        </p15:guide>
        <p15:guide id="382" orient="horz" pos="3959" userDrawn="1">
          <p15:clr>
            <a:srgbClr val="A4A3A4"/>
          </p15:clr>
        </p15:guide>
        <p15:guide id="383" orient="horz" pos="3936" userDrawn="1">
          <p15:clr>
            <a:srgbClr val="A4A3A4"/>
          </p15:clr>
        </p15:guide>
        <p15:guide id="384" orient="horz" pos="5161" userDrawn="1">
          <p15:clr>
            <a:srgbClr val="A4A3A4"/>
          </p15:clr>
        </p15:guide>
        <p15:guide id="385" orient="horz" pos="5138" userDrawn="1">
          <p15:clr>
            <a:srgbClr val="A4A3A4"/>
          </p15:clr>
        </p15:guide>
        <p15:guide id="386" orient="horz" pos="4186" userDrawn="1">
          <p15:clr>
            <a:srgbClr val="A4A3A4"/>
          </p15:clr>
        </p15:guide>
        <p15:guide id="387" orient="horz" pos="4844" userDrawn="1">
          <p15:clr>
            <a:srgbClr val="A4A3A4"/>
          </p15:clr>
        </p15:guide>
        <p15:guide id="388" orient="horz" pos="4821" userDrawn="1">
          <p15:clr>
            <a:srgbClr val="A4A3A4"/>
          </p15:clr>
        </p15:guide>
        <p15:guide id="389" orient="horz" pos="5411" userDrawn="1">
          <p15:clr>
            <a:srgbClr val="A4A3A4"/>
          </p15:clr>
        </p15:guide>
        <p15:guide id="390" orient="horz" pos="5388" userDrawn="1">
          <p15:clr>
            <a:srgbClr val="A4A3A4"/>
          </p15:clr>
        </p15:guide>
        <p15:guide id="391" orient="horz" pos="5365" userDrawn="1">
          <p15:clr>
            <a:srgbClr val="A4A3A4"/>
          </p15:clr>
        </p15:guide>
        <p15:guide id="392" orient="horz" pos="5728" userDrawn="1">
          <p15:clr>
            <a:srgbClr val="A4A3A4"/>
          </p15:clr>
        </p15:guide>
        <p15:guide id="393" orient="horz" pos="2372" userDrawn="1">
          <p15:clr>
            <a:srgbClr val="A4A3A4"/>
          </p15:clr>
        </p15:guide>
        <p15:guide id="394" orient="horz" pos="2349" userDrawn="1">
          <p15:clr>
            <a:srgbClr val="A4A3A4"/>
          </p15:clr>
        </p15:guide>
        <p15:guide id="395" orient="horz" pos="2984" userDrawn="1">
          <p15:clr>
            <a:srgbClr val="A4A3A4"/>
          </p15:clr>
        </p15:guide>
        <p15:guide id="396" pos="1457" userDrawn="1">
          <p15:clr>
            <a:srgbClr val="A4A3A4"/>
          </p15:clr>
        </p15:guide>
        <p15:guide id="397" orient="horz" pos="2326" userDrawn="1">
          <p15:clr>
            <a:srgbClr val="A4A3A4"/>
          </p15:clr>
        </p15:guide>
        <p15:guide id="398" orient="horz" pos="2304" userDrawn="1">
          <p15:clr>
            <a:srgbClr val="A4A3A4"/>
          </p15:clr>
        </p15:guide>
        <p15:guide id="399" orient="horz" pos="2281" userDrawn="1">
          <p15:clr>
            <a:srgbClr val="A4A3A4"/>
          </p15:clr>
        </p15:guide>
        <p15:guide id="400" pos="1185" userDrawn="1">
          <p15:clr>
            <a:srgbClr val="A4A3A4"/>
          </p15:clr>
        </p15:guide>
        <p15:guide id="401" pos="1162" userDrawn="1">
          <p15:clr>
            <a:srgbClr val="A4A3A4"/>
          </p15:clr>
        </p15:guide>
        <p15:guide id="402" pos="1003" userDrawn="1">
          <p15:clr>
            <a:srgbClr val="A4A3A4"/>
          </p15:clr>
        </p15:guide>
        <p15:guide id="403" pos="1139" userDrawn="1">
          <p15:clr>
            <a:srgbClr val="A4A3A4"/>
          </p15:clr>
        </p15:guide>
        <p15:guide id="404" pos="1094" userDrawn="1">
          <p15:clr>
            <a:srgbClr val="A4A3A4"/>
          </p15:clr>
        </p15:guide>
        <p15:guide id="405" pos="1117" userDrawn="1">
          <p15:clr>
            <a:srgbClr val="A4A3A4"/>
          </p15:clr>
        </p15:guide>
        <p15:guide id="406" orient="horz" pos="1374" userDrawn="1">
          <p15:clr>
            <a:srgbClr val="A4A3A4"/>
          </p15:clr>
        </p15:guide>
        <p15:guide id="407" orient="horz" pos="1487" userDrawn="1">
          <p15:clr>
            <a:srgbClr val="A4A3A4"/>
          </p15:clr>
        </p15:guide>
        <p15:guide id="408" pos="4247" userDrawn="1">
          <p15:clr>
            <a:srgbClr val="A4A3A4"/>
          </p15:clr>
        </p15:guide>
        <p15:guide id="409" orient="horz" pos="3755" userDrawn="1">
          <p15:clr>
            <a:srgbClr val="A4A3A4"/>
          </p15:clr>
        </p15:guide>
        <p15:guide id="410" pos="2409" userDrawn="1">
          <p15:clr>
            <a:srgbClr val="A4A3A4"/>
          </p15:clr>
        </p15:guide>
        <p15:guide id="411" pos="3385" userDrawn="1">
          <p15:clr>
            <a:srgbClr val="A4A3A4"/>
          </p15:clr>
        </p15:guide>
        <p15:guide id="412" orient="horz" pos="5774" userDrawn="1">
          <p15:clr>
            <a:srgbClr val="A4A3A4"/>
          </p15:clr>
        </p15:guide>
        <p15:guide id="413" orient="horz" pos="1238" userDrawn="1">
          <p15:clr>
            <a:srgbClr val="A4A3A4"/>
          </p15:clr>
        </p15:guide>
        <p15:guide id="414" orient="horz" pos="1215" userDrawn="1">
          <p15:clr>
            <a:srgbClr val="A4A3A4"/>
          </p15:clr>
        </p15:guide>
        <p15:guide id="415" orient="horz" pos="1033" userDrawn="1">
          <p15:clr>
            <a:srgbClr val="A4A3A4"/>
          </p15:clr>
        </p15:guide>
        <p15:guide id="416" orient="horz" pos="3143" userDrawn="1">
          <p15:clr>
            <a:srgbClr val="A4A3A4"/>
          </p15:clr>
        </p15:guide>
        <p15:guide id="417" orient="horz" pos="3120" userDrawn="1">
          <p15:clr>
            <a:srgbClr val="A4A3A4"/>
          </p15:clr>
        </p15:guide>
        <p15:guide id="418" orient="horz" pos="4027" userDrawn="1">
          <p15:clr>
            <a:srgbClr val="A4A3A4"/>
          </p15:clr>
        </p15:guide>
        <p15:guide id="419" orient="horz" pos="4095" userDrawn="1">
          <p15:clr>
            <a:srgbClr val="A4A3A4"/>
          </p15:clr>
        </p15:guide>
        <p15:guide id="420" orient="horz" pos="4073" userDrawn="1">
          <p15:clr>
            <a:srgbClr val="A4A3A4"/>
          </p15:clr>
        </p15:guide>
        <p15:guide id="421" orient="horz" pos="5343" userDrawn="1">
          <p15:clr>
            <a:srgbClr val="A4A3A4"/>
          </p15:clr>
        </p15:guide>
        <p15:guide id="422" orient="horz" pos="6000" userDrawn="1">
          <p15:clr>
            <a:srgbClr val="A4A3A4"/>
          </p15:clr>
        </p15:guide>
        <p15:guide id="423" orient="horz" pos="671" userDrawn="1">
          <p15:clr>
            <a:srgbClr val="A4A3A4"/>
          </p15:clr>
        </p15:guide>
        <p15:guide id="424" orient="horz" pos="1328" userDrawn="1">
          <p15:clr>
            <a:srgbClr val="A4A3A4"/>
          </p15:clr>
        </p15:guide>
        <p15:guide id="425" orient="horz" pos="1306" userDrawn="1">
          <p15:clr>
            <a:srgbClr val="A4A3A4"/>
          </p15:clr>
        </p15:guide>
        <p15:guide id="426" orient="horz" pos="1646" userDrawn="1">
          <p15:clr>
            <a:srgbClr val="A4A3A4"/>
          </p15:clr>
        </p15:guide>
        <p15:guide id="427" orient="horz" pos="3415" userDrawn="1">
          <p15:clr>
            <a:srgbClr val="A4A3A4"/>
          </p15:clr>
        </p15:guide>
        <p15:guide id="428" pos="1298" userDrawn="1">
          <p15:clr>
            <a:srgbClr val="A4A3A4"/>
          </p15:clr>
        </p15:guide>
        <p15:guide id="429" pos="1275" userDrawn="1">
          <p15:clr>
            <a:srgbClr val="A4A3A4"/>
          </p15:clr>
        </p15:guide>
        <p15:guide id="430" pos="1253" userDrawn="1">
          <p15:clr>
            <a:srgbClr val="A4A3A4"/>
          </p15:clr>
        </p15:guide>
        <p15:guide id="431" pos="1207" userDrawn="1">
          <p15:clr>
            <a:srgbClr val="A4A3A4"/>
          </p15:clr>
        </p15:guide>
        <p15:guide id="432" orient="horz" pos="5864" userDrawn="1">
          <p15:clr>
            <a:srgbClr val="A4A3A4"/>
          </p15:clr>
        </p15:guide>
        <p15:guide id="433" orient="horz" pos="584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99"/>
    <a:srgbClr val="FF5050"/>
    <a:srgbClr val="D0E9A9"/>
    <a:srgbClr val="D4D4D4"/>
    <a:srgbClr val="808080"/>
    <a:srgbClr val="A00000"/>
    <a:srgbClr val="000000"/>
    <a:srgbClr val="0066FF"/>
    <a:srgbClr val="056AFF"/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409" autoAdjust="0"/>
    <p:restoredTop sz="91790" autoAdjust="0"/>
  </p:normalViewPr>
  <p:slideViewPr>
    <p:cSldViewPr snapToGrid="0">
      <p:cViewPr varScale="1">
        <p:scale>
          <a:sx n="105" d="100"/>
          <a:sy n="105" d="100"/>
        </p:scale>
        <p:origin x="2970" y="120"/>
      </p:cViewPr>
      <p:guideLst>
        <p:guide orient="horz" pos="761"/>
        <p:guide pos="1389"/>
        <p:guide orient="horz" pos="4005"/>
        <p:guide pos="2772"/>
        <p:guide orient="horz" pos="943"/>
        <p:guide orient="horz" pos="3211"/>
        <p:guide pos="300"/>
        <p:guide pos="210"/>
        <p:guide pos="2795"/>
        <p:guide orient="horz" pos="285"/>
        <p:guide orient="horz" pos="603"/>
        <p:guide orient="horz" pos="784"/>
        <p:guide pos="1616"/>
        <p:guide pos="232"/>
        <p:guide pos="3090"/>
        <p:guide pos="731"/>
        <p:guide orient="horz" pos="6204"/>
        <p:guide orient="horz" pos="3279"/>
        <p:guide orient="horz" pos="5660"/>
        <p:guide pos="164"/>
        <p:guide orient="horz" pos="1963"/>
        <p:guide orient="horz" pos="1396"/>
        <p:guide pos="2205"/>
        <p:guide orient="horz" pos="4503"/>
        <p:guide orient="horz" pos="1827"/>
        <p:guide pos="754"/>
        <p:guide orient="horz" pos="5184"/>
        <p:guide pos="119"/>
        <p:guide orient="horz" pos="217"/>
        <p:guide pos="142"/>
        <p:guide orient="horz" pos="739"/>
        <p:guide orient="horz" pos="240"/>
        <p:guide pos="1593"/>
        <p:guide orient="horz" pos="81"/>
        <p:guide pos="2115"/>
        <p:guide orient="horz" pos="580"/>
        <p:guide orient="horz" pos="512"/>
        <p:guide pos="96"/>
        <p:guide orient="horz" pos="1918"/>
        <p:guide orient="horz" pos="2190"/>
        <p:guide orient="horz" pos="2553"/>
        <p:guide orient="horz" pos="2099"/>
        <p:guide orient="horz" pos="2734"/>
        <p:guide orient="horz" pos="4481"/>
        <p:guide orient="horz" pos="3347"/>
        <p:guide pos="1865"/>
        <p:guide orient="horz" pos="3483"/>
        <p:guide orient="horz" pos="6023"/>
        <p:guide orient="horz" pos="6091"/>
        <p:guide pos="3974"/>
        <p:guide pos="3181"/>
        <p:guide pos="3158"/>
        <p:guide pos="3135"/>
        <p:guide pos="3271"/>
        <p:guide pos="3226"/>
        <p:guide pos="3997"/>
        <p:guide pos="2251"/>
        <p:guide orient="horz" pos="5048"/>
        <p:guide orient="horz" pos="5637"/>
        <p:guide pos="777"/>
        <p:guide orient="horz" pos="6227"/>
        <p:guide orient="horz" pos="3891"/>
        <p:guide pos="799"/>
        <p:guide orient="horz" pos="4458"/>
        <p:guide pos="2228"/>
        <p:guide orient="horz" pos="4299"/>
        <p:guide orient="horz" pos="4345"/>
        <p:guide orient="horz" pos="4413"/>
        <p:guide orient="horz" pos="4322"/>
        <p:guide orient="horz" pos="4367"/>
        <p:guide orient="horz" pos="5025"/>
        <p:guide orient="horz" pos="5547"/>
        <p:guide orient="horz" pos="3846"/>
        <p:guide pos="1321"/>
        <p:guide pos="1548"/>
        <p:guide orient="horz" pos="1351"/>
        <p:guide orient="horz" pos="1192"/>
        <p:guide pos="3407"/>
        <p:guide orient="horz" pos="1260"/>
        <p:guide orient="horz" pos="2530"/>
        <p:guide pos="2818"/>
        <p:guide pos="3249"/>
        <p:guide orient="horz" pos="1986"/>
        <p:guide orient="horz" pos="2689"/>
        <p:guide pos="1842"/>
        <p:guide pos="1706"/>
        <p:guide pos="3045"/>
        <p:guide pos="1911"/>
        <p:guide pos="1684"/>
        <p:guide pos="1661"/>
        <p:guide pos="2455"/>
        <p:guide pos="2296"/>
        <p:guide pos="2387"/>
        <p:guide pos="2682"/>
        <p:guide pos="2614"/>
        <p:guide pos="2591"/>
        <p:guide orient="horz" pos="2712"/>
        <p:guide orient="horz" pos="2576"/>
        <p:guide orient="horz" pos="2054"/>
        <p:guide orient="horz" pos="2031"/>
        <p:guide pos="3317"/>
        <p:guide pos="3430"/>
        <p:guide pos="3362"/>
        <p:guide pos="3884"/>
        <p:guide pos="3339"/>
        <p:guide pos="3453"/>
        <p:guide pos="2568"/>
        <p:guide pos="3498"/>
        <p:guide pos="3543"/>
        <p:guide pos="3521"/>
        <p:guide pos="3566"/>
        <p:guide pos="3589"/>
        <p:guide pos="2999"/>
        <p:guide pos="3022"/>
        <p:guide pos="2954"/>
        <p:guide pos="3067"/>
        <p:guide pos="2931"/>
        <p:guide orient="horz" pos="2009"/>
        <p:guide orient="horz" pos="2666"/>
        <p:guide orient="horz" pos="2644"/>
        <p:guide pos="1344"/>
        <p:guide pos="1366"/>
        <p:guide pos="1412"/>
        <p:guide pos="2840"/>
        <p:guide pos="4292"/>
        <p:guide pos="3612"/>
        <p:guide pos="4269"/>
        <p:guide pos="4201"/>
        <p:guide pos="3634"/>
        <p:guide pos="3657"/>
        <p:guide pos="3680"/>
        <p:guide pos="1797"/>
        <p:guide pos="1774"/>
        <p:guide pos="1570"/>
        <p:guide pos="1480"/>
        <p:guide orient="horz" pos="4980"/>
        <p:guide orient="horz" pos="5002"/>
        <p:guide orient="horz" pos="5070"/>
        <p:guide orient="horz" pos="5592"/>
        <p:guide orient="horz" pos="5615"/>
        <p:guide orient="horz" pos="5569"/>
        <p:guide orient="horz" pos="5751"/>
        <p:guide orient="horz" pos="5819"/>
        <p:guide orient="horz" pos="6182"/>
        <p:guide orient="horz" pos="4277"/>
        <p:guide pos="3929"/>
        <p:guide pos="3906"/>
        <p:guide pos="3952"/>
        <p:guide pos="3861"/>
        <p:guide pos="3838"/>
        <p:guide pos="3816"/>
        <p:guide pos="3793"/>
        <p:guide pos="3770"/>
        <p:guide pos="3748"/>
        <p:guide pos="3702"/>
        <p:guide pos="3725"/>
        <p:guide pos="3475"/>
        <p:guide orient="horz" pos="3800"/>
        <p:guide orient="horz" pos="3823"/>
        <p:guide pos="1729"/>
        <p:guide pos="1434"/>
        <p:guide pos="890"/>
        <p:guide pos="255"/>
        <p:guide pos="1638"/>
        <p:guide orient="horz" pos="6159"/>
        <p:guide pos="2432"/>
        <p:guide orient="horz" pos="5093"/>
        <p:guide orient="horz" pos="5116"/>
        <p:guide pos="2001"/>
        <p:guide orient="horz" pos="308"/>
        <p:guide orient="horz" pos="330"/>
        <p:guide orient="horz" pos="353"/>
        <p:guide pos="73"/>
        <p:guide orient="horz" pos="2916"/>
        <p:guide orient="horz" pos="1011"/>
        <p:guide orient="horz" pos="920"/>
        <p:guide pos="1525"/>
        <p:guide pos="1752"/>
        <p:guide orient="horz" pos="2077"/>
        <p:guide orient="horz" pos="3392"/>
        <p:guide orient="horz" pos="2757"/>
        <p:guide orient="horz" pos="2780"/>
        <p:guide pos="278"/>
        <p:guide pos="663"/>
        <p:guide pos="709"/>
        <p:guide pos="640"/>
        <p:guide pos="618"/>
        <p:guide pos="595"/>
        <p:guide pos="572"/>
        <p:guide pos="550"/>
        <p:guide pos="527"/>
        <p:guide pos="504"/>
        <p:guide pos="482"/>
        <p:guide pos="459"/>
        <p:guide pos="436"/>
        <p:guide pos="414"/>
        <p:guide pos="391"/>
        <p:guide pos="368"/>
        <p:guide pos="323"/>
        <p:guide pos="346"/>
        <p:guide pos="2727"/>
        <p:guide pos="2704"/>
        <p:guide pos="2636"/>
        <p:guide pos="2523"/>
        <p:guide pos="2500"/>
        <p:guide pos="2478"/>
        <p:guide orient="horz" pos="3732"/>
        <p:guide orient="horz" pos="3778"/>
        <p:guide orient="horz" pos="4254"/>
        <p:guide orient="horz" pos="4209"/>
        <p:guide pos="822"/>
        <p:guide pos="845"/>
        <p:guide orient="horz" pos="4594"/>
        <p:guide pos="2273"/>
        <p:guide pos="1956"/>
        <p:guide pos="2137"/>
        <p:guide orient="horz" pos="1056"/>
        <p:guide orient="horz" pos="1805"/>
        <p:guide orient="horz" pos="376"/>
        <p:guide orient="horz" pos="965"/>
        <p:guide orient="horz" pos="1714"/>
        <p:guide pos="2024"/>
        <p:guide pos="2183"/>
        <p:guide pos="2319"/>
        <p:guide pos="2341"/>
        <p:guide pos="2364"/>
        <p:guide orient="horz" pos="2440"/>
        <p:guide pos="2750"/>
        <p:guide pos="2546"/>
        <p:guide pos="3113"/>
        <p:guide orient="horz" pos="557"/>
        <p:guide orient="horz" pos="535"/>
        <p:guide orient="horz" pos="466"/>
        <p:guide orient="horz" pos="444"/>
        <p:guide orient="horz" pos="421"/>
        <p:guide pos="2160"/>
        <p:guide pos="1049"/>
        <p:guide pos="1071"/>
        <p:guide orient="horz" pos="1464"/>
        <p:guide pos="1979"/>
        <p:guide orient="horz" pos="1442"/>
        <p:guide orient="horz" pos="1510"/>
        <p:guide pos="1026"/>
        <p:guide pos="3203"/>
        <p:guide orient="horz" pos="1102"/>
        <p:guide orient="horz" pos="1850"/>
        <p:guide pos="28"/>
        <p:guide pos="51"/>
        <p:guide pos="187"/>
        <p:guide orient="horz" pos="2802"/>
        <p:guide orient="horz" pos="2825"/>
        <p:guide orient="horz" pos="2939"/>
        <p:guide pos="981"/>
        <p:guide pos="958"/>
        <p:guide pos="935"/>
        <p:guide pos="913"/>
        <p:guide pos="867"/>
        <p:guide orient="horz" pos="3528"/>
        <p:guide orient="horz" pos="3551"/>
        <p:guide orient="horz" pos="3574"/>
        <p:guide orient="horz" pos="3596"/>
        <p:guide pos="2092"/>
        <p:guide pos="2069"/>
        <p:guide pos="2047"/>
        <p:guide pos="1933"/>
        <p:guide pos="1888"/>
        <p:guide orient="horz" pos="2893"/>
        <p:guide orient="horz" pos="2871"/>
        <p:guide orient="horz" pos="3664"/>
        <p:guide orient="horz" pos="3642"/>
        <p:guide orient="horz" pos="4050"/>
        <p:guide orient="horz" pos="4572"/>
        <p:guide orient="horz" pos="4617"/>
        <p:guide orient="horz" pos="4640"/>
        <p:guide orient="horz" pos="4662"/>
        <p:guide orient="horz" pos="4685"/>
        <p:guide orient="horz" pos="4708"/>
        <p:guide orient="horz" pos="4730"/>
        <p:guide orient="horz" pos="4753"/>
        <p:guide orient="horz" pos="3438"/>
        <p:guide orient="horz" pos="3460"/>
        <p:guide pos="2886"/>
        <p:guide pos="4065"/>
        <p:guide orient="horz" pos="5252"/>
        <p:guide orient="horz" pos="6136"/>
        <p:guide orient="horz" pos="6114"/>
        <p:guide pos="2976"/>
        <p:guide orient="horz" pos="875"/>
        <p:guide orient="horz" pos="829"/>
        <p:guide orient="horz" pos="807"/>
        <p:guide orient="horz" pos="1419"/>
        <p:guide orient="horz" pos="1578"/>
        <p:guide orient="horz" pos="1623"/>
        <p:guide orient="horz" pos="1532"/>
        <p:guide pos="686"/>
        <p:guide orient="horz" pos="2235"/>
        <p:guide orient="horz" pos="2417"/>
        <p:guide orient="horz" pos="3029"/>
        <p:guide orient="horz" pos="3052"/>
        <p:guide orient="horz" pos="3007"/>
        <p:guide orient="horz" pos="2394"/>
        <p:guide orient="horz" pos="1555"/>
        <p:guide orient="horz" pos="3710"/>
        <p:guide orient="horz" pos="3687"/>
        <p:guide orient="horz" pos="4934"/>
        <p:guide orient="horz" pos="4912"/>
        <p:guide orient="horz" pos="4957"/>
        <p:guide orient="horz" pos="4889"/>
        <p:guide orient="horz" pos="4231"/>
        <p:guide orient="horz" pos="648"/>
        <p:guide orient="horz" pos="625"/>
        <p:guide pos="2908"/>
        <p:guide orient="horz" pos="3369"/>
        <p:guide orient="horz" pos="2167"/>
        <p:guide orient="horz" pos="172"/>
        <p:guide orient="horz" pos="149"/>
        <p:guide orient="horz" pos="126"/>
        <p:guide/>
        <p:guide orient="horz" pos="104"/>
        <p:guide orient="horz" pos="2145"/>
        <p:guide orient="horz" pos="2961"/>
        <p:guide orient="horz" pos="716"/>
        <p:guide orient="horz" pos="693"/>
        <p:guide orient="horz" pos="58"/>
        <p:guide orient="horz" pos="36"/>
        <p:guide orient="horz" pos="262"/>
        <p:guide orient="horz" pos="4549"/>
        <p:guide orient="horz" pos="3619"/>
        <p:guide orient="horz" pos="3165"/>
        <p:guide orient="horz" pos="489"/>
        <p:guide orient="horz" pos="3914"/>
        <p:guide orient="horz" pos="1737"/>
        <p:guide orient="horz" pos="1691"/>
        <p:guide orient="horz" pos="3256"/>
        <p:guide orient="horz" pos="3868"/>
        <p:guide pos="3294"/>
        <p:guide orient="horz" pos="3959"/>
        <p:guide orient="horz" pos="3936"/>
        <p:guide orient="horz" pos="5161"/>
        <p:guide orient="horz" pos="5138"/>
        <p:guide orient="horz" pos="4186"/>
        <p:guide orient="horz" pos="4844"/>
        <p:guide orient="horz" pos="4821"/>
        <p:guide orient="horz" pos="5411"/>
        <p:guide orient="horz" pos="5388"/>
        <p:guide orient="horz" pos="5365"/>
        <p:guide orient="horz" pos="5728"/>
        <p:guide orient="horz" pos="2372"/>
        <p:guide orient="horz" pos="2349"/>
        <p:guide orient="horz" pos="2984"/>
        <p:guide pos="1457"/>
        <p:guide orient="horz" pos="2326"/>
        <p:guide orient="horz" pos="2304"/>
        <p:guide orient="horz" pos="2281"/>
        <p:guide pos="1185"/>
        <p:guide pos="1162"/>
        <p:guide pos="1003"/>
        <p:guide pos="1139"/>
        <p:guide pos="1094"/>
        <p:guide pos="1117"/>
        <p:guide orient="horz" pos="1374"/>
        <p:guide orient="horz" pos="1487"/>
        <p:guide pos="4247"/>
        <p:guide orient="horz" pos="3755"/>
        <p:guide pos="2409"/>
        <p:guide pos="3385"/>
        <p:guide orient="horz" pos="5774"/>
        <p:guide orient="horz" pos="1238"/>
        <p:guide orient="horz" pos="1215"/>
        <p:guide orient="horz" pos="1033"/>
        <p:guide orient="horz" pos="3143"/>
        <p:guide orient="horz" pos="3120"/>
        <p:guide orient="horz" pos="4027"/>
        <p:guide orient="horz" pos="4095"/>
        <p:guide orient="horz" pos="4073"/>
        <p:guide orient="horz" pos="5343"/>
        <p:guide orient="horz" pos="6000"/>
        <p:guide orient="horz" pos="671"/>
        <p:guide orient="horz" pos="1328"/>
        <p:guide orient="horz" pos="1306"/>
        <p:guide orient="horz" pos="1646"/>
        <p:guide orient="horz" pos="3415"/>
        <p:guide pos="1298"/>
        <p:guide pos="1275"/>
        <p:guide pos="1253"/>
        <p:guide pos="1207"/>
        <p:guide orient="horz" pos="5864"/>
        <p:guide orient="horz" pos="5842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6" y="9"/>
            <a:ext cx="2945659" cy="495427"/>
          </a:xfrm>
          <a:prstGeom prst="rect">
            <a:avLst/>
          </a:prstGeom>
        </p:spPr>
        <p:txBody>
          <a:bodyPr vert="horz" lIns="95192" tIns="47596" rIns="95192" bIns="47596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50" y="9"/>
            <a:ext cx="2945659" cy="495427"/>
          </a:xfrm>
          <a:prstGeom prst="rect">
            <a:avLst/>
          </a:prstGeom>
        </p:spPr>
        <p:txBody>
          <a:bodyPr vert="horz" lIns="95192" tIns="47596" rIns="95192" bIns="47596" rtlCol="0"/>
          <a:lstStyle>
            <a:lvl1pPr algn="r">
              <a:defRPr sz="1300"/>
            </a:lvl1pPr>
          </a:lstStyle>
          <a:p>
            <a:fld id="{E29AC161-8CAB-407C-8BF3-8C221900EC31}" type="datetimeFigureOut">
              <a:rPr lang="ko-KR" altLang="en-US" smtClean="0"/>
              <a:t>2022-06-2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46313" y="1235075"/>
            <a:ext cx="2305050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192" tIns="47596" rIns="95192" bIns="47596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51986"/>
            <a:ext cx="5438140" cy="3887986"/>
          </a:xfrm>
          <a:prstGeom prst="rect">
            <a:avLst/>
          </a:prstGeom>
        </p:spPr>
        <p:txBody>
          <a:bodyPr vert="horz" lIns="95192" tIns="47596" rIns="95192" bIns="47596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6" y="9378825"/>
            <a:ext cx="2945659" cy="495426"/>
          </a:xfrm>
          <a:prstGeom prst="rect">
            <a:avLst/>
          </a:prstGeom>
        </p:spPr>
        <p:txBody>
          <a:bodyPr vert="horz" lIns="95192" tIns="47596" rIns="95192" bIns="47596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50" y="9378825"/>
            <a:ext cx="2945659" cy="495426"/>
          </a:xfrm>
          <a:prstGeom prst="rect">
            <a:avLst/>
          </a:prstGeom>
        </p:spPr>
        <p:txBody>
          <a:bodyPr vert="horz" lIns="95192" tIns="47596" rIns="95192" bIns="47596" rtlCol="0" anchor="b"/>
          <a:lstStyle>
            <a:lvl1pPr algn="r">
              <a:defRPr sz="1300"/>
            </a:lvl1pPr>
          </a:lstStyle>
          <a:p>
            <a:fld id="{896B9CDA-CD40-450E-A963-40C6C9E720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52386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6B9CDA-CD40-450E-A963-40C6C9E72028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749153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6B9CDA-CD40-450E-A963-40C6C9E72028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96377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6/24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744461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111EC-215B-4DBE-8A7F-30D2C8C2B373}" type="datetimeFigureOut">
              <a:rPr lang="ko-KR" altLang="en-US" smtClean="0"/>
              <a:pPr/>
              <a:t>2022-06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DB24B2-3394-49BF-AF3A-5CD18F46B60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90646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5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5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111EC-215B-4DBE-8A7F-30D2C8C2B373}" type="datetimeFigureOut">
              <a:rPr lang="ko-KR" altLang="en-US" smtClean="0"/>
              <a:t>2022-06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DB24B2-3394-49BF-AF3A-5CD18F46B6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220484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83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16520" indent="0" algn="ctr">
              <a:buNone/>
              <a:defRPr sz="1385"/>
            </a:lvl2pPr>
            <a:lvl3pPr marL="633039" indent="0" algn="ctr">
              <a:buNone/>
              <a:defRPr sz="1246"/>
            </a:lvl3pPr>
            <a:lvl4pPr marL="949559" indent="0" algn="ctr">
              <a:buNone/>
              <a:defRPr sz="1108"/>
            </a:lvl4pPr>
            <a:lvl5pPr marL="1266078" indent="0" algn="ctr">
              <a:buNone/>
              <a:defRPr sz="1108"/>
            </a:lvl5pPr>
            <a:lvl6pPr marL="1582598" indent="0" algn="ctr">
              <a:buNone/>
              <a:defRPr sz="1108"/>
            </a:lvl6pPr>
            <a:lvl7pPr marL="1899117" indent="0" algn="ctr">
              <a:buNone/>
              <a:defRPr sz="1108"/>
            </a:lvl7pPr>
            <a:lvl8pPr marL="2215637" indent="0" algn="ctr">
              <a:buNone/>
              <a:defRPr sz="1108"/>
            </a:lvl8pPr>
            <a:lvl9pPr marL="2532156" indent="0" algn="ctr">
              <a:buNone/>
              <a:defRPr sz="1108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28005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111EC-215B-4DBE-8A7F-30D2C8C2B373}" type="datetimeFigureOut">
              <a:rPr lang="ko-KR" altLang="en-US" smtClean="0"/>
              <a:t>2022-06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DB24B2-3394-49BF-AF3A-5CD18F46B6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90229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111EC-215B-4DBE-8A7F-30D2C8C2B373}" type="datetimeFigureOut">
              <a:rPr lang="ko-KR" altLang="en-US" smtClean="0"/>
              <a:t>2022-06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DB24B2-3394-49BF-AF3A-5CD18F46B6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17785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111EC-215B-4DBE-8A7F-30D2C8C2B373}" type="datetimeFigureOut">
              <a:rPr lang="ko-KR" altLang="en-US" smtClean="0"/>
              <a:t>2022-06-2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DB24B2-3394-49BF-AF3A-5CD18F46B6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427633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9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4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9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111EC-215B-4DBE-8A7F-30D2C8C2B373}" type="datetimeFigureOut">
              <a:rPr lang="ko-KR" altLang="en-US" smtClean="0"/>
              <a:t>2022-06-24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DB24B2-3394-49BF-AF3A-5CD18F46B6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55635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111EC-215B-4DBE-8A7F-30D2C8C2B373}" type="datetimeFigureOut">
              <a:rPr lang="ko-KR" altLang="en-US" smtClean="0"/>
              <a:t>2022-06-24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DB24B2-3394-49BF-AF3A-5CD18F46B6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83832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111EC-215B-4DBE-8A7F-30D2C8C2B373}" type="datetimeFigureOut">
              <a:rPr lang="ko-KR" altLang="en-US" smtClean="0"/>
              <a:pPr/>
              <a:t>2022-06-2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DB24B2-3394-49BF-AF3A-5CD18F46B60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03969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5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111EC-215B-4DBE-8A7F-30D2C8C2B373}" type="datetimeFigureOut">
              <a:rPr lang="ko-KR" altLang="en-US" smtClean="0"/>
              <a:t>2022-06-2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DB24B2-3394-49BF-AF3A-5CD18F46B6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4369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5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111EC-215B-4DBE-8A7F-30D2C8C2B373}" type="datetimeFigureOut">
              <a:rPr lang="ko-KR" altLang="en-US" smtClean="0"/>
              <a:t>2022-06-2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DB24B2-3394-49BF-AF3A-5CD18F46B6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5439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dirty="0"/>
              <a:t>6/24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98127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4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Relationship Id="rId6" Type="http://schemas.microsoft.com/office/2007/relationships/hdphoto" Target="../media/hdphoto1.wdp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2.xml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그룹 4">
            <a:extLst>
              <a:ext uri="{FF2B5EF4-FFF2-40B4-BE49-F238E27FC236}">
                <a16:creationId xmlns:a16="http://schemas.microsoft.com/office/drawing/2014/main" id="{8EE23130-8E21-4CD8-B993-F14F2B3DB407}"/>
              </a:ext>
            </a:extLst>
          </p:cNvPr>
          <p:cNvGrpSpPr/>
          <p:nvPr/>
        </p:nvGrpSpPr>
        <p:grpSpPr>
          <a:xfrm>
            <a:off x="1934646" y="5532521"/>
            <a:ext cx="2474809" cy="1023017"/>
            <a:chOff x="12546682" y="-770496"/>
            <a:chExt cx="4070877" cy="1682787"/>
          </a:xfrm>
        </p:grpSpPr>
        <p:pic>
          <p:nvPicPr>
            <p:cNvPr id="370" name="Picture 567">
              <a:extLst>
                <a:ext uri="{FF2B5EF4-FFF2-40B4-BE49-F238E27FC236}">
                  <a16:creationId xmlns:a16="http://schemas.microsoft.com/office/drawing/2014/main" id="{673C8F50-2EC5-416E-B3CB-4DB9DA32337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/>
            <a:stretch>
              <a:fillRect/>
            </a:stretch>
          </p:blipFill>
          <p:spPr bwMode="auto">
            <a:xfrm>
              <a:off x="12546682" y="-770496"/>
              <a:ext cx="4070877" cy="16827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71" name="Line 568">
              <a:extLst>
                <a:ext uri="{FF2B5EF4-FFF2-40B4-BE49-F238E27FC236}">
                  <a16:creationId xmlns:a16="http://schemas.microsoft.com/office/drawing/2014/main" id="{A164A20F-2D69-4202-B8A9-B9E6CF619B5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558356" y="-628514"/>
              <a:ext cx="0" cy="149411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ko-KR" altLang="en-US" sz="18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itchFamily="34" charset="0"/>
                <a:ea typeface="굴림" charset="-127"/>
                <a:cs typeface="Arial" pitchFamily="34" charset="0"/>
              </a:endParaRPr>
            </a:p>
          </p:txBody>
        </p:sp>
        <p:sp>
          <p:nvSpPr>
            <p:cNvPr id="372" name="Line 569">
              <a:extLst>
                <a:ext uri="{FF2B5EF4-FFF2-40B4-BE49-F238E27FC236}">
                  <a16:creationId xmlns:a16="http://schemas.microsoft.com/office/drawing/2014/main" id="{4D80A303-67C6-4537-97FF-A335EC38B80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585460" y="-619762"/>
              <a:ext cx="0" cy="149703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ko-KR" altLang="en-US" sz="18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itchFamily="34" charset="0"/>
                <a:ea typeface="굴림" charset="-127"/>
                <a:cs typeface="Arial" pitchFamily="34" charset="0"/>
              </a:endParaRPr>
            </a:p>
          </p:txBody>
        </p:sp>
        <p:sp>
          <p:nvSpPr>
            <p:cNvPr id="373" name="Line 570">
              <a:extLst>
                <a:ext uri="{FF2B5EF4-FFF2-40B4-BE49-F238E27FC236}">
                  <a16:creationId xmlns:a16="http://schemas.microsoft.com/office/drawing/2014/main" id="{E2D6526D-AB00-467C-9F03-37BFDC7849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555436" y="865600"/>
              <a:ext cx="403586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ko-KR" altLang="en-US" sz="18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itchFamily="34" charset="0"/>
                <a:ea typeface="굴림" charset="-127"/>
                <a:cs typeface="Arial" pitchFamily="34" charset="0"/>
              </a:endParaRPr>
            </a:p>
          </p:txBody>
        </p:sp>
      </p:grpSp>
      <p:grpSp>
        <p:nvGrpSpPr>
          <p:cNvPr id="6" name="그룹 5">
            <a:extLst>
              <a:ext uri="{FF2B5EF4-FFF2-40B4-BE49-F238E27FC236}">
                <a16:creationId xmlns:a16="http://schemas.microsoft.com/office/drawing/2014/main" id="{B786AD78-6594-4479-9A22-47FB3241A98B}"/>
              </a:ext>
            </a:extLst>
          </p:cNvPr>
          <p:cNvGrpSpPr/>
          <p:nvPr/>
        </p:nvGrpSpPr>
        <p:grpSpPr>
          <a:xfrm>
            <a:off x="1925688" y="7825968"/>
            <a:ext cx="2474809" cy="1023017"/>
            <a:chOff x="12546682" y="-770496"/>
            <a:chExt cx="4070877" cy="1682787"/>
          </a:xfrm>
        </p:grpSpPr>
        <p:pic>
          <p:nvPicPr>
            <p:cNvPr id="363" name="Picture 567">
              <a:extLst>
                <a:ext uri="{FF2B5EF4-FFF2-40B4-BE49-F238E27FC236}">
                  <a16:creationId xmlns:a16="http://schemas.microsoft.com/office/drawing/2014/main" id="{CCE81A51-56BB-4C32-9948-522A9807772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/>
            <a:stretch>
              <a:fillRect/>
            </a:stretch>
          </p:blipFill>
          <p:spPr bwMode="auto">
            <a:xfrm>
              <a:off x="12546682" y="-770496"/>
              <a:ext cx="4070877" cy="16827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64" name="Line 568">
              <a:extLst>
                <a:ext uri="{FF2B5EF4-FFF2-40B4-BE49-F238E27FC236}">
                  <a16:creationId xmlns:a16="http://schemas.microsoft.com/office/drawing/2014/main" id="{5839EA61-39DB-4B3B-8B0A-694C9E248A1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558356" y="-628514"/>
              <a:ext cx="0" cy="149411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ko-KR" altLang="en-US" sz="18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itchFamily="34" charset="0"/>
                <a:ea typeface="굴림" charset="-127"/>
                <a:cs typeface="Arial" pitchFamily="34" charset="0"/>
              </a:endParaRPr>
            </a:p>
          </p:txBody>
        </p:sp>
        <p:sp>
          <p:nvSpPr>
            <p:cNvPr id="365" name="Line 569">
              <a:extLst>
                <a:ext uri="{FF2B5EF4-FFF2-40B4-BE49-F238E27FC236}">
                  <a16:creationId xmlns:a16="http://schemas.microsoft.com/office/drawing/2014/main" id="{66A8D169-FCA7-4935-B8C4-FD067718EFE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585460" y="-619762"/>
              <a:ext cx="0" cy="149703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ko-KR" altLang="en-US" sz="18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itchFamily="34" charset="0"/>
                <a:ea typeface="굴림" charset="-127"/>
                <a:cs typeface="Arial" pitchFamily="34" charset="0"/>
              </a:endParaRPr>
            </a:p>
          </p:txBody>
        </p:sp>
        <p:sp>
          <p:nvSpPr>
            <p:cNvPr id="366" name="Line 570">
              <a:extLst>
                <a:ext uri="{FF2B5EF4-FFF2-40B4-BE49-F238E27FC236}">
                  <a16:creationId xmlns:a16="http://schemas.microsoft.com/office/drawing/2014/main" id="{5BDB4A45-B841-47E8-B73F-FE300C5B022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555436" y="865600"/>
              <a:ext cx="403586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ko-KR" altLang="en-US" sz="18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itchFamily="34" charset="0"/>
                <a:ea typeface="굴림" charset="-127"/>
                <a:cs typeface="Arial" pitchFamily="34" charset="0"/>
              </a:endParaRPr>
            </a:p>
          </p:txBody>
        </p:sp>
        <p:sp>
          <p:nvSpPr>
            <p:cNvPr id="367" name="Rectangle 571">
              <a:extLst>
                <a:ext uri="{FF2B5EF4-FFF2-40B4-BE49-F238E27FC236}">
                  <a16:creationId xmlns:a16="http://schemas.microsoft.com/office/drawing/2014/main" id="{08303032-C8ED-4ED8-8C58-AED8E2A0121E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12718854" y="-307513"/>
              <a:ext cx="1056385" cy="1024285"/>
            </a:xfrm>
            <a:prstGeom prst="rect">
              <a:avLst/>
            </a:prstGeom>
            <a:solidFill>
              <a:srgbClr val="FF0000">
                <a:alpha val="50195"/>
              </a:srgbClr>
            </a:solidFill>
            <a:ln w="9525">
              <a:noFill/>
              <a:miter lim="800000"/>
              <a:headEnd/>
              <a:tailEnd/>
            </a:ln>
          </p:spPr>
          <p:txBody>
            <a:bodyPr wrap="none" anchor="ctr"/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ko-KR" altLang="en-US" sz="18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itchFamily="34" charset="0"/>
                <a:ea typeface="굴림" charset="-127"/>
                <a:cs typeface="Arial" pitchFamily="34" charset="0"/>
              </a:endParaRPr>
            </a:p>
          </p:txBody>
        </p:sp>
        <p:sp>
          <p:nvSpPr>
            <p:cNvPr id="368" name="Rectangle 572">
              <a:extLst>
                <a:ext uri="{FF2B5EF4-FFF2-40B4-BE49-F238E27FC236}">
                  <a16:creationId xmlns:a16="http://schemas.microsoft.com/office/drawing/2014/main" id="{29578D28-8B60-4FA2-9113-ABD0D4CE2608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14058306" y="-307513"/>
              <a:ext cx="1056385" cy="1024285"/>
            </a:xfrm>
            <a:prstGeom prst="rect">
              <a:avLst/>
            </a:prstGeom>
            <a:solidFill>
              <a:srgbClr val="FF0000">
                <a:alpha val="50000"/>
              </a:srgbClr>
            </a:solidFill>
            <a:ln w="9525">
              <a:noFill/>
              <a:miter lim="800000"/>
              <a:headEnd/>
              <a:tailEnd/>
            </a:ln>
          </p:spPr>
          <p:txBody>
            <a:bodyPr wrap="none" anchor="ctr"/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ko-KR" altLang="en-US" sz="18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itchFamily="34" charset="0"/>
                <a:ea typeface="굴림" charset="-127"/>
                <a:cs typeface="Arial" pitchFamily="34" charset="0"/>
              </a:endParaRPr>
            </a:p>
          </p:txBody>
        </p:sp>
        <p:sp>
          <p:nvSpPr>
            <p:cNvPr id="369" name="Rectangle 573">
              <a:extLst>
                <a:ext uri="{FF2B5EF4-FFF2-40B4-BE49-F238E27FC236}">
                  <a16:creationId xmlns:a16="http://schemas.microsoft.com/office/drawing/2014/main" id="{DE2DF39F-7966-4DC4-A425-C27F4A0648A9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15383164" y="-307513"/>
              <a:ext cx="1056385" cy="1024285"/>
            </a:xfrm>
            <a:prstGeom prst="rect">
              <a:avLst/>
            </a:prstGeom>
            <a:solidFill>
              <a:srgbClr val="FF0000">
                <a:alpha val="50000"/>
              </a:srgbClr>
            </a:solidFill>
            <a:ln w="9525">
              <a:noFill/>
              <a:miter lim="800000"/>
              <a:headEnd/>
              <a:tailEnd/>
            </a:ln>
          </p:spPr>
          <p:txBody>
            <a:bodyPr wrap="none" anchor="ctr"/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ko-KR" altLang="en-US" sz="18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itchFamily="34" charset="0"/>
                <a:ea typeface="굴림" charset="-127"/>
                <a:cs typeface="Arial" pitchFamily="34" charset="0"/>
              </a:endParaRPr>
            </a:p>
          </p:txBody>
        </p:sp>
      </p:grpSp>
      <p:sp>
        <p:nvSpPr>
          <p:cNvPr id="7" name="Freeform 575">
            <a:extLst>
              <a:ext uri="{FF2B5EF4-FFF2-40B4-BE49-F238E27FC236}">
                <a16:creationId xmlns:a16="http://schemas.microsoft.com/office/drawing/2014/main" id="{CD5F912C-87BF-430B-858C-8586F222EC5F}"/>
              </a:ext>
            </a:extLst>
          </p:cNvPr>
          <p:cNvSpPr>
            <a:spLocks/>
          </p:cNvSpPr>
          <p:nvPr/>
        </p:nvSpPr>
        <p:spPr bwMode="auto">
          <a:xfrm>
            <a:off x="1953880" y="5317970"/>
            <a:ext cx="2478212" cy="778552"/>
          </a:xfrm>
          <a:custGeom>
            <a:avLst/>
            <a:gdLst>
              <a:gd name="T0" fmla="*/ 0 w 3906"/>
              <a:gd name="T1" fmla="*/ 0 h 1242"/>
              <a:gd name="T2" fmla="*/ 0 w 3906"/>
              <a:gd name="T3" fmla="*/ 2 h 1242"/>
              <a:gd name="T4" fmla="*/ 1 w 3906"/>
              <a:gd name="T5" fmla="*/ 2 h 1242"/>
              <a:gd name="T6" fmla="*/ 1 w 3906"/>
              <a:gd name="T7" fmla="*/ 5 h 1242"/>
              <a:gd name="T8" fmla="*/ 1 w 3906"/>
              <a:gd name="T9" fmla="*/ 5 h 1242"/>
              <a:gd name="T10" fmla="*/ 4 w 3906"/>
              <a:gd name="T11" fmla="*/ 5 h 1242"/>
              <a:gd name="T12" fmla="*/ 4 w 3906"/>
              <a:gd name="T13" fmla="*/ 5 h 1242"/>
              <a:gd name="T14" fmla="*/ 4 w 3906"/>
              <a:gd name="T15" fmla="*/ 2 h 1242"/>
              <a:gd name="T16" fmla="*/ 7 w 3906"/>
              <a:gd name="T17" fmla="*/ 2 h 1242"/>
              <a:gd name="T18" fmla="*/ 7 w 3906"/>
              <a:gd name="T19" fmla="*/ 5 h 1242"/>
              <a:gd name="T20" fmla="*/ 7 w 3906"/>
              <a:gd name="T21" fmla="*/ 5 h 1242"/>
              <a:gd name="T22" fmla="*/ 10 w 3906"/>
              <a:gd name="T23" fmla="*/ 5 h 1242"/>
              <a:gd name="T24" fmla="*/ 10 w 3906"/>
              <a:gd name="T25" fmla="*/ 5 h 1242"/>
              <a:gd name="T26" fmla="*/ 10 w 3906"/>
              <a:gd name="T27" fmla="*/ 2 h 1242"/>
              <a:gd name="T28" fmla="*/ 12 w 3906"/>
              <a:gd name="T29" fmla="*/ 2 h 1242"/>
              <a:gd name="T30" fmla="*/ 12 w 3906"/>
              <a:gd name="T31" fmla="*/ 5 h 1242"/>
              <a:gd name="T32" fmla="*/ 12 w 3906"/>
              <a:gd name="T33" fmla="*/ 5 h 1242"/>
              <a:gd name="T34" fmla="*/ 15 w 3906"/>
              <a:gd name="T35" fmla="*/ 5 h 1242"/>
              <a:gd name="T36" fmla="*/ 15 w 3906"/>
              <a:gd name="T37" fmla="*/ 5 h 1242"/>
              <a:gd name="T38" fmla="*/ 15 w 3906"/>
              <a:gd name="T39" fmla="*/ 5 h 1242"/>
              <a:gd name="T40" fmla="*/ 16 w 3906"/>
              <a:gd name="T41" fmla="*/ 2 h 1242"/>
              <a:gd name="T42" fmla="*/ 17 w 3906"/>
              <a:gd name="T43" fmla="*/ 2 h 1242"/>
              <a:gd name="T44" fmla="*/ 17 w 3906"/>
              <a:gd name="T45" fmla="*/ 0 h 1242"/>
              <a:gd name="T46" fmla="*/ 0 w 3906"/>
              <a:gd name="T47" fmla="*/ 0 h 1242"/>
              <a:gd name="T48" fmla="*/ 0 60000 65536"/>
              <a:gd name="T49" fmla="*/ 0 60000 65536"/>
              <a:gd name="T50" fmla="*/ 0 60000 65536"/>
              <a:gd name="T51" fmla="*/ 0 60000 65536"/>
              <a:gd name="T52" fmla="*/ 0 60000 65536"/>
              <a:gd name="T53" fmla="*/ 0 60000 65536"/>
              <a:gd name="T54" fmla="*/ 0 60000 65536"/>
              <a:gd name="T55" fmla="*/ 0 60000 65536"/>
              <a:gd name="T56" fmla="*/ 0 60000 65536"/>
              <a:gd name="T57" fmla="*/ 0 60000 65536"/>
              <a:gd name="T58" fmla="*/ 0 60000 65536"/>
              <a:gd name="T59" fmla="*/ 0 60000 65536"/>
              <a:gd name="T60" fmla="*/ 0 60000 65536"/>
              <a:gd name="T61" fmla="*/ 0 60000 65536"/>
              <a:gd name="T62" fmla="*/ 0 60000 65536"/>
              <a:gd name="T63" fmla="*/ 0 60000 65536"/>
              <a:gd name="T64" fmla="*/ 0 60000 65536"/>
              <a:gd name="T65" fmla="*/ 0 60000 65536"/>
              <a:gd name="T66" fmla="*/ 0 60000 65536"/>
              <a:gd name="T67" fmla="*/ 0 60000 65536"/>
              <a:gd name="T68" fmla="*/ 0 60000 65536"/>
              <a:gd name="T69" fmla="*/ 0 60000 65536"/>
              <a:gd name="T70" fmla="*/ 0 60000 65536"/>
              <a:gd name="T71" fmla="*/ 0 60000 65536"/>
              <a:gd name="T72" fmla="*/ 0 w 3906"/>
              <a:gd name="T73" fmla="*/ 0 h 1242"/>
              <a:gd name="T74" fmla="*/ 3906 w 3906"/>
              <a:gd name="T75" fmla="*/ 1242 h 1242"/>
            </a:gdLst>
            <a:ahLst/>
            <a:cxnLst>
              <a:cxn ang="T48">
                <a:pos x="T0" y="T1"/>
              </a:cxn>
              <a:cxn ang="T49">
                <a:pos x="T2" y="T3"/>
              </a:cxn>
              <a:cxn ang="T50">
                <a:pos x="T4" y="T5"/>
              </a:cxn>
              <a:cxn ang="T51">
                <a:pos x="T6" y="T7"/>
              </a:cxn>
              <a:cxn ang="T52">
                <a:pos x="T8" y="T9"/>
              </a:cxn>
              <a:cxn ang="T53">
                <a:pos x="T10" y="T11"/>
              </a:cxn>
              <a:cxn ang="T54">
                <a:pos x="T12" y="T13"/>
              </a:cxn>
              <a:cxn ang="T55">
                <a:pos x="T14" y="T15"/>
              </a:cxn>
              <a:cxn ang="T56">
                <a:pos x="T16" y="T17"/>
              </a:cxn>
              <a:cxn ang="T57">
                <a:pos x="T18" y="T19"/>
              </a:cxn>
              <a:cxn ang="T58">
                <a:pos x="T20" y="T21"/>
              </a:cxn>
              <a:cxn ang="T59">
                <a:pos x="T22" y="T23"/>
              </a:cxn>
              <a:cxn ang="T60">
                <a:pos x="T24" y="T25"/>
              </a:cxn>
              <a:cxn ang="T61">
                <a:pos x="T26" y="T27"/>
              </a:cxn>
              <a:cxn ang="T62">
                <a:pos x="T28" y="T29"/>
              </a:cxn>
              <a:cxn ang="T63">
                <a:pos x="T30" y="T31"/>
              </a:cxn>
              <a:cxn ang="T64">
                <a:pos x="T32" y="T33"/>
              </a:cxn>
              <a:cxn ang="T65">
                <a:pos x="T34" y="T35"/>
              </a:cxn>
              <a:cxn ang="T66">
                <a:pos x="T36" y="T37"/>
              </a:cxn>
              <a:cxn ang="T67">
                <a:pos x="T38" y="T39"/>
              </a:cxn>
              <a:cxn ang="T68">
                <a:pos x="T40" y="T41"/>
              </a:cxn>
              <a:cxn ang="T69">
                <a:pos x="T42" y="T43"/>
              </a:cxn>
              <a:cxn ang="T70">
                <a:pos x="T44" y="T45"/>
              </a:cxn>
              <a:cxn ang="T71">
                <a:pos x="T46" y="T47"/>
              </a:cxn>
            </a:cxnLst>
            <a:rect l="T72" t="T73" r="T74" b="T75"/>
            <a:pathLst>
              <a:path w="3906" h="1242">
                <a:moveTo>
                  <a:pt x="0" y="3"/>
                </a:moveTo>
                <a:lnTo>
                  <a:pt x="0" y="381"/>
                </a:lnTo>
                <a:lnTo>
                  <a:pt x="250" y="380"/>
                </a:lnTo>
                <a:lnTo>
                  <a:pt x="289" y="1195"/>
                </a:lnTo>
                <a:lnTo>
                  <a:pt x="324" y="1239"/>
                </a:lnTo>
                <a:lnTo>
                  <a:pt x="943" y="1242"/>
                </a:lnTo>
                <a:lnTo>
                  <a:pt x="996" y="1194"/>
                </a:lnTo>
                <a:lnTo>
                  <a:pt x="1031" y="374"/>
                </a:lnTo>
                <a:lnTo>
                  <a:pt x="1562" y="372"/>
                </a:lnTo>
                <a:lnTo>
                  <a:pt x="1605" y="1197"/>
                </a:lnTo>
                <a:lnTo>
                  <a:pt x="1648" y="1242"/>
                </a:lnTo>
                <a:lnTo>
                  <a:pt x="2256" y="1242"/>
                </a:lnTo>
                <a:lnTo>
                  <a:pt x="2312" y="1194"/>
                </a:lnTo>
                <a:lnTo>
                  <a:pt x="2342" y="380"/>
                </a:lnTo>
                <a:lnTo>
                  <a:pt x="2886" y="378"/>
                </a:lnTo>
                <a:lnTo>
                  <a:pt x="2907" y="1185"/>
                </a:lnTo>
                <a:lnTo>
                  <a:pt x="2969" y="1242"/>
                </a:lnTo>
                <a:lnTo>
                  <a:pt x="3582" y="1242"/>
                </a:lnTo>
                <a:lnTo>
                  <a:pt x="3574" y="1237"/>
                </a:lnTo>
                <a:lnTo>
                  <a:pt x="3633" y="1192"/>
                </a:lnTo>
                <a:lnTo>
                  <a:pt x="3662" y="382"/>
                </a:lnTo>
                <a:lnTo>
                  <a:pt x="3906" y="381"/>
                </a:lnTo>
                <a:lnTo>
                  <a:pt x="3906" y="0"/>
                </a:lnTo>
                <a:lnTo>
                  <a:pt x="0" y="3"/>
                </a:lnTo>
                <a:close/>
              </a:path>
            </a:pathLst>
          </a:custGeom>
          <a:solidFill>
            <a:srgbClr val="BBE0E3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ko-KR" altLang="en-US" sz="1800" b="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Arial" pitchFamily="34" charset="0"/>
              <a:ea typeface="굴림" charset="-127"/>
              <a:cs typeface="Arial" pitchFamily="34" charset="0"/>
            </a:endParaRPr>
          </a:p>
        </p:txBody>
      </p:sp>
      <p:sp>
        <p:nvSpPr>
          <p:cNvPr id="8" name="AutoShape 62">
            <a:extLst>
              <a:ext uri="{FF2B5EF4-FFF2-40B4-BE49-F238E27FC236}">
                <a16:creationId xmlns:a16="http://schemas.microsoft.com/office/drawing/2014/main" id="{56BF5259-10F4-42A7-B693-C6929DD557F7}"/>
              </a:ext>
            </a:extLst>
          </p:cNvPr>
          <p:cNvSpPr>
            <a:spLocks noChangeAspect="1" noChangeArrowheads="1"/>
          </p:cNvSpPr>
          <p:nvPr/>
        </p:nvSpPr>
        <p:spPr bwMode="auto">
          <a:xfrm rot="10800000">
            <a:off x="2129244" y="5800938"/>
            <a:ext cx="454865" cy="545339"/>
          </a:xfrm>
          <a:custGeom>
            <a:avLst/>
            <a:gdLst>
              <a:gd name="T0" fmla="*/ 0 w 21600"/>
              <a:gd name="T1" fmla="*/ 0 h 21600"/>
              <a:gd name="T2" fmla="*/ 0 w 21600"/>
              <a:gd name="T3" fmla="*/ 0 h 21600"/>
              <a:gd name="T4" fmla="*/ 0 w 21600"/>
              <a:gd name="T5" fmla="*/ 0 h 21600"/>
              <a:gd name="T6" fmla="*/ 0 w 21600"/>
              <a:gd name="T7" fmla="*/ 0 h 21600"/>
              <a:gd name="T8" fmla="*/ 0 60000 65536"/>
              <a:gd name="T9" fmla="*/ 0 60000 65536"/>
              <a:gd name="T10" fmla="*/ 0 60000 65536"/>
              <a:gd name="T11" fmla="*/ 0 60000 65536"/>
              <a:gd name="T12" fmla="*/ 0 w 21600"/>
              <a:gd name="T13" fmla="*/ 0 h 21600"/>
              <a:gd name="T14" fmla="*/ 21600 w 21600"/>
              <a:gd name="T15" fmla="*/ 7736 h 2160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21600" h="21600">
                <a:moveTo>
                  <a:pt x="10740" y="10800"/>
                </a:moveTo>
                <a:cubicBezTo>
                  <a:pt x="10740" y="10766"/>
                  <a:pt x="10766" y="10740"/>
                  <a:pt x="10800" y="10740"/>
                </a:cubicBezTo>
                <a:cubicBezTo>
                  <a:pt x="10833" y="10739"/>
                  <a:pt x="10859" y="10766"/>
                  <a:pt x="10860" y="10799"/>
                </a:cubicBezTo>
                <a:lnTo>
                  <a:pt x="21600" y="10800"/>
                </a:lnTo>
                <a:cubicBezTo>
                  <a:pt x="21600" y="4835"/>
                  <a:pt x="16764" y="0"/>
                  <a:pt x="10800" y="0"/>
                </a:cubicBezTo>
                <a:cubicBezTo>
                  <a:pt x="4835" y="0"/>
                  <a:pt x="0" y="4835"/>
                  <a:pt x="0" y="10800"/>
                </a:cubicBezTo>
                <a:close/>
              </a:path>
            </a:pathLst>
          </a:custGeom>
          <a:solidFill>
            <a:srgbClr val="00CC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ko-KR" altLang="en-US" sz="180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Arial" pitchFamily="34" charset="0"/>
              <a:ea typeface="굴림" charset="-127"/>
              <a:cs typeface="Arial" pitchFamily="34" charset="0"/>
            </a:endParaRPr>
          </a:p>
        </p:txBody>
      </p:sp>
      <p:grpSp>
        <p:nvGrpSpPr>
          <p:cNvPr id="9" name="그룹 8">
            <a:extLst>
              <a:ext uri="{FF2B5EF4-FFF2-40B4-BE49-F238E27FC236}">
                <a16:creationId xmlns:a16="http://schemas.microsoft.com/office/drawing/2014/main" id="{2B82DB17-2EBF-4CCB-B0F1-751A4EFE6E4B}"/>
              </a:ext>
            </a:extLst>
          </p:cNvPr>
          <p:cNvGrpSpPr/>
          <p:nvPr/>
        </p:nvGrpSpPr>
        <p:grpSpPr>
          <a:xfrm rot="10800000">
            <a:off x="2360454" y="6287351"/>
            <a:ext cx="70913" cy="48223"/>
            <a:chOff x="9017763" y="2551103"/>
            <a:chExt cx="116646" cy="79323"/>
          </a:xfrm>
        </p:grpSpPr>
        <p:sp>
          <p:nvSpPr>
            <p:cNvPr id="361" name="타원 360">
              <a:extLst>
                <a:ext uri="{FF2B5EF4-FFF2-40B4-BE49-F238E27FC236}">
                  <a16:creationId xmlns:a16="http://schemas.microsoft.com/office/drawing/2014/main" id="{A3D013C0-69C1-47E5-8DCF-FE49808ACA0A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362" name="타원 361">
              <a:extLst>
                <a:ext uri="{FF2B5EF4-FFF2-40B4-BE49-F238E27FC236}">
                  <a16:creationId xmlns:a16="http://schemas.microsoft.com/office/drawing/2014/main" id="{39194834-0060-4985-8C0E-E2905BF2897B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10" name="그룹 9">
            <a:extLst>
              <a:ext uri="{FF2B5EF4-FFF2-40B4-BE49-F238E27FC236}">
                <a16:creationId xmlns:a16="http://schemas.microsoft.com/office/drawing/2014/main" id="{0F539BB0-F171-4C18-9043-802253E63BB4}"/>
              </a:ext>
            </a:extLst>
          </p:cNvPr>
          <p:cNvGrpSpPr/>
          <p:nvPr/>
        </p:nvGrpSpPr>
        <p:grpSpPr>
          <a:xfrm rot="10800000">
            <a:off x="2346756" y="6233153"/>
            <a:ext cx="70913" cy="48223"/>
            <a:chOff x="9017763" y="2551103"/>
            <a:chExt cx="116646" cy="79323"/>
          </a:xfrm>
        </p:grpSpPr>
        <p:sp>
          <p:nvSpPr>
            <p:cNvPr id="359" name="타원 358">
              <a:extLst>
                <a:ext uri="{FF2B5EF4-FFF2-40B4-BE49-F238E27FC236}">
                  <a16:creationId xmlns:a16="http://schemas.microsoft.com/office/drawing/2014/main" id="{8540CF3C-A9A0-4387-A241-A65636124B65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360" name="타원 359">
              <a:extLst>
                <a:ext uri="{FF2B5EF4-FFF2-40B4-BE49-F238E27FC236}">
                  <a16:creationId xmlns:a16="http://schemas.microsoft.com/office/drawing/2014/main" id="{A2CCADB6-5D56-4C4A-9A82-60E42EE69C38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11" name="그룹 10">
            <a:extLst>
              <a:ext uri="{FF2B5EF4-FFF2-40B4-BE49-F238E27FC236}">
                <a16:creationId xmlns:a16="http://schemas.microsoft.com/office/drawing/2014/main" id="{510AAB83-F545-4D9F-8049-B3070F3F6FBF}"/>
              </a:ext>
            </a:extLst>
          </p:cNvPr>
          <p:cNvGrpSpPr/>
          <p:nvPr/>
        </p:nvGrpSpPr>
        <p:grpSpPr>
          <a:xfrm rot="10800000">
            <a:off x="2269015" y="6217445"/>
            <a:ext cx="70913" cy="48223"/>
            <a:chOff x="9017763" y="2551103"/>
            <a:chExt cx="116646" cy="79323"/>
          </a:xfrm>
        </p:grpSpPr>
        <p:sp>
          <p:nvSpPr>
            <p:cNvPr id="357" name="타원 356">
              <a:extLst>
                <a:ext uri="{FF2B5EF4-FFF2-40B4-BE49-F238E27FC236}">
                  <a16:creationId xmlns:a16="http://schemas.microsoft.com/office/drawing/2014/main" id="{92DBE760-2FD4-4930-B177-9E66BE680EE8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358" name="타원 357">
              <a:extLst>
                <a:ext uri="{FF2B5EF4-FFF2-40B4-BE49-F238E27FC236}">
                  <a16:creationId xmlns:a16="http://schemas.microsoft.com/office/drawing/2014/main" id="{A53EE7BE-B842-483D-8978-2B95B055A113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12" name="그룹 11">
            <a:extLst>
              <a:ext uri="{FF2B5EF4-FFF2-40B4-BE49-F238E27FC236}">
                <a16:creationId xmlns:a16="http://schemas.microsoft.com/office/drawing/2014/main" id="{9BE3B745-D089-4644-81F0-0384AE866230}"/>
              </a:ext>
            </a:extLst>
          </p:cNvPr>
          <p:cNvGrpSpPr/>
          <p:nvPr/>
        </p:nvGrpSpPr>
        <p:grpSpPr>
          <a:xfrm rot="10800000">
            <a:off x="2182565" y="6197135"/>
            <a:ext cx="70913" cy="48223"/>
            <a:chOff x="9017763" y="2551103"/>
            <a:chExt cx="116646" cy="79323"/>
          </a:xfrm>
        </p:grpSpPr>
        <p:sp>
          <p:nvSpPr>
            <p:cNvPr id="355" name="타원 354">
              <a:extLst>
                <a:ext uri="{FF2B5EF4-FFF2-40B4-BE49-F238E27FC236}">
                  <a16:creationId xmlns:a16="http://schemas.microsoft.com/office/drawing/2014/main" id="{D860E7A8-5FDE-4A90-91AA-6F648A2321E5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356" name="타원 355">
              <a:extLst>
                <a:ext uri="{FF2B5EF4-FFF2-40B4-BE49-F238E27FC236}">
                  <a16:creationId xmlns:a16="http://schemas.microsoft.com/office/drawing/2014/main" id="{74B7F7BD-6251-4BEC-A226-32834877F948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13" name="그룹 12">
            <a:extLst>
              <a:ext uri="{FF2B5EF4-FFF2-40B4-BE49-F238E27FC236}">
                <a16:creationId xmlns:a16="http://schemas.microsoft.com/office/drawing/2014/main" id="{160F0E42-12B2-4D94-9BD0-E3AEFC09A171}"/>
              </a:ext>
            </a:extLst>
          </p:cNvPr>
          <p:cNvGrpSpPr/>
          <p:nvPr/>
        </p:nvGrpSpPr>
        <p:grpSpPr>
          <a:xfrm rot="10800000">
            <a:off x="2412663" y="6238925"/>
            <a:ext cx="70913" cy="48223"/>
            <a:chOff x="9017763" y="2551103"/>
            <a:chExt cx="116646" cy="79323"/>
          </a:xfrm>
        </p:grpSpPr>
        <p:sp>
          <p:nvSpPr>
            <p:cNvPr id="353" name="타원 352">
              <a:extLst>
                <a:ext uri="{FF2B5EF4-FFF2-40B4-BE49-F238E27FC236}">
                  <a16:creationId xmlns:a16="http://schemas.microsoft.com/office/drawing/2014/main" id="{5BE7F4E7-464C-40B2-9B8D-3C2F08EE3F1E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354" name="타원 353">
              <a:extLst>
                <a:ext uri="{FF2B5EF4-FFF2-40B4-BE49-F238E27FC236}">
                  <a16:creationId xmlns:a16="http://schemas.microsoft.com/office/drawing/2014/main" id="{F0D1FF87-8C33-4A36-984E-549F62254C63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14" name="그룹 13">
            <a:extLst>
              <a:ext uri="{FF2B5EF4-FFF2-40B4-BE49-F238E27FC236}">
                <a16:creationId xmlns:a16="http://schemas.microsoft.com/office/drawing/2014/main" id="{B66DBEEB-45AA-4C7C-9A65-AAAC132F3DC2}"/>
              </a:ext>
            </a:extLst>
          </p:cNvPr>
          <p:cNvGrpSpPr/>
          <p:nvPr/>
        </p:nvGrpSpPr>
        <p:grpSpPr>
          <a:xfrm rot="10800000">
            <a:off x="2451356" y="6209352"/>
            <a:ext cx="70913" cy="48223"/>
            <a:chOff x="9017763" y="2551103"/>
            <a:chExt cx="116646" cy="79323"/>
          </a:xfrm>
        </p:grpSpPr>
        <p:sp>
          <p:nvSpPr>
            <p:cNvPr id="351" name="타원 350">
              <a:extLst>
                <a:ext uri="{FF2B5EF4-FFF2-40B4-BE49-F238E27FC236}">
                  <a16:creationId xmlns:a16="http://schemas.microsoft.com/office/drawing/2014/main" id="{B3FAB8B4-BEFD-4CC5-9223-EC0FB884FD9F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352" name="타원 351">
              <a:extLst>
                <a:ext uri="{FF2B5EF4-FFF2-40B4-BE49-F238E27FC236}">
                  <a16:creationId xmlns:a16="http://schemas.microsoft.com/office/drawing/2014/main" id="{F96B670F-D011-4538-9438-E5860FBA40DE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15" name="그룹 14">
            <a:extLst>
              <a:ext uri="{FF2B5EF4-FFF2-40B4-BE49-F238E27FC236}">
                <a16:creationId xmlns:a16="http://schemas.microsoft.com/office/drawing/2014/main" id="{CBE851AD-3142-4067-AA5D-5E068E2E13DD}"/>
              </a:ext>
            </a:extLst>
          </p:cNvPr>
          <p:cNvGrpSpPr/>
          <p:nvPr/>
        </p:nvGrpSpPr>
        <p:grpSpPr>
          <a:xfrm rot="10800000">
            <a:off x="2368637" y="6190236"/>
            <a:ext cx="70913" cy="48223"/>
            <a:chOff x="9017763" y="2551103"/>
            <a:chExt cx="116646" cy="79323"/>
          </a:xfrm>
        </p:grpSpPr>
        <p:sp>
          <p:nvSpPr>
            <p:cNvPr id="349" name="타원 348">
              <a:extLst>
                <a:ext uri="{FF2B5EF4-FFF2-40B4-BE49-F238E27FC236}">
                  <a16:creationId xmlns:a16="http://schemas.microsoft.com/office/drawing/2014/main" id="{F4B4EEF5-DEE6-4871-BE72-28648DF3D70D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350" name="타원 349">
              <a:extLst>
                <a:ext uri="{FF2B5EF4-FFF2-40B4-BE49-F238E27FC236}">
                  <a16:creationId xmlns:a16="http://schemas.microsoft.com/office/drawing/2014/main" id="{0708E35B-4B22-400F-9512-CC8F45DA5EE4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16" name="그룹 15">
            <a:extLst>
              <a:ext uri="{FF2B5EF4-FFF2-40B4-BE49-F238E27FC236}">
                <a16:creationId xmlns:a16="http://schemas.microsoft.com/office/drawing/2014/main" id="{BB1F8557-8973-49BD-A9D1-3C45F9DA5923}"/>
              </a:ext>
            </a:extLst>
          </p:cNvPr>
          <p:cNvGrpSpPr/>
          <p:nvPr/>
        </p:nvGrpSpPr>
        <p:grpSpPr>
          <a:xfrm rot="10800000">
            <a:off x="2378003" y="6284148"/>
            <a:ext cx="70913" cy="48223"/>
            <a:chOff x="9017763" y="2551103"/>
            <a:chExt cx="116646" cy="79323"/>
          </a:xfrm>
        </p:grpSpPr>
        <p:sp>
          <p:nvSpPr>
            <p:cNvPr id="347" name="타원 346">
              <a:extLst>
                <a:ext uri="{FF2B5EF4-FFF2-40B4-BE49-F238E27FC236}">
                  <a16:creationId xmlns:a16="http://schemas.microsoft.com/office/drawing/2014/main" id="{197DA0E8-C932-41A3-9C96-458430F8FC19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348" name="타원 347">
              <a:extLst>
                <a:ext uri="{FF2B5EF4-FFF2-40B4-BE49-F238E27FC236}">
                  <a16:creationId xmlns:a16="http://schemas.microsoft.com/office/drawing/2014/main" id="{60DFE6FB-7956-4BBA-A6D5-79AEEFC3AD74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17" name="그룹 16">
            <a:extLst>
              <a:ext uri="{FF2B5EF4-FFF2-40B4-BE49-F238E27FC236}">
                <a16:creationId xmlns:a16="http://schemas.microsoft.com/office/drawing/2014/main" id="{AC6631BE-BA5F-4342-8F19-038D2C607984}"/>
              </a:ext>
            </a:extLst>
          </p:cNvPr>
          <p:cNvGrpSpPr/>
          <p:nvPr/>
        </p:nvGrpSpPr>
        <p:grpSpPr>
          <a:xfrm rot="10800000">
            <a:off x="2304522" y="6287351"/>
            <a:ext cx="70913" cy="48223"/>
            <a:chOff x="9017763" y="2551103"/>
            <a:chExt cx="116646" cy="79323"/>
          </a:xfrm>
        </p:grpSpPr>
        <p:sp>
          <p:nvSpPr>
            <p:cNvPr id="345" name="타원 344">
              <a:extLst>
                <a:ext uri="{FF2B5EF4-FFF2-40B4-BE49-F238E27FC236}">
                  <a16:creationId xmlns:a16="http://schemas.microsoft.com/office/drawing/2014/main" id="{D1B69AFF-9F18-436E-850B-EA08A8626D6B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346" name="타원 345">
              <a:extLst>
                <a:ext uri="{FF2B5EF4-FFF2-40B4-BE49-F238E27FC236}">
                  <a16:creationId xmlns:a16="http://schemas.microsoft.com/office/drawing/2014/main" id="{15BC280B-C504-47A7-AE7F-D003A0BBEF25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18" name="그룹 17">
            <a:extLst>
              <a:ext uri="{FF2B5EF4-FFF2-40B4-BE49-F238E27FC236}">
                <a16:creationId xmlns:a16="http://schemas.microsoft.com/office/drawing/2014/main" id="{7C1EB221-FCEB-4734-B010-3A51A70920CD}"/>
              </a:ext>
            </a:extLst>
          </p:cNvPr>
          <p:cNvGrpSpPr/>
          <p:nvPr/>
        </p:nvGrpSpPr>
        <p:grpSpPr>
          <a:xfrm rot="10800000">
            <a:off x="2210980" y="6209197"/>
            <a:ext cx="70913" cy="48223"/>
            <a:chOff x="9017763" y="2551103"/>
            <a:chExt cx="116646" cy="79323"/>
          </a:xfrm>
        </p:grpSpPr>
        <p:sp>
          <p:nvSpPr>
            <p:cNvPr id="343" name="타원 342">
              <a:extLst>
                <a:ext uri="{FF2B5EF4-FFF2-40B4-BE49-F238E27FC236}">
                  <a16:creationId xmlns:a16="http://schemas.microsoft.com/office/drawing/2014/main" id="{4D8D65DC-46CB-449B-9ADA-418836B8DE94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344" name="타원 343">
              <a:extLst>
                <a:ext uri="{FF2B5EF4-FFF2-40B4-BE49-F238E27FC236}">
                  <a16:creationId xmlns:a16="http://schemas.microsoft.com/office/drawing/2014/main" id="{8BA840F1-40B4-4418-91BE-CD32FFA2BC62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19" name="그룹 18">
            <a:extLst>
              <a:ext uri="{FF2B5EF4-FFF2-40B4-BE49-F238E27FC236}">
                <a16:creationId xmlns:a16="http://schemas.microsoft.com/office/drawing/2014/main" id="{C30573CE-C821-4A4A-AF8E-57189E0BF496}"/>
              </a:ext>
            </a:extLst>
          </p:cNvPr>
          <p:cNvGrpSpPr/>
          <p:nvPr/>
        </p:nvGrpSpPr>
        <p:grpSpPr>
          <a:xfrm rot="10800000">
            <a:off x="2269447" y="6257643"/>
            <a:ext cx="70913" cy="48223"/>
            <a:chOff x="9017763" y="2551103"/>
            <a:chExt cx="116646" cy="79323"/>
          </a:xfrm>
        </p:grpSpPr>
        <p:sp>
          <p:nvSpPr>
            <p:cNvPr id="341" name="타원 340">
              <a:extLst>
                <a:ext uri="{FF2B5EF4-FFF2-40B4-BE49-F238E27FC236}">
                  <a16:creationId xmlns:a16="http://schemas.microsoft.com/office/drawing/2014/main" id="{DB05E442-CB17-4A3B-B43B-4AB6E2B147A7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342" name="타원 341">
              <a:extLst>
                <a:ext uri="{FF2B5EF4-FFF2-40B4-BE49-F238E27FC236}">
                  <a16:creationId xmlns:a16="http://schemas.microsoft.com/office/drawing/2014/main" id="{90E40340-7D95-4D07-986F-A33859FD9D56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20" name="그룹 19">
            <a:extLst>
              <a:ext uri="{FF2B5EF4-FFF2-40B4-BE49-F238E27FC236}">
                <a16:creationId xmlns:a16="http://schemas.microsoft.com/office/drawing/2014/main" id="{E24D5CFD-B0D9-4D45-BF5B-29CE0FEA79FF}"/>
              </a:ext>
            </a:extLst>
          </p:cNvPr>
          <p:cNvGrpSpPr/>
          <p:nvPr/>
        </p:nvGrpSpPr>
        <p:grpSpPr>
          <a:xfrm rot="10800000">
            <a:off x="2230530" y="6270947"/>
            <a:ext cx="70913" cy="48223"/>
            <a:chOff x="9017763" y="2551103"/>
            <a:chExt cx="116646" cy="79323"/>
          </a:xfrm>
        </p:grpSpPr>
        <p:sp>
          <p:nvSpPr>
            <p:cNvPr id="339" name="타원 338">
              <a:extLst>
                <a:ext uri="{FF2B5EF4-FFF2-40B4-BE49-F238E27FC236}">
                  <a16:creationId xmlns:a16="http://schemas.microsoft.com/office/drawing/2014/main" id="{5D2EC014-6500-49D4-99FE-571E524AB8E8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340" name="타원 339">
              <a:extLst>
                <a:ext uri="{FF2B5EF4-FFF2-40B4-BE49-F238E27FC236}">
                  <a16:creationId xmlns:a16="http://schemas.microsoft.com/office/drawing/2014/main" id="{E5A7C03C-F09D-444F-AD4C-8853E9F5BB93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sp>
        <p:nvSpPr>
          <p:cNvPr id="21" name="Freeform 575">
            <a:extLst>
              <a:ext uri="{FF2B5EF4-FFF2-40B4-BE49-F238E27FC236}">
                <a16:creationId xmlns:a16="http://schemas.microsoft.com/office/drawing/2014/main" id="{4A388782-F98F-4C84-8464-6CC523968312}"/>
              </a:ext>
            </a:extLst>
          </p:cNvPr>
          <p:cNvSpPr>
            <a:spLocks/>
          </p:cNvSpPr>
          <p:nvPr/>
        </p:nvSpPr>
        <p:spPr bwMode="auto">
          <a:xfrm>
            <a:off x="1912041" y="7627677"/>
            <a:ext cx="2478212" cy="778552"/>
          </a:xfrm>
          <a:custGeom>
            <a:avLst/>
            <a:gdLst>
              <a:gd name="T0" fmla="*/ 0 w 3906"/>
              <a:gd name="T1" fmla="*/ 0 h 1242"/>
              <a:gd name="T2" fmla="*/ 0 w 3906"/>
              <a:gd name="T3" fmla="*/ 2 h 1242"/>
              <a:gd name="T4" fmla="*/ 1 w 3906"/>
              <a:gd name="T5" fmla="*/ 2 h 1242"/>
              <a:gd name="T6" fmla="*/ 1 w 3906"/>
              <a:gd name="T7" fmla="*/ 5 h 1242"/>
              <a:gd name="T8" fmla="*/ 1 w 3906"/>
              <a:gd name="T9" fmla="*/ 5 h 1242"/>
              <a:gd name="T10" fmla="*/ 4 w 3906"/>
              <a:gd name="T11" fmla="*/ 5 h 1242"/>
              <a:gd name="T12" fmla="*/ 4 w 3906"/>
              <a:gd name="T13" fmla="*/ 5 h 1242"/>
              <a:gd name="T14" fmla="*/ 4 w 3906"/>
              <a:gd name="T15" fmla="*/ 2 h 1242"/>
              <a:gd name="T16" fmla="*/ 7 w 3906"/>
              <a:gd name="T17" fmla="*/ 2 h 1242"/>
              <a:gd name="T18" fmla="*/ 7 w 3906"/>
              <a:gd name="T19" fmla="*/ 5 h 1242"/>
              <a:gd name="T20" fmla="*/ 7 w 3906"/>
              <a:gd name="T21" fmla="*/ 5 h 1242"/>
              <a:gd name="T22" fmla="*/ 10 w 3906"/>
              <a:gd name="T23" fmla="*/ 5 h 1242"/>
              <a:gd name="T24" fmla="*/ 10 w 3906"/>
              <a:gd name="T25" fmla="*/ 5 h 1242"/>
              <a:gd name="T26" fmla="*/ 10 w 3906"/>
              <a:gd name="T27" fmla="*/ 2 h 1242"/>
              <a:gd name="T28" fmla="*/ 12 w 3906"/>
              <a:gd name="T29" fmla="*/ 2 h 1242"/>
              <a:gd name="T30" fmla="*/ 12 w 3906"/>
              <a:gd name="T31" fmla="*/ 5 h 1242"/>
              <a:gd name="T32" fmla="*/ 12 w 3906"/>
              <a:gd name="T33" fmla="*/ 5 h 1242"/>
              <a:gd name="T34" fmla="*/ 15 w 3906"/>
              <a:gd name="T35" fmla="*/ 5 h 1242"/>
              <a:gd name="T36" fmla="*/ 15 w 3906"/>
              <a:gd name="T37" fmla="*/ 5 h 1242"/>
              <a:gd name="T38" fmla="*/ 15 w 3906"/>
              <a:gd name="T39" fmla="*/ 5 h 1242"/>
              <a:gd name="T40" fmla="*/ 16 w 3906"/>
              <a:gd name="T41" fmla="*/ 2 h 1242"/>
              <a:gd name="T42" fmla="*/ 17 w 3906"/>
              <a:gd name="T43" fmla="*/ 2 h 1242"/>
              <a:gd name="T44" fmla="*/ 17 w 3906"/>
              <a:gd name="T45" fmla="*/ 0 h 1242"/>
              <a:gd name="T46" fmla="*/ 0 w 3906"/>
              <a:gd name="T47" fmla="*/ 0 h 1242"/>
              <a:gd name="T48" fmla="*/ 0 60000 65536"/>
              <a:gd name="T49" fmla="*/ 0 60000 65536"/>
              <a:gd name="T50" fmla="*/ 0 60000 65536"/>
              <a:gd name="T51" fmla="*/ 0 60000 65536"/>
              <a:gd name="T52" fmla="*/ 0 60000 65536"/>
              <a:gd name="T53" fmla="*/ 0 60000 65536"/>
              <a:gd name="T54" fmla="*/ 0 60000 65536"/>
              <a:gd name="T55" fmla="*/ 0 60000 65536"/>
              <a:gd name="T56" fmla="*/ 0 60000 65536"/>
              <a:gd name="T57" fmla="*/ 0 60000 65536"/>
              <a:gd name="T58" fmla="*/ 0 60000 65536"/>
              <a:gd name="T59" fmla="*/ 0 60000 65536"/>
              <a:gd name="T60" fmla="*/ 0 60000 65536"/>
              <a:gd name="T61" fmla="*/ 0 60000 65536"/>
              <a:gd name="T62" fmla="*/ 0 60000 65536"/>
              <a:gd name="T63" fmla="*/ 0 60000 65536"/>
              <a:gd name="T64" fmla="*/ 0 60000 65536"/>
              <a:gd name="T65" fmla="*/ 0 60000 65536"/>
              <a:gd name="T66" fmla="*/ 0 60000 65536"/>
              <a:gd name="T67" fmla="*/ 0 60000 65536"/>
              <a:gd name="T68" fmla="*/ 0 60000 65536"/>
              <a:gd name="T69" fmla="*/ 0 60000 65536"/>
              <a:gd name="T70" fmla="*/ 0 60000 65536"/>
              <a:gd name="T71" fmla="*/ 0 60000 65536"/>
              <a:gd name="T72" fmla="*/ 0 w 3906"/>
              <a:gd name="T73" fmla="*/ 0 h 1242"/>
              <a:gd name="T74" fmla="*/ 3906 w 3906"/>
              <a:gd name="T75" fmla="*/ 1242 h 1242"/>
            </a:gdLst>
            <a:ahLst/>
            <a:cxnLst>
              <a:cxn ang="T48">
                <a:pos x="T0" y="T1"/>
              </a:cxn>
              <a:cxn ang="T49">
                <a:pos x="T2" y="T3"/>
              </a:cxn>
              <a:cxn ang="T50">
                <a:pos x="T4" y="T5"/>
              </a:cxn>
              <a:cxn ang="T51">
                <a:pos x="T6" y="T7"/>
              </a:cxn>
              <a:cxn ang="T52">
                <a:pos x="T8" y="T9"/>
              </a:cxn>
              <a:cxn ang="T53">
                <a:pos x="T10" y="T11"/>
              </a:cxn>
              <a:cxn ang="T54">
                <a:pos x="T12" y="T13"/>
              </a:cxn>
              <a:cxn ang="T55">
                <a:pos x="T14" y="T15"/>
              </a:cxn>
              <a:cxn ang="T56">
                <a:pos x="T16" y="T17"/>
              </a:cxn>
              <a:cxn ang="T57">
                <a:pos x="T18" y="T19"/>
              </a:cxn>
              <a:cxn ang="T58">
                <a:pos x="T20" y="T21"/>
              </a:cxn>
              <a:cxn ang="T59">
                <a:pos x="T22" y="T23"/>
              </a:cxn>
              <a:cxn ang="T60">
                <a:pos x="T24" y="T25"/>
              </a:cxn>
              <a:cxn ang="T61">
                <a:pos x="T26" y="T27"/>
              </a:cxn>
              <a:cxn ang="T62">
                <a:pos x="T28" y="T29"/>
              </a:cxn>
              <a:cxn ang="T63">
                <a:pos x="T30" y="T31"/>
              </a:cxn>
              <a:cxn ang="T64">
                <a:pos x="T32" y="T33"/>
              </a:cxn>
              <a:cxn ang="T65">
                <a:pos x="T34" y="T35"/>
              </a:cxn>
              <a:cxn ang="T66">
                <a:pos x="T36" y="T37"/>
              </a:cxn>
              <a:cxn ang="T67">
                <a:pos x="T38" y="T39"/>
              </a:cxn>
              <a:cxn ang="T68">
                <a:pos x="T40" y="T41"/>
              </a:cxn>
              <a:cxn ang="T69">
                <a:pos x="T42" y="T43"/>
              </a:cxn>
              <a:cxn ang="T70">
                <a:pos x="T44" y="T45"/>
              </a:cxn>
              <a:cxn ang="T71">
                <a:pos x="T46" y="T47"/>
              </a:cxn>
            </a:cxnLst>
            <a:rect l="T72" t="T73" r="T74" b="T75"/>
            <a:pathLst>
              <a:path w="3906" h="1242">
                <a:moveTo>
                  <a:pt x="0" y="3"/>
                </a:moveTo>
                <a:lnTo>
                  <a:pt x="0" y="381"/>
                </a:lnTo>
                <a:lnTo>
                  <a:pt x="250" y="380"/>
                </a:lnTo>
                <a:lnTo>
                  <a:pt x="289" y="1195"/>
                </a:lnTo>
                <a:lnTo>
                  <a:pt x="324" y="1239"/>
                </a:lnTo>
                <a:lnTo>
                  <a:pt x="943" y="1242"/>
                </a:lnTo>
                <a:lnTo>
                  <a:pt x="996" y="1194"/>
                </a:lnTo>
                <a:lnTo>
                  <a:pt x="1031" y="374"/>
                </a:lnTo>
                <a:lnTo>
                  <a:pt x="1562" y="372"/>
                </a:lnTo>
                <a:lnTo>
                  <a:pt x="1605" y="1197"/>
                </a:lnTo>
                <a:lnTo>
                  <a:pt x="1648" y="1242"/>
                </a:lnTo>
                <a:lnTo>
                  <a:pt x="2256" y="1242"/>
                </a:lnTo>
                <a:lnTo>
                  <a:pt x="2312" y="1194"/>
                </a:lnTo>
                <a:lnTo>
                  <a:pt x="2342" y="380"/>
                </a:lnTo>
                <a:lnTo>
                  <a:pt x="2886" y="378"/>
                </a:lnTo>
                <a:lnTo>
                  <a:pt x="2907" y="1185"/>
                </a:lnTo>
                <a:lnTo>
                  <a:pt x="2969" y="1242"/>
                </a:lnTo>
                <a:lnTo>
                  <a:pt x="3582" y="1242"/>
                </a:lnTo>
                <a:lnTo>
                  <a:pt x="3574" y="1237"/>
                </a:lnTo>
                <a:lnTo>
                  <a:pt x="3633" y="1192"/>
                </a:lnTo>
                <a:lnTo>
                  <a:pt x="3662" y="382"/>
                </a:lnTo>
                <a:lnTo>
                  <a:pt x="3906" y="381"/>
                </a:lnTo>
                <a:lnTo>
                  <a:pt x="3906" y="0"/>
                </a:lnTo>
                <a:lnTo>
                  <a:pt x="0" y="3"/>
                </a:lnTo>
                <a:close/>
              </a:path>
            </a:pathLst>
          </a:custGeom>
          <a:solidFill>
            <a:srgbClr val="BBE0E3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ko-KR" altLang="en-US" sz="1800" b="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Arial" pitchFamily="34" charset="0"/>
              <a:ea typeface="굴림" charset="-127"/>
              <a:cs typeface="Arial" pitchFamily="34" charset="0"/>
            </a:endParaRPr>
          </a:p>
        </p:txBody>
      </p:sp>
      <p:grpSp>
        <p:nvGrpSpPr>
          <p:cNvPr id="22" name="그룹 21">
            <a:extLst>
              <a:ext uri="{FF2B5EF4-FFF2-40B4-BE49-F238E27FC236}">
                <a16:creationId xmlns:a16="http://schemas.microsoft.com/office/drawing/2014/main" id="{945025F4-C03A-483D-A8F9-6551A9056927}"/>
              </a:ext>
            </a:extLst>
          </p:cNvPr>
          <p:cNvGrpSpPr/>
          <p:nvPr/>
        </p:nvGrpSpPr>
        <p:grpSpPr>
          <a:xfrm>
            <a:off x="2087404" y="8110645"/>
            <a:ext cx="454865" cy="545339"/>
            <a:chOff x="5459353" y="3044741"/>
            <a:chExt cx="748219" cy="897043"/>
          </a:xfrm>
        </p:grpSpPr>
        <p:sp>
          <p:nvSpPr>
            <p:cNvPr id="302" name="AutoShape 62">
              <a:extLst>
                <a:ext uri="{FF2B5EF4-FFF2-40B4-BE49-F238E27FC236}">
                  <a16:creationId xmlns:a16="http://schemas.microsoft.com/office/drawing/2014/main" id="{B98B97EF-893B-4598-90B2-2ED21BCB678E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10800000">
              <a:off x="5459353" y="3044741"/>
              <a:ext cx="748219" cy="897043"/>
            </a:xfrm>
            <a:custGeom>
              <a:avLst/>
              <a:gdLst>
                <a:gd name="T0" fmla="*/ 0 w 21600"/>
                <a:gd name="T1" fmla="*/ 0 h 21600"/>
                <a:gd name="T2" fmla="*/ 0 w 21600"/>
                <a:gd name="T3" fmla="*/ 0 h 21600"/>
                <a:gd name="T4" fmla="*/ 0 w 21600"/>
                <a:gd name="T5" fmla="*/ 0 h 21600"/>
                <a:gd name="T6" fmla="*/ 0 w 21600"/>
                <a:gd name="T7" fmla="*/ 0 h 21600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1600"/>
                <a:gd name="T13" fmla="*/ 0 h 21600"/>
                <a:gd name="T14" fmla="*/ 21600 w 21600"/>
                <a:gd name="T15" fmla="*/ 7736 h 21600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1600" h="21600">
                  <a:moveTo>
                    <a:pt x="10740" y="10800"/>
                  </a:moveTo>
                  <a:cubicBezTo>
                    <a:pt x="10740" y="10766"/>
                    <a:pt x="10766" y="10740"/>
                    <a:pt x="10800" y="10740"/>
                  </a:cubicBezTo>
                  <a:cubicBezTo>
                    <a:pt x="10833" y="10739"/>
                    <a:pt x="10859" y="10766"/>
                    <a:pt x="10860" y="10799"/>
                  </a:cubicBezTo>
                  <a:lnTo>
                    <a:pt x="21600" y="10800"/>
                  </a:lnTo>
                  <a:cubicBezTo>
                    <a:pt x="21600" y="4835"/>
                    <a:pt x="16764" y="0"/>
                    <a:pt x="10800" y="0"/>
                  </a:cubicBezTo>
                  <a:cubicBezTo>
                    <a:pt x="4835" y="0"/>
                    <a:pt x="0" y="4835"/>
                    <a:pt x="0" y="10800"/>
                  </a:cubicBezTo>
                  <a:close/>
                </a:path>
              </a:pathLst>
            </a:custGeom>
            <a:solidFill>
              <a:srgbClr val="00CC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ko-KR" altLang="en-US" sz="180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itchFamily="34" charset="0"/>
                <a:ea typeface="굴림" charset="-127"/>
                <a:cs typeface="Arial" pitchFamily="34" charset="0"/>
              </a:endParaRPr>
            </a:p>
          </p:txBody>
        </p:sp>
        <p:grpSp>
          <p:nvGrpSpPr>
            <p:cNvPr id="303" name="그룹 302">
              <a:extLst>
                <a:ext uri="{FF2B5EF4-FFF2-40B4-BE49-F238E27FC236}">
                  <a16:creationId xmlns:a16="http://schemas.microsoft.com/office/drawing/2014/main" id="{531CB2FB-573A-41CB-9815-F9247E1BED12}"/>
                </a:ext>
              </a:extLst>
            </p:cNvPr>
            <p:cNvGrpSpPr/>
            <p:nvPr/>
          </p:nvGrpSpPr>
          <p:grpSpPr>
            <a:xfrm rot="10800000">
              <a:off x="5839676" y="3844854"/>
              <a:ext cx="116646" cy="79323"/>
              <a:chOff x="9017763" y="2551103"/>
              <a:chExt cx="116646" cy="79323"/>
            </a:xfrm>
          </p:grpSpPr>
          <p:sp>
            <p:nvSpPr>
              <p:cNvPr id="337" name="타원 336">
                <a:extLst>
                  <a:ext uri="{FF2B5EF4-FFF2-40B4-BE49-F238E27FC236}">
                    <a16:creationId xmlns:a16="http://schemas.microsoft.com/office/drawing/2014/main" id="{675E6752-0D76-4AE1-8346-2CA72078F436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338" name="타원 337">
                <a:extLst>
                  <a:ext uri="{FF2B5EF4-FFF2-40B4-BE49-F238E27FC236}">
                    <a16:creationId xmlns:a16="http://schemas.microsoft.com/office/drawing/2014/main" id="{39941280-E429-4EC0-8836-D69E872E952C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304" name="그룹 303">
              <a:extLst>
                <a:ext uri="{FF2B5EF4-FFF2-40B4-BE49-F238E27FC236}">
                  <a16:creationId xmlns:a16="http://schemas.microsoft.com/office/drawing/2014/main" id="{167F375B-C5F9-4432-905D-96C093848D0E}"/>
                </a:ext>
              </a:extLst>
            </p:cNvPr>
            <p:cNvGrpSpPr/>
            <p:nvPr/>
          </p:nvGrpSpPr>
          <p:grpSpPr>
            <a:xfrm rot="10800000">
              <a:off x="5865441" y="3734093"/>
              <a:ext cx="116646" cy="79323"/>
              <a:chOff x="9017763" y="2551103"/>
              <a:chExt cx="116646" cy="79323"/>
            </a:xfrm>
          </p:grpSpPr>
          <p:sp>
            <p:nvSpPr>
              <p:cNvPr id="335" name="타원 334">
                <a:extLst>
                  <a:ext uri="{FF2B5EF4-FFF2-40B4-BE49-F238E27FC236}">
                    <a16:creationId xmlns:a16="http://schemas.microsoft.com/office/drawing/2014/main" id="{AFE9A1C5-0641-4DFB-8960-F30FD62D6C60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336" name="타원 335">
                <a:extLst>
                  <a:ext uri="{FF2B5EF4-FFF2-40B4-BE49-F238E27FC236}">
                    <a16:creationId xmlns:a16="http://schemas.microsoft.com/office/drawing/2014/main" id="{A9577404-95AA-4041-A4F6-23441410A346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305" name="그룹 304">
              <a:extLst>
                <a:ext uri="{FF2B5EF4-FFF2-40B4-BE49-F238E27FC236}">
                  <a16:creationId xmlns:a16="http://schemas.microsoft.com/office/drawing/2014/main" id="{B29FB4B5-F8BC-4DA4-BD8C-8B2B1487260B}"/>
                </a:ext>
              </a:extLst>
            </p:cNvPr>
            <p:cNvGrpSpPr/>
            <p:nvPr/>
          </p:nvGrpSpPr>
          <p:grpSpPr>
            <a:xfrm rot="10800000">
              <a:off x="5751416" y="3696733"/>
              <a:ext cx="116646" cy="79323"/>
              <a:chOff x="9017763" y="2551103"/>
              <a:chExt cx="116646" cy="79323"/>
            </a:xfrm>
          </p:grpSpPr>
          <p:sp>
            <p:nvSpPr>
              <p:cNvPr id="333" name="타원 332">
                <a:extLst>
                  <a:ext uri="{FF2B5EF4-FFF2-40B4-BE49-F238E27FC236}">
                    <a16:creationId xmlns:a16="http://schemas.microsoft.com/office/drawing/2014/main" id="{6053C1CE-99DC-412A-B3A2-B246DDE382C2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334" name="타원 333">
                <a:extLst>
                  <a:ext uri="{FF2B5EF4-FFF2-40B4-BE49-F238E27FC236}">
                    <a16:creationId xmlns:a16="http://schemas.microsoft.com/office/drawing/2014/main" id="{C3F9CAE3-647B-4542-8361-1E8F50267E08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306" name="그룹 305">
              <a:extLst>
                <a:ext uri="{FF2B5EF4-FFF2-40B4-BE49-F238E27FC236}">
                  <a16:creationId xmlns:a16="http://schemas.microsoft.com/office/drawing/2014/main" id="{FEFDDBB9-021B-43F4-BED0-9EA2DE474663}"/>
                </a:ext>
              </a:extLst>
            </p:cNvPr>
            <p:cNvGrpSpPr/>
            <p:nvPr/>
          </p:nvGrpSpPr>
          <p:grpSpPr>
            <a:xfrm rot="10800000">
              <a:off x="5779260" y="3791807"/>
              <a:ext cx="116646" cy="79323"/>
              <a:chOff x="9017763" y="2551103"/>
              <a:chExt cx="116646" cy="79323"/>
            </a:xfrm>
          </p:grpSpPr>
          <p:sp>
            <p:nvSpPr>
              <p:cNvPr id="331" name="타원 330">
                <a:extLst>
                  <a:ext uri="{FF2B5EF4-FFF2-40B4-BE49-F238E27FC236}">
                    <a16:creationId xmlns:a16="http://schemas.microsoft.com/office/drawing/2014/main" id="{74F5004F-9CF1-4CBB-B227-D14EFEE20B74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332" name="타원 331">
                <a:extLst>
                  <a:ext uri="{FF2B5EF4-FFF2-40B4-BE49-F238E27FC236}">
                    <a16:creationId xmlns:a16="http://schemas.microsoft.com/office/drawing/2014/main" id="{F58134EA-0675-4B40-94E3-7E9472BC297E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307" name="그룹 306">
              <a:extLst>
                <a:ext uri="{FF2B5EF4-FFF2-40B4-BE49-F238E27FC236}">
                  <a16:creationId xmlns:a16="http://schemas.microsoft.com/office/drawing/2014/main" id="{D1A956E5-5DBF-4DAF-87D5-B6291151A743}"/>
                </a:ext>
              </a:extLst>
            </p:cNvPr>
            <p:cNvGrpSpPr/>
            <p:nvPr/>
          </p:nvGrpSpPr>
          <p:grpSpPr>
            <a:xfrm rot="10800000">
              <a:off x="5925557" y="3765197"/>
              <a:ext cx="116646" cy="79323"/>
              <a:chOff x="9017763" y="2551103"/>
              <a:chExt cx="116646" cy="79323"/>
            </a:xfrm>
          </p:grpSpPr>
          <p:sp>
            <p:nvSpPr>
              <p:cNvPr id="329" name="타원 328">
                <a:extLst>
                  <a:ext uri="{FF2B5EF4-FFF2-40B4-BE49-F238E27FC236}">
                    <a16:creationId xmlns:a16="http://schemas.microsoft.com/office/drawing/2014/main" id="{2C9FD00D-DE73-4755-B5F4-65636BAA2970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330" name="타원 329">
                <a:extLst>
                  <a:ext uri="{FF2B5EF4-FFF2-40B4-BE49-F238E27FC236}">
                    <a16:creationId xmlns:a16="http://schemas.microsoft.com/office/drawing/2014/main" id="{6C0ABC97-DF3B-4CEA-B3FB-C67C1A588A7D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308" name="그룹 307">
              <a:extLst>
                <a:ext uri="{FF2B5EF4-FFF2-40B4-BE49-F238E27FC236}">
                  <a16:creationId xmlns:a16="http://schemas.microsoft.com/office/drawing/2014/main" id="{4798BAF4-883B-4994-ADA7-1B626C8B801E}"/>
                </a:ext>
              </a:extLst>
            </p:cNvPr>
            <p:cNvGrpSpPr/>
            <p:nvPr/>
          </p:nvGrpSpPr>
          <p:grpSpPr>
            <a:xfrm rot="10800000">
              <a:off x="5872136" y="3721651"/>
              <a:ext cx="116646" cy="79323"/>
              <a:chOff x="9017763" y="2551103"/>
              <a:chExt cx="116646" cy="79323"/>
            </a:xfrm>
          </p:grpSpPr>
          <p:sp>
            <p:nvSpPr>
              <p:cNvPr id="327" name="타원 326">
                <a:extLst>
                  <a:ext uri="{FF2B5EF4-FFF2-40B4-BE49-F238E27FC236}">
                    <a16:creationId xmlns:a16="http://schemas.microsoft.com/office/drawing/2014/main" id="{12C303CF-F7CD-46B8-8A5B-900E320D1BA3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328" name="타원 327">
                <a:extLst>
                  <a:ext uri="{FF2B5EF4-FFF2-40B4-BE49-F238E27FC236}">
                    <a16:creationId xmlns:a16="http://schemas.microsoft.com/office/drawing/2014/main" id="{D87A02CA-ABDA-4DF8-958A-2B728DF919BB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309" name="그룹 308">
              <a:extLst>
                <a:ext uri="{FF2B5EF4-FFF2-40B4-BE49-F238E27FC236}">
                  <a16:creationId xmlns:a16="http://schemas.microsoft.com/office/drawing/2014/main" id="{B0F8D655-B57C-402B-86B5-7A68DAE5103F}"/>
                </a:ext>
              </a:extLst>
            </p:cNvPr>
            <p:cNvGrpSpPr/>
            <p:nvPr/>
          </p:nvGrpSpPr>
          <p:grpSpPr>
            <a:xfrm rot="10800000">
              <a:off x="5756906" y="3719763"/>
              <a:ext cx="116646" cy="79323"/>
              <a:chOff x="9017763" y="2551103"/>
              <a:chExt cx="116646" cy="79323"/>
            </a:xfrm>
          </p:grpSpPr>
          <p:sp>
            <p:nvSpPr>
              <p:cNvPr id="325" name="타원 324">
                <a:extLst>
                  <a:ext uri="{FF2B5EF4-FFF2-40B4-BE49-F238E27FC236}">
                    <a16:creationId xmlns:a16="http://schemas.microsoft.com/office/drawing/2014/main" id="{EFB8E07C-89BB-48A9-9615-7B258BBF564A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326" name="타원 325">
                <a:extLst>
                  <a:ext uri="{FF2B5EF4-FFF2-40B4-BE49-F238E27FC236}">
                    <a16:creationId xmlns:a16="http://schemas.microsoft.com/office/drawing/2014/main" id="{218CD5FF-D6A0-4E2D-A4FE-80D5F59684B1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310" name="그룹 309">
              <a:extLst>
                <a:ext uri="{FF2B5EF4-FFF2-40B4-BE49-F238E27FC236}">
                  <a16:creationId xmlns:a16="http://schemas.microsoft.com/office/drawing/2014/main" id="{8AAC8AE4-A1CA-461C-98C5-CB585C09D3FC}"/>
                </a:ext>
              </a:extLst>
            </p:cNvPr>
            <p:cNvGrpSpPr/>
            <p:nvPr/>
          </p:nvGrpSpPr>
          <p:grpSpPr>
            <a:xfrm rot="10800000">
              <a:off x="5849043" y="3847219"/>
              <a:ext cx="116646" cy="79323"/>
              <a:chOff x="9017763" y="2551103"/>
              <a:chExt cx="116646" cy="79323"/>
            </a:xfrm>
          </p:grpSpPr>
          <p:sp>
            <p:nvSpPr>
              <p:cNvPr id="323" name="타원 322">
                <a:extLst>
                  <a:ext uri="{FF2B5EF4-FFF2-40B4-BE49-F238E27FC236}">
                    <a16:creationId xmlns:a16="http://schemas.microsoft.com/office/drawing/2014/main" id="{C8373EAA-662F-4455-9635-CEB5D39C5DBC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324" name="타원 323">
                <a:extLst>
                  <a:ext uri="{FF2B5EF4-FFF2-40B4-BE49-F238E27FC236}">
                    <a16:creationId xmlns:a16="http://schemas.microsoft.com/office/drawing/2014/main" id="{A76B588B-F622-488B-B87D-5775A07BADC9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311" name="그룹 310">
              <a:extLst>
                <a:ext uri="{FF2B5EF4-FFF2-40B4-BE49-F238E27FC236}">
                  <a16:creationId xmlns:a16="http://schemas.microsoft.com/office/drawing/2014/main" id="{6B5F49E6-B31E-4DDE-B820-B60A63267430}"/>
                </a:ext>
              </a:extLst>
            </p:cNvPr>
            <p:cNvGrpSpPr/>
            <p:nvPr/>
          </p:nvGrpSpPr>
          <p:grpSpPr>
            <a:xfrm rot="10800000">
              <a:off x="5747673" y="3844854"/>
              <a:ext cx="116646" cy="79323"/>
              <a:chOff x="9017763" y="2551103"/>
              <a:chExt cx="116646" cy="79323"/>
            </a:xfrm>
          </p:grpSpPr>
          <p:sp>
            <p:nvSpPr>
              <p:cNvPr id="321" name="타원 320">
                <a:extLst>
                  <a:ext uri="{FF2B5EF4-FFF2-40B4-BE49-F238E27FC236}">
                    <a16:creationId xmlns:a16="http://schemas.microsoft.com/office/drawing/2014/main" id="{84DCAC15-9419-47A4-8620-74069A73A865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322" name="타원 321">
                <a:extLst>
                  <a:ext uri="{FF2B5EF4-FFF2-40B4-BE49-F238E27FC236}">
                    <a16:creationId xmlns:a16="http://schemas.microsoft.com/office/drawing/2014/main" id="{9F8EB4FF-27D3-46B9-B585-63F5A4FD77AF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312" name="그룹 311">
              <a:extLst>
                <a:ext uri="{FF2B5EF4-FFF2-40B4-BE49-F238E27FC236}">
                  <a16:creationId xmlns:a16="http://schemas.microsoft.com/office/drawing/2014/main" id="{E38A8BAF-9D3A-4CE4-B6F5-B05C618830F2}"/>
                </a:ext>
              </a:extLst>
            </p:cNvPr>
            <p:cNvGrpSpPr/>
            <p:nvPr/>
          </p:nvGrpSpPr>
          <p:grpSpPr>
            <a:xfrm rot="10800000">
              <a:off x="5709298" y="3729814"/>
              <a:ext cx="116646" cy="79323"/>
              <a:chOff x="9017763" y="2551103"/>
              <a:chExt cx="116646" cy="79323"/>
            </a:xfrm>
          </p:grpSpPr>
          <p:sp>
            <p:nvSpPr>
              <p:cNvPr id="319" name="타원 318">
                <a:extLst>
                  <a:ext uri="{FF2B5EF4-FFF2-40B4-BE49-F238E27FC236}">
                    <a16:creationId xmlns:a16="http://schemas.microsoft.com/office/drawing/2014/main" id="{EA2EC8EA-B4A2-41C2-A5B3-B7D96992CE35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320" name="타원 319">
                <a:extLst>
                  <a:ext uri="{FF2B5EF4-FFF2-40B4-BE49-F238E27FC236}">
                    <a16:creationId xmlns:a16="http://schemas.microsoft.com/office/drawing/2014/main" id="{19A4CF95-B47B-408E-9DC6-86C0754D2332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313" name="그룹 312">
              <a:extLst>
                <a:ext uri="{FF2B5EF4-FFF2-40B4-BE49-F238E27FC236}">
                  <a16:creationId xmlns:a16="http://schemas.microsoft.com/office/drawing/2014/main" id="{935BF4E9-8971-46D2-9DC4-E074622C23B1}"/>
                </a:ext>
              </a:extLst>
            </p:cNvPr>
            <p:cNvGrpSpPr/>
            <p:nvPr/>
          </p:nvGrpSpPr>
          <p:grpSpPr>
            <a:xfrm rot="10800000">
              <a:off x="5689977" y="3795986"/>
              <a:ext cx="116646" cy="79323"/>
              <a:chOff x="9017763" y="2551103"/>
              <a:chExt cx="116646" cy="79323"/>
            </a:xfrm>
          </p:grpSpPr>
          <p:sp>
            <p:nvSpPr>
              <p:cNvPr id="317" name="타원 316">
                <a:extLst>
                  <a:ext uri="{FF2B5EF4-FFF2-40B4-BE49-F238E27FC236}">
                    <a16:creationId xmlns:a16="http://schemas.microsoft.com/office/drawing/2014/main" id="{8DFBF711-F776-4E29-AB25-1CE331314DAF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318" name="타원 317">
                <a:extLst>
                  <a:ext uri="{FF2B5EF4-FFF2-40B4-BE49-F238E27FC236}">
                    <a16:creationId xmlns:a16="http://schemas.microsoft.com/office/drawing/2014/main" id="{3BDB4DDC-D57F-44E0-823D-287BB6D8B3F3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314" name="그룹 313">
              <a:extLst>
                <a:ext uri="{FF2B5EF4-FFF2-40B4-BE49-F238E27FC236}">
                  <a16:creationId xmlns:a16="http://schemas.microsoft.com/office/drawing/2014/main" id="{6CB138F7-DF08-4E67-9C55-4B79E2A545C5}"/>
                </a:ext>
              </a:extLst>
            </p:cNvPr>
            <p:cNvGrpSpPr/>
            <p:nvPr/>
          </p:nvGrpSpPr>
          <p:grpSpPr>
            <a:xfrm rot="10800000">
              <a:off x="5687107" y="3795985"/>
              <a:ext cx="116646" cy="79323"/>
              <a:chOff x="9017763" y="2551103"/>
              <a:chExt cx="116646" cy="79323"/>
            </a:xfrm>
          </p:grpSpPr>
          <p:sp>
            <p:nvSpPr>
              <p:cNvPr id="315" name="타원 314">
                <a:extLst>
                  <a:ext uri="{FF2B5EF4-FFF2-40B4-BE49-F238E27FC236}">
                    <a16:creationId xmlns:a16="http://schemas.microsoft.com/office/drawing/2014/main" id="{F8B7D988-EC81-4A35-AF69-2A4847EA1822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316" name="타원 315">
                <a:extLst>
                  <a:ext uri="{FF2B5EF4-FFF2-40B4-BE49-F238E27FC236}">
                    <a16:creationId xmlns:a16="http://schemas.microsoft.com/office/drawing/2014/main" id="{D505996C-83AB-4DFF-99B8-B61DA4EEF9C8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</p:grpSp>
      <p:grpSp>
        <p:nvGrpSpPr>
          <p:cNvPr id="23" name="그룹 22">
            <a:extLst>
              <a:ext uri="{FF2B5EF4-FFF2-40B4-BE49-F238E27FC236}">
                <a16:creationId xmlns:a16="http://schemas.microsoft.com/office/drawing/2014/main" id="{9B4A2FDA-92FE-4CBA-B986-2C9841A05784}"/>
              </a:ext>
            </a:extLst>
          </p:cNvPr>
          <p:cNvGrpSpPr/>
          <p:nvPr/>
        </p:nvGrpSpPr>
        <p:grpSpPr>
          <a:xfrm>
            <a:off x="2929386" y="8108693"/>
            <a:ext cx="454865" cy="545339"/>
            <a:chOff x="5459353" y="3044741"/>
            <a:chExt cx="748219" cy="897043"/>
          </a:xfrm>
        </p:grpSpPr>
        <p:sp>
          <p:nvSpPr>
            <p:cNvPr id="265" name="AutoShape 62">
              <a:extLst>
                <a:ext uri="{FF2B5EF4-FFF2-40B4-BE49-F238E27FC236}">
                  <a16:creationId xmlns:a16="http://schemas.microsoft.com/office/drawing/2014/main" id="{99A4D025-1C32-4A36-8008-1412B780F707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10800000">
              <a:off x="5459353" y="3044741"/>
              <a:ext cx="748219" cy="897043"/>
            </a:xfrm>
            <a:custGeom>
              <a:avLst/>
              <a:gdLst>
                <a:gd name="T0" fmla="*/ 0 w 21600"/>
                <a:gd name="T1" fmla="*/ 0 h 21600"/>
                <a:gd name="T2" fmla="*/ 0 w 21600"/>
                <a:gd name="T3" fmla="*/ 0 h 21600"/>
                <a:gd name="T4" fmla="*/ 0 w 21600"/>
                <a:gd name="T5" fmla="*/ 0 h 21600"/>
                <a:gd name="T6" fmla="*/ 0 w 21600"/>
                <a:gd name="T7" fmla="*/ 0 h 21600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1600"/>
                <a:gd name="T13" fmla="*/ 0 h 21600"/>
                <a:gd name="T14" fmla="*/ 21600 w 21600"/>
                <a:gd name="T15" fmla="*/ 7736 h 21600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1600" h="21600">
                  <a:moveTo>
                    <a:pt x="10740" y="10800"/>
                  </a:moveTo>
                  <a:cubicBezTo>
                    <a:pt x="10740" y="10766"/>
                    <a:pt x="10766" y="10740"/>
                    <a:pt x="10800" y="10740"/>
                  </a:cubicBezTo>
                  <a:cubicBezTo>
                    <a:pt x="10833" y="10739"/>
                    <a:pt x="10859" y="10766"/>
                    <a:pt x="10860" y="10799"/>
                  </a:cubicBezTo>
                  <a:lnTo>
                    <a:pt x="21600" y="10800"/>
                  </a:lnTo>
                  <a:cubicBezTo>
                    <a:pt x="21600" y="4835"/>
                    <a:pt x="16764" y="0"/>
                    <a:pt x="10800" y="0"/>
                  </a:cubicBezTo>
                  <a:cubicBezTo>
                    <a:pt x="4835" y="0"/>
                    <a:pt x="0" y="4835"/>
                    <a:pt x="0" y="10800"/>
                  </a:cubicBezTo>
                  <a:close/>
                </a:path>
              </a:pathLst>
            </a:custGeom>
            <a:solidFill>
              <a:srgbClr val="00CC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ko-KR" altLang="en-US" sz="180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itchFamily="34" charset="0"/>
                <a:ea typeface="굴림" charset="-127"/>
                <a:cs typeface="Arial" pitchFamily="34" charset="0"/>
              </a:endParaRPr>
            </a:p>
          </p:txBody>
        </p:sp>
        <p:grpSp>
          <p:nvGrpSpPr>
            <p:cNvPr id="266" name="그룹 265">
              <a:extLst>
                <a:ext uri="{FF2B5EF4-FFF2-40B4-BE49-F238E27FC236}">
                  <a16:creationId xmlns:a16="http://schemas.microsoft.com/office/drawing/2014/main" id="{F0A10CBA-F191-4CD6-92D7-DFBCA98FC572}"/>
                </a:ext>
              </a:extLst>
            </p:cNvPr>
            <p:cNvGrpSpPr/>
            <p:nvPr/>
          </p:nvGrpSpPr>
          <p:grpSpPr>
            <a:xfrm rot="10800000">
              <a:off x="5839676" y="3844854"/>
              <a:ext cx="116646" cy="79323"/>
              <a:chOff x="9017763" y="2551103"/>
              <a:chExt cx="116646" cy="79323"/>
            </a:xfrm>
          </p:grpSpPr>
          <p:sp>
            <p:nvSpPr>
              <p:cNvPr id="300" name="타원 299">
                <a:extLst>
                  <a:ext uri="{FF2B5EF4-FFF2-40B4-BE49-F238E27FC236}">
                    <a16:creationId xmlns:a16="http://schemas.microsoft.com/office/drawing/2014/main" id="{C9AB327E-7646-459B-84D9-8D2B59F3A5C9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301" name="타원 300">
                <a:extLst>
                  <a:ext uri="{FF2B5EF4-FFF2-40B4-BE49-F238E27FC236}">
                    <a16:creationId xmlns:a16="http://schemas.microsoft.com/office/drawing/2014/main" id="{CDF3FE3E-869E-4A67-8109-DB7625278968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267" name="그룹 266">
              <a:extLst>
                <a:ext uri="{FF2B5EF4-FFF2-40B4-BE49-F238E27FC236}">
                  <a16:creationId xmlns:a16="http://schemas.microsoft.com/office/drawing/2014/main" id="{F304F7CF-ADCF-4D28-BD79-34FC55202E41}"/>
                </a:ext>
              </a:extLst>
            </p:cNvPr>
            <p:cNvGrpSpPr/>
            <p:nvPr/>
          </p:nvGrpSpPr>
          <p:grpSpPr>
            <a:xfrm rot="10800000">
              <a:off x="5865441" y="3734093"/>
              <a:ext cx="116646" cy="79323"/>
              <a:chOff x="9017763" y="2551103"/>
              <a:chExt cx="116646" cy="79323"/>
            </a:xfrm>
          </p:grpSpPr>
          <p:sp>
            <p:nvSpPr>
              <p:cNvPr id="298" name="타원 297">
                <a:extLst>
                  <a:ext uri="{FF2B5EF4-FFF2-40B4-BE49-F238E27FC236}">
                    <a16:creationId xmlns:a16="http://schemas.microsoft.com/office/drawing/2014/main" id="{B72A6218-3090-45A9-8EA6-7507F6BCE2DA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299" name="타원 298">
                <a:extLst>
                  <a:ext uri="{FF2B5EF4-FFF2-40B4-BE49-F238E27FC236}">
                    <a16:creationId xmlns:a16="http://schemas.microsoft.com/office/drawing/2014/main" id="{DB893CE4-69C6-4B06-9B02-B864E983D3FE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268" name="그룹 267">
              <a:extLst>
                <a:ext uri="{FF2B5EF4-FFF2-40B4-BE49-F238E27FC236}">
                  <a16:creationId xmlns:a16="http://schemas.microsoft.com/office/drawing/2014/main" id="{0E6A601B-7129-4C50-BEEA-1E2CC061052C}"/>
                </a:ext>
              </a:extLst>
            </p:cNvPr>
            <p:cNvGrpSpPr/>
            <p:nvPr/>
          </p:nvGrpSpPr>
          <p:grpSpPr>
            <a:xfrm rot="10800000">
              <a:off x="5751416" y="3696733"/>
              <a:ext cx="116646" cy="79323"/>
              <a:chOff x="9017763" y="2551103"/>
              <a:chExt cx="116646" cy="79323"/>
            </a:xfrm>
          </p:grpSpPr>
          <p:sp>
            <p:nvSpPr>
              <p:cNvPr id="296" name="타원 295">
                <a:extLst>
                  <a:ext uri="{FF2B5EF4-FFF2-40B4-BE49-F238E27FC236}">
                    <a16:creationId xmlns:a16="http://schemas.microsoft.com/office/drawing/2014/main" id="{B0C8DFEA-32B5-4F8A-8387-F8084E284897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297" name="타원 296">
                <a:extLst>
                  <a:ext uri="{FF2B5EF4-FFF2-40B4-BE49-F238E27FC236}">
                    <a16:creationId xmlns:a16="http://schemas.microsoft.com/office/drawing/2014/main" id="{485076B0-B53C-45BD-A8F5-CB81AFD94ACC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269" name="그룹 268">
              <a:extLst>
                <a:ext uri="{FF2B5EF4-FFF2-40B4-BE49-F238E27FC236}">
                  <a16:creationId xmlns:a16="http://schemas.microsoft.com/office/drawing/2014/main" id="{DA674FFB-5081-448F-984E-F35EE9EBCEAB}"/>
                </a:ext>
              </a:extLst>
            </p:cNvPr>
            <p:cNvGrpSpPr/>
            <p:nvPr/>
          </p:nvGrpSpPr>
          <p:grpSpPr>
            <a:xfrm rot="10800000">
              <a:off x="5779260" y="3791807"/>
              <a:ext cx="116646" cy="79323"/>
              <a:chOff x="9017763" y="2551103"/>
              <a:chExt cx="116646" cy="79323"/>
            </a:xfrm>
          </p:grpSpPr>
          <p:sp>
            <p:nvSpPr>
              <p:cNvPr id="294" name="타원 293">
                <a:extLst>
                  <a:ext uri="{FF2B5EF4-FFF2-40B4-BE49-F238E27FC236}">
                    <a16:creationId xmlns:a16="http://schemas.microsoft.com/office/drawing/2014/main" id="{FB5CFF62-1583-4321-8ED2-1B7516047F67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295" name="타원 294">
                <a:extLst>
                  <a:ext uri="{FF2B5EF4-FFF2-40B4-BE49-F238E27FC236}">
                    <a16:creationId xmlns:a16="http://schemas.microsoft.com/office/drawing/2014/main" id="{FDB1234B-936B-4C43-B033-D0A81C5B0F68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270" name="그룹 269">
              <a:extLst>
                <a:ext uri="{FF2B5EF4-FFF2-40B4-BE49-F238E27FC236}">
                  <a16:creationId xmlns:a16="http://schemas.microsoft.com/office/drawing/2014/main" id="{5C9946D0-9FFF-4378-B617-29219A1903DF}"/>
                </a:ext>
              </a:extLst>
            </p:cNvPr>
            <p:cNvGrpSpPr/>
            <p:nvPr/>
          </p:nvGrpSpPr>
          <p:grpSpPr>
            <a:xfrm rot="10800000">
              <a:off x="5925557" y="3765197"/>
              <a:ext cx="116646" cy="79323"/>
              <a:chOff x="9017763" y="2551103"/>
              <a:chExt cx="116646" cy="79323"/>
            </a:xfrm>
          </p:grpSpPr>
          <p:sp>
            <p:nvSpPr>
              <p:cNvPr id="292" name="타원 291">
                <a:extLst>
                  <a:ext uri="{FF2B5EF4-FFF2-40B4-BE49-F238E27FC236}">
                    <a16:creationId xmlns:a16="http://schemas.microsoft.com/office/drawing/2014/main" id="{F5FD2616-0228-49DC-8B4E-0B93610565A8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293" name="타원 292">
                <a:extLst>
                  <a:ext uri="{FF2B5EF4-FFF2-40B4-BE49-F238E27FC236}">
                    <a16:creationId xmlns:a16="http://schemas.microsoft.com/office/drawing/2014/main" id="{C4BA5D0A-2778-4046-9B0D-1FE730DA3A6D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271" name="그룹 270">
              <a:extLst>
                <a:ext uri="{FF2B5EF4-FFF2-40B4-BE49-F238E27FC236}">
                  <a16:creationId xmlns:a16="http://schemas.microsoft.com/office/drawing/2014/main" id="{EAF76DC7-6E57-4872-AA92-28F267544579}"/>
                </a:ext>
              </a:extLst>
            </p:cNvPr>
            <p:cNvGrpSpPr/>
            <p:nvPr/>
          </p:nvGrpSpPr>
          <p:grpSpPr>
            <a:xfrm rot="10800000">
              <a:off x="5872136" y="3721651"/>
              <a:ext cx="116646" cy="79323"/>
              <a:chOff x="9017763" y="2551103"/>
              <a:chExt cx="116646" cy="79323"/>
            </a:xfrm>
          </p:grpSpPr>
          <p:sp>
            <p:nvSpPr>
              <p:cNvPr id="290" name="타원 289">
                <a:extLst>
                  <a:ext uri="{FF2B5EF4-FFF2-40B4-BE49-F238E27FC236}">
                    <a16:creationId xmlns:a16="http://schemas.microsoft.com/office/drawing/2014/main" id="{CDD3BF5C-03FC-4B55-832E-6B4DD00CBC7B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291" name="타원 290">
                <a:extLst>
                  <a:ext uri="{FF2B5EF4-FFF2-40B4-BE49-F238E27FC236}">
                    <a16:creationId xmlns:a16="http://schemas.microsoft.com/office/drawing/2014/main" id="{D49BD4C5-EFDC-4917-B84E-5FF9FAD51B8E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272" name="그룹 271">
              <a:extLst>
                <a:ext uri="{FF2B5EF4-FFF2-40B4-BE49-F238E27FC236}">
                  <a16:creationId xmlns:a16="http://schemas.microsoft.com/office/drawing/2014/main" id="{C42ECB6F-8713-4761-8C4C-F543CF3DFD5C}"/>
                </a:ext>
              </a:extLst>
            </p:cNvPr>
            <p:cNvGrpSpPr/>
            <p:nvPr/>
          </p:nvGrpSpPr>
          <p:grpSpPr>
            <a:xfrm rot="10800000">
              <a:off x="5756906" y="3719763"/>
              <a:ext cx="116646" cy="79323"/>
              <a:chOff x="9017763" y="2551103"/>
              <a:chExt cx="116646" cy="79323"/>
            </a:xfrm>
          </p:grpSpPr>
          <p:sp>
            <p:nvSpPr>
              <p:cNvPr id="288" name="타원 287">
                <a:extLst>
                  <a:ext uri="{FF2B5EF4-FFF2-40B4-BE49-F238E27FC236}">
                    <a16:creationId xmlns:a16="http://schemas.microsoft.com/office/drawing/2014/main" id="{9B795193-A40A-46F7-86DC-BBD10871BF4E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289" name="타원 288">
                <a:extLst>
                  <a:ext uri="{FF2B5EF4-FFF2-40B4-BE49-F238E27FC236}">
                    <a16:creationId xmlns:a16="http://schemas.microsoft.com/office/drawing/2014/main" id="{3EC84400-A9DF-49F3-B343-3147948E19C4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273" name="그룹 272">
              <a:extLst>
                <a:ext uri="{FF2B5EF4-FFF2-40B4-BE49-F238E27FC236}">
                  <a16:creationId xmlns:a16="http://schemas.microsoft.com/office/drawing/2014/main" id="{F94E1F79-ED50-4391-B5FA-8DE4A7978273}"/>
                </a:ext>
              </a:extLst>
            </p:cNvPr>
            <p:cNvGrpSpPr/>
            <p:nvPr/>
          </p:nvGrpSpPr>
          <p:grpSpPr>
            <a:xfrm rot="10800000">
              <a:off x="5849043" y="3847219"/>
              <a:ext cx="116646" cy="79323"/>
              <a:chOff x="9017763" y="2551103"/>
              <a:chExt cx="116646" cy="79323"/>
            </a:xfrm>
          </p:grpSpPr>
          <p:sp>
            <p:nvSpPr>
              <p:cNvPr id="286" name="타원 285">
                <a:extLst>
                  <a:ext uri="{FF2B5EF4-FFF2-40B4-BE49-F238E27FC236}">
                    <a16:creationId xmlns:a16="http://schemas.microsoft.com/office/drawing/2014/main" id="{5F80AB5A-2833-4BDD-A666-980977B122FC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287" name="타원 286">
                <a:extLst>
                  <a:ext uri="{FF2B5EF4-FFF2-40B4-BE49-F238E27FC236}">
                    <a16:creationId xmlns:a16="http://schemas.microsoft.com/office/drawing/2014/main" id="{29DF0B29-92A4-48F2-9F97-2BD7E662D1D3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274" name="그룹 273">
              <a:extLst>
                <a:ext uri="{FF2B5EF4-FFF2-40B4-BE49-F238E27FC236}">
                  <a16:creationId xmlns:a16="http://schemas.microsoft.com/office/drawing/2014/main" id="{BFBCC9ED-2709-497C-BB75-8136D2DB45F8}"/>
                </a:ext>
              </a:extLst>
            </p:cNvPr>
            <p:cNvGrpSpPr/>
            <p:nvPr/>
          </p:nvGrpSpPr>
          <p:grpSpPr>
            <a:xfrm rot="10800000">
              <a:off x="5747673" y="3844854"/>
              <a:ext cx="116646" cy="79323"/>
              <a:chOff x="9017763" y="2551103"/>
              <a:chExt cx="116646" cy="79323"/>
            </a:xfrm>
          </p:grpSpPr>
          <p:sp>
            <p:nvSpPr>
              <p:cNvPr id="284" name="타원 283">
                <a:extLst>
                  <a:ext uri="{FF2B5EF4-FFF2-40B4-BE49-F238E27FC236}">
                    <a16:creationId xmlns:a16="http://schemas.microsoft.com/office/drawing/2014/main" id="{973D0F61-F3D8-4C4E-9D4C-6405C94836B0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285" name="타원 284">
                <a:extLst>
                  <a:ext uri="{FF2B5EF4-FFF2-40B4-BE49-F238E27FC236}">
                    <a16:creationId xmlns:a16="http://schemas.microsoft.com/office/drawing/2014/main" id="{B921B98E-92BC-4BD7-AB8F-C32A638B7E34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275" name="그룹 274">
              <a:extLst>
                <a:ext uri="{FF2B5EF4-FFF2-40B4-BE49-F238E27FC236}">
                  <a16:creationId xmlns:a16="http://schemas.microsoft.com/office/drawing/2014/main" id="{A535A5C7-10D6-49DB-B45C-582A59CAC7C7}"/>
                </a:ext>
              </a:extLst>
            </p:cNvPr>
            <p:cNvGrpSpPr/>
            <p:nvPr/>
          </p:nvGrpSpPr>
          <p:grpSpPr>
            <a:xfrm rot="10800000">
              <a:off x="5709298" y="3729814"/>
              <a:ext cx="116646" cy="79323"/>
              <a:chOff x="9017763" y="2551103"/>
              <a:chExt cx="116646" cy="79323"/>
            </a:xfrm>
          </p:grpSpPr>
          <p:sp>
            <p:nvSpPr>
              <p:cNvPr id="282" name="타원 281">
                <a:extLst>
                  <a:ext uri="{FF2B5EF4-FFF2-40B4-BE49-F238E27FC236}">
                    <a16:creationId xmlns:a16="http://schemas.microsoft.com/office/drawing/2014/main" id="{58AA3394-BF4D-465C-BC6A-3F0E46BED658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283" name="타원 282">
                <a:extLst>
                  <a:ext uri="{FF2B5EF4-FFF2-40B4-BE49-F238E27FC236}">
                    <a16:creationId xmlns:a16="http://schemas.microsoft.com/office/drawing/2014/main" id="{EAED45C1-E467-416A-9FA8-AC416962EFD7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276" name="그룹 275">
              <a:extLst>
                <a:ext uri="{FF2B5EF4-FFF2-40B4-BE49-F238E27FC236}">
                  <a16:creationId xmlns:a16="http://schemas.microsoft.com/office/drawing/2014/main" id="{49056CB0-D366-4A98-B270-DB4564010B2C}"/>
                </a:ext>
              </a:extLst>
            </p:cNvPr>
            <p:cNvGrpSpPr/>
            <p:nvPr/>
          </p:nvGrpSpPr>
          <p:grpSpPr>
            <a:xfrm rot="10800000">
              <a:off x="5689977" y="3795986"/>
              <a:ext cx="116646" cy="79323"/>
              <a:chOff x="9017763" y="2551103"/>
              <a:chExt cx="116646" cy="79323"/>
            </a:xfrm>
          </p:grpSpPr>
          <p:sp>
            <p:nvSpPr>
              <p:cNvPr id="280" name="타원 279">
                <a:extLst>
                  <a:ext uri="{FF2B5EF4-FFF2-40B4-BE49-F238E27FC236}">
                    <a16:creationId xmlns:a16="http://schemas.microsoft.com/office/drawing/2014/main" id="{AAA7CC72-5538-4762-90EF-1CA5474322DF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281" name="타원 280">
                <a:extLst>
                  <a:ext uri="{FF2B5EF4-FFF2-40B4-BE49-F238E27FC236}">
                    <a16:creationId xmlns:a16="http://schemas.microsoft.com/office/drawing/2014/main" id="{6A6F668C-F444-4D30-834B-E50F8B9F5D81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277" name="그룹 276">
              <a:extLst>
                <a:ext uri="{FF2B5EF4-FFF2-40B4-BE49-F238E27FC236}">
                  <a16:creationId xmlns:a16="http://schemas.microsoft.com/office/drawing/2014/main" id="{81B16671-ACDD-4204-8D1F-B788D8D87FB8}"/>
                </a:ext>
              </a:extLst>
            </p:cNvPr>
            <p:cNvGrpSpPr/>
            <p:nvPr/>
          </p:nvGrpSpPr>
          <p:grpSpPr>
            <a:xfrm rot="10800000">
              <a:off x="5687107" y="3795985"/>
              <a:ext cx="116646" cy="79323"/>
              <a:chOff x="9017763" y="2551103"/>
              <a:chExt cx="116646" cy="79323"/>
            </a:xfrm>
          </p:grpSpPr>
          <p:sp>
            <p:nvSpPr>
              <p:cNvPr id="278" name="타원 277">
                <a:extLst>
                  <a:ext uri="{FF2B5EF4-FFF2-40B4-BE49-F238E27FC236}">
                    <a16:creationId xmlns:a16="http://schemas.microsoft.com/office/drawing/2014/main" id="{E64ABF8E-DE5B-4F7C-B743-A04006EE56BB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279" name="타원 278">
                <a:extLst>
                  <a:ext uri="{FF2B5EF4-FFF2-40B4-BE49-F238E27FC236}">
                    <a16:creationId xmlns:a16="http://schemas.microsoft.com/office/drawing/2014/main" id="{76B44E37-CF6B-4334-A4F5-0B6B51E13CF0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</p:grpSp>
      <p:grpSp>
        <p:nvGrpSpPr>
          <p:cNvPr id="24" name="그룹 23">
            <a:extLst>
              <a:ext uri="{FF2B5EF4-FFF2-40B4-BE49-F238E27FC236}">
                <a16:creationId xmlns:a16="http://schemas.microsoft.com/office/drawing/2014/main" id="{4A950508-1E56-486F-A98F-CD5638868046}"/>
              </a:ext>
            </a:extLst>
          </p:cNvPr>
          <p:cNvGrpSpPr/>
          <p:nvPr/>
        </p:nvGrpSpPr>
        <p:grpSpPr>
          <a:xfrm>
            <a:off x="3755905" y="8096146"/>
            <a:ext cx="454865" cy="545339"/>
            <a:chOff x="5459353" y="3044741"/>
            <a:chExt cx="748219" cy="897043"/>
          </a:xfrm>
        </p:grpSpPr>
        <p:sp>
          <p:nvSpPr>
            <p:cNvPr id="228" name="AutoShape 62">
              <a:extLst>
                <a:ext uri="{FF2B5EF4-FFF2-40B4-BE49-F238E27FC236}">
                  <a16:creationId xmlns:a16="http://schemas.microsoft.com/office/drawing/2014/main" id="{6082B3AA-A476-453E-A49C-69396D99620D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10800000">
              <a:off x="5459353" y="3044741"/>
              <a:ext cx="748219" cy="897043"/>
            </a:xfrm>
            <a:custGeom>
              <a:avLst/>
              <a:gdLst>
                <a:gd name="T0" fmla="*/ 0 w 21600"/>
                <a:gd name="T1" fmla="*/ 0 h 21600"/>
                <a:gd name="T2" fmla="*/ 0 w 21600"/>
                <a:gd name="T3" fmla="*/ 0 h 21600"/>
                <a:gd name="T4" fmla="*/ 0 w 21600"/>
                <a:gd name="T5" fmla="*/ 0 h 21600"/>
                <a:gd name="T6" fmla="*/ 0 w 21600"/>
                <a:gd name="T7" fmla="*/ 0 h 21600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1600"/>
                <a:gd name="T13" fmla="*/ 0 h 21600"/>
                <a:gd name="T14" fmla="*/ 21600 w 21600"/>
                <a:gd name="T15" fmla="*/ 7736 h 21600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1600" h="21600">
                  <a:moveTo>
                    <a:pt x="10740" y="10800"/>
                  </a:moveTo>
                  <a:cubicBezTo>
                    <a:pt x="10740" y="10766"/>
                    <a:pt x="10766" y="10740"/>
                    <a:pt x="10800" y="10740"/>
                  </a:cubicBezTo>
                  <a:cubicBezTo>
                    <a:pt x="10833" y="10739"/>
                    <a:pt x="10859" y="10766"/>
                    <a:pt x="10860" y="10799"/>
                  </a:cubicBezTo>
                  <a:lnTo>
                    <a:pt x="21600" y="10800"/>
                  </a:lnTo>
                  <a:cubicBezTo>
                    <a:pt x="21600" y="4835"/>
                    <a:pt x="16764" y="0"/>
                    <a:pt x="10800" y="0"/>
                  </a:cubicBezTo>
                  <a:cubicBezTo>
                    <a:pt x="4835" y="0"/>
                    <a:pt x="0" y="4835"/>
                    <a:pt x="0" y="10800"/>
                  </a:cubicBezTo>
                  <a:close/>
                </a:path>
              </a:pathLst>
            </a:custGeom>
            <a:solidFill>
              <a:srgbClr val="00CC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ko-KR" altLang="en-US" sz="180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itchFamily="34" charset="0"/>
                <a:ea typeface="굴림" charset="-127"/>
                <a:cs typeface="Arial" pitchFamily="34" charset="0"/>
              </a:endParaRPr>
            </a:p>
          </p:txBody>
        </p:sp>
        <p:grpSp>
          <p:nvGrpSpPr>
            <p:cNvPr id="229" name="그룹 228">
              <a:extLst>
                <a:ext uri="{FF2B5EF4-FFF2-40B4-BE49-F238E27FC236}">
                  <a16:creationId xmlns:a16="http://schemas.microsoft.com/office/drawing/2014/main" id="{73C9CF98-1239-4573-82C5-FEA364BA19A7}"/>
                </a:ext>
              </a:extLst>
            </p:cNvPr>
            <p:cNvGrpSpPr/>
            <p:nvPr/>
          </p:nvGrpSpPr>
          <p:grpSpPr>
            <a:xfrm rot="10800000">
              <a:off x="5839676" y="3844854"/>
              <a:ext cx="116646" cy="79323"/>
              <a:chOff x="9017763" y="2551103"/>
              <a:chExt cx="116646" cy="79323"/>
            </a:xfrm>
          </p:grpSpPr>
          <p:sp>
            <p:nvSpPr>
              <p:cNvPr id="263" name="타원 262">
                <a:extLst>
                  <a:ext uri="{FF2B5EF4-FFF2-40B4-BE49-F238E27FC236}">
                    <a16:creationId xmlns:a16="http://schemas.microsoft.com/office/drawing/2014/main" id="{A8D3A11A-23CC-433E-AF7B-631AC564CC15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264" name="타원 263">
                <a:extLst>
                  <a:ext uri="{FF2B5EF4-FFF2-40B4-BE49-F238E27FC236}">
                    <a16:creationId xmlns:a16="http://schemas.microsoft.com/office/drawing/2014/main" id="{D3182612-54E8-45F0-A9EB-FC672319485E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230" name="그룹 229">
              <a:extLst>
                <a:ext uri="{FF2B5EF4-FFF2-40B4-BE49-F238E27FC236}">
                  <a16:creationId xmlns:a16="http://schemas.microsoft.com/office/drawing/2014/main" id="{467B53D0-7AE1-4A86-ABD1-A7F8018DCC4B}"/>
                </a:ext>
              </a:extLst>
            </p:cNvPr>
            <p:cNvGrpSpPr/>
            <p:nvPr/>
          </p:nvGrpSpPr>
          <p:grpSpPr>
            <a:xfrm rot="10800000">
              <a:off x="5865441" y="3734093"/>
              <a:ext cx="116646" cy="79323"/>
              <a:chOff x="9017763" y="2551103"/>
              <a:chExt cx="116646" cy="79323"/>
            </a:xfrm>
          </p:grpSpPr>
          <p:sp>
            <p:nvSpPr>
              <p:cNvPr id="261" name="타원 260">
                <a:extLst>
                  <a:ext uri="{FF2B5EF4-FFF2-40B4-BE49-F238E27FC236}">
                    <a16:creationId xmlns:a16="http://schemas.microsoft.com/office/drawing/2014/main" id="{B17B3A60-8F4B-4335-AA1A-CB16BB5F04B5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262" name="타원 261">
                <a:extLst>
                  <a:ext uri="{FF2B5EF4-FFF2-40B4-BE49-F238E27FC236}">
                    <a16:creationId xmlns:a16="http://schemas.microsoft.com/office/drawing/2014/main" id="{F109A508-9478-4E6B-A42D-B8DCF4CEC4CA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231" name="그룹 230">
              <a:extLst>
                <a:ext uri="{FF2B5EF4-FFF2-40B4-BE49-F238E27FC236}">
                  <a16:creationId xmlns:a16="http://schemas.microsoft.com/office/drawing/2014/main" id="{0E48060B-1A48-49C6-A73B-E5723532C2A3}"/>
                </a:ext>
              </a:extLst>
            </p:cNvPr>
            <p:cNvGrpSpPr/>
            <p:nvPr/>
          </p:nvGrpSpPr>
          <p:grpSpPr>
            <a:xfrm rot="10800000">
              <a:off x="5751416" y="3696733"/>
              <a:ext cx="116646" cy="79323"/>
              <a:chOff x="9017763" y="2551103"/>
              <a:chExt cx="116646" cy="79323"/>
            </a:xfrm>
          </p:grpSpPr>
          <p:sp>
            <p:nvSpPr>
              <p:cNvPr id="259" name="타원 258">
                <a:extLst>
                  <a:ext uri="{FF2B5EF4-FFF2-40B4-BE49-F238E27FC236}">
                    <a16:creationId xmlns:a16="http://schemas.microsoft.com/office/drawing/2014/main" id="{047BEAE0-12C0-473A-8335-CBAA370C77B1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260" name="타원 259">
                <a:extLst>
                  <a:ext uri="{FF2B5EF4-FFF2-40B4-BE49-F238E27FC236}">
                    <a16:creationId xmlns:a16="http://schemas.microsoft.com/office/drawing/2014/main" id="{3DC34F9C-FEC5-44A9-AE70-0EABA3098542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232" name="그룹 231">
              <a:extLst>
                <a:ext uri="{FF2B5EF4-FFF2-40B4-BE49-F238E27FC236}">
                  <a16:creationId xmlns:a16="http://schemas.microsoft.com/office/drawing/2014/main" id="{1151796B-87B7-4383-B039-F09246426753}"/>
                </a:ext>
              </a:extLst>
            </p:cNvPr>
            <p:cNvGrpSpPr/>
            <p:nvPr/>
          </p:nvGrpSpPr>
          <p:grpSpPr>
            <a:xfrm rot="10800000">
              <a:off x="5779260" y="3791807"/>
              <a:ext cx="116646" cy="79323"/>
              <a:chOff x="9017763" y="2551103"/>
              <a:chExt cx="116646" cy="79323"/>
            </a:xfrm>
          </p:grpSpPr>
          <p:sp>
            <p:nvSpPr>
              <p:cNvPr id="257" name="타원 256">
                <a:extLst>
                  <a:ext uri="{FF2B5EF4-FFF2-40B4-BE49-F238E27FC236}">
                    <a16:creationId xmlns:a16="http://schemas.microsoft.com/office/drawing/2014/main" id="{7C2E4BCE-FE6D-46AE-9852-1C91A5BDB3AC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258" name="타원 257">
                <a:extLst>
                  <a:ext uri="{FF2B5EF4-FFF2-40B4-BE49-F238E27FC236}">
                    <a16:creationId xmlns:a16="http://schemas.microsoft.com/office/drawing/2014/main" id="{3CCF8D05-392C-460C-8692-C203797158EF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233" name="그룹 232">
              <a:extLst>
                <a:ext uri="{FF2B5EF4-FFF2-40B4-BE49-F238E27FC236}">
                  <a16:creationId xmlns:a16="http://schemas.microsoft.com/office/drawing/2014/main" id="{9BDD0522-D453-45A1-8658-B5F97891A777}"/>
                </a:ext>
              </a:extLst>
            </p:cNvPr>
            <p:cNvGrpSpPr/>
            <p:nvPr/>
          </p:nvGrpSpPr>
          <p:grpSpPr>
            <a:xfrm rot="10800000">
              <a:off x="5925557" y="3765197"/>
              <a:ext cx="116646" cy="79323"/>
              <a:chOff x="9017763" y="2551103"/>
              <a:chExt cx="116646" cy="79323"/>
            </a:xfrm>
          </p:grpSpPr>
          <p:sp>
            <p:nvSpPr>
              <p:cNvPr id="255" name="타원 254">
                <a:extLst>
                  <a:ext uri="{FF2B5EF4-FFF2-40B4-BE49-F238E27FC236}">
                    <a16:creationId xmlns:a16="http://schemas.microsoft.com/office/drawing/2014/main" id="{A9AA0509-4573-4CAF-BA97-8A3A81E891F0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256" name="타원 255">
                <a:extLst>
                  <a:ext uri="{FF2B5EF4-FFF2-40B4-BE49-F238E27FC236}">
                    <a16:creationId xmlns:a16="http://schemas.microsoft.com/office/drawing/2014/main" id="{27A2AC42-8EFA-4FE6-B324-3C24A4652211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234" name="그룹 233">
              <a:extLst>
                <a:ext uri="{FF2B5EF4-FFF2-40B4-BE49-F238E27FC236}">
                  <a16:creationId xmlns:a16="http://schemas.microsoft.com/office/drawing/2014/main" id="{80EDB229-931D-418B-81DA-E6F4E781E17B}"/>
                </a:ext>
              </a:extLst>
            </p:cNvPr>
            <p:cNvGrpSpPr/>
            <p:nvPr/>
          </p:nvGrpSpPr>
          <p:grpSpPr>
            <a:xfrm rot="10800000">
              <a:off x="5872136" y="3721651"/>
              <a:ext cx="116646" cy="79323"/>
              <a:chOff x="9017763" y="2551103"/>
              <a:chExt cx="116646" cy="79323"/>
            </a:xfrm>
          </p:grpSpPr>
          <p:sp>
            <p:nvSpPr>
              <p:cNvPr id="253" name="타원 252">
                <a:extLst>
                  <a:ext uri="{FF2B5EF4-FFF2-40B4-BE49-F238E27FC236}">
                    <a16:creationId xmlns:a16="http://schemas.microsoft.com/office/drawing/2014/main" id="{9EDA4720-94F5-49EB-800F-D803FCB1135E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254" name="타원 253">
                <a:extLst>
                  <a:ext uri="{FF2B5EF4-FFF2-40B4-BE49-F238E27FC236}">
                    <a16:creationId xmlns:a16="http://schemas.microsoft.com/office/drawing/2014/main" id="{5190723C-8455-4662-A80F-C5B1FA8A62D2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235" name="그룹 234">
              <a:extLst>
                <a:ext uri="{FF2B5EF4-FFF2-40B4-BE49-F238E27FC236}">
                  <a16:creationId xmlns:a16="http://schemas.microsoft.com/office/drawing/2014/main" id="{4714F129-DC9D-4CF0-8C9F-71714B559AA8}"/>
                </a:ext>
              </a:extLst>
            </p:cNvPr>
            <p:cNvGrpSpPr/>
            <p:nvPr/>
          </p:nvGrpSpPr>
          <p:grpSpPr>
            <a:xfrm rot="10800000">
              <a:off x="5756906" y="3719763"/>
              <a:ext cx="116646" cy="79323"/>
              <a:chOff x="9017763" y="2551103"/>
              <a:chExt cx="116646" cy="79323"/>
            </a:xfrm>
          </p:grpSpPr>
          <p:sp>
            <p:nvSpPr>
              <p:cNvPr id="251" name="타원 250">
                <a:extLst>
                  <a:ext uri="{FF2B5EF4-FFF2-40B4-BE49-F238E27FC236}">
                    <a16:creationId xmlns:a16="http://schemas.microsoft.com/office/drawing/2014/main" id="{5011DEEC-6524-450F-BF32-63CD35A80DEE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252" name="타원 251">
                <a:extLst>
                  <a:ext uri="{FF2B5EF4-FFF2-40B4-BE49-F238E27FC236}">
                    <a16:creationId xmlns:a16="http://schemas.microsoft.com/office/drawing/2014/main" id="{E7E12E31-5D32-45A2-90E3-5B2AB43649F0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236" name="그룹 235">
              <a:extLst>
                <a:ext uri="{FF2B5EF4-FFF2-40B4-BE49-F238E27FC236}">
                  <a16:creationId xmlns:a16="http://schemas.microsoft.com/office/drawing/2014/main" id="{669CB73B-ADD4-46BD-8197-EE9D5FB37E9D}"/>
                </a:ext>
              </a:extLst>
            </p:cNvPr>
            <p:cNvGrpSpPr/>
            <p:nvPr/>
          </p:nvGrpSpPr>
          <p:grpSpPr>
            <a:xfrm rot="10800000">
              <a:off x="5849043" y="3847219"/>
              <a:ext cx="116646" cy="79323"/>
              <a:chOff x="9017763" y="2551103"/>
              <a:chExt cx="116646" cy="79323"/>
            </a:xfrm>
          </p:grpSpPr>
          <p:sp>
            <p:nvSpPr>
              <p:cNvPr id="249" name="타원 248">
                <a:extLst>
                  <a:ext uri="{FF2B5EF4-FFF2-40B4-BE49-F238E27FC236}">
                    <a16:creationId xmlns:a16="http://schemas.microsoft.com/office/drawing/2014/main" id="{5026B855-538A-4FCA-90B3-135E5DB145F7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250" name="타원 249">
                <a:extLst>
                  <a:ext uri="{FF2B5EF4-FFF2-40B4-BE49-F238E27FC236}">
                    <a16:creationId xmlns:a16="http://schemas.microsoft.com/office/drawing/2014/main" id="{D1545079-9738-4D9F-BD61-5CF6A34D4477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237" name="그룹 236">
              <a:extLst>
                <a:ext uri="{FF2B5EF4-FFF2-40B4-BE49-F238E27FC236}">
                  <a16:creationId xmlns:a16="http://schemas.microsoft.com/office/drawing/2014/main" id="{0E539CB8-2DF5-4B28-9A5D-D5A74AB9C02B}"/>
                </a:ext>
              </a:extLst>
            </p:cNvPr>
            <p:cNvGrpSpPr/>
            <p:nvPr/>
          </p:nvGrpSpPr>
          <p:grpSpPr>
            <a:xfrm rot="10800000">
              <a:off x="5747673" y="3844854"/>
              <a:ext cx="116646" cy="79323"/>
              <a:chOff x="9017763" y="2551103"/>
              <a:chExt cx="116646" cy="79323"/>
            </a:xfrm>
          </p:grpSpPr>
          <p:sp>
            <p:nvSpPr>
              <p:cNvPr id="247" name="타원 246">
                <a:extLst>
                  <a:ext uri="{FF2B5EF4-FFF2-40B4-BE49-F238E27FC236}">
                    <a16:creationId xmlns:a16="http://schemas.microsoft.com/office/drawing/2014/main" id="{987B72BE-A0F1-4F19-A932-1743666F9F07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248" name="타원 247">
                <a:extLst>
                  <a:ext uri="{FF2B5EF4-FFF2-40B4-BE49-F238E27FC236}">
                    <a16:creationId xmlns:a16="http://schemas.microsoft.com/office/drawing/2014/main" id="{D353D63F-238D-4924-9537-A3B91AA41C3D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238" name="그룹 237">
              <a:extLst>
                <a:ext uri="{FF2B5EF4-FFF2-40B4-BE49-F238E27FC236}">
                  <a16:creationId xmlns:a16="http://schemas.microsoft.com/office/drawing/2014/main" id="{6B1D8972-AD71-4254-BFC4-DC6DB896063E}"/>
                </a:ext>
              </a:extLst>
            </p:cNvPr>
            <p:cNvGrpSpPr/>
            <p:nvPr/>
          </p:nvGrpSpPr>
          <p:grpSpPr>
            <a:xfrm rot="10800000">
              <a:off x="5709298" y="3729814"/>
              <a:ext cx="116646" cy="79323"/>
              <a:chOff x="9017763" y="2551103"/>
              <a:chExt cx="116646" cy="79323"/>
            </a:xfrm>
          </p:grpSpPr>
          <p:sp>
            <p:nvSpPr>
              <p:cNvPr id="245" name="타원 244">
                <a:extLst>
                  <a:ext uri="{FF2B5EF4-FFF2-40B4-BE49-F238E27FC236}">
                    <a16:creationId xmlns:a16="http://schemas.microsoft.com/office/drawing/2014/main" id="{A069B40B-7703-4F0E-9A4A-CD1BDF82284B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246" name="타원 245">
                <a:extLst>
                  <a:ext uri="{FF2B5EF4-FFF2-40B4-BE49-F238E27FC236}">
                    <a16:creationId xmlns:a16="http://schemas.microsoft.com/office/drawing/2014/main" id="{2A133874-6174-4CB5-B7EF-2BE3C67DE646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239" name="그룹 238">
              <a:extLst>
                <a:ext uri="{FF2B5EF4-FFF2-40B4-BE49-F238E27FC236}">
                  <a16:creationId xmlns:a16="http://schemas.microsoft.com/office/drawing/2014/main" id="{9022B009-06ED-41A2-8D97-7E2CF3825C90}"/>
                </a:ext>
              </a:extLst>
            </p:cNvPr>
            <p:cNvGrpSpPr/>
            <p:nvPr/>
          </p:nvGrpSpPr>
          <p:grpSpPr>
            <a:xfrm rot="10800000">
              <a:off x="5689977" y="3795986"/>
              <a:ext cx="116646" cy="79323"/>
              <a:chOff x="9017763" y="2551103"/>
              <a:chExt cx="116646" cy="79323"/>
            </a:xfrm>
          </p:grpSpPr>
          <p:sp>
            <p:nvSpPr>
              <p:cNvPr id="243" name="타원 242">
                <a:extLst>
                  <a:ext uri="{FF2B5EF4-FFF2-40B4-BE49-F238E27FC236}">
                    <a16:creationId xmlns:a16="http://schemas.microsoft.com/office/drawing/2014/main" id="{56621CEA-28D5-4F5A-B767-787E68B0FDA3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244" name="타원 243">
                <a:extLst>
                  <a:ext uri="{FF2B5EF4-FFF2-40B4-BE49-F238E27FC236}">
                    <a16:creationId xmlns:a16="http://schemas.microsoft.com/office/drawing/2014/main" id="{A4EE3891-2175-4938-9D24-59AA738914AA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  <p:grpSp>
          <p:nvGrpSpPr>
            <p:cNvPr id="240" name="그룹 239">
              <a:extLst>
                <a:ext uri="{FF2B5EF4-FFF2-40B4-BE49-F238E27FC236}">
                  <a16:creationId xmlns:a16="http://schemas.microsoft.com/office/drawing/2014/main" id="{A287B150-488B-475F-82B6-C7580AD9ACC5}"/>
                </a:ext>
              </a:extLst>
            </p:cNvPr>
            <p:cNvGrpSpPr/>
            <p:nvPr/>
          </p:nvGrpSpPr>
          <p:grpSpPr>
            <a:xfrm rot="10800000">
              <a:off x="5687107" y="3795985"/>
              <a:ext cx="116646" cy="79323"/>
              <a:chOff x="9017763" y="2551103"/>
              <a:chExt cx="116646" cy="79323"/>
            </a:xfrm>
          </p:grpSpPr>
          <p:sp>
            <p:nvSpPr>
              <p:cNvPr id="241" name="타원 240">
                <a:extLst>
                  <a:ext uri="{FF2B5EF4-FFF2-40B4-BE49-F238E27FC236}">
                    <a16:creationId xmlns:a16="http://schemas.microsoft.com/office/drawing/2014/main" id="{768FE2DF-477A-4FFB-B3CC-C9E8895A1CD3}"/>
                  </a:ext>
                </a:extLst>
              </p:cNvPr>
              <p:cNvSpPr/>
              <p:nvPr/>
            </p:nvSpPr>
            <p:spPr>
              <a:xfrm rot="10800000" flipH="1" flipV="1">
                <a:off x="9017763" y="2551103"/>
                <a:ext cx="116646" cy="79323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60">
                  <a:latin typeface="HY강M" pitchFamily="18" charset="-127"/>
                  <a:ea typeface="HY강M" pitchFamily="18" charset="-127"/>
                </a:endParaRPr>
              </a:p>
            </p:txBody>
          </p:sp>
          <p:sp>
            <p:nvSpPr>
              <p:cNvPr id="242" name="타원 241">
                <a:extLst>
                  <a:ext uri="{FF2B5EF4-FFF2-40B4-BE49-F238E27FC236}">
                    <a16:creationId xmlns:a16="http://schemas.microsoft.com/office/drawing/2014/main" id="{10CCBAF2-F777-46EA-A69C-65A922A69E1A}"/>
                  </a:ext>
                </a:extLst>
              </p:cNvPr>
              <p:cNvSpPr/>
              <p:nvPr/>
            </p:nvSpPr>
            <p:spPr>
              <a:xfrm flipH="1" flipV="1">
                <a:off x="9076086" y="2577273"/>
                <a:ext cx="30809" cy="3859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60"/>
              </a:p>
            </p:txBody>
          </p:sp>
        </p:grpSp>
      </p:grpSp>
      <p:sp>
        <p:nvSpPr>
          <p:cNvPr id="25" name="직사각형 686">
            <a:extLst>
              <a:ext uri="{FF2B5EF4-FFF2-40B4-BE49-F238E27FC236}">
                <a16:creationId xmlns:a16="http://schemas.microsoft.com/office/drawing/2014/main" id="{5D631707-F9BA-408A-9199-BAA01E58B1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62201" y="4892702"/>
            <a:ext cx="2606182" cy="205457"/>
          </a:xfrm>
          <a:prstGeom prst="rect">
            <a:avLst/>
          </a:prstGeom>
          <a:noFill/>
          <a:ln w="9525" algn="ctr">
            <a:noFill/>
            <a:round/>
            <a:headEnd/>
            <a:tailEnd/>
          </a:ln>
        </p:spPr>
        <p:txBody>
          <a:bodyPr anchor="ctr"/>
          <a:lstStyle/>
          <a:p>
            <a:pPr>
              <a:defRPr/>
            </a:pPr>
            <a:r>
              <a:rPr kumimoji="1" lang="en-US" altLang="ko-KR" sz="1400" kern="0" dirty="0">
                <a:solidFill>
                  <a:srgbClr val="080808"/>
                </a:solidFill>
                <a:latin typeface="Arial" pitchFamily="34" charset="0"/>
                <a:ea typeface="굴림" charset="-127"/>
                <a:cs typeface="Arial" pitchFamily="34" charset="0"/>
              </a:rPr>
              <a:t> </a:t>
            </a:r>
            <a:r>
              <a:rPr kumimoji="1" lang="en-US" altLang="ko-KR" sz="1400" kern="0" dirty="0">
                <a:solidFill>
                  <a:sysClr val="windowText" lastClr="000000"/>
                </a:solidFill>
                <a:latin typeface="Arial" pitchFamily="34" charset="0"/>
                <a:ea typeface="굴림" charset="-127"/>
                <a:cs typeface="Arial" pitchFamily="34" charset="0"/>
              </a:rPr>
              <a:t>Pillar/well 3D cell Culture</a:t>
            </a:r>
            <a:endParaRPr kumimoji="1" lang="ko-KR" altLang="en-US" sz="1400" b="0" i="0" u="none" strike="noStrike" kern="0" cap="none" spc="0" normalizeH="0" baseline="0" noProof="0" dirty="0">
              <a:ln>
                <a:noFill/>
              </a:ln>
              <a:solidFill>
                <a:srgbClr val="080808"/>
              </a:solidFill>
              <a:effectLst/>
              <a:uLnTx/>
              <a:uFillTx/>
              <a:latin typeface="Arial" pitchFamily="34" charset="0"/>
              <a:ea typeface="굴림" charset="-127"/>
              <a:cs typeface="Arial" pitchFamily="34" charset="0"/>
            </a:endParaRPr>
          </a:p>
        </p:txBody>
      </p:sp>
      <p:grpSp>
        <p:nvGrpSpPr>
          <p:cNvPr id="26" name="그룹 25">
            <a:extLst>
              <a:ext uri="{FF2B5EF4-FFF2-40B4-BE49-F238E27FC236}">
                <a16:creationId xmlns:a16="http://schemas.microsoft.com/office/drawing/2014/main" id="{52D4C771-4D11-4B8C-8963-823DDF5B98D0}"/>
              </a:ext>
            </a:extLst>
          </p:cNvPr>
          <p:cNvGrpSpPr/>
          <p:nvPr/>
        </p:nvGrpSpPr>
        <p:grpSpPr>
          <a:xfrm rot="10800000">
            <a:off x="2477018" y="6182320"/>
            <a:ext cx="70913" cy="48223"/>
            <a:chOff x="9017763" y="2551103"/>
            <a:chExt cx="116646" cy="79323"/>
          </a:xfrm>
        </p:grpSpPr>
        <p:sp>
          <p:nvSpPr>
            <p:cNvPr id="226" name="타원 225">
              <a:extLst>
                <a:ext uri="{FF2B5EF4-FFF2-40B4-BE49-F238E27FC236}">
                  <a16:creationId xmlns:a16="http://schemas.microsoft.com/office/drawing/2014/main" id="{42D14E88-C08D-470C-953E-A3049A5407F6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227" name="타원 226">
              <a:extLst>
                <a:ext uri="{FF2B5EF4-FFF2-40B4-BE49-F238E27FC236}">
                  <a16:creationId xmlns:a16="http://schemas.microsoft.com/office/drawing/2014/main" id="{CF8BE63C-6825-46BF-B08C-19A83DB5F240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sp>
        <p:nvSpPr>
          <p:cNvPr id="27" name="AutoShape 62">
            <a:extLst>
              <a:ext uri="{FF2B5EF4-FFF2-40B4-BE49-F238E27FC236}">
                <a16:creationId xmlns:a16="http://schemas.microsoft.com/office/drawing/2014/main" id="{6B670066-C5BA-42E4-852A-F1233C354A84}"/>
              </a:ext>
            </a:extLst>
          </p:cNvPr>
          <p:cNvSpPr>
            <a:spLocks noChangeAspect="1" noChangeArrowheads="1"/>
          </p:cNvSpPr>
          <p:nvPr/>
        </p:nvSpPr>
        <p:spPr bwMode="auto">
          <a:xfrm rot="10800000">
            <a:off x="2975206" y="5798743"/>
            <a:ext cx="454865" cy="545339"/>
          </a:xfrm>
          <a:custGeom>
            <a:avLst/>
            <a:gdLst>
              <a:gd name="T0" fmla="*/ 0 w 21600"/>
              <a:gd name="T1" fmla="*/ 0 h 21600"/>
              <a:gd name="T2" fmla="*/ 0 w 21600"/>
              <a:gd name="T3" fmla="*/ 0 h 21600"/>
              <a:gd name="T4" fmla="*/ 0 w 21600"/>
              <a:gd name="T5" fmla="*/ 0 h 21600"/>
              <a:gd name="T6" fmla="*/ 0 w 21600"/>
              <a:gd name="T7" fmla="*/ 0 h 21600"/>
              <a:gd name="T8" fmla="*/ 0 60000 65536"/>
              <a:gd name="T9" fmla="*/ 0 60000 65536"/>
              <a:gd name="T10" fmla="*/ 0 60000 65536"/>
              <a:gd name="T11" fmla="*/ 0 60000 65536"/>
              <a:gd name="T12" fmla="*/ 0 w 21600"/>
              <a:gd name="T13" fmla="*/ 0 h 21600"/>
              <a:gd name="T14" fmla="*/ 21600 w 21600"/>
              <a:gd name="T15" fmla="*/ 7736 h 2160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21600" h="21600">
                <a:moveTo>
                  <a:pt x="10740" y="10800"/>
                </a:moveTo>
                <a:cubicBezTo>
                  <a:pt x="10740" y="10766"/>
                  <a:pt x="10766" y="10740"/>
                  <a:pt x="10800" y="10740"/>
                </a:cubicBezTo>
                <a:cubicBezTo>
                  <a:pt x="10833" y="10739"/>
                  <a:pt x="10859" y="10766"/>
                  <a:pt x="10860" y="10799"/>
                </a:cubicBezTo>
                <a:lnTo>
                  <a:pt x="21600" y="10800"/>
                </a:lnTo>
                <a:cubicBezTo>
                  <a:pt x="21600" y="4835"/>
                  <a:pt x="16764" y="0"/>
                  <a:pt x="10800" y="0"/>
                </a:cubicBezTo>
                <a:cubicBezTo>
                  <a:pt x="4835" y="0"/>
                  <a:pt x="0" y="4835"/>
                  <a:pt x="0" y="10800"/>
                </a:cubicBezTo>
                <a:close/>
              </a:path>
            </a:pathLst>
          </a:custGeom>
          <a:solidFill>
            <a:srgbClr val="00CC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ko-KR" altLang="en-US" sz="180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Arial" pitchFamily="34" charset="0"/>
              <a:ea typeface="굴림" charset="-127"/>
              <a:cs typeface="Arial" pitchFamily="34" charset="0"/>
            </a:endParaRPr>
          </a:p>
        </p:txBody>
      </p:sp>
      <p:grpSp>
        <p:nvGrpSpPr>
          <p:cNvPr id="28" name="그룹 27">
            <a:extLst>
              <a:ext uri="{FF2B5EF4-FFF2-40B4-BE49-F238E27FC236}">
                <a16:creationId xmlns:a16="http://schemas.microsoft.com/office/drawing/2014/main" id="{8CD5C9E9-1304-4C26-BF0D-8693DFF289D5}"/>
              </a:ext>
            </a:extLst>
          </p:cNvPr>
          <p:cNvGrpSpPr/>
          <p:nvPr/>
        </p:nvGrpSpPr>
        <p:grpSpPr>
          <a:xfrm rot="10800000">
            <a:off x="3206416" y="6285156"/>
            <a:ext cx="70913" cy="48223"/>
            <a:chOff x="9017763" y="2551103"/>
            <a:chExt cx="116646" cy="79323"/>
          </a:xfrm>
        </p:grpSpPr>
        <p:sp>
          <p:nvSpPr>
            <p:cNvPr id="224" name="타원 223">
              <a:extLst>
                <a:ext uri="{FF2B5EF4-FFF2-40B4-BE49-F238E27FC236}">
                  <a16:creationId xmlns:a16="http://schemas.microsoft.com/office/drawing/2014/main" id="{69876B0B-672D-4F51-AB8B-8A959A2BFCBB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225" name="타원 224">
              <a:extLst>
                <a:ext uri="{FF2B5EF4-FFF2-40B4-BE49-F238E27FC236}">
                  <a16:creationId xmlns:a16="http://schemas.microsoft.com/office/drawing/2014/main" id="{A381BD6B-7314-48DA-8A14-44A3E95529ED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29" name="그룹 28">
            <a:extLst>
              <a:ext uri="{FF2B5EF4-FFF2-40B4-BE49-F238E27FC236}">
                <a16:creationId xmlns:a16="http://schemas.microsoft.com/office/drawing/2014/main" id="{22351716-AD00-47D3-A175-3C7953DFE238}"/>
              </a:ext>
            </a:extLst>
          </p:cNvPr>
          <p:cNvGrpSpPr/>
          <p:nvPr/>
        </p:nvGrpSpPr>
        <p:grpSpPr>
          <a:xfrm rot="10800000">
            <a:off x="3192719" y="6230958"/>
            <a:ext cx="70913" cy="48223"/>
            <a:chOff x="9017763" y="2551103"/>
            <a:chExt cx="116646" cy="79323"/>
          </a:xfrm>
        </p:grpSpPr>
        <p:sp>
          <p:nvSpPr>
            <p:cNvPr id="222" name="타원 221">
              <a:extLst>
                <a:ext uri="{FF2B5EF4-FFF2-40B4-BE49-F238E27FC236}">
                  <a16:creationId xmlns:a16="http://schemas.microsoft.com/office/drawing/2014/main" id="{08951F3C-5FB4-4892-B63E-240E13CBBE55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223" name="타원 222">
              <a:extLst>
                <a:ext uri="{FF2B5EF4-FFF2-40B4-BE49-F238E27FC236}">
                  <a16:creationId xmlns:a16="http://schemas.microsoft.com/office/drawing/2014/main" id="{1FDD0B47-F907-4BEF-9B65-6984691F3A1E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30" name="그룹 29">
            <a:extLst>
              <a:ext uri="{FF2B5EF4-FFF2-40B4-BE49-F238E27FC236}">
                <a16:creationId xmlns:a16="http://schemas.microsoft.com/office/drawing/2014/main" id="{74917B5B-6BD3-4826-BD4F-29E3FC36E166}"/>
              </a:ext>
            </a:extLst>
          </p:cNvPr>
          <p:cNvGrpSpPr/>
          <p:nvPr/>
        </p:nvGrpSpPr>
        <p:grpSpPr>
          <a:xfrm rot="10800000">
            <a:off x="3114977" y="6215249"/>
            <a:ext cx="70913" cy="48223"/>
            <a:chOff x="9017763" y="2551103"/>
            <a:chExt cx="116646" cy="79323"/>
          </a:xfrm>
        </p:grpSpPr>
        <p:sp>
          <p:nvSpPr>
            <p:cNvPr id="220" name="타원 219">
              <a:extLst>
                <a:ext uri="{FF2B5EF4-FFF2-40B4-BE49-F238E27FC236}">
                  <a16:creationId xmlns:a16="http://schemas.microsoft.com/office/drawing/2014/main" id="{8C66DBBD-B48F-435A-A5DE-86EEF6184ED2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221" name="타원 220">
              <a:extLst>
                <a:ext uri="{FF2B5EF4-FFF2-40B4-BE49-F238E27FC236}">
                  <a16:creationId xmlns:a16="http://schemas.microsoft.com/office/drawing/2014/main" id="{F7AC2B94-86D3-49FC-8935-172976BCC1D3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31" name="그룹 30">
            <a:extLst>
              <a:ext uri="{FF2B5EF4-FFF2-40B4-BE49-F238E27FC236}">
                <a16:creationId xmlns:a16="http://schemas.microsoft.com/office/drawing/2014/main" id="{B0F13315-9528-41DD-9425-15DE292EF027}"/>
              </a:ext>
            </a:extLst>
          </p:cNvPr>
          <p:cNvGrpSpPr/>
          <p:nvPr/>
        </p:nvGrpSpPr>
        <p:grpSpPr>
          <a:xfrm rot="10800000">
            <a:off x="3028527" y="6194940"/>
            <a:ext cx="70913" cy="48223"/>
            <a:chOff x="9017763" y="2551103"/>
            <a:chExt cx="116646" cy="79323"/>
          </a:xfrm>
        </p:grpSpPr>
        <p:sp>
          <p:nvSpPr>
            <p:cNvPr id="218" name="타원 217">
              <a:extLst>
                <a:ext uri="{FF2B5EF4-FFF2-40B4-BE49-F238E27FC236}">
                  <a16:creationId xmlns:a16="http://schemas.microsoft.com/office/drawing/2014/main" id="{0E3ED52F-58B7-461B-B0E3-BDB56CFA1CED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219" name="타원 218">
              <a:extLst>
                <a:ext uri="{FF2B5EF4-FFF2-40B4-BE49-F238E27FC236}">
                  <a16:creationId xmlns:a16="http://schemas.microsoft.com/office/drawing/2014/main" id="{45B9C829-CA90-4731-A2E1-FDD85B561E5B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32" name="그룹 31">
            <a:extLst>
              <a:ext uri="{FF2B5EF4-FFF2-40B4-BE49-F238E27FC236}">
                <a16:creationId xmlns:a16="http://schemas.microsoft.com/office/drawing/2014/main" id="{C078ED53-7494-4B0D-9CDF-EFFB6457A695}"/>
              </a:ext>
            </a:extLst>
          </p:cNvPr>
          <p:cNvGrpSpPr/>
          <p:nvPr/>
        </p:nvGrpSpPr>
        <p:grpSpPr>
          <a:xfrm rot="10800000">
            <a:off x="3258625" y="6236730"/>
            <a:ext cx="70913" cy="48223"/>
            <a:chOff x="9017763" y="2551103"/>
            <a:chExt cx="116646" cy="79323"/>
          </a:xfrm>
        </p:grpSpPr>
        <p:sp>
          <p:nvSpPr>
            <p:cNvPr id="216" name="타원 215">
              <a:extLst>
                <a:ext uri="{FF2B5EF4-FFF2-40B4-BE49-F238E27FC236}">
                  <a16:creationId xmlns:a16="http://schemas.microsoft.com/office/drawing/2014/main" id="{67FD4EE5-ED77-433A-A48C-678C577C0604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217" name="타원 216">
              <a:extLst>
                <a:ext uri="{FF2B5EF4-FFF2-40B4-BE49-F238E27FC236}">
                  <a16:creationId xmlns:a16="http://schemas.microsoft.com/office/drawing/2014/main" id="{79758B60-69C0-4AA6-8055-5B82EA66F024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33" name="그룹 32">
            <a:extLst>
              <a:ext uri="{FF2B5EF4-FFF2-40B4-BE49-F238E27FC236}">
                <a16:creationId xmlns:a16="http://schemas.microsoft.com/office/drawing/2014/main" id="{2F1D48D5-0250-444C-914C-F30B3C4ACDFA}"/>
              </a:ext>
            </a:extLst>
          </p:cNvPr>
          <p:cNvGrpSpPr/>
          <p:nvPr/>
        </p:nvGrpSpPr>
        <p:grpSpPr>
          <a:xfrm rot="10800000">
            <a:off x="3297318" y="6207157"/>
            <a:ext cx="70913" cy="48223"/>
            <a:chOff x="9017763" y="2551103"/>
            <a:chExt cx="116646" cy="79323"/>
          </a:xfrm>
        </p:grpSpPr>
        <p:sp>
          <p:nvSpPr>
            <p:cNvPr id="214" name="타원 213">
              <a:extLst>
                <a:ext uri="{FF2B5EF4-FFF2-40B4-BE49-F238E27FC236}">
                  <a16:creationId xmlns:a16="http://schemas.microsoft.com/office/drawing/2014/main" id="{B236145F-E1BB-47D7-AD8E-3EC0283CB118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215" name="타원 214">
              <a:extLst>
                <a:ext uri="{FF2B5EF4-FFF2-40B4-BE49-F238E27FC236}">
                  <a16:creationId xmlns:a16="http://schemas.microsoft.com/office/drawing/2014/main" id="{6EAE0439-4C48-4D6C-9F5D-27AEDA00EA80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34" name="그룹 33">
            <a:extLst>
              <a:ext uri="{FF2B5EF4-FFF2-40B4-BE49-F238E27FC236}">
                <a16:creationId xmlns:a16="http://schemas.microsoft.com/office/drawing/2014/main" id="{49342047-897B-4CF9-B3C6-0D16A46FE0DC}"/>
              </a:ext>
            </a:extLst>
          </p:cNvPr>
          <p:cNvGrpSpPr/>
          <p:nvPr/>
        </p:nvGrpSpPr>
        <p:grpSpPr>
          <a:xfrm rot="10800000">
            <a:off x="3214600" y="6188041"/>
            <a:ext cx="70913" cy="48223"/>
            <a:chOff x="9017763" y="2551103"/>
            <a:chExt cx="116646" cy="79323"/>
          </a:xfrm>
        </p:grpSpPr>
        <p:sp>
          <p:nvSpPr>
            <p:cNvPr id="212" name="타원 211">
              <a:extLst>
                <a:ext uri="{FF2B5EF4-FFF2-40B4-BE49-F238E27FC236}">
                  <a16:creationId xmlns:a16="http://schemas.microsoft.com/office/drawing/2014/main" id="{C4445053-FF1C-45EE-821A-B85C0D95CF6B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213" name="타원 212">
              <a:extLst>
                <a:ext uri="{FF2B5EF4-FFF2-40B4-BE49-F238E27FC236}">
                  <a16:creationId xmlns:a16="http://schemas.microsoft.com/office/drawing/2014/main" id="{737B4350-BF11-484E-BBB1-56B80056AD23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35" name="그룹 34">
            <a:extLst>
              <a:ext uri="{FF2B5EF4-FFF2-40B4-BE49-F238E27FC236}">
                <a16:creationId xmlns:a16="http://schemas.microsoft.com/office/drawing/2014/main" id="{22B8D9D4-A54C-4F63-A9FC-3FA7C40C188C}"/>
              </a:ext>
            </a:extLst>
          </p:cNvPr>
          <p:cNvGrpSpPr/>
          <p:nvPr/>
        </p:nvGrpSpPr>
        <p:grpSpPr>
          <a:xfrm rot="10800000">
            <a:off x="3223965" y="6281953"/>
            <a:ext cx="70913" cy="48223"/>
            <a:chOff x="9017763" y="2551103"/>
            <a:chExt cx="116646" cy="79323"/>
          </a:xfrm>
        </p:grpSpPr>
        <p:sp>
          <p:nvSpPr>
            <p:cNvPr id="210" name="타원 209">
              <a:extLst>
                <a:ext uri="{FF2B5EF4-FFF2-40B4-BE49-F238E27FC236}">
                  <a16:creationId xmlns:a16="http://schemas.microsoft.com/office/drawing/2014/main" id="{53B0B404-2878-4455-B703-8694E836A772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211" name="타원 210">
              <a:extLst>
                <a:ext uri="{FF2B5EF4-FFF2-40B4-BE49-F238E27FC236}">
                  <a16:creationId xmlns:a16="http://schemas.microsoft.com/office/drawing/2014/main" id="{AE54B243-4D17-48DA-A38B-02618CD45E3D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36" name="그룹 35">
            <a:extLst>
              <a:ext uri="{FF2B5EF4-FFF2-40B4-BE49-F238E27FC236}">
                <a16:creationId xmlns:a16="http://schemas.microsoft.com/office/drawing/2014/main" id="{4507D5DD-38E8-40CA-B604-230557AD0478}"/>
              </a:ext>
            </a:extLst>
          </p:cNvPr>
          <p:cNvGrpSpPr/>
          <p:nvPr/>
        </p:nvGrpSpPr>
        <p:grpSpPr>
          <a:xfrm rot="10800000">
            <a:off x="3150484" y="6285156"/>
            <a:ext cx="70913" cy="48223"/>
            <a:chOff x="9017763" y="2551103"/>
            <a:chExt cx="116646" cy="79323"/>
          </a:xfrm>
        </p:grpSpPr>
        <p:sp>
          <p:nvSpPr>
            <p:cNvPr id="208" name="타원 207">
              <a:extLst>
                <a:ext uri="{FF2B5EF4-FFF2-40B4-BE49-F238E27FC236}">
                  <a16:creationId xmlns:a16="http://schemas.microsoft.com/office/drawing/2014/main" id="{85EBFAD6-2E53-4A64-A048-667934F1B4CC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209" name="타원 208">
              <a:extLst>
                <a:ext uri="{FF2B5EF4-FFF2-40B4-BE49-F238E27FC236}">
                  <a16:creationId xmlns:a16="http://schemas.microsoft.com/office/drawing/2014/main" id="{059A5179-0CF2-48EB-B7DB-135032CBA29E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37" name="그룹 36">
            <a:extLst>
              <a:ext uri="{FF2B5EF4-FFF2-40B4-BE49-F238E27FC236}">
                <a16:creationId xmlns:a16="http://schemas.microsoft.com/office/drawing/2014/main" id="{A300870A-66FE-43C3-A8F2-FD98E3F0AD4C}"/>
              </a:ext>
            </a:extLst>
          </p:cNvPr>
          <p:cNvGrpSpPr/>
          <p:nvPr/>
        </p:nvGrpSpPr>
        <p:grpSpPr>
          <a:xfrm rot="10800000">
            <a:off x="3056942" y="6207002"/>
            <a:ext cx="70913" cy="48223"/>
            <a:chOff x="9017763" y="2551103"/>
            <a:chExt cx="116646" cy="79323"/>
          </a:xfrm>
        </p:grpSpPr>
        <p:sp>
          <p:nvSpPr>
            <p:cNvPr id="206" name="타원 205">
              <a:extLst>
                <a:ext uri="{FF2B5EF4-FFF2-40B4-BE49-F238E27FC236}">
                  <a16:creationId xmlns:a16="http://schemas.microsoft.com/office/drawing/2014/main" id="{45EDD12F-10CC-481E-8AA7-0DB973B4D988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207" name="타원 206">
              <a:extLst>
                <a:ext uri="{FF2B5EF4-FFF2-40B4-BE49-F238E27FC236}">
                  <a16:creationId xmlns:a16="http://schemas.microsoft.com/office/drawing/2014/main" id="{8B4D408F-ED12-49A0-A116-B11EA9585875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38" name="그룹 37">
            <a:extLst>
              <a:ext uri="{FF2B5EF4-FFF2-40B4-BE49-F238E27FC236}">
                <a16:creationId xmlns:a16="http://schemas.microsoft.com/office/drawing/2014/main" id="{48D7D188-B120-4A2C-BED8-9629E795B063}"/>
              </a:ext>
            </a:extLst>
          </p:cNvPr>
          <p:cNvGrpSpPr/>
          <p:nvPr/>
        </p:nvGrpSpPr>
        <p:grpSpPr>
          <a:xfrm rot="10800000">
            <a:off x="3115409" y="6255447"/>
            <a:ext cx="70913" cy="48223"/>
            <a:chOff x="9017763" y="2551103"/>
            <a:chExt cx="116646" cy="79323"/>
          </a:xfrm>
        </p:grpSpPr>
        <p:sp>
          <p:nvSpPr>
            <p:cNvPr id="204" name="타원 203">
              <a:extLst>
                <a:ext uri="{FF2B5EF4-FFF2-40B4-BE49-F238E27FC236}">
                  <a16:creationId xmlns:a16="http://schemas.microsoft.com/office/drawing/2014/main" id="{052365E9-3901-4B11-AE53-010592AFD552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205" name="타원 204">
              <a:extLst>
                <a:ext uri="{FF2B5EF4-FFF2-40B4-BE49-F238E27FC236}">
                  <a16:creationId xmlns:a16="http://schemas.microsoft.com/office/drawing/2014/main" id="{8B008088-8402-4614-9A6F-2E300B19659D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39" name="그룹 38">
            <a:extLst>
              <a:ext uri="{FF2B5EF4-FFF2-40B4-BE49-F238E27FC236}">
                <a16:creationId xmlns:a16="http://schemas.microsoft.com/office/drawing/2014/main" id="{629C88DF-DEC6-453D-8A6E-2CE79D581304}"/>
              </a:ext>
            </a:extLst>
          </p:cNvPr>
          <p:cNvGrpSpPr/>
          <p:nvPr/>
        </p:nvGrpSpPr>
        <p:grpSpPr>
          <a:xfrm rot="10800000">
            <a:off x="3076492" y="6268752"/>
            <a:ext cx="70913" cy="48223"/>
            <a:chOff x="9017763" y="2551103"/>
            <a:chExt cx="116646" cy="79323"/>
          </a:xfrm>
        </p:grpSpPr>
        <p:sp>
          <p:nvSpPr>
            <p:cNvPr id="202" name="타원 201">
              <a:extLst>
                <a:ext uri="{FF2B5EF4-FFF2-40B4-BE49-F238E27FC236}">
                  <a16:creationId xmlns:a16="http://schemas.microsoft.com/office/drawing/2014/main" id="{067DFB4F-018A-4319-BF0E-FCE5F8A5DF79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203" name="타원 202">
              <a:extLst>
                <a:ext uri="{FF2B5EF4-FFF2-40B4-BE49-F238E27FC236}">
                  <a16:creationId xmlns:a16="http://schemas.microsoft.com/office/drawing/2014/main" id="{15EE35EB-7247-42E0-90F0-1C2460C1BFDA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40" name="그룹 39">
            <a:extLst>
              <a:ext uri="{FF2B5EF4-FFF2-40B4-BE49-F238E27FC236}">
                <a16:creationId xmlns:a16="http://schemas.microsoft.com/office/drawing/2014/main" id="{6D9D5A05-F973-4CDB-902B-721208908B95}"/>
              </a:ext>
            </a:extLst>
          </p:cNvPr>
          <p:cNvGrpSpPr/>
          <p:nvPr/>
        </p:nvGrpSpPr>
        <p:grpSpPr>
          <a:xfrm rot="10800000">
            <a:off x="3322980" y="6180124"/>
            <a:ext cx="70913" cy="48223"/>
            <a:chOff x="9017763" y="2551103"/>
            <a:chExt cx="116646" cy="79323"/>
          </a:xfrm>
        </p:grpSpPr>
        <p:sp>
          <p:nvSpPr>
            <p:cNvPr id="200" name="타원 199">
              <a:extLst>
                <a:ext uri="{FF2B5EF4-FFF2-40B4-BE49-F238E27FC236}">
                  <a16:creationId xmlns:a16="http://schemas.microsoft.com/office/drawing/2014/main" id="{B24DEE4E-3123-4CF4-8FB7-5727ADC2CE50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201" name="타원 200">
              <a:extLst>
                <a:ext uri="{FF2B5EF4-FFF2-40B4-BE49-F238E27FC236}">
                  <a16:creationId xmlns:a16="http://schemas.microsoft.com/office/drawing/2014/main" id="{61A5FF5F-2497-4043-BB55-B3553F53D4F5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sp>
        <p:nvSpPr>
          <p:cNvPr id="41" name="AutoShape 62">
            <a:extLst>
              <a:ext uri="{FF2B5EF4-FFF2-40B4-BE49-F238E27FC236}">
                <a16:creationId xmlns:a16="http://schemas.microsoft.com/office/drawing/2014/main" id="{2C143A9E-B017-48F3-8E50-55098063B9AB}"/>
              </a:ext>
            </a:extLst>
          </p:cNvPr>
          <p:cNvSpPr>
            <a:spLocks noChangeAspect="1" noChangeArrowheads="1"/>
          </p:cNvSpPr>
          <p:nvPr/>
        </p:nvSpPr>
        <p:spPr bwMode="auto">
          <a:xfrm rot="10800000">
            <a:off x="3805718" y="5794557"/>
            <a:ext cx="454865" cy="545339"/>
          </a:xfrm>
          <a:custGeom>
            <a:avLst/>
            <a:gdLst>
              <a:gd name="T0" fmla="*/ 0 w 21600"/>
              <a:gd name="T1" fmla="*/ 0 h 21600"/>
              <a:gd name="T2" fmla="*/ 0 w 21600"/>
              <a:gd name="T3" fmla="*/ 0 h 21600"/>
              <a:gd name="T4" fmla="*/ 0 w 21600"/>
              <a:gd name="T5" fmla="*/ 0 h 21600"/>
              <a:gd name="T6" fmla="*/ 0 w 21600"/>
              <a:gd name="T7" fmla="*/ 0 h 21600"/>
              <a:gd name="T8" fmla="*/ 0 60000 65536"/>
              <a:gd name="T9" fmla="*/ 0 60000 65536"/>
              <a:gd name="T10" fmla="*/ 0 60000 65536"/>
              <a:gd name="T11" fmla="*/ 0 60000 65536"/>
              <a:gd name="T12" fmla="*/ 0 w 21600"/>
              <a:gd name="T13" fmla="*/ 0 h 21600"/>
              <a:gd name="T14" fmla="*/ 21600 w 21600"/>
              <a:gd name="T15" fmla="*/ 7736 h 2160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21600" h="21600">
                <a:moveTo>
                  <a:pt x="10740" y="10800"/>
                </a:moveTo>
                <a:cubicBezTo>
                  <a:pt x="10740" y="10766"/>
                  <a:pt x="10766" y="10740"/>
                  <a:pt x="10800" y="10740"/>
                </a:cubicBezTo>
                <a:cubicBezTo>
                  <a:pt x="10833" y="10739"/>
                  <a:pt x="10859" y="10766"/>
                  <a:pt x="10860" y="10799"/>
                </a:cubicBezTo>
                <a:lnTo>
                  <a:pt x="21600" y="10800"/>
                </a:lnTo>
                <a:cubicBezTo>
                  <a:pt x="21600" y="4835"/>
                  <a:pt x="16764" y="0"/>
                  <a:pt x="10800" y="0"/>
                </a:cubicBezTo>
                <a:cubicBezTo>
                  <a:pt x="4835" y="0"/>
                  <a:pt x="0" y="4835"/>
                  <a:pt x="0" y="10800"/>
                </a:cubicBezTo>
                <a:close/>
              </a:path>
            </a:pathLst>
          </a:custGeom>
          <a:solidFill>
            <a:srgbClr val="00CC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ko-KR" altLang="en-US" sz="180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Arial" pitchFamily="34" charset="0"/>
              <a:ea typeface="굴림" charset="-127"/>
              <a:cs typeface="Arial" pitchFamily="34" charset="0"/>
            </a:endParaRPr>
          </a:p>
        </p:txBody>
      </p:sp>
      <p:grpSp>
        <p:nvGrpSpPr>
          <p:cNvPr id="42" name="그룹 41">
            <a:extLst>
              <a:ext uri="{FF2B5EF4-FFF2-40B4-BE49-F238E27FC236}">
                <a16:creationId xmlns:a16="http://schemas.microsoft.com/office/drawing/2014/main" id="{A847EB80-B539-4797-9942-A52F8210C709}"/>
              </a:ext>
            </a:extLst>
          </p:cNvPr>
          <p:cNvGrpSpPr/>
          <p:nvPr/>
        </p:nvGrpSpPr>
        <p:grpSpPr>
          <a:xfrm rot="10800000">
            <a:off x="4036928" y="6280970"/>
            <a:ext cx="70913" cy="48223"/>
            <a:chOff x="9017763" y="2551103"/>
            <a:chExt cx="116646" cy="79323"/>
          </a:xfrm>
        </p:grpSpPr>
        <p:sp>
          <p:nvSpPr>
            <p:cNvPr id="198" name="타원 197">
              <a:extLst>
                <a:ext uri="{FF2B5EF4-FFF2-40B4-BE49-F238E27FC236}">
                  <a16:creationId xmlns:a16="http://schemas.microsoft.com/office/drawing/2014/main" id="{A73CF4F2-6F36-44F5-9FB6-61DCC7F35558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99" name="타원 198">
              <a:extLst>
                <a:ext uri="{FF2B5EF4-FFF2-40B4-BE49-F238E27FC236}">
                  <a16:creationId xmlns:a16="http://schemas.microsoft.com/office/drawing/2014/main" id="{2F3D36FA-778B-4A59-BDF1-6E3E133CF8E5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43" name="그룹 42">
            <a:extLst>
              <a:ext uri="{FF2B5EF4-FFF2-40B4-BE49-F238E27FC236}">
                <a16:creationId xmlns:a16="http://schemas.microsoft.com/office/drawing/2014/main" id="{B9EAF1EC-25C4-4F20-BADD-B3831E76849B}"/>
              </a:ext>
            </a:extLst>
          </p:cNvPr>
          <p:cNvGrpSpPr/>
          <p:nvPr/>
        </p:nvGrpSpPr>
        <p:grpSpPr>
          <a:xfrm rot="10800000">
            <a:off x="4023230" y="6226771"/>
            <a:ext cx="70913" cy="48223"/>
            <a:chOff x="9017763" y="2551103"/>
            <a:chExt cx="116646" cy="79323"/>
          </a:xfrm>
        </p:grpSpPr>
        <p:sp>
          <p:nvSpPr>
            <p:cNvPr id="196" name="타원 195">
              <a:extLst>
                <a:ext uri="{FF2B5EF4-FFF2-40B4-BE49-F238E27FC236}">
                  <a16:creationId xmlns:a16="http://schemas.microsoft.com/office/drawing/2014/main" id="{F6C86521-149E-4032-9AB1-F06A8A6E6FE0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97" name="타원 196">
              <a:extLst>
                <a:ext uri="{FF2B5EF4-FFF2-40B4-BE49-F238E27FC236}">
                  <a16:creationId xmlns:a16="http://schemas.microsoft.com/office/drawing/2014/main" id="{63DE0F37-4C35-4171-9A90-C5BB5C59E53B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44" name="그룹 43">
            <a:extLst>
              <a:ext uri="{FF2B5EF4-FFF2-40B4-BE49-F238E27FC236}">
                <a16:creationId xmlns:a16="http://schemas.microsoft.com/office/drawing/2014/main" id="{22E82503-7A18-4555-8EC5-7E2784B605EA}"/>
              </a:ext>
            </a:extLst>
          </p:cNvPr>
          <p:cNvGrpSpPr/>
          <p:nvPr/>
        </p:nvGrpSpPr>
        <p:grpSpPr>
          <a:xfrm rot="10800000">
            <a:off x="3945489" y="6211063"/>
            <a:ext cx="70913" cy="48223"/>
            <a:chOff x="9017763" y="2551103"/>
            <a:chExt cx="116646" cy="79323"/>
          </a:xfrm>
        </p:grpSpPr>
        <p:sp>
          <p:nvSpPr>
            <p:cNvPr id="194" name="타원 193">
              <a:extLst>
                <a:ext uri="{FF2B5EF4-FFF2-40B4-BE49-F238E27FC236}">
                  <a16:creationId xmlns:a16="http://schemas.microsoft.com/office/drawing/2014/main" id="{FBC08489-3839-4894-9B20-41830AECCC47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95" name="타원 194">
              <a:extLst>
                <a:ext uri="{FF2B5EF4-FFF2-40B4-BE49-F238E27FC236}">
                  <a16:creationId xmlns:a16="http://schemas.microsoft.com/office/drawing/2014/main" id="{A6ACD7C6-E531-4FF7-B70C-05DBC7020B61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45" name="그룹 44">
            <a:extLst>
              <a:ext uri="{FF2B5EF4-FFF2-40B4-BE49-F238E27FC236}">
                <a16:creationId xmlns:a16="http://schemas.microsoft.com/office/drawing/2014/main" id="{68C56F79-4B6C-49A2-8221-52BBBBE290EF}"/>
              </a:ext>
            </a:extLst>
          </p:cNvPr>
          <p:cNvGrpSpPr/>
          <p:nvPr/>
        </p:nvGrpSpPr>
        <p:grpSpPr>
          <a:xfrm rot="10800000">
            <a:off x="3859039" y="6190754"/>
            <a:ext cx="70913" cy="48223"/>
            <a:chOff x="9017763" y="2551103"/>
            <a:chExt cx="116646" cy="79323"/>
          </a:xfrm>
        </p:grpSpPr>
        <p:sp>
          <p:nvSpPr>
            <p:cNvPr id="192" name="타원 191">
              <a:extLst>
                <a:ext uri="{FF2B5EF4-FFF2-40B4-BE49-F238E27FC236}">
                  <a16:creationId xmlns:a16="http://schemas.microsoft.com/office/drawing/2014/main" id="{08016720-340A-4EBC-894C-E51BF19DE93D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93" name="타원 192">
              <a:extLst>
                <a:ext uri="{FF2B5EF4-FFF2-40B4-BE49-F238E27FC236}">
                  <a16:creationId xmlns:a16="http://schemas.microsoft.com/office/drawing/2014/main" id="{97DB455A-7CE8-4632-8241-9C4A48A5C99F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46" name="그룹 45">
            <a:extLst>
              <a:ext uri="{FF2B5EF4-FFF2-40B4-BE49-F238E27FC236}">
                <a16:creationId xmlns:a16="http://schemas.microsoft.com/office/drawing/2014/main" id="{5F76C827-C34F-49CF-92CC-A84FEEA84699}"/>
              </a:ext>
            </a:extLst>
          </p:cNvPr>
          <p:cNvGrpSpPr/>
          <p:nvPr/>
        </p:nvGrpSpPr>
        <p:grpSpPr>
          <a:xfrm rot="10800000">
            <a:off x="4089137" y="6232544"/>
            <a:ext cx="70913" cy="48223"/>
            <a:chOff x="9017763" y="2551103"/>
            <a:chExt cx="116646" cy="79323"/>
          </a:xfrm>
        </p:grpSpPr>
        <p:sp>
          <p:nvSpPr>
            <p:cNvPr id="190" name="타원 189">
              <a:extLst>
                <a:ext uri="{FF2B5EF4-FFF2-40B4-BE49-F238E27FC236}">
                  <a16:creationId xmlns:a16="http://schemas.microsoft.com/office/drawing/2014/main" id="{22B2BEA1-2ED7-4497-8C51-97DE2CD8B4F0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91" name="타원 190">
              <a:extLst>
                <a:ext uri="{FF2B5EF4-FFF2-40B4-BE49-F238E27FC236}">
                  <a16:creationId xmlns:a16="http://schemas.microsoft.com/office/drawing/2014/main" id="{0F0A99AD-B504-43EE-927F-CD4F8D66937D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47" name="그룹 46">
            <a:extLst>
              <a:ext uri="{FF2B5EF4-FFF2-40B4-BE49-F238E27FC236}">
                <a16:creationId xmlns:a16="http://schemas.microsoft.com/office/drawing/2014/main" id="{0096CF47-9C58-47E4-8341-C9733A43E22A}"/>
              </a:ext>
            </a:extLst>
          </p:cNvPr>
          <p:cNvGrpSpPr/>
          <p:nvPr/>
        </p:nvGrpSpPr>
        <p:grpSpPr>
          <a:xfrm rot="10800000">
            <a:off x="4127830" y="6202971"/>
            <a:ext cx="70913" cy="48223"/>
            <a:chOff x="9017763" y="2551103"/>
            <a:chExt cx="116646" cy="79323"/>
          </a:xfrm>
        </p:grpSpPr>
        <p:sp>
          <p:nvSpPr>
            <p:cNvPr id="188" name="타원 187">
              <a:extLst>
                <a:ext uri="{FF2B5EF4-FFF2-40B4-BE49-F238E27FC236}">
                  <a16:creationId xmlns:a16="http://schemas.microsoft.com/office/drawing/2014/main" id="{4F939209-D754-4B5B-B6B4-4C2229FE42EF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89" name="타원 188">
              <a:extLst>
                <a:ext uri="{FF2B5EF4-FFF2-40B4-BE49-F238E27FC236}">
                  <a16:creationId xmlns:a16="http://schemas.microsoft.com/office/drawing/2014/main" id="{E27CA0DE-6016-4F5B-A5B4-4F3B5EC369AE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48" name="그룹 47">
            <a:extLst>
              <a:ext uri="{FF2B5EF4-FFF2-40B4-BE49-F238E27FC236}">
                <a16:creationId xmlns:a16="http://schemas.microsoft.com/office/drawing/2014/main" id="{B5C80178-98D8-4ECF-B4F7-609CA3E681BD}"/>
              </a:ext>
            </a:extLst>
          </p:cNvPr>
          <p:cNvGrpSpPr/>
          <p:nvPr/>
        </p:nvGrpSpPr>
        <p:grpSpPr>
          <a:xfrm rot="10800000">
            <a:off x="4045112" y="6183855"/>
            <a:ext cx="70913" cy="48223"/>
            <a:chOff x="9017763" y="2551103"/>
            <a:chExt cx="116646" cy="79323"/>
          </a:xfrm>
        </p:grpSpPr>
        <p:sp>
          <p:nvSpPr>
            <p:cNvPr id="186" name="타원 185">
              <a:extLst>
                <a:ext uri="{FF2B5EF4-FFF2-40B4-BE49-F238E27FC236}">
                  <a16:creationId xmlns:a16="http://schemas.microsoft.com/office/drawing/2014/main" id="{80A77FB7-823D-468F-AA18-CC1509A54FB7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87" name="타원 186">
              <a:extLst>
                <a:ext uri="{FF2B5EF4-FFF2-40B4-BE49-F238E27FC236}">
                  <a16:creationId xmlns:a16="http://schemas.microsoft.com/office/drawing/2014/main" id="{E6C333DD-9D82-45EA-B2B3-74AF3588FE29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49" name="그룹 48">
            <a:extLst>
              <a:ext uri="{FF2B5EF4-FFF2-40B4-BE49-F238E27FC236}">
                <a16:creationId xmlns:a16="http://schemas.microsoft.com/office/drawing/2014/main" id="{B937DBFE-2092-4BA5-9368-25959FCFC269}"/>
              </a:ext>
            </a:extLst>
          </p:cNvPr>
          <p:cNvGrpSpPr/>
          <p:nvPr/>
        </p:nvGrpSpPr>
        <p:grpSpPr>
          <a:xfrm rot="10800000">
            <a:off x="4054477" y="6277766"/>
            <a:ext cx="70913" cy="48223"/>
            <a:chOff x="9017763" y="2551103"/>
            <a:chExt cx="116646" cy="79323"/>
          </a:xfrm>
        </p:grpSpPr>
        <p:sp>
          <p:nvSpPr>
            <p:cNvPr id="184" name="타원 183">
              <a:extLst>
                <a:ext uri="{FF2B5EF4-FFF2-40B4-BE49-F238E27FC236}">
                  <a16:creationId xmlns:a16="http://schemas.microsoft.com/office/drawing/2014/main" id="{67B0829B-554C-4619-9D7C-F6DE6F8FBB86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85" name="타원 184">
              <a:extLst>
                <a:ext uri="{FF2B5EF4-FFF2-40B4-BE49-F238E27FC236}">
                  <a16:creationId xmlns:a16="http://schemas.microsoft.com/office/drawing/2014/main" id="{8C2D9981-0E0A-4984-A2CE-4E17B042001D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50" name="그룹 49">
            <a:extLst>
              <a:ext uri="{FF2B5EF4-FFF2-40B4-BE49-F238E27FC236}">
                <a16:creationId xmlns:a16="http://schemas.microsoft.com/office/drawing/2014/main" id="{66AD49BC-9E36-4A2E-9C94-A9316F5F6C00}"/>
              </a:ext>
            </a:extLst>
          </p:cNvPr>
          <p:cNvGrpSpPr/>
          <p:nvPr/>
        </p:nvGrpSpPr>
        <p:grpSpPr>
          <a:xfrm rot="10800000">
            <a:off x="3980996" y="6280970"/>
            <a:ext cx="70913" cy="48223"/>
            <a:chOff x="9017763" y="2551103"/>
            <a:chExt cx="116646" cy="79323"/>
          </a:xfrm>
        </p:grpSpPr>
        <p:sp>
          <p:nvSpPr>
            <p:cNvPr id="182" name="타원 181">
              <a:extLst>
                <a:ext uri="{FF2B5EF4-FFF2-40B4-BE49-F238E27FC236}">
                  <a16:creationId xmlns:a16="http://schemas.microsoft.com/office/drawing/2014/main" id="{FF559334-87EC-46B3-B0A2-54D1AD859BBC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83" name="타원 182">
              <a:extLst>
                <a:ext uri="{FF2B5EF4-FFF2-40B4-BE49-F238E27FC236}">
                  <a16:creationId xmlns:a16="http://schemas.microsoft.com/office/drawing/2014/main" id="{F152CD6E-192A-49FB-BB6A-E259362BEC44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51" name="그룹 50">
            <a:extLst>
              <a:ext uri="{FF2B5EF4-FFF2-40B4-BE49-F238E27FC236}">
                <a16:creationId xmlns:a16="http://schemas.microsoft.com/office/drawing/2014/main" id="{42BA866C-5EE8-4181-B04D-3D66C4586097}"/>
              </a:ext>
            </a:extLst>
          </p:cNvPr>
          <p:cNvGrpSpPr/>
          <p:nvPr/>
        </p:nvGrpSpPr>
        <p:grpSpPr>
          <a:xfrm rot="10800000">
            <a:off x="3887454" y="6202816"/>
            <a:ext cx="70913" cy="48223"/>
            <a:chOff x="9017763" y="2551103"/>
            <a:chExt cx="116646" cy="79323"/>
          </a:xfrm>
        </p:grpSpPr>
        <p:sp>
          <p:nvSpPr>
            <p:cNvPr id="180" name="타원 179">
              <a:extLst>
                <a:ext uri="{FF2B5EF4-FFF2-40B4-BE49-F238E27FC236}">
                  <a16:creationId xmlns:a16="http://schemas.microsoft.com/office/drawing/2014/main" id="{3C43D5DC-01B5-44C4-97F0-6DFA5F8932BB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81" name="타원 180">
              <a:extLst>
                <a:ext uri="{FF2B5EF4-FFF2-40B4-BE49-F238E27FC236}">
                  <a16:creationId xmlns:a16="http://schemas.microsoft.com/office/drawing/2014/main" id="{E84B951D-D515-41D3-BA18-D820E0023693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52" name="그룹 51">
            <a:extLst>
              <a:ext uri="{FF2B5EF4-FFF2-40B4-BE49-F238E27FC236}">
                <a16:creationId xmlns:a16="http://schemas.microsoft.com/office/drawing/2014/main" id="{6E46A90D-0077-49D1-A854-CF7C5F47989F}"/>
              </a:ext>
            </a:extLst>
          </p:cNvPr>
          <p:cNvGrpSpPr/>
          <p:nvPr/>
        </p:nvGrpSpPr>
        <p:grpSpPr>
          <a:xfrm rot="10800000">
            <a:off x="3945921" y="6251261"/>
            <a:ext cx="70913" cy="48223"/>
            <a:chOff x="9017763" y="2551103"/>
            <a:chExt cx="116646" cy="79323"/>
          </a:xfrm>
        </p:grpSpPr>
        <p:sp>
          <p:nvSpPr>
            <p:cNvPr id="178" name="타원 177">
              <a:extLst>
                <a:ext uri="{FF2B5EF4-FFF2-40B4-BE49-F238E27FC236}">
                  <a16:creationId xmlns:a16="http://schemas.microsoft.com/office/drawing/2014/main" id="{2A196617-2F9C-42BE-9E97-B069C09C0511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79" name="타원 178">
              <a:extLst>
                <a:ext uri="{FF2B5EF4-FFF2-40B4-BE49-F238E27FC236}">
                  <a16:creationId xmlns:a16="http://schemas.microsoft.com/office/drawing/2014/main" id="{7463F443-0DC6-47EC-B586-7A136682F794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53" name="그룹 52">
            <a:extLst>
              <a:ext uri="{FF2B5EF4-FFF2-40B4-BE49-F238E27FC236}">
                <a16:creationId xmlns:a16="http://schemas.microsoft.com/office/drawing/2014/main" id="{0006A639-621A-4903-A968-7CF59022F82A}"/>
              </a:ext>
            </a:extLst>
          </p:cNvPr>
          <p:cNvGrpSpPr/>
          <p:nvPr/>
        </p:nvGrpSpPr>
        <p:grpSpPr>
          <a:xfrm rot="10800000">
            <a:off x="3907004" y="6264566"/>
            <a:ext cx="70913" cy="48223"/>
            <a:chOff x="9017763" y="2551103"/>
            <a:chExt cx="116646" cy="79323"/>
          </a:xfrm>
        </p:grpSpPr>
        <p:sp>
          <p:nvSpPr>
            <p:cNvPr id="176" name="타원 175">
              <a:extLst>
                <a:ext uri="{FF2B5EF4-FFF2-40B4-BE49-F238E27FC236}">
                  <a16:creationId xmlns:a16="http://schemas.microsoft.com/office/drawing/2014/main" id="{23069313-1BF2-4A30-97B7-C565F63D526A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77" name="타원 176">
              <a:extLst>
                <a:ext uri="{FF2B5EF4-FFF2-40B4-BE49-F238E27FC236}">
                  <a16:creationId xmlns:a16="http://schemas.microsoft.com/office/drawing/2014/main" id="{9E531E69-51E1-4D0E-B3D5-2F06BE02CCDB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54" name="그룹 53">
            <a:extLst>
              <a:ext uri="{FF2B5EF4-FFF2-40B4-BE49-F238E27FC236}">
                <a16:creationId xmlns:a16="http://schemas.microsoft.com/office/drawing/2014/main" id="{4BF4FE0F-0A3A-4390-AE59-B47E835142EB}"/>
              </a:ext>
            </a:extLst>
          </p:cNvPr>
          <p:cNvGrpSpPr/>
          <p:nvPr/>
        </p:nvGrpSpPr>
        <p:grpSpPr>
          <a:xfrm rot="10800000">
            <a:off x="4153492" y="6175938"/>
            <a:ext cx="70913" cy="48223"/>
            <a:chOff x="9017763" y="2551103"/>
            <a:chExt cx="116646" cy="79323"/>
          </a:xfrm>
        </p:grpSpPr>
        <p:sp>
          <p:nvSpPr>
            <p:cNvPr id="174" name="타원 173">
              <a:extLst>
                <a:ext uri="{FF2B5EF4-FFF2-40B4-BE49-F238E27FC236}">
                  <a16:creationId xmlns:a16="http://schemas.microsoft.com/office/drawing/2014/main" id="{E329F9CD-AA56-438B-8BD3-444A2B6D870E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75" name="타원 174">
              <a:extLst>
                <a:ext uri="{FF2B5EF4-FFF2-40B4-BE49-F238E27FC236}">
                  <a16:creationId xmlns:a16="http://schemas.microsoft.com/office/drawing/2014/main" id="{39E399E9-4A23-47DF-AF35-BE9C49435BE2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pic>
        <p:nvPicPr>
          <p:cNvPr id="56" name="그림 55">
            <a:extLst>
              <a:ext uri="{FF2B5EF4-FFF2-40B4-BE49-F238E27FC236}">
                <a16:creationId xmlns:a16="http://schemas.microsoft.com/office/drawing/2014/main" id="{190A539A-B844-4553-84E0-5439739806B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6613" t="30329" r="49327" b="56563"/>
          <a:stretch/>
        </p:blipFill>
        <p:spPr>
          <a:xfrm>
            <a:off x="4526764" y="5624157"/>
            <a:ext cx="792218" cy="738582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  <p:pic>
        <p:nvPicPr>
          <p:cNvPr id="102" name="Picture 7" descr="화살표_목표3">
            <a:extLst>
              <a:ext uri="{FF2B5EF4-FFF2-40B4-BE49-F238E27FC236}">
                <a16:creationId xmlns:a16="http://schemas.microsoft.com/office/drawing/2014/main" id="{390B41A7-D538-48BB-B173-C480F774A90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6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 flipH="1">
            <a:off x="2528311" y="6905482"/>
            <a:ext cx="1303783" cy="4569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4" name="직사각형 686">
            <a:extLst>
              <a:ext uri="{FF2B5EF4-FFF2-40B4-BE49-F238E27FC236}">
                <a16:creationId xmlns:a16="http://schemas.microsoft.com/office/drawing/2014/main" id="{4064A6C4-5481-4AA0-9BE9-1CB7BE3011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22982" y="6818795"/>
            <a:ext cx="1448441" cy="205457"/>
          </a:xfrm>
          <a:prstGeom prst="rect">
            <a:avLst/>
          </a:prstGeom>
          <a:noFill/>
          <a:ln w="9525" algn="ctr">
            <a:noFill/>
            <a:round/>
            <a:headEnd/>
            <a:tailEnd/>
          </a:ln>
        </p:spPr>
        <p:txBody>
          <a:bodyPr anchor="ctr"/>
          <a:lstStyle/>
          <a:p>
            <a:pPr algn="ctr">
              <a:defRPr/>
            </a:pPr>
            <a:r>
              <a:rPr kumimoji="1" lang="en-US" altLang="ko-KR" sz="1400" kern="0" dirty="0">
                <a:solidFill>
                  <a:sysClr val="windowText" lastClr="000000"/>
                </a:solidFill>
                <a:latin typeface="Arial" pitchFamily="34" charset="0"/>
                <a:ea typeface="굴림" charset="-127"/>
                <a:cs typeface="Arial" pitchFamily="34" charset="0"/>
              </a:rPr>
              <a:t>3D cell Culture</a:t>
            </a:r>
            <a:endParaRPr kumimoji="1" lang="ko-KR" altLang="en-US" sz="1400" b="0" i="0" u="none" strike="noStrike" kern="0" cap="none" spc="0" normalizeH="0" baseline="0" noProof="0" dirty="0">
              <a:ln>
                <a:noFill/>
              </a:ln>
              <a:solidFill>
                <a:srgbClr val="080808"/>
              </a:solidFill>
              <a:effectLst/>
              <a:uLnTx/>
              <a:uFillTx/>
              <a:latin typeface="Arial" pitchFamily="34" charset="0"/>
              <a:ea typeface="굴림" charset="-127"/>
              <a:cs typeface="Arial" pitchFamily="34" charset="0"/>
            </a:endParaRPr>
          </a:p>
        </p:txBody>
      </p:sp>
      <p:sp>
        <p:nvSpPr>
          <p:cNvPr id="105" name="사각형: 둥근 모서리 548">
            <a:extLst>
              <a:ext uri="{FF2B5EF4-FFF2-40B4-BE49-F238E27FC236}">
                <a16:creationId xmlns:a16="http://schemas.microsoft.com/office/drawing/2014/main" id="{3C8F82C7-738F-445E-990A-E12A65D29A62}"/>
              </a:ext>
            </a:extLst>
          </p:cNvPr>
          <p:cNvSpPr/>
          <p:nvPr/>
        </p:nvSpPr>
        <p:spPr>
          <a:xfrm>
            <a:off x="3700731" y="5939828"/>
            <a:ext cx="653032" cy="435153"/>
          </a:xfrm>
          <a:prstGeom prst="round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" name="Rectangle 571">
            <a:extLst>
              <a:ext uri="{FF2B5EF4-FFF2-40B4-BE49-F238E27FC236}">
                <a16:creationId xmlns:a16="http://schemas.microsoft.com/office/drawing/2014/main" id="{526D2F3D-7E9B-4A83-997C-08E5F4DA2F03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346332" y="2761913"/>
            <a:ext cx="1485583" cy="473768"/>
          </a:xfrm>
          <a:prstGeom prst="rect">
            <a:avLst/>
          </a:prstGeom>
          <a:solidFill>
            <a:srgbClr val="FF0000">
              <a:alpha val="50195"/>
            </a:srgbClr>
          </a:solidFill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ko-KR" altLang="en-US" sz="1800" b="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Arial" pitchFamily="34" charset="0"/>
              <a:ea typeface="굴림" charset="-127"/>
              <a:cs typeface="Arial" pitchFamily="34" charset="0"/>
            </a:endParaRPr>
          </a:p>
        </p:txBody>
      </p:sp>
      <p:pic>
        <p:nvPicPr>
          <p:cNvPr id="55" name="그림 54">
            <a:extLst>
              <a:ext uri="{FF2B5EF4-FFF2-40B4-BE49-F238E27FC236}">
                <a16:creationId xmlns:a16="http://schemas.microsoft.com/office/drawing/2014/main" id="{C175B55C-716A-4379-B526-10BB8D85B4C2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56195" t="18342" r="30339" b="60614"/>
          <a:stretch/>
        </p:blipFill>
        <p:spPr>
          <a:xfrm>
            <a:off x="3981696" y="981571"/>
            <a:ext cx="845908" cy="751179"/>
          </a:xfrm>
          <a:prstGeom prst="rect">
            <a:avLst/>
          </a:prstGeom>
          <a:ln w="12700">
            <a:solidFill>
              <a:schemeClr val="tx1"/>
            </a:solidFill>
          </a:ln>
          <a:effectLst>
            <a:softEdge rad="112500"/>
          </a:effectLst>
        </p:spPr>
      </p:pic>
      <p:sp>
        <p:nvSpPr>
          <p:cNvPr id="57" name="자유형: 도형 422">
            <a:extLst>
              <a:ext uri="{FF2B5EF4-FFF2-40B4-BE49-F238E27FC236}">
                <a16:creationId xmlns:a16="http://schemas.microsoft.com/office/drawing/2014/main" id="{C766CABA-A6A1-40DF-B999-BEA69856C8AD}"/>
              </a:ext>
            </a:extLst>
          </p:cNvPr>
          <p:cNvSpPr/>
          <p:nvPr/>
        </p:nvSpPr>
        <p:spPr>
          <a:xfrm>
            <a:off x="3168181" y="1264922"/>
            <a:ext cx="572507" cy="343082"/>
          </a:xfrm>
          <a:custGeom>
            <a:avLst/>
            <a:gdLst>
              <a:gd name="connsiteX0" fmla="*/ 0 w 914400"/>
              <a:gd name="connsiteY0" fmla="*/ 590550 h 590550"/>
              <a:gd name="connsiteX1" fmla="*/ 44450 w 914400"/>
              <a:gd name="connsiteY1" fmla="*/ 330200 h 590550"/>
              <a:gd name="connsiteX2" fmla="*/ 209550 w 914400"/>
              <a:gd name="connsiteY2" fmla="*/ 120650 h 590550"/>
              <a:gd name="connsiteX3" fmla="*/ 361950 w 914400"/>
              <a:gd name="connsiteY3" fmla="*/ 0 h 590550"/>
              <a:gd name="connsiteX4" fmla="*/ 730250 w 914400"/>
              <a:gd name="connsiteY4" fmla="*/ 101600 h 590550"/>
              <a:gd name="connsiteX5" fmla="*/ 812800 w 914400"/>
              <a:gd name="connsiteY5" fmla="*/ 323850 h 590550"/>
              <a:gd name="connsiteX6" fmla="*/ 914400 w 914400"/>
              <a:gd name="connsiteY6" fmla="*/ 577850 h 590550"/>
              <a:gd name="connsiteX7" fmla="*/ 0 w 914400"/>
              <a:gd name="connsiteY7" fmla="*/ 590550 h 590550"/>
              <a:gd name="connsiteX0" fmla="*/ 0 w 914400"/>
              <a:gd name="connsiteY0" fmla="*/ 590691 h 590691"/>
              <a:gd name="connsiteX1" fmla="*/ 44450 w 914400"/>
              <a:gd name="connsiteY1" fmla="*/ 330341 h 590691"/>
              <a:gd name="connsiteX2" fmla="*/ 209550 w 914400"/>
              <a:gd name="connsiteY2" fmla="*/ 120791 h 590691"/>
              <a:gd name="connsiteX3" fmla="*/ 361950 w 914400"/>
              <a:gd name="connsiteY3" fmla="*/ 141 h 590691"/>
              <a:gd name="connsiteX4" fmla="*/ 730250 w 914400"/>
              <a:gd name="connsiteY4" fmla="*/ 101741 h 590691"/>
              <a:gd name="connsiteX5" fmla="*/ 812800 w 914400"/>
              <a:gd name="connsiteY5" fmla="*/ 323991 h 590691"/>
              <a:gd name="connsiteX6" fmla="*/ 914400 w 914400"/>
              <a:gd name="connsiteY6" fmla="*/ 577991 h 590691"/>
              <a:gd name="connsiteX7" fmla="*/ 0 w 914400"/>
              <a:gd name="connsiteY7" fmla="*/ 590691 h 590691"/>
              <a:gd name="connsiteX0" fmla="*/ 0 w 914400"/>
              <a:gd name="connsiteY0" fmla="*/ 590691 h 590691"/>
              <a:gd name="connsiteX1" fmla="*/ 44450 w 914400"/>
              <a:gd name="connsiteY1" fmla="*/ 330341 h 590691"/>
              <a:gd name="connsiteX2" fmla="*/ 209550 w 914400"/>
              <a:gd name="connsiteY2" fmla="*/ 120791 h 590691"/>
              <a:gd name="connsiteX3" fmla="*/ 361950 w 914400"/>
              <a:gd name="connsiteY3" fmla="*/ 141 h 590691"/>
              <a:gd name="connsiteX4" fmla="*/ 730250 w 914400"/>
              <a:gd name="connsiteY4" fmla="*/ 101741 h 590691"/>
              <a:gd name="connsiteX5" fmla="*/ 812800 w 914400"/>
              <a:gd name="connsiteY5" fmla="*/ 323991 h 590691"/>
              <a:gd name="connsiteX6" fmla="*/ 914400 w 914400"/>
              <a:gd name="connsiteY6" fmla="*/ 577991 h 590691"/>
              <a:gd name="connsiteX7" fmla="*/ 0 w 914400"/>
              <a:gd name="connsiteY7" fmla="*/ 590691 h 590691"/>
              <a:gd name="connsiteX0" fmla="*/ 0 w 914400"/>
              <a:gd name="connsiteY0" fmla="*/ 590694 h 590694"/>
              <a:gd name="connsiteX1" fmla="*/ 44450 w 914400"/>
              <a:gd name="connsiteY1" fmla="*/ 330344 h 590694"/>
              <a:gd name="connsiteX2" fmla="*/ 209550 w 914400"/>
              <a:gd name="connsiteY2" fmla="*/ 120794 h 590694"/>
              <a:gd name="connsiteX3" fmla="*/ 361950 w 914400"/>
              <a:gd name="connsiteY3" fmla="*/ 144 h 590694"/>
              <a:gd name="connsiteX4" fmla="*/ 730250 w 914400"/>
              <a:gd name="connsiteY4" fmla="*/ 101744 h 590694"/>
              <a:gd name="connsiteX5" fmla="*/ 850900 w 914400"/>
              <a:gd name="connsiteY5" fmla="*/ 330344 h 590694"/>
              <a:gd name="connsiteX6" fmla="*/ 914400 w 914400"/>
              <a:gd name="connsiteY6" fmla="*/ 577994 h 590694"/>
              <a:gd name="connsiteX7" fmla="*/ 0 w 914400"/>
              <a:gd name="connsiteY7" fmla="*/ 590694 h 590694"/>
              <a:gd name="connsiteX0" fmla="*/ 0 w 914400"/>
              <a:gd name="connsiteY0" fmla="*/ 590694 h 590694"/>
              <a:gd name="connsiteX1" fmla="*/ 44450 w 914400"/>
              <a:gd name="connsiteY1" fmla="*/ 330344 h 590694"/>
              <a:gd name="connsiteX2" fmla="*/ 209550 w 914400"/>
              <a:gd name="connsiteY2" fmla="*/ 120794 h 590694"/>
              <a:gd name="connsiteX3" fmla="*/ 361950 w 914400"/>
              <a:gd name="connsiteY3" fmla="*/ 144 h 590694"/>
              <a:gd name="connsiteX4" fmla="*/ 730250 w 914400"/>
              <a:gd name="connsiteY4" fmla="*/ 101744 h 590694"/>
              <a:gd name="connsiteX5" fmla="*/ 850900 w 914400"/>
              <a:gd name="connsiteY5" fmla="*/ 330344 h 590694"/>
              <a:gd name="connsiteX6" fmla="*/ 914400 w 914400"/>
              <a:gd name="connsiteY6" fmla="*/ 577994 h 590694"/>
              <a:gd name="connsiteX7" fmla="*/ 0 w 914400"/>
              <a:gd name="connsiteY7" fmla="*/ 590694 h 590694"/>
              <a:gd name="connsiteX0" fmla="*/ 0 w 914400"/>
              <a:gd name="connsiteY0" fmla="*/ 590694 h 590694"/>
              <a:gd name="connsiteX1" fmla="*/ 44450 w 914400"/>
              <a:gd name="connsiteY1" fmla="*/ 330344 h 590694"/>
              <a:gd name="connsiteX2" fmla="*/ 209550 w 914400"/>
              <a:gd name="connsiteY2" fmla="*/ 120794 h 590694"/>
              <a:gd name="connsiteX3" fmla="*/ 361950 w 914400"/>
              <a:gd name="connsiteY3" fmla="*/ 144 h 590694"/>
              <a:gd name="connsiteX4" fmla="*/ 730250 w 914400"/>
              <a:gd name="connsiteY4" fmla="*/ 101744 h 590694"/>
              <a:gd name="connsiteX5" fmla="*/ 850900 w 914400"/>
              <a:gd name="connsiteY5" fmla="*/ 330344 h 590694"/>
              <a:gd name="connsiteX6" fmla="*/ 914400 w 914400"/>
              <a:gd name="connsiteY6" fmla="*/ 577994 h 590694"/>
              <a:gd name="connsiteX7" fmla="*/ 0 w 914400"/>
              <a:gd name="connsiteY7" fmla="*/ 590694 h 590694"/>
              <a:gd name="connsiteX0" fmla="*/ 60980 w 975380"/>
              <a:gd name="connsiteY0" fmla="*/ 590694 h 590694"/>
              <a:gd name="connsiteX1" fmla="*/ 105430 w 975380"/>
              <a:gd name="connsiteY1" fmla="*/ 330344 h 590694"/>
              <a:gd name="connsiteX2" fmla="*/ 270530 w 975380"/>
              <a:gd name="connsiteY2" fmla="*/ 120794 h 590694"/>
              <a:gd name="connsiteX3" fmla="*/ 422930 w 975380"/>
              <a:gd name="connsiteY3" fmla="*/ 144 h 590694"/>
              <a:gd name="connsiteX4" fmla="*/ 791230 w 975380"/>
              <a:gd name="connsiteY4" fmla="*/ 101744 h 590694"/>
              <a:gd name="connsiteX5" fmla="*/ 911880 w 975380"/>
              <a:gd name="connsiteY5" fmla="*/ 330344 h 590694"/>
              <a:gd name="connsiteX6" fmla="*/ 975380 w 975380"/>
              <a:gd name="connsiteY6" fmla="*/ 577994 h 590694"/>
              <a:gd name="connsiteX7" fmla="*/ 60980 w 975380"/>
              <a:gd name="connsiteY7" fmla="*/ 590694 h 590694"/>
              <a:gd name="connsiteX0" fmla="*/ 60980 w 975380"/>
              <a:gd name="connsiteY0" fmla="*/ 590694 h 616688"/>
              <a:gd name="connsiteX1" fmla="*/ 105430 w 975380"/>
              <a:gd name="connsiteY1" fmla="*/ 330344 h 616688"/>
              <a:gd name="connsiteX2" fmla="*/ 270530 w 975380"/>
              <a:gd name="connsiteY2" fmla="*/ 120794 h 616688"/>
              <a:gd name="connsiteX3" fmla="*/ 422930 w 975380"/>
              <a:gd name="connsiteY3" fmla="*/ 144 h 616688"/>
              <a:gd name="connsiteX4" fmla="*/ 791230 w 975380"/>
              <a:gd name="connsiteY4" fmla="*/ 101744 h 616688"/>
              <a:gd name="connsiteX5" fmla="*/ 911880 w 975380"/>
              <a:gd name="connsiteY5" fmla="*/ 330344 h 616688"/>
              <a:gd name="connsiteX6" fmla="*/ 975380 w 975380"/>
              <a:gd name="connsiteY6" fmla="*/ 577994 h 616688"/>
              <a:gd name="connsiteX7" fmla="*/ 60980 w 975380"/>
              <a:gd name="connsiteY7" fmla="*/ 590694 h 616688"/>
              <a:gd name="connsiteX0" fmla="*/ 80378 w 918578"/>
              <a:gd name="connsiteY0" fmla="*/ 635144 h 649729"/>
              <a:gd name="connsiteX1" fmla="*/ 48628 w 918578"/>
              <a:gd name="connsiteY1" fmla="*/ 330344 h 649729"/>
              <a:gd name="connsiteX2" fmla="*/ 213728 w 918578"/>
              <a:gd name="connsiteY2" fmla="*/ 120794 h 649729"/>
              <a:gd name="connsiteX3" fmla="*/ 366128 w 918578"/>
              <a:gd name="connsiteY3" fmla="*/ 144 h 649729"/>
              <a:gd name="connsiteX4" fmla="*/ 734428 w 918578"/>
              <a:gd name="connsiteY4" fmla="*/ 101744 h 649729"/>
              <a:gd name="connsiteX5" fmla="*/ 855078 w 918578"/>
              <a:gd name="connsiteY5" fmla="*/ 330344 h 649729"/>
              <a:gd name="connsiteX6" fmla="*/ 918578 w 918578"/>
              <a:gd name="connsiteY6" fmla="*/ 577994 h 649729"/>
              <a:gd name="connsiteX7" fmla="*/ 80378 w 918578"/>
              <a:gd name="connsiteY7" fmla="*/ 635144 h 649729"/>
              <a:gd name="connsiteX0" fmla="*/ 80378 w 918578"/>
              <a:gd name="connsiteY0" fmla="*/ 584344 h 613042"/>
              <a:gd name="connsiteX1" fmla="*/ 48628 w 918578"/>
              <a:gd name="connsiteY1" fmla="*/ 330344 h 613042"/>
              <a:gd name="connsiteX2" fmla="*/ 213728 w 918578"/>
              <a:gd name="connsiteY2" fmla="*/ 120794 h 613042"/>
              <a:gd name="connsiteX3" fmla="*/ 366128 w 918578"/>
              <a:gd name="connsiteY3" fmla="*/ 144 h 613042"/>
              <a:gd name="connsiteX4" fmla="*/ 734428 w 918578"/>
              <a:gd name="connsiteY4" fmla="*/ 101744 h 613042"/>
              <a:gd name="connsiteX5" fmla="*/ 855078 w 918578"/>
              <a:gd name="connsiteY5" fmla="*/ 330344 h 613042"/>
              <a:gd name="connsiteX6" fmla="*/ 918578 w 918578"/>
              <a:gd name="connsiteY6" fmla="*/ 577994 h 613042"/>
              <a:gd name="connsiteX7" fmla="*/ 80378 w 918578"/>
              <a:gd name="connsiteY7" fmla="*/ 584344 h 613042"/>
              <a:gd name="connsiteX0" fmla="*/ 80378 w 919038"/>
              <a:gd name="connsiteY0" fmla="*/ 584344 h 628201"/>
              <a:gd name="connsiteX1" fmla="*/ 48628 w 919038"/>
              <a:gd name="connsiteY1" fmla="*/ 330344 h 628201"/>
              <a:gd name="connsiteX2" fmla="*/ 213728 w 919038"/>
              <a:gd name="connsiteY2" fmla="*/ 120794 h 628201"/>
              <a:gd name="connsiteX3" fmla="*/ 366128 w 919038"/>
              <a:gd name="connsiteY3" fmla="*/ 144 h 628201"/>
              <a:gd name="connsiteX4" fmla="*/ 734428 w 919038"/>
              <a:gd name="connsiteY4" fmla="*/ 101744 h 628201"/>
              <a:gd name="connsiteX5" fmla="*/ 855078 w 919038"/>
              <a:gd name="connsiteY5" fmla="*/ 330344 h 628201"/>
              <a:gd name="connsiteX6" fmla="*/ 918578 w 919038"/>
              <a:gd name="connsiteY6" fmla="*/ 577994 h 628201"/>
              <a:gd name="connsiteX7" fmla="*/ 80378 w 919038"/>
              <a:gd name="connsiteY7" fmla="*/ 584344 h 628201"/>
              <a:gd name="connsiteX0" fmla="*/ 76368 w 861839"/>
              <a:gd name="connsiteY0" fmla="*/ 584344 h 616919"/>
              <a:gd name="connsiteX1" fmla="*/ 44618 w 861839"/>
              <a:gd name="connsiteY1" fmla="*/ 330344 h 616919"/>
              <a:gd name="connsiteX2" fmla="*/ 209718 w 861839"/>
              <a:gd name="connsiteY2" fmla="*/ 120794 h 616919"/>
              <a:gd name="connsiteX3" fmla="*/ 362118 w 861839"/>
              <a:gd name="connsiteY3" fmla="*/ 144 h 616919"/>
              <a:gd name="connsiteX4" fmla="*/ 730418 w 861839"/>
              <a:gd name="connsiteY4" fmla="*/ 101744 h 616919"/>
              <a:gd name="connsiteX5" fmla="*/ 851068 w 861839"/>
              <a:gd name="connsiteY5" fmla="*/ 330344 h 616919"/>
              <a:gd name="connsiteX6" fmla="*/ 857418 w 861839"/>
              <a:gd name="connsiteY6" fmla="*/ 558944 h 616919"/>
              <a:gd name="connsiteX7" fmla="*/ 76368 w 861839"/>
              <a:gd name="connsiteY7" fmla="*/ 584344 h 616919"/>
              <a:gd name="connsiteX0" fmla="*/ 76368 w 861839"/>
              <a:gd name="connsiteY0" fmla="*/ 578011 h 610586"/>
              <a:gd name="connsiteX1" fmla="*/ 44618 w 861839"/>
              <a:gd name="connsiteY1" fmla="*/ 324011 h 610586"/>
              <a:gd name="connsiteX2" fmla="*/ 209718 w 861839"/>
              <a:gd name="connsiteY2" fmla="*/ 114461 h 610586"/>
              <a:gd name="connsiteX3" fmla="*/ 400218 w 861839"/>
              <a:gd name="connsiteY3" fmla="*/ 161 h 610586"/>
              <a:gd name="connsiteX4" fmla="*/ 730418 w 861839"/>
              <a:gd name="connsiteY4" fmla="*/ 95411 h 610586"/>
              <a:gd name="connsiteX5" fmla="*/ 851068 w 861839"/>
              <a:gd name="connsiteY5" fmla="*/ 324011 h 610586"/>
              <a:gd name="connsiteX6" fmla="*/ 857418 w 861839"/>
              <a:gd name="connsiteY6" fmla="*/ 552611 h 610586"/>
              <a:gd name="connsiteX7" fmla="*/ 76368 w 861839"/>
              <a:gd name="connsiteY7" fmla="*/ 578011 h 610586"/>
              <a:gd name="connsiteX0" fmla="*/ 72787 w 858258"/>
              <a:gd name="connsiteY0" fmla="*/ 577870 h 610445"/>
              <a:gd name="connsiteX1" fmla="*/ 41037 w 858258"/>
              <a:gd name="connsiteY1" fmla="*/ 323870 h 610445"/>
              <a:gd name="connsiteX2" fmla="*/ 136287 w 858258"/>
              <a:gd name="connsiteY2" fmla="*/ 101620 h 610445"/>
              <a:gd name="connsiteX3" fmla="*/ 396637 w 858258"/>
              <a:gd name="connsiteY3" fmla="*/ 20 h 610445"/>
              <a:gd name="connsiteX4" fmla="*/ 726837 w 858258"/>
              <a:gd name="connsiteY4" fmla="*/ 95270 h 610445"/>
              <a:gd name="connsiteX5" fmla="*/ 847487 w 858258"/>
              <a:gd name="connsiteY5" fmla="*/ 323870 h 610445"/>
              <a:gd name="connsiteX6" fmla="*/ 853837 w 858258"/>
              <a:gd name="connsiteY6" fmla="*/ 552470 h 610445"/>
              <a:gd name="connsiteX7" fmla="*/ 72787 w 858258"/>
              <a:gd name="connsiteY7" fmla="*/ 577870 h 610445"/>
              <a:gd name="connsiteX0" fmla="*/ 72787 w 860103"/>
              <a:gd name="connsiteY0" fmla="*/ 577991 h 610566"/>
              <a:gd name="connsiteX1" fmla="*/ 41037 w 860103"/>
              <a:gd name="connsiteY1" fmla="*/ 323991 h 610566"/>
              <a:gd name="connsiteX2" fmla="*/ 136287 w 860103"/>
              <a:gd name="connsiteY2" fmla="*/ 101741 h 610566"/>
              <a:gd name="connsiteX3" fmla="*/ 396637 w 860103"/>
              <a:gd name="connsiteY3" fmla="*/ 141 h 610566"/>
              <a:gd name="connsiteX4" fmla="*/ 701437 w 860103"/>
              <a:gd name="connsiteY4" fmla="*/ 120791 h 610566"/>
              <a:gd name="connsiteX5" fmla="*/ 847487 w 860103"/>
              <a:gd name="connsiteY5" fmla="*/ 323991 h 610566"/>
              <a:gd name="connsiteX6" fmla="*/ 853837 w 860103"/>
              <a:gd name="connsiteY6" fmla="*/ 552591 h 610566"/>
              <a:gd name="connsiteX7" fmla="*/ 72787 w 860103"/>
              <a:gd name="connsiteY7" fmla="*/ 577991 h 610566"/>
              <a:gd name="connsiteX0" fmla="*/ 72787 w 895070"/>
              <a:gd name="connsiteY0" fmla="*/ 577991 h 596838"/>
              <a:gd name="connsiteX1" fmla="*/ 41037 w 895070"/>
              <a:gd name="connsiteY1" fmla="*/ 323991 h 596838"/>
              <a:gd name="connsiteX2" fmla="*/ 136287 w 895070"/>
              <a:gd name="connsiteY2" fmla="*/ 101741 h 596838"/>
              <a:gd name="connsiteX3" fmla="*/ 396637 w 895070"/>
              <a:gd name="connsiteY3" fmla="*/ 141 h 596838"/>
              <a:gd name="connsiteX4" fmla="*/ 701437 w 895070"/>
              <a:gd name="connsiteY4" fmla="*/ 120791 h 596838"/>
              <a:gd name="connsiteX5" fmla="*/ 777637 w 895070"/>
              <a:gd name="connsiteY5" fmla="*/ 349391 h 596838"/>
              <a:gd name="connsiteX6" fmla="*/ 853837 w 895070"/>
              <a:gd name="connsiteY6" fmla="*/ 552591 h 596838"/>
              <a:gd name="connsiteX7" fmla="*/ 72787 w 895070"/>
              <a:gd name="connsiteY7" fmla="*/ 577991 h 596838"/>
              <a:gd name="connsiteX0" fmla="*/ 72787 w 917761"/>
              <a:gd name="connsiteY0" fmla="*/ 577991 h 596343"/>
              <a:gd name="connsiteX1" fmla="*/ 41037 w 917761"/>
              <a:gd name="connsiteY1" fmla="*/ 323991 h 596343"/>
              <a:gd name="connsiteX2" fmla="*/ 136287 w 917761"/>
              <a:gd name="connsiteY2" fmla="*/ 101741 h 596343"/>
              <a:gd name="connsiteX3" fmla="*/ 396637 w 917761"/>
              <a:gd name="connsiteY3" fmla="*/ 141 h 596343"/>
              <a:gd name="connsiteX4" fmla="*/ 701437 w 917761"/>
              <a:gd name="connsiteY4" fmla="*/ 120791 h 596343"/>
              <a:gd name="connsiteX5" fmla="*/ 853837 w 917761"/>
              <a:gd name="connsiteY5" fmla="*/ 362091 h 596343"/>
              <a:gd name="connsiteX6" fmla="*/ 853837 w 917761"/>
              <a:gd name="connsiteY6" fmla="*/ 552591 h 596343"/>
              <a:gd name="connsiteX7" fmla="*/ 72787 w 917761"/>
              <a:gd name="connsiteY7" fmla="*/ 577991 h 596343"/>
              <a:gd name="connsiteX0" fmla="*/ 75506 w 949897"/>
              <a:gd name="connsiteY0" fmla="*/ 577991 h 598659"/>
              <a:gd name="connsiteX1" fmla="*/ 43756 w 949897"/>
              <a:gd name="connsiteY1" fmla="*/ 323991 h 598659"/>
              <a:gd name="connsiteX2" fmla="*/ 139006 w 949897"/>
              <a:gd name="connsiteY2" fmla="*/ 101741 h 598659"/>
              <a:gd name="connsiteX3" fmla="*/ 399356 w 949897"/>
              <a:gd name="connsiteY3" fmla="*/ 141 h 598659"/>
              <a:gd name="connsiteX4" fmla="*/ 704156 w 949897"/>
              <a:gd name="connsiteY4" fmla="*/ 120791 h 598659"/>
              <a:gd name="connsiteX5" fmla="*/ 856556 w 949897"/>
              <a:gd name="connsiteY5" fmla="*/ 362091 h 598659"/>
              <a:gd name="connsiteX6" fmla="*/ 894656 w 949897"/>
              <a:gd name="connsiteY6" fmla="*/ 558941 h 598659"/>
              <a:gd name="connsiteX7" fmla="*/ 75506 w 949897"/>
              <a:gd name="connsiteY7" fmla="*/ 577991 h 598659"/>
              <a:gd name="connsiteX0" fmla="*/ 75506 w 958289"/>
              <a:gd name="connsiteY0" fmla="*/ 577991 h 598659"/>
              <a:gd name="connsiteX1" fmla="*/ 43756 w 958289"/>
              <a:gd name="connsiteY1" fmla="*/ 323991 h 598659"/>
              <a:gd name="connsiteX2" fmla="*/ 139006 w 958289"/>
              <a:gd name="connsiteY2" fmla="*/ 101741 h 598659"/>
              <a:gd name="connsiteX3" fmla="*/ 399356 w 958289"/>
              <a:gd name="connsiteY3" fmla="*/ 141 h 598659"/>
              <a:gd name="connsiteX4" fmla="*/ 704156 w 958289"/>
              <a:gd name="connsiteY4" fmla="*/ 120791 h 598659"/>
              <a:gd name="connsiteX5" fmla="*/ 881956 w 958289"/>
              <a:gd name="connsiteY5" fmla="*/ 362091 h 598659"/>
              <a:gd name="connsiteX6" fmla="*/ 894656 w 958289"/>
              <a:gd name="connsiteY6" fmla="*/ 558941 h 598659"/>
              <a:gd name="connsiteX7" fmla="*/ 75506 w 958289"/>
              <a:gd name="connsiteY7" fmla="*/ 577991 h 598659"/>
              <a:gd name="connsiteX0" fmla="*/ 75506 w 958289"/>
              <a:gd name="connsiteY0" fmla="*/ 571657 h 592325"/>
              <a:gd name="connsiteX1" fmla="*/ 43756 w 958289"/>
              <a:gd name="connsiteY1" fmla="*/ 317657 h 592325"/>
              <a:gd name="connsiteX2" fmla="*/ 139006 w 958289"/>
              <a:gd name="connsiteY2" fmla="*/ 95407 h 592325"/>
              <a:gd name="connsiteX3" fmla="*/ 462856 w 958289"/>
              <a:gd name="connsiteY3" fmla="*/ 157 h 592325"/>
              <a:gd name="connsiteX4" fmla="*/ 704156 w 958289"/>
              <a:gd name="connsiteY4" fmla="*/ 114457 h 592325"/>
              <a:gd name="connsiteX5" fmla="*/ 881956 w 958289"/>
              <a:gd name="connsiteY5" fmla="*/ 355757 h 592325"/>
              <a:gd name="connsiteX6" fmla="*/ 894656 w 958289"/>
              <a:gd name="connsiteY6" fmla="*/ 552607 h 592325"/>
              <a:gd name="connsiteX7" fmla="*/ 75506 w 958289"/>
              <a:gd name="connsiteY7" fmla="*/ 571657 h 592325"/>
              <a:gd name="connsiteX0" fmla="*/ 77088 w 959871"/>
              <a:gd name="connsiteY0" fmla="*/ 571564 h 592232"/>
              <a:gd name="connsiteX1" fmla="*/ 45338 w 959871"/>
              <a:gd name="connsiteY1" fmla="*/ 317564 h 592232"/>
              <a:gd name="connsiteX2" fmla="*/ 172338 w 959871"/>
              <a:gd name="connsiteY2" fmla="*/ 101664 h 592232"/>
              <a:gd name="connsiteX3" fmla="*/ 464438 w 959871"/>
              <a:gd name="connsiteY3" fmla="*/ 64 h 592232"/>
              <a:gd name="connsiteX4" fmla="*/ 705738 w 959871"/>
              <a:gd name="connsiteY4" fmla="*/ 114364 h 592232"/>
              <a:gd name="connsiteX5" fmla="*/ 883538 w 959871"/>
              <a:gd name="connsiteY5" fmla="*/ 355664 h 592232"/>
              <a:gd name="connsiteX6" fmla="*/ 896238 w 959871"/>
              <a:gd name="connsiteY6" fmla="*/ 552514 h 592232"/>
              <a:gd name="connsiteX7" fmla="*/ 77088 w 959871"/>
              <a:gd name="connsiteY7" fmla="*/ 571564 h 592232"/>
              <a:gd name="connsiteX0" fmla="*/ 31750 w 914533"/>
              <a:gd name="connsiteY0" fmla="*/ 571564 h 592232"/>
              <a:gd name="connsiteX1" fmla="*/ 0 w 914533"/>
              <a:gd name="connsiteY1" fmla="*/ 317564 h 592232"/>
              <a:gd name="connsiteX2" fmla="*/ 127000 w 914533"/>
              <a:gd name="connsiteY2" fmla="*/ 101664 h 592232"/>
              <a:gd name="connsiteX3" fmla="*/ 419100 w 914533"/>
              <a:gd name="connsiteY3" fmla="*/ 64 h 592232"/>
              <a:gd name="connsiteX4" fmla="*/ 660400 w 914533"/>
              <a:gd name="connsiteY4" fmla="*/ 114364 h 592232"/>
              <a:gd name="connsiteX5" fmla="*/ 838200 w 914533"/>
              <a:gd name="connsiteY5" fmla="*/ 355664 h 592232"/>
              <a:gd name="connsiteX6" fmla="*/ 850900 w 914533"/>
              <a:gd name="connsiteY6" fmla="*/ 552514 h 592232"/>
              <a:gd name="connsiteX7" fmla="*/ 31750 w 914533"/>
              <a:gd name="connsiteY7" fmla="*/ 571564 h 592232"/>
              <a:gd name="connsiteX0" fmla="*/ 77088 w 959871"/>
              <a:gd name="connsiteY0" fmla="*/ 571564 h 592232"/>
              <a:gd name="connsiteX1" fmla="*/ 45338 w 959871"/>
              <a:gd name="connsiteY1" fmla="*/ 317564 h 592232"/>
              <a:gd name="connsiteX2" fmla="*/ 172338 w 959871"/>
              <a:gd name="connsiteY2" fmla="*/ 101664 h 592232"/>
              <a:gd name="connsiteX3" fmla="*/ 464438 w 959871"/>
              <a:gd name="connsiteY3" fmla="*/ 64 h 592232"/>
              <a:gd name="connsiteX4" fmla="*/ 705738 w 959871"/>
              <a:gd name="connsiteY4" fmla="*/ 114364 h 592232"/>
              <a:gd name="connsiteX5" fmla="*/ 883538 w 959871"/>
              <a:gd name="connsiteY5" fmla="*/ 355664 h 592232"/>
              <a:gd name="connsiteX6" fmla="*/ 896238 w 959871"/>
              <a:gd name="connsiteY6" fmla="*/ 552514 h 592232"/>
              <a:gd name="connsiteX7" fmla="*/ 77088 w 959871"/>
              <a:gd name="connsiteY7" fmla="*/ 571564 h 592232"/>
              <a:gd name="connsiteX0" fmla="*/ 77088 w 959871"/>
              <a:gd name="connsiteY0" fmla="*/ 571564 h 571564"/>
              <a:gd name="connsiteX1" fmla="*/ 45338 w 959871"/>
              <a:gd name="connsiteY1" fmla="*/ 317564 h 571564"/>
              <a:gd name="connsiteX2" fmla="*/ 172338 w 959871"/>
              <a:gd name="connsiteY2" fmla="*/ 101664 h 571564"/>
              <a:gd name="connsiteX3" fmla="*/ 464438 w 959871"/>
              <a:gd name="connsiteY3" fmla="*/ 64 h 571564"/>
              <a:gd name="connsiteX4" fmla="*/ 705738 w 959871"/>
              <a:gd name="connsiteY4" fmla="*/ 114364 h 571564"/>
              <a:gd name="connsiteX5" fmla="*/ 883538 w 959871"/>
              <a:gd name="connsiteY5" fmla="*/ 355664 h 571564"/>
              <a:gd name="connsiteX6" fmla="*/ 896238 w 959871"/>
              <a:gd name="connsiteY6" fmla="*/ 552514 h 571564"/>
              <a:gd name="connsiteX7" fmla="*/ 77088 w 959871"/>
              <a:gd name="connsiteY7" fmla="*/ 571564 h 571564"/>
              <a:gd name="connsiteX0" fmla="*/ 76704 w 955639"/>
              <a:gd name="connsiteY0" fmla="*/ 571564 h 592606"/>
              <a:gd name="connsiteX1" fmla="*/ 44954 w 955639"/>
              <a:gd name="connsiteY1" fmla="*/ 317564 h 592606"/>
              <a:gd name="connsiteX2" fmla="*/ 171954 w 955639"/>
              <a:gd name="connsiteY2" fmla="*/ 101664 h 592606"/>
              <a:gd name="connsiteX3" fmla="*/ 464054 w 955639"/>
              <a:gd name="connsiteY3" fmla="*/ 64 h 592606"/>
              <a:gd name="connsiteX4" fmla="*/ 705354 w 955639"/>
              <a:gd name="connsiteY4" fmla="*/ 114364 h 592606"/>
              <a:gd name="connsiteX5" fmla="*/ 883154 w 955639"/>
              <a:gd name="connsiteY5" fmla="*/ 355664 h 592606"/>
              <a:gd name="connsiteX6" fmla="*/ 890431 w 955639"/>
              <a:gd name="connsiteY6" fmla="*/ 579629 h 592606"/>
              <a:gd name="connsiteX7" fmla="*/ 76704 w 955639"/>
              <a:gd name="connsiteY7" fmla="*/ 571564 h 592606"/>
              <a:gd name="connsiteX0" fmla="*/ 78243 w 972971"/>
              <a:gd name="connsiteY0" fmla="*/ 571564 h 597283"/>
              <a:gd name="connsiteX1" fmla="*/ 46493 w 972971"/>
              <a:gd name="connsiteY1" fmla="*/ 317564 h 597283"/>
              <a:gd name="connsiteX2" fmla="*/ 173493 w 972971"/>
              <a:gd name="connsiteY2" fmla="*/ 101664 h 597283"/>
              <a:gd name="connsiteX3" fmla="*/ 465593 w 972971"/>
              <a:gd name="connsiteY3" fmla="*/ 64 h 597283"/>
              <a:gd name="connsiteX4" fmla="*/ 706893 w 972971"/>
              <a:gd name="connsiteY4" fmla="*/ 114364 h 597283"/>
              <a:gd name="connsiteX5" fmla="*/ 884693 w 972971"/>
              <a:gd name="connsiteY5" fmla="*/ 355664 h 597283"/>
              <a:gd name="connsiteX6" fmla="*/ 913662 w 972971"/>
              <a:gd name="connsiteY6" fmla="*/ 590475 h 597283"/>
              <a:gd name="connsiteX7" fmla="*/ 78243 w 972971"/>
              <a:gd name="connsiteY7" fmla="*/ 571564 h 597283"/>
              <a:gd name="connsiteX0" fmla="*/ 78243 w 972971"/>
              <a:gd name="connsiteY0" fmla="*/ 571564 h 590475"/>
              <a:gd name="connsiteX1" fmla="*/ 46493 w 972971"/>
              <a:gd name="connsiteY1" fmla="*/ 317564 h 590475"/>
              <a:gd name="connsiteX2" fmla="*/ 173493 w 972971"/>
              <a:gd name="connsiteY2" fmla="*/ 101664 h 590475"/>
              <a:gd name="connsiteX3" fmla="*/ 465593 w 972971"/>
              <a:gd name="connsiteY3" fmla="*/ 64 h 590475"/>
              <a:gd name="connsiteX4" fmla="*/ 706893 w 972971"/>
              <a:gd name="connsiteY4" fmla="*/ 114364 h 590475"/>
              <a:gd name="connsiteX5" fmla="*/ 884693 w 972971"/>
              <a:gd name="connsiteY5" fmla="*/ 355664 h 590475"/>
              <a:gd name="connsiteX6" fmla="*/ 913662 w 972971"/>
              <a:gd name="connsiteY6" fmla="*/ 590475 h 590475"/>
              <a:gd name="connsiteX7" fmla="*/ 78243 w 972971"/>
              <a:gd name="connsiteY7" fmla="*/ 571564 h 590475"/>
              <a:gd name="connsiteX0" fmla="*/ 71834 w 989860"/>
              <a:gd name="connsiteY0" fmla="*/ 593256 h 608606"/>
              <a:gd name="connsiteX1" fmla="*/ 61776 w 989860"/>
              <a:gd name="connsiteY1" fmla="*/ 317564 h 608606"/>
              <a:gd name="connsiteX2" fmla="*/ 188776 w 989860"/>
              <a:gd name="connsiteY2" fmla="*/ 101664 h 608606"/>
              <a:gd name="connsiteX3" fmla="*/ 480876 w 989860"/>
              <a:gd name="connsiteY3" fmla="*/ 64 h 608606"/>
              <a:gd name="connsiteX4" fmla="*/ 722176 w 989860"/>
              <a:gd name="connsiteY4" fmla="*/ 114364 h 608606"/>
              <a:gd name="connsiteX5" fmla="*/ 899976 w 989860"/>
              <a:gd name="connsiteY5" fmla="*/ 355664 h 608606"/>
              <a:gd name="connsiteX6" fmla="*/ 928945 w 989860"/>
              <a:gd name="connsiteY6" fmla="*/ 590475 h 608606"/>
              <a:gd name="connsiteX7" fmla="*/ 71834 w 989860"/>
              <a:gd name="connsiteY7" fmla="*/ 593256 h 608606"/>
              <a:gd name="connsiteX0" fmla="*/ 71834 w 989860"/>
              <a:gd name="connsiteY0" fmla="*/ 593569 h 608919"/>
              <a:gd name="connsiteX1" fmla="*/ 61776 w 989860"/>
              <a:gd name="connsiteY1" fmla="*/ 317877 h 608919"/>
              <a:gd name="connsiteX2" fmla="*/ 188776 w 989860"/>
              <a:gd name="connsiteY2" fmla="*/ 101977 h 608919"/>
              <a:gd name="connsiteX3" fmla="*/ 480876 w 989860"/>
              <a:gd name="connsiteY3" fmla="*/ 377 h 608919"/>
              <a:gd name="connsiteX4" fmla="*/ 834782 w 989860"/>
              <a:gd name="connsiteY4" fmla="*/ 134549 h 608919"/>
              <a:gd name="connsiteX5" fmla="*/ 899976 w 989860"/>
              <a:gd name="connsiteY5" fmla="*/ 355977 h 608919"/>
              <a:gd name="connsiteX6" fmla="*/ 928945 w 989860"/>
              <a:gd name="connsiteY6" fmla="*/ 590788 h 608919"/>
              <a:gd name="connsiteX7" fmla="*/ 71834 w 989860"/>
              <a:gd name="connsiteY7" fmla="*/ 593569 h 608919"/>
              <a:gd name="connsiteX0" fmla="*/ 71834 w 989860"/>
              <a:gd name="connsiteY0" fmla="*/ 573844 h 589194"/>
              <a:gd name="connsiteX1" fmla="*/ 61776 w 989860"/>
              <a:gd name="connsiteY1" fmla="*/ 298152 h 589194"/>
              <a:gd name="connsiteX2" fmla="*/ 188776 w 989860"/>
              <a:gd name="connsiteY2" fmla="*/ 82252 h 589194"/>
              <a:gd name="connsiteX3" fmla="*/ 646473 w 989860"/>
              <a:gd name="connsiteY3" fmla="*/ 523 h 589194"/>
              <a:gd name="connsiteX4" fmla="*/ 834782 w 989860"/>
              <a:gd name="connsiteY4" fmla="*/ 114824 h 589194"/>
              <a:gd name="connsiteX5" fmla="*/ 899976 w 989860"/>
              <a:gd name="connsiteY5" fmla="*/ 336252 h 589194"/>
              <a:gd name="connsiteX6" fmla="*/ 928945 w 989860"/>
              <a:gd name="connsiteY6" fmla="*/ 571063 h 589194"/>
              <a:gd name="connsiteX7" fmla="*/ 71834 w 989860"/>
              <a:gd name="connsiteY7" fmla="*/ 573844 h 589194"/>
              <a:gd name="connsiteX0" fmla="*/ 78274 w 996300"/>
              <a:gd name="connsiteY0" fmla="*/ 573334 h 588684"/>
              <a:gd name="connsiteX1" fmla="*/ 68216 w 996300"/>
              <a:gd name="connsiteY1" fmla="*/ 297642 h 588684"/>
              <a:gd name="connsiteX2" fmla="*/ 334318 w 996300"/>
              <a:gd name="connsiteY2" fmla="*/ 108237 h 588684"/>
              <a:gd name="connsiteX3" fmla="*/ 652913 w 996300"/>
              <a:gd name="connsiteY3" fmla="*/ 13 h 588684"/>
              <a:gd name="connsiteX4" fmla="*/ 841222 w 996300"/>
              <a:gd name="connsiteY4" fmla="*/ 114314 h 588684"/>
              <a:gd name="connsiteX5" fmla="*/ 906416 w 996300"/>
              <a:gd name="connsiteY5" fmla="*/ 335742 h 588684"/>
              <a:gd name="connsiteX6" fmla="*/ 935385 w 996300"/>
              <a:gd name="connsiteY6" fmla="*/ 570553 h 588684"/>
              <a:gd name="connsiteX7" fmla="*/ 78274 w 996300"/>
              <a:gd name="connsiteY7" fmla="*/ 573334 h 588684"/>
              <a:gd name="connsiteX0" fmla="*/ 64322 w 982348"/>
              <a:gd name="connsiteY0" fmla="*/ 573334 h 588684"/>
              <a:gd name="connsiteX1" fmla="*/ 100632 w 982348"/>
              <a:gd name="connsiteY1" fmla="*/ 310890 h 588684"/>
              <a:gd name="connsiteX2" fmla="*/ 320366 w 982348"/>
              <a:gd name="connsiteY2" fmla="*/ 108237 h 588684"/>
              <a:gd name="connsiteX3" fmla="*/ 638961 w 982348"/>
              <a:gd name="connsiteY3" fmla="*/ 13 h 588684"/>
              <a:gd name="connsiteX4" fmla="*/ 827270 w 982348"/>
              <a:gd name="connsiteY4" fmla="*/ 114314 h 588684"/>
              <a:gd name="connsiteX5" fmla="*/ 892464 w 982348"/>
              <a:gd name="connsiteY5" fmla="*/ 335742 h 588684"/>
              <a:gd name="connsiteX6" fmla="*/ 921433 w 982348"/>
              <a:gd name="connsiteY6" fmla="*/ 570553 h 588684"/>
              <a:gd name="connsiteX7" fmla="*/ 64322 w 982348"/>
              <a:gd name="connsiteY7" fmla="*/ 573334 h 5886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982348" h="588684">
                <a:moveTo>
                  <a:pt x="64322" y="573334"/>
                </a:moveTo>
                <a:cubicBezTo>
                  <a:pt x="-80206" y="527849"/>
                  <a:pt x="57958" y="388406"/>
                  <a:pt x="100632" y="310890"/>
                </a:cubicBezTo>
                <a:cubicBezTo>
                  <a:pt x="143306" y="233374"/>
                  <a:pt x="230645" y="160050"/>
                  <a:pt x="320366" y="108237"/>
                </a:cubicBezTo>
                <a:cubicBezTo>
                  <a:pt x="410087" y="56424"/>
                  <a:pt x="554477" y="-1000"/>
                  <a:pt x="638961" y="13"/>
                </a:cubicBezTo>
                <a:cubicBezTo>
                  <a:pt x="723445" y="1026"/>
                  <a:pt x="785020" y="58359"/>
                  <a:pt x="827270" y="114314"/>
                </a:cubicBezTo>
                <a:cubicBezTo>
                  <a:pt x="869520" y="170269"/>
                  <a:pt x="860714" y="262717"/>
                  <a:pt x="892464" y="335742"/>
                </a:cubicBezTo>
                <a:cubicBezTo>
                  <a:pt x="924214" y="408767"/>
                  <a:pt x="1059457" y="530954"/>
                  <a:pt x="921433" y="570553"/>
                </a:cubicBezTo>
                <a:cubicBezTo>
                  <a:pt x="783409" y="610152"/>
                  <a:pt x="350026" y="572407"/>
                  <a:pt x="64322" y="573334"/>
                </a:cubicBezTo>
                <a:close/>
              </a:path>
            </a:pathLst>
          </a:custGeom>
          <a:solidFill>
            <a:srgbClr val="00CC00"/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ko-KR" altLang="en-US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/>
              <a:ea typeface="맑은 고딕"/>
              <a:cs typeface="+mn-cs"/>
            </a:endParaRPr>
          </a:p>
        </p:txBody>
      </p:sp>
      <p:sp>
        <p:nvSpPr>
          <p:cNvPr id="58" name="자유형: 도형 259">
            <a:extLst>
              <a:ext uri="{FF2B5EF4-FFF2-40B4-BE49-F238E27FC236}">
                <a16:creationId xmlns:a16="http://schemas.microsoft.com/office/drawing/2014/main" id="{B188F175-F72D-42E3-A6EA-2153F1FCBBF1}"/>
              </a:ext>
            </a:extLst>
          </p:cNvPr>
          <p:cNvSpPr/>
          <p:nvPr/>
        </p:nvSpPr>
        <p:spPr>
          <a:xfrm>
            <a:off x="2441668" y="1261760"/>
            <a:ext cx="576885" cy="354693"/>
          </a:xfrm>
          <a:custGeom>
            <a:avLst/>
            <a:gdLst>
              <a:gd name="connsiteX0" fmla="*/ 0 w 914400"/>
              <a:gd name="connsiteY0" fmla="*/ 590550 h 590550"/>
              <a:gd name="connsiteX1" fmla="*/ 44450 w 914400"/>
              <a:gd name="connsiteY1" fmla="*/ 330200 h 590550"/>
              <a:gd name="connsiteX2" fmla="*/ 209550 w 914400"/>
              <a:gd name="connsiteY2" fmla="*/ 120650 h 590550"/>
              <a:gd name="connsiteX3" fmla="*/ 361950 w 914400"/>
              <a:gd name="connsiteY3" fmla="*/ 0 h 590550"/>
              <a:gd name="connsiteX4" fmla="*/ 730250 w 914400"/>
              <a:gd name="connsiteY4" fmla="*/ 101600 h 590550"/>
              <a:gd name="connsiteX5" fmla="*/ 812800 w 914400"/>
              <a:gd name="connsiteY5" fmla="*/ 323850 h 590550"/>
              <a:gd name="connsiteX6" fmla="*/ 914400 w 914400"/>
              <a:gd name="connsiteY6" fmla="*/ 577850 h 590550"/>
              <a:gd name="connsiteX7" fmla="*/ 0 w 914400"/>
              <a:gd name="connsiteY7" fmla="*/ 590550 h 590550"/>
              <a:gd name="connsiteX0" fmla="*/ 0 w 914400"/>
              <a:gd name="connsiteY0" fmla="*/ 590691 h 590691"/>
              <a:gd name="connsiteX1" fmla="*/ 44450 w 914400"/>
              <a:gd name="connsiteY1" fmla="*/ 330341 h 590691"/>
              <a:gd name="connsiteX2" fmla="*/ 209550 w 914400"/>
              <a:gd name="connsiteY2" fmla="*/ 120791 h 590691"/>
              <a:gd name="connsiteX3" fmla="*/ 361950 w 914400"/>
              <a:gd name="connsiteY3" fmla="*/ 141 h 590691"/>
              <a:gd name="connsiteX4" fmla="*/ 730250 w 914400"/>
              <a:gd name="connsiteY4" fmla="*/ 101741 h 590691"/>
              <a:gd name="connsiteX5" fmla="*/ 812800 w 914400"/>
              <a:gd name="connsiteY5" fmla="*/ 323991 h 590691"/>
              <a:gd name="connsiteX6" fmla="*/ 914400 w 914400"/>
              <a:gd name="connsiteY6" fmla="*/ 577991 h 590691"/>
              <a:gd name="connsiteX7" fmla="*/ 0 w 914400"/>
              <a:gd name="connsiteY7" fmla="*/ 590691 h 590691"/>
              <a:gd name="connsiteX0" fmla="*/ 0 w 914400"/>
              <a:gd name="connsiteY0" fmla="*/ 590691 h 590691"/>
              <a:gd name="connsiteX1" fmla="*/ 44450 w 914400"/>
              <a:gd name="connsiteY1" fmla="*/ 330341 h 590691"/>
              <a:gd name="connsiteX2" fmla="*/ 209550 w 914400"/>
              <a:gd name="connsiteY2" fmla="*/ 120791 h 590691"/>
              <a:gd name="connsiteX3" fmla="*/ 361950 w 914400"/>
              <a:gd name="connsiteY3" fmla="*/ 141 h 590691"/>
              <a:gd name="connsiteX4" fmla="*/ 730250 w 914400"/>
              <a:gd name="connsiteY4" fmla="*/ 101741 h 590691"/>
              <a:gd name="connsiteX5" fmla="*/ 812800 w 914400"/>
              <a:gd name="connsiteY5" fmla="*/ 323991 h 590691"/>
              <a:gd name="connsiteX6" fmla="*/ 914400 w 914400"/>
              <a:gd name="connsiteY6" fmla="*/ 577991 h 590691"/>
              <a:gd name="connsiteX7" fmla="*/ 0 w 914400"/>
              <a:gd name="connsiteY7" fmla="*/ 590691 h 590691"/>
              <a:gd name="connsiteX0" fmla="*/ 0 w 914400"/>
              <a:gd name="connsiteY0" fmla="*/ 590694 h 590694"/>
              <a:gd name="connsiteX1" fmla="*/ 44450 w 914400"/>
              <a:gd name="connsiteY1" fmla="*/ 330344 h 590694"/>
              <a:gd name="connsiteX2" fmla="*/ 209550 w 914400"/>
              <a:gd name="connsiteY2" fmla="*/ 120794 h 590694"/>
              <a:gd name="connsiteX3" fmla="*/ 361950 w 914400"/>
              <a:gd name="connsiteY3" fmla="*/ 144 h 590694"/>
              <a:gd name="connsiteX4" fmla="*/ 730250 w 914400"/>
              <a:gd name="connsiteY4" fmla="*/ 101744 h 590694"/>
              <a:gd name="connsiteX5" fmla="*/ 850900 w 914400"/>
              <a:gd name="connsiteY5" fmla="*/ 330344 h 590694"/>
              <a:gd name="connsiteX6" fmla="*/ 914400 w 914400"/>
              <a:gd name="connsiteY6" fmla="*/ 577994 h 590694"/>
              <a:gd name="connsiteX7" fmla="*/ 0 w 914400"/>
              <a:gd name="connsiteY7" fmla="*/ 590694 h 590694"/>
              <a:gd name="connsiteX0" fmla="*/ 0 w 914400"/>
              <a:gd name="connsiteY0" fmla="*/ 590694 h 590694"/>
              <a:gd name="connsiteX1" fmla="*/ 44450 w 914400"/>
              <a:gd name="connsiteY1" fmla="*/ 330344 h 590694"/>
              <a:gd name="connsiteX2" fmla="*/ 209550 w 914400"/>
              <a:gd name="connsiteY2" fmla="*/ 120794 h 590694"/>
              <a:gd name="connsiteX3" fmla="*/ 361950 w 914400"/>
              <a:gd name="connsiteY3" fmla="*/ 144 h 590694"/>
              <a:gd name="connsiteX4" fmla="*/ 730250 w 914400"/>
              <a:gd name="connsiteY4" fmla="*/ 101744 h 590694"/>
              <a:gd name="connsiteX5" fmla="*/ 850900 w 914400"/>
              <a:gd name="connsiteY5" fmla="*/ 330344 h 590694"/>
              <a:gd name="connsiteX6" fmla="*/ 914400 w 914400"/>
              <a:gd name="connsiteY6" fmla="*/ 577994 h 590694"/>
              <a:gd name="connsiteX7" fmla="*/ 0 w 914400"/>
              <a:gd name="connsiteY7" fmla="*/ 590694 h 590694"/>
              <a:gd name="connsiteX0" fmla="*/ 0 w 914400"/>
              <a:gd name="connsiteY0" fmla="*/ 590694 h 590694"/>
              <a:gd name="connsiteX1" fmla="*/ 44450 w 914400"/>
              <a:gd name="connsiteY1" fmla="*/ 330344 h 590694"/>
              <a:gd name="connsiteX2" fmla="*/ 209550 w 914400"/>
              <a:gd name="connsiteY2" fmla="*/ 120794 h 590694"/>
              <a:gd name="connsiteX3" fmla="*/ 361950 w 914400"/>
              <a:gd name="connsiteY3" fmla="*/ 144 h 590694"/>
              <a:gd name="connsiteX4" fmla="*/ 730250 w 914400"/>
              <a:gd name="connsiteY4" fmla="*/ 101744 h 590694"/>
              <a:gd name="connsiteX5" fmla="*/ 850900 w 914400"/>
              <a:gd name="connsiteY5" fmla="*/ 330344 h 590694"/>
              <a:gd name="connsiteX6" fmla="*/ 914400 w 914400"/>
              <a:gd name="connsiteY6" fmla="*/ 577994 h 590694"/>
              <a:gd name="connsiteX7" fmla="*/ 0 w 914400"/>
              <a:gd name="connsiteY7" fmla="*/ 590694 h 590694"/>
              <a:gd name="connsiteX0" fmla="*/ 60980 w 975380"/>
              <a:gd name="connsiteY0" fmla="*/ 590694 h 590694"/>
              <a:gd name="connsiteX1" fmla="*/ 105430 w 975380"/>
              <a:gd name="connsiteY1" fmla="*/ 330344 h 590694"/>
              <a:gd name="connsiteX2" fmla="*/ 270530 w 975380"/>
              <a:gd name="connsiteY2" fmla="*/ 120794 h 590694"/>
              <a:gd name="connsiteX3" fmla="*/ 422930 w 975380"/>
              <a:gd name="connsiteY3" fmla="*/ 144 h 590694"/>
              <a:gd name="connsiteX4" fmla="*/ 791230 w 975380"/>
              <a:gd name="connsiteY4" fmla="*/ 101744 h 590694"/>
              <a:gd name="connsiteX5" fmla="*/ 911880 w 975380"/>
              <a:gd name="connsiteY5" fmla="*/ 330344 h 590694"/>
              <a:gd name="connsiteX6" fmla="*/ 975380 w 975380"/>
              <a:gd name="connsiteY6" fmla="*/ 577994 h 590694"/>
              <a:gd name="connsiteX7" fmla="*/ 60980 w 975380"/>
              <a:gd name="connsiteY7" fmla="*/ 590694 h 590694"/>
              <a:gd name="connsiteX0" fmla="*/ 60980 w 975380"/>
              <a:gd name="connsiteY0" fmla="*/ 590694 h 616688"/>
              <a:gd name="connsiteX1" fmla="*/ 105430 w 975380"/>
              <a:gd name="connsiteY1" fmla="*/ 330344 h 616688"/>
              <a:gd name="connsiteX2" fmla="*/ 270530 w 975380"/>
              <a:gd name="connsiteY2" fmla="*/ 120794 h 616688"/>
              <a:gd name="connsiteX3" fmla="*/ 422930 w 975380"/>
              <a:gd name="connsiteY3" fmla="*/ 144 h 616688"/>
              <a:gd name="connsiteX4" fmla="*/ 791230 w 975380"/>
              <a:gd name="connsiteY4" fmla="*/ 101744 h 616688"/>
              <a:gd name="connsiteX5" fmla="*/ 911880 w 975380"/>
              <a:gd name="connsiteY5" fmla="*/ 330344 h 616688"/>
              <a:gd name="connsiteX6" fmla="*/ 975380 w 975380"/>
              <a:gd name="connsiteY6" fmla="*/ 577994 h 616688"/>
              <a:gd name="connsiteX7" fmla="*/ 60980 w 975380"/>
              <a:gd name="connsiteY7" fmla="*/ 590694 h 616688"/>
              <a:gd name="connsiteX0" fmla="*/ 80378 w 918578"/>
              <a:gd name="connsiteY0" fmla="*/ 635144 h 649729"/>
              <a:gd name="connsiteX1" fmla="*/ 48628 w 918578"/>
              <a:gd name="connsiteY1" fmla="*/ 330344 h 649729"/>
              <a:gd name="connsiteX2" fmla="*/ 213728 w 918578"/>
              <a:gd name="connsiteY2" fmla="*/ 120794 h 649729"/>
              <a:gd name="connsiteX3" fmla="*/ 366128 w 918578"/>
              <a:gd name="connsiteY3" fmla="*/ 144 h 649729"/>
              <a:gd name="connsiteX4" fmla="*/ 734428 w 918578"/>
              <a:gd name="connsiteY4" fmla="*/ 101744 h 649729"/>
              <a:gd name="connsiteX5" fmla="*/ 855078 w 918578"/>
              <a:gd name="connsiteY5" fmla="*/ 330344 h 649729"/>
              <a:gd name="connsiteX6" fmla="*/ 918578 w 918578"/>
              <a:gd name="connsiteY6" fmla="*/ 577994 h 649729"/>
              <a:gd name="connsiteX7" fmla="*/ 80378 w 918578"/>
              <a:gd name="connsiteY7" fmla="*/ 635144 h 649729"/>
              <a:gd name="connsiteX0" fmla="*/ 80378 w 918578"/>
              <a:gd name="connsiteY0" fmla="*/ 584344 h 613042"/>
              <a:gd name="connsiteX1" fmla="*/ 48628 w 918578"/>
              <a:gd name="connsiteY1" fmla="*/ 330344 h 613042"/>
              <a:gd name="connsiteX2" fmla="*/ 213728 w 918578"/>
              <a:gd name="connsiteY2" fmla="*/ 120794 h 613042"/>
              <a:gd name="connsiteX3" fmla="*/ 366128 w 918578"/>
              <a:gd name="connsiteY3" fmla="*/ 144 h 613042"/>
              <a:gd name="connsiteX4" fmla="*/ 734428 w 918578"/>
              <a:gd name="connsiteY4" fmla="*/ 101744 h 613042"/>
              <a:gd name="connsiteX5" fmla="*/ 855078 w 918578"/>
              <a:gd name="connsiteY5" fmla="*/ 330344 h 613042"/>
              <a:gd name="connsiteX6" fmla="*/ 918578 w 918578"/>
              <a:gd name="connsiteY6" fmla="*/ 577994 h 613042"/>
              <a:gd name="connsiteX7" fmla="*/ 80378 w 918578"/>
              <a:gd name="connsiteY7" fmla="*/ 584344 h 613042"/>
              <a:gd name="connsiteX0" fmla="*/ 80378 w 919038"/>
              <a:gd name="connsiteY0" fmla="*/ 584344 h 628201"/>
              <a:gd name="connsiteX1" fmla="*/ 48628 w 919038"/>
              <a:gd name="connsiteY1" fmla="*/ 330344 h 628201"/>
              <a:gd name="connsiteX2" fmla="*/ 213728 w 919038"/>
              <a:gd name="connsiteY2" fmla="*/ 120794 h 628201"/>
              <a:gd name="connsiteX3" fmla="*/ 366128 w 919038"/>
              <a:gd name="connsiteY3" fmla="*/ 144 h 628201"/>
              <a:gd name="connsiteX4" fmla="*/ 734428 w 919038"/>
              <a:gd name="connsiteY4" fmla="*/ 101744 h 628201"/>
              <a:gd name="connsiteX5" fmla="*/ 855078 w 919038"/>
              <a:gd name="connsiteY5" fmla="*/ 330344 h 628201"/>
              <a:gd name="connsiteX6" fmla="*/ 918578 w 919038"/>
              <a:gd name="connsiteY6" fmla="*/ 577994 h 628201"/>
              <a:gd name="connsiteX7" fmla="*/ 80378 w 919038"/>
              <a:gd name="connsiteY7" fmla="*/ 584344 h 628201"/>
              <a:gd name="connsiteX0" fmla="*/ 76368 w 861839"/>
              <a:gd name="connsiteY0" fmla="*/ 584344 h 616919"/>
              <a:gd name="connsiteX1" fmla="*/ 44618 w 861839"/>
              <a:gd name="connsiteY1" fmla="*/ 330344 h 616919"/>
              <a:gd name="connsiteX2" fmla="*/ 209718 w 861839"/>
              <a:gd name="connsiteY2" fmla="*/ 120794 h 616919"/>
              <a:gd name="connsiteX3" fmla="*/ 362118 w 861839"/>
              <a:gd name="connsiteY3" fmla="*/ 144 h 616919"/>
              <a:gd name="connsiteX4" fmla="*/ 730418 w 861839"/>
              <a:gd name="connsiteY4" fmla="*/ 101744 h 616919"/>
              <a:gd name="connsiteX5" fmla="*/ 851068 w 861839"/>
              <a:gd name="connsiteY5" fmla="*/ 330344 h 616919"/>
              <a:gd name="connsiteX6" fmla="*/ 857418 w 861839"/>
              <a:gd name="connsiteY6" fmla="*/ 558944 h 616919"/>
              <a:gd name="connsiteX7" fmla="*/ 76368 w 861839"/>
              <a:gd name="connsiteY7" fmla="*/ 584344 h 616919"/>
              <a:gd name="connsiteX0" fmla="*/ 76368 w 861839"/>
              <a:gd name="connsiteY0" fmla="*/ 578011 h 610586"/>
              <a:gd name="connsiteX1" fmla="*/ 44618 w 861839"/>
              <a:gd name="connsiteY1" fmla="*/ 324011 h 610586"/>
              <a:gd name="connsiteX2" fmla="*/ 209718 w 861839"/>
              <a:gd name="connsiteY2" fmla="*/ 114461 h 610586"/>
              <a:gd name="connsiteX3" fmla="*/ 400218 w 861839"/>
              <a:gd name="connsiteY3" fmla="*/ 161 h 610586"/>
              <a:gd name="connsiteX4" fmla="*/ 730418 w 861839"/>
              <a:gd name="connsiteY4" fmla="*/ 95411 h 610586"/>
              <a:gd name="connsiteX5" fmla="*/ 851068 w 861839"/>
              <a:gd name="connsiteY5" fmla="*/ 324011 h 610586"/>
              <a:gd name="connsiteX6" fmla="*/ 857418 w 861839"/>
              <a:gd name="connsiteY6" fmla="*/ 552611 h 610586"/>
              <a:gd name="connsiteX7" fmla="*/ 76368 w 861839"/>
              <a:gd name="connsiteY7" fmla="*/ 578011 h 610586"/>
              <a:gd name="connsiteX0" fmla="*/ 72787 w 858258"/>
              <a:gd name="connsiteY0" fmla="*/ 577870 h 610445"/>
              <a:gd name="connsiteX1" fmla="*/ 41037 w 858258"/>
              <a:gd name="connsiteY1" fmla="*/ 323870 h 610445"/>
              <a:gd name="connsiteX2" fmla="*/ 136287 w 858258"/>
              <a:gd name="connsiteY2" fmla="*/ 101620 h 610445"/>
              <a:gd name="connsiteX3" fmla="*/ 396637 w 858258"/>
              <a:gd name="connsiteY3" fmla="*/ 20 h 610445"/>
              <a:gd name="connsiteX4" fmla="*/ 726837 w 858258"/>
              <a:gd name="connsiteY4" fmla="*/ 95270 h 610445"/>
              <a:gd name="connsiteX5" fmla="*/ 847487 w 858258"/>
              <a:gd name="connsiteY5" fmla="*/ 323870 h 610445"/>
              <a:gd name="connsiteX6" fmla="*/ 853837 w 858258"/>
              <a:gd name="connsiteY6" fmla="*/ 552470 h 610445"/>
              <a:gd name="connsiteX7" fmla="*/ 72787 w 858258"/>
              <a:gd name="connsiteY7" fmla="*/ 577870 h 610445"/>
              <a:gd name="connsiteX0" fmla="*/ 72787 w 860103"/>
              <a:gd name="connsiteY0" fmla="*/ 577991 h 610566"/>
              <a:gd name="connsiteX1" fmla="*/ 41037 w 860103"/>
              <a:gd name="connsiteY1" fmla="*/ 323991 h 610566"/>
              <a:gd name="connsiteX2" fmla="*/ 136287 w 860103"/>
              <a:gd name="connsiteY2" fmla="*/ 101741 h 610566"/>
              <a:gd name="connsiteX3" fmla="*/ 396637 w 860103"/>
              <a:gd name="connsiteY3" fmla="*/ 141 h 610566"/>
              <a:gd name="connsiteX4" fmla="*/ 701437 w 860103"/>
              <a:gd name="connsiteY4" fmla="*/ 120791 h 610566"/>
              <a:gd name="connsiteX5" fmla="*/ 847487 w 860103"/>
              <a:gd name="connsiteY5" fmla="*/ 323991 h 610566"/>
              <a:gd name="connsiteX6" fmla="*/ 853837 w 860103"/>
              <a:gd name="connsiteY6" fmla="*/ 552591 h 610566"/>
              <a:gd name="connsiteX7" fmla="*/ 72787 w 860103"/>
              <a:gd name="connsiteY7" fmla="*/ 577991 h 610566"/>
              <a:gd name="connsiteX0" fmla="*/ 72787 w 895070"/>
              <a:gd name="connsiteY0" fmla="*/ 577991 h 596838"/>
              <a:gd name="connsiteX1" fmla="*/ 41037 w 895070"/>
              <a:gd name="connsiteY1" fmla="*/ 323991 h 596838"/>
              <a:gd name="connsiteX2" fmla="*/ 136287 w 895070"/>
              <a:gd name="connsiteY2" fmla="*/ 101741 h 596838"/>
              <a:gd name="connsiteX3" fmla="*/ 396637 w 895070"/>
              <a:gd name="connsiteY3" fmla="*/ 141 h 596838"/>
              <a:gd name="connsiteX4" fmla="*/ 701437 w 895070"/>
              <a:gd name="connsiteY4" fmla="*/ 120791 h 596838"/>
              <a:gd name="connsiteX5" fmla="*/ 777637 w 895070"/>
              <a:gd name="connsiteY5" fmla="*/ 349391 h 596838"/>
              <a:gd name="connsiteX6" fmla="*/ 853837 w 895070"/>
              <a:gd name="connsiteY6" fmla="*/ 552591 h 596838"/>
              <a:gd name="connsiteX7" fmla="*/ 72787 w 895070"/>
              <a:gd name="connsiteY7" fmla="*/ 577991 h 596838"/>
              <a:gd name="connsiteX0" fmla="*/ 72787 w 917761"/>
              <a:gd name="connsiteY0" fmla="*/ 577991 h 596343"/>
              <a:gd name="connsiteX1" fmla="*/ 41037 w 917761"/>
              <a:gd name="connsiteY1" fmla="*/ 323991 h 596343"/>
              <a:gd name="connsiteX2" fmla="*/ 136287 w 917761"/>
              <a:gd name="connsiteY2" fmla="*/ 101741 h 596343"/>
              <a:gd name="connsiteX3" fmla="*/ 396637 w 917761"/>
              <a:gd name="connsiteY3" fmla="*/ 141 h 596343"/>
              <a:gd name="connsiteX4" fmla="*/ 701437 w 917761"/>
              <a:gd name="connsiteY4" fmla="*/ 120791 h 596343"/>
              <a:gd name="connsiteX5" fmla="*/ 853837 w 917761"/>
              <a:gd name="connsiteY5" fmla="*/ 362091 h 596343"/>
              <a:gd name="connsiteX6" fmla="*/ 853837 w 917761"/>
              <a:gd name="connsiteY6" fmla="*/ 552591 h 596343"/>
              <a:gd name="connsiteX7" fmla="*/ 72787 w 917761"/>
              <a:gd name="connsiteY7" fmla="*/ 577991 h 596343"/>
              <a:gd name="connsiteX0" fmla="*/ 75506 w 949897"/>
              <a:gd name="connsiteY0" fmla="*/ 577991 h 598659"/>
              <a:gd name="connsiteX1" fmla="*/ 43756 w 949897"/>
              <a:gd name="connsiteY1" fmla="*/ 323991 h 598659"/>
              <a:gd name="connsiteX2" fmla="*/ 139006 w 949897"/>
              <a:gd name="connsiteY2" fmla="*/ 101741 h 598659"/>
              <a:gd name="connsiteX3" fmla="*/ 399356 w 949897"/>
              <a:gd name="connsiteY3" fmla="*/ 141 h 598659"/>
              <a:gd name="connsiteX4" fmla="*/ 704156 w 949897"/>
              <a:gd name="connsiteY4" fmla="*/ 120791 h 598659"/>
              <a:gd name="connsiteX5" fmla="*/ 856556 w 949897"/>
              <a:gd name="connsiteY5" fmla="*/ 362091 h 598659"/>
              <a:gd name="connsiteX6" fmla="*/ 894656 w 949897"/>
              <a:gd name="connsiteY6" fmla="*/ 558941 h 598659"/>
              <a:gd name="connsiteX7" fmla="*/ 75506 w 949897"/>
              <a:gd name="connsiteY7" fmla="*/ 577991 h 598659"/>
              <a:gd name="connsiteX0" fmla="*/ 75506 w 958289"/>
              <a:gd name="connsiteY0" fmla="*/ 577991 h 598659"/>
              <a:gd name="connsiteX1" fmla="*/ 43756 w 958289"/>
              <a:gd name="connsiteY1" fmla="*/ 323991 h 598659"/>
              <a:gd name="connsiteX2" fmla="*/ 139006 w 958289"/>
              <a:gd name="connsiteY2" fmla="*/ 101741 h 598659"/>
              <a:gd name="connsiteX3" fmla="*/ 399356 w 958289"/>
              <a:gd name="connsiteY3" fmla="*/ 141 h 598659"/>
              <a:gd name="connsiteX4" fmla="*/ 704156 w 958289"/>
              <a:gd name="connsiteY4" fmla="*/ 120791 h 598659"/>
              <a:gd name="connsiteX5" fmla="*/ 881956 w 958289"/>
              <a:gd name="connsiteY5" fmla="*/ 362091 h 598659"/>
              <a:gd name="connsiteX6" fmla="*/ 894656 w 958289"/>
              <a:gd name="connsiteY6" fmla="*/ 558941 h 598659"/>
              <a:gd name="connsiteX7" fmla="*/ 75506 w 958289"/>
              <a:gd name="connsiteY7" fmla="*/ 577991 h 598659"/>
              <a:gd name="connsiteX0" fmla="*/ 75506 w 958289"/>
              <a:gd name="connsiteY0" fmla="*/ 571657 h 592325"/>
              <a:gd name="connsiteX1" fmla="*/ 43756 w 958289"/>
              <a:gd name="connsiteY1" fmla="*/ 317657 h 592325"/>
              <a:gd name="connsiteX2" fmla="*/ 139006 w 958289"/>
              <a:gd name="connsiteY2" fmla="*/ 95407 h 592325"/>
              <a:gd name="connsiteX3" fmla="*/ 462856 w 958289"/>
              <a:gd name="connsiteY3" fmla="*/ 157 h 592325"/>
              <a:gd name="connsiteX4" fmla="*/ 704156 w 958289"/>
              <a:gd name="connsiteY4" fmla="*/ 114457 h 592325"/>
              <a:gd name="connsiteX5" fmla="*/ 881956 w 958289"/>
              <a:gd name="connsiteY5" fmla="*/ 355757 h 592325"/>
              <a:gd name="connsiteX6" fmla="*/ 894656 w 958289"/>
              <a:gd name="connsiteY6" fmla="*/ 552607 h 592325"/>
              <a:gd name="connsiteX7" fmla="*/ 75506 w 958289"/>
              <a:gd name="connsiteY7" fmla="*/ 571657 h 592325"/>
              <a:gd name="connsiteX0" fmla="*/ 77088 w 959871"/>
              <a:gd name="connsiteY0" fmla="*/ 571564 h 592232"/>
              <a:gd name="connsiteX1" fmla="*/ 45338 w 959871"/>
              <a:gd name="connsiteY1" fmla="*/ 317564 h 592232"/>
              <a:gd name="connsiteX2" fmla="*/ 172338 w 959871"/>
              <a:gd name="connsiteY2" fmla="*/ 101664 h 592232"/>
              <a:gd name="connsiteX3" fmla="*/ 464438 w 959871"/>
              <a:gd name="connsiteY3" fmla="*/ 64 h 592232"/>
              <a:gd name="connsiteX4" fmla="*/ 705738 w 959871"/>
              <a:gd name="connsiteY4" fmla="*/ 114364 h 592232"/>
              <a:gd name="connsiteX5" fmla="*/ 883538 w 959871"/>
              <a:gd name="connsiteY5" fmla="*/ 355664 h 592232"/>
              <a:gd name="connsiteX6" fmla="*/ 896238 w 959871"/>
              <a:gd name="connsiteY6" fmla="*/ 552514 h 592232"/>
              <a:gd name="connsiteX7" fmla="*/ 77088 w 959871"/>
              <a:gd name="connsiteY7" fmla="*/ 571564 h 592232"/>
              <a:gd name="connsiteX0" fmla="*/ 31750 w 914533"/>
              <a:gd name="connsiteY0" fmla="*/ 571564 h 592232"/>
              <a:gd name="connsiteX1" fmla="*/ 0 w 914533"/>
              <a:gd name="connsiteY1" fmla="*/ 317564 h 592232"/>
              <a:gd name="connsiteX2" fmla="*/ 127000 w 914533"/>
              <a:gd name="connsiteY2" fmla="*/ 101664 h 592232"/>
              <a:gd name="connsiteX3" fmla="*/ 419100 w 914533"/>
              <a:gd name="connsiteY3" fmla="*/ 64 h 592232"/>
              <a:gd name="connsiteX4" fmla="*/ 660400 w 914533"/>
              <a:gd name="connsiteY4" fmla="*/ 114364 h 592232"/>
              <a:gd name="connsiteX5" fmla="*/ 838200 w 914533"/>
              <a:gd name="connsiteY5" fmla="*/ 355664 h 592232"/>
              <a:gd name="connsiteX6" fmla="*/ 850900 w 914533"/>
              <a:gd name="connsiteY6" fmla="*/ 552514 h 592232"/>
              <a:gd name="connsiteX7" fmla="*/ 31750 w 914533"/>
              <a:gd name="connsiteY7" fmla="*/ 571564 h 592232"/>
              <a:gd name="connsiteX0" fmla="*/ 77088 w 959871"/>
              <a:gd name="connsiteY0" fmla="*/ 571564 h 592232"/>
              <a:gd name="connsiteX1" fmla="*/ 45338 w 959871"/>
              <a:gd name="connsiteY1" fmla="*/ 317564 h 592232"/>
              <a:gd name="connsiteX2" fmla="*/ 172338 w 959871"/>
              <a:gd name="connsiteY2" fmla="*/ 101664 h 592232"/>
              <a:gd name="connsiteX3" fmla="*/ 464438 w 959871"/>
              <a:gd name="connsiteY3" fmla="*/ 64 h 592232"/>
              <a:gd name="connsiteX4" fmla="*/ 705738 w 959871"/>
              <a:gd name="connsiteY4" fmla="*/ 114364 h 592232"/>
              <a:gd name="connsiteX5" fmla="*/ 883538 w 959871"/>
              <a:gd name="connsiteY5" fmla="*/ 355664 h 592232"/>
              <a:gd name="connsiteX6" fmla="*/ 896238 w 959871"/>
              <a:gd name="connsiteY6" fmla="*/ 552514 h 592232"/>
              <a:gd name="connsiteX7" fmla="*/ 77088 w 959871"/>
              <a:gd name="connsiteY7" fmla="*/ 571564 h 592232"/>
              <a:gd name="connsiteX0" fmla="*/ 77088 w 959871"/>
              <a:gd name="connsiteY0" fmla="*/ 571564 h 571564"/>
              <a:gd name="connsiteX1" fmla="*/ 45338 w 959871"/>
              <a:gd name="connsiteY1" fmla="*/ 317564 h 571564"/>
              <a:gd name="connsiteX2" fmla="*/ 172338 w 959871"/>
              <a:gd name="connsiteY2" fmla="*/ 101664 h 571564"/>
              <a:gd name="connsiteX3" fmla="*/ 464438 w 959871"/>
              <a:gd name="connsiteY3" fmla="*/ 64 h 571564"/>
              <a:gd name="connsiteX4" fmla="*/ 705738 w 959871"/>
              <a:gd name="connsiteY4" fmla="*/ 114364 h 571564"/>
              <a:gd name="connsiteX5" fmla="*/ 883538 w 959871"/>
              <a:gd name="connsiteY5" fmla="*/ 355664 h 571564"/>
              <a:gd name="connsiteX6" fmla="*/ 896238 w 959871"/>
              <a:gd name="connsiteY6" fmla="*/ 552514 h 571564"/>
              <a:gd name="connsiteX7" fmla="*/ 77088 w 959871"/>
              <a:gd name="connsiteY7" fmla="*/ 571564 h 571564"/>
              <a:gd name="connsiteX0" fmla="*/ 76704 w 955639"/>
              <a:gd name="connsiteY0" fmla="*/ 571564 h 592606"/>
              <a:gd name="connsiteX1" fmla="*/ 44954 w 955639"/>
              <a:gd name="connsiteY1" fmla="*/ 317564 h 592606"/>
              <a:gd name="connsiteX2" fmla="*/ 171954 w 955639"/>
              <a:gd name="connsiteY2" fmla="*/ 101664 h 592606"/>
              <a:gd name="connsiteX3" fmla="*/ 464054 w 955639"/>
              <a:gd name="connsiteY3" fmla="*/ 64 h 592606"/>
              <a:gd name="connsiteX4" fmla="*/ 705354 w 955639"/>
              <a:gd name="connsiteY4" fmla="*/ 114364 h 592606"/>
              <a:gd name="connsiteX5" fmla="*/ 883154 w 955639"/>
              <a:gd name="connsiteY5" fmla="*/ 355664 h 592606"/>
              <a:gd name="connsiteX6" fmla="*/ 890431 w 955639"/>
              <a:gd name="connsiteY6" fmla="*/ 579629 h 592606"/>
              <a:gd name="connsiteX7" fmla="*/ 76704 w 955639"/>
              <a:gd name="connsiteY7" fmla="*/ 571564 h 592606"/>
              <a:gd name="connsiteX0" fmla="*/ 78243 w 972971"/>
              <a:gd name="connsiteY0" fmla="*/ 571564 h 597283"/>
              <a:gd name="connsiteX1" fmla="*/ 46493 w 972971"/>
              <a:gd name="connsiteY1" fmla="*/ 317564 h 597283"/>
              <a:gd name="connsiteX2" fmla="*/ 173493 w 972971"/>
              <a:gd name="connsiteY2" fmla="*/ 101664 h 597283"/>
              <a:gd name="connsiteX3" fmla="*/ 465593 w 972971"/>
              <a:gd name="connsiteY3" fmla="*/ 64 h 597283"/>
              <a:gd name="connsiteX4" fmla="*/ 706893 w 972971"/>
              <a:gd name="connsiteY4" fmla="*/ 114364 h 597283"/>
              <a:gd name="connsiteX5" fmla="*/ 884693 w 972971"/>
              <a:gd name="connsiteY5" fmla="*/ 355664 h 597283"/>
              <a:gd name="connsiteX6" fmla="*/ 913662 w 972971"/>
              <a:gd name="connsiteY6" fmla="*/ 590475 h 597283"/>
              <a:gd name="connsiteX7" fmla="*/ 78243 w 972971"/>
              <a:gd name="connsiteY7" fmla="*/ 571564 h 597283"/>
              <a:gd name="connsiteX0" fmla="*/ 78243 w 972971"/>
              <a:gd name="connsiteY0" fmla="*/ 571564 h 590475"/>
              <a:gd name="connsiteX1" fmla="*/ 46493 w 972971"/>
              <a:gd name="connsiteY1" fmla="*/ 317564 h 590475"/>
              <a:gd name="connsiteX2" fmla="*/ 173493 w 972971"/>
              <a:gd name="connsiteY2" fmla="*/ 101664 h 590475"/>
              <a:gd name="connsiteX3" fmla="*/ 465593 w 972971"/>
              <a:gd name="connsiteY3" fmla="*/ 64 h 590475"/>
              <a:gd name="connsiteX4" fmla="*/ 706893 w 972971"/>
              <a:gd name="connsiteY4" fmla="*/ 114364 h 590475"/>
              <a:gd name="connsiteX5" fmla="*/ 884693 w 972971"/>
              <a:gd name="connsiteY5" fmla="*/ 355664 h 590475"/>
              <a:gd name="connsiteX6" fmla="*/ 913662 w 972971"/>
              <a:gd name="connsiteY6" fmla="*/ 590475 h 590475"/>
              <a:gd name="connsiteX7" fmla="*/ 78243 w 972971"/>
              <a:gd name="connsiteY7" fmla="*/ 571564 h 590475"/>
              <a:gd name="connsiteX0" fmla="*/ 71834 w 989860"/>
              <a:gd name="connsiteY0" fmla="*/ 593256 h 608606"/>
              <a:gd name="connsiteX1" fmla="*/ 61776 w 989860"/>
              <a:gd name="connsiteY1" fmla="*/ 317564 h 608606"/>
              <a:gd name="connsiteX2" fmla="*/ 188776 w 989860"/>
              <a:gd name="connsiteY2" fmla="*/ 101664 h 608606"/>
              <a:gd name="connsiteX3" fmla="*/ 480876 w 989860"/>
              <a:gd name="connsiteY3" fmla="*/ 64 h 608606"/>
              <a:gd name="connsiteX4" fmla="*/ 722176 w 989860"/>
              <a:gd name="connsiteY4" fmla="*/ 114364 h 608606"/>
              <a:gd name="connsiteX5" fmla="*/ 899976 w 989860"/>
              <a:gd name="connsiteY5" fmla="*/ 355664 h 608606"/>
              <a:gd name="connsiteX6" fmla="*/ 928945 w 989860"/>
              <a:gd name="connsiteY6" fmla="*/ 590475 h 608606"/>
              <a:gd name="connsiteX7" fmla="*/ 71834 w 989860"/>
              <a:gd name="connsiteY7" fmla="*/ 593256 h 60860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989860" h="608606">
                <a:moveTo>
                  <a:pt x="71834" y="593256"/>
                </a:moveTo>
                <a:cubicBezTo>
                  <a:pt x="-72694" y="547771"/>
                  <a:pt x="42286" y="399496"/>
                  <a:pt x="61776" y="317564"/>
                </a:cubicBezTo>
                <a:cubicBezTo>
                  <a:pt x="81266" y="235632"/>
                  <a:pt x="118926" y="154581"/>
                  <a:pt x="188776" y="101664"/>
                </a:cubicBezTo>
                <a:cubicBezTo>
                  <a:pt x="258626" y="48747"/>
                  <a:pt x="391976" y="-2053"/>
                  <a:pt x="480876" y="64"/>
                </a:cubicBezTo>
                <a:cubicBezTo>
                  <a:pt x="569776" y="2181"/>
                  <a:pt x="652326" y="55097"/>
                  <a:pt x="722176" y="114364"/>
                </a:cubicBezTo>
                <a:cubicBezTo>
                  <a:pt x="792026" y="173631"/>
                  <a:pt x="868226" y="282639"/>
                  <a:pt x="899976" y="355664"/>
                </a:cubicBezTo>
                <a:cubicBezTo>
                  <a:pt x="931726" y="428689"/>
                  <a:pt x="1066969" y="550876"/>
                  <a:pt x="928945" y="590475"/>
                </a:cubicBezTo>
                <a:cubicBezTo>
                  <a:pt x="790921" y="630074"/>
                  <a:pt x="357538" y="592329"/>
                  <a:pt x="71834" y="593256"/>
                </a:cubicBezTo>
                <a:close/>
              </a:path>
            </a:pathLst>
          </a:custGeom>
          <a:solidFill>
            <a:srgbClr val="00CC00"/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ko-KR" altLang="en-US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/>
              <a:ea typeface="맑은 고딕"/>
              <a:cs typeface="+mn-cs"/>
            </a:endParaRPr>
          </a:p>
        </p:txBody>
      </p:sp>
      <p:sp>
        <p:nvSpPr>
          <p:cNvPr id="59" name="직사각형 58">
            <a:extLst>
              <a:ext uri="{FF2B5EF4-FFF2-40B4-BE49-F238E27FC236}">
                <a16:creationId xmlns:a16="http://schemas.microsoft.com/office/drawing/2014/main" id="{ABD708CB-E608-4610-9AC4-24C733D97AA1}"/>
              </a:ext>
            </a:extLst>
          </p:cNvPr>
          <p:cNvSpPr/>
          <p:nvPr/>
        </p:nvSpPr>
        <p:spPr>
          <a:xfrm>
            <a:off x="2351654" y="1608650"/>
            <a:ext cx="1493471" cy="98848"/>
          </a:xfrm>
          <a:prstGeom prst="rect">
            <a:avLst/>
          </a:prstGeom>
          <a:solidFill>
            <a:srgbClr val="3A4858">
              <a:lumMod val="20000"/>
              <a:lumOff val="80000"/>
            </a:srgbClr>
          </a:soli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ko-KR" altLang="en-US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/>
              <a:ea typeface="맑은 고딕"/>
              <a:cs typeface="+mn-cs"/>
            </a:endParaRPr>
          </a:p>
        </p:txBody>
      </p:sp>
      <p:grpSp>
        <p:nvGrpSpPr>
          <p:cNvPr id="60" name="그룹 59">
            <a:extLst>
              <a:ext uri="{FF2B5EF4-FFF2-40B4-BE49-F238E27FC236}">
                <a16:creationId xmlns:a16="http://schemas.microsoft.com/office/drawing/2014/main" id="{BEDB9DF9-3B83-4AB0-B368-9BCAA0B5F340}"/>
              </a:ext>
            </a:extLst>
          </p:cNvPr>
          <p:cNvGrpSpPr/>
          <p:nvPr/>
        </p:nvGrpSpPr>
        <p:grpSpPr>
          <a:xfrm rot="10800000">
            <a:off x="2694654" y="1402071"/>
            <a:ext cx="70913" cy="48223"/>
            <a:chOff x="9017763" y="2551103"/>
            <a:chExt cx="116646" cy="79323"/>
          </a:xfrm>
        </p:grpSpPr>
        <p:sp>
          <p:nvSpPr>
            <p:cNvPr id="172" name="타원 171">
              <a:extLst>
                <a:ext uri="{FF2B5EF4-FFF2-40B4-BE49-F238E27FC236}">
                  <a16:creationId xmlns:a16="http://schemas.microsoft.com/office/drawing/2014/main" id="{2A4FE676-69F9-4011-9A14-9120F31BD9DD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73" name="타원 172">
              <a:extLst>
                <a:ext uri="{FF2B5EF4-FFF2-40B4-BE49-F238E27FC236}">
                  <a16:creationId xmlns:a16="http://schemas.microsoft.com/office/drawing/2014/main" id="{9B6A5C8D-84A3-4863-8166-D65AFAFD2A77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61" name="그룹 60">
            <a:extLst>
              <a:ext uri="{FF2B5EF4-FFF2-40B4-BE49-F238E27FC236}">
                <a16:creationId xmlns:a16="http://schemas.microsoft.com/office/drawing/2014/main" id="{7BE605AB-5DD5-4197-AA2E-CB5E242470D9}"/>
              </a:ext>
            </a:extLst>
          </p:cNvPr>
          <p:cNvGrpSpPr/>
          <p:nvPr/>
        </p:nvGrpSpPr>
        <p:grpSpPr>
          <a:xfrm rot="10800000">
            <a:off x="3502621" y="1343390"/>
            <a:ext cx="70913" cy="48223"/>
            <a:chOff x="9017763" y="2551103"/>
            <a:chExt cx="116646" cy="79323"/>
          </a:xfrm>
        </p:grpSpPr>
        <p:sp>
          <p:nvSpPr>
            <p:cNvPr id="170" name="타원 169">
              <a:extLst>
                <a:ext uri="{FF2B5EF4-FFF2-40B4-BE49-F238E27FC236}">
                  <a16:creationId xmlns:a16="http://schemas.microsoft.com/office/drawing/2014/main" id="{2F74ABF4-7DF2-481C-A7FE-34DFF15C5EB9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71" name="타원 170">
              <a:extLst>
                <a:ext uri="{FF2B5EF4-FFF2-40B4-BE49-F238E27FC236}">
                  <a16:creationId xmlns:a16="http://schemas.microsoft.com/office/drawing/2014/main" id="{7CAC4877-8D1A-40B4-A430-EDDF6B104251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62" name="그룹 61">
            <a:extLst>
              <a:ext uri="{FF2B5EF4-FFF2-40B4-BE49-F238E27FC236}">
                <a16:creationId xmlns:a16="http://schemas.microsoft.com/office/drawing/2014/main" id="{376C259B-1865-4EF8-BCAF-3CEEC0506EB2}"/>
              </a:ext>
            </a:extLst>
          </p:cNvPr>
          <p:cNvGrpSpPr/>
          <p:nvPr/>
        </p:nvGrpSpPr>
        <p:grpSpPr>
          <a:xfrm rot="10800000">
            <a:off x="2565945" y="1309910"/>
            <a:ext cx="70913" cy="48223"/>
            <a:chOff x="9017763" y="2551103"/>
            <a:chExt cx="116646" cy="79323"/>
          </a:xfrm>
        </p:grpSpPr>
        <p:sp>
          <p:nvSpPr>
            <p:cNvPr id="168" name="타원 167">
              <a:extLst>
                <a:ext uri="{FF2B5EF4-FFF2-40B4-BE49-F238E27FC236}">
                  <a16:creationId xmlns:a16="http://schemas.microsoft.com/office/drawing/2014/main" id="{A2A7E629-4B62-4C82-9358-C69F0EB89763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69" name="타원 168">
              <a:extLst>
                <a:ext uri="{FF2B5EF4-FFF2-40B4-BE49-F238E27FC236}">
                  <a16:creationId xmlns:a16="http://schemas.microsoft.com/office/drawing/2014/main" id="{FCF551DC-8307-4D53-A685-10EF7AB3F348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63" name="그룹 62">
            <a:extLst>
              <a:ext uri="{FF2B5EF4-FFF2-40B4-BE49-F238E27FC236}">
                <a16:creationId xmlns:a16="http://schemas.microsoft.com/office/drawing/2014/main" id="{B25BA9B3-BD3E-484C-B329-5048DEA92F6D}"/>
              </a:ext>
            </a:extLst>
          </p:cNvPr>
          <p:cNvGrpSpPr/>
          <p:nvPr/>
        </p:nvGrpSpPr>
        <p:grpSpPr>
          <a:xfrm rot="10800000">
            <a:off x="3577988" y="1495471"/>
            <a:ext cx="70913" cy="48223"/>
            <a:chOff x="9017763" y="2551103"/>
            <a:chExt cx="116646" cy="79323"/>
          </a:xfrm>
        </p:grpSpPr>
        <p:sp>
          <p:nvSpPr>
            <p:cNvPr id="166" name="타원 165">
              <a:extLst>
                <a:ext uri="{FF2B5EF4-FFF2-40B4-BE49-F238E27FC236}">
                  <a16:creationId xmlns:a16="http://schemas.microsoft.com/office/drawing/2014/main" id="{07D7A4E4-4652-4284-9F5F-7BED6E21FB9F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67" name="타원 166">
              <a:extLst>
                <a:ext uri="{FF2B5EF4-FFF2-40B4-BE49-F238E27FC236}">
                  <a16:creationId xmlns:a16="http://schemas.microsoft.com/office/drawing/2014/main" id="{2791181A-CF35-47DB-9115-064F27015DB9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64" name="그룹 63">
            <a:extLst>
              <a:ext uri="{FF2B5EF4-FFF2-40B4-BE49-F238E27FC236}">
                <a16:creationId xmlns:a16="http://schemas.microsoft.com/office/drawing/2014/main" id="{47935D3F-C14D-4EF2-A517-86D13ACDB247}"/>
              </a:ext>
            </a:extLst>
          </p:cNvPr>
          <p:cNvGrpSpPr/>
          <p:nvPr/>
        </p:nvGrpSpPr>
        <p:grpSpPr>
          <a:xfrm rot="10800000">
            <a:off x="3501951" y="1410483"/>
            <a:ext cx="70913" cy="48223"/>
            <a:chOff x="9017763" y="2551103"/>
            <a:chExt cx="116646" cy="79323"/>
          </a:xfrm>
        </p:grpSpPr>
        <p:sp>
          <p:nvSpPr>
            <p:cNvPr id="164" name="타원 163">
              <a:extLst>
                <a:ext uri="{FF2B5EF4-FFF2-40B4-BE49-F238E27FC236}">
                  <a16:creationId xmlns:a16="http://schemas.microsoft.com/office/drawing/2014/main" id="{DE3D5BCF-A34D-4A8D-A62C-4A2AF05BF698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65" name="타원 164">
              <a:extLst>
                <a:ext uri="{FF2B5EF4-FFF2-40B4-BE49-F238E27FC236}">
                  <a16:creationId xmlns:a16="http://schemas.microsoft.com/office/drawing/2014/main" id="{B1E7C97D-6589-4A43-9A5E-4570CF94E602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65" name="그룹 64">
            <a:extLst>
              <a:ext uri="{FF2B5EF4-FFF2-40B4-BE49-F238E27FC236}">
                <a16:creationId xmlns:a16="http://schemas.microsoft.com/office/drawing/2014/main" id="{AF49ADB6-AEF1-44F3-8DBD-8179E1E756F0}"/>
              </a:ext>
            </a:extLst>
          </p:cNvPr>
          <p:cNvGrpSpPr/>
          <p:nvPr/>
        </p:nvGrpSpPr>
        <p:grpSpPr>
          <a:xfrm rot="10800000">
            <a:off x="3391740" y="1386764"/>
            <a:ext cx="70913" cy="48223"/>
            <a:chOff x="9017763" y="2551103"/>
            <a:chExt cx="116646" cy="79323"/>
          </a:xfrm>
        </p:grpSpPr>
        <p:sp>
          <p:nvSpPr>
            <p:cNvPr id="162" name="타원 161">
              <a:extLst>
                <a:ext uri="{FF2B5EF4-FFF2-40B4-BE49-F238E27FC236}">
                  <a16:creationId xmlns:a16="http://schemas.microsoft.com/office/drawing/2014/main" id="{607CB95B-FE8E-4F16-84A3-582809520369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63" name="타원 162">
              <a:extLst>
                <a:ext uri="{FF2B5EF4-FFF2-40B4-BE49-F238E27FC236}">
                  <a16:creationId xmlns:a16="http://schemas.microsoft.com/office/drawing/2014/main" id="{5CDD5843-54AF-4412-BD28-A32EFBCF8059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66" name="그룹 65">
            <a:extLst>
              <a:ext uri="{FF2B5EF4-FFF2-40B4-BE49-F238E27FC236}">
                <a16:creationId xmlns:a16="http://schemas.microsoft.com/office/drawing/2014/main" id="{F3B23773-F991-48BE-AFB9-293A4C4AC52F}"/>
              </a:ext>
            </a:extLst>
          </p:cNvPr>
          <p:cNvGrpSpPr/>
          <p:nvPr/>
        </p:nvGrpSpPr>
        <p:grpSpPr>
          <a:xfrm rot="10800000">
            <a:off x="2912401" y="1523563"/>
            <a:ext cx="70913" cy="48223"/>
            <a:chOff x="9017763" y="2551103"/>
            <a:chExt cx="116646" cy="79323"/>
          </a:xfrm>
        </p:grpSpPr>
        <p:sp>
          <p:nvSpPr>
            <p:cNvPr id="160" name="타원 159">
              <a:extLst>
                <a:ext uri="{FF2B5EF4-FFF2-40B4-BE49-F238E27FC236}">
                  <a16:creationId xmlns:a16="http://schemas.microsoft.com/office/drawing/2014/main" id="{C1A3B4C3-3E65-49F3-B0BE-47DE45E1841E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61" name="타원 160">
              <a:extLst>
                <a:ext uri="{FF2B5EF4-FFF2-40B4-BE49-F238E27FC236}">
                  <a16:creationId xmlns:a16="http://schemas.microsoft.com/office/drawing/2014/main" id="{FFD6336F-2FE0-4E1C-8962-D0B7ACDDBA7B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67" name="그룹 66">
            <a:extLst>
              <a:ext uri="{FF2B5EF4-FFF2-40B4-BE49-F238E27FC236}">
                <a16:creationId xmlns:a16="http://schemas.microsoft.com/office/drawing/2014/main" id="{4482BC5B-7234-478B-A835-31B49C4E957E}"/>
              </a:ext>
            </a:extLst>
          </p:cNvPr>
          <p:cNvGrpSpPr/>
          <p:nvPr/>
        </p:nvGrpSpPr>
        <p:grpSpPr>
          <a:xfrm rot="10800000">
            <a:off x="2755007" y="1504985"/>
            <a:ext cx="70913" cy="48223"/>
            <a:chOff x="9017763" y="2551103"/>
            <a:chExt cx="116646" cy="79323"/>
          </a:xfrm>
        </p:grpSpPr>
        <p:sp>
          <p:nvSpPr>
            <p:cNvPr id="158" name="타원 157">
              <a:extLst>
                <a:ext uri="{FF2B5EF4-FFF2-40B4-BE49-F238E27FC236}">
                  <a16:creationId xmlns:a16="http://schemas.microsoft.com/office/drawing/2014/main" id="{61B35882-93DE-47FA-8928-948A4DCC66ED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59" name="타원 158">
              <a:extLst>
                <a:ext uri="{FF2B5EF4-FFF2-40B4-BE49-F238E27FC236}">
                  <a16:creationId xmlns:a16="http://schemas.microsoft.com/office/drawing/2014/main" id="{A963DD41-426A-4C9C-99D4-F17F3063FE54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68" name="그룹 67">
            <a:extLst>
              <a:ext uri="{FF2B5EF4-FFF2-40B4-BE49-F238E27FC236}">
                <a16:creationId xmlns:a16="http://schemas.microsoft.com/office/drawing/2014/main" id="{30418037-1791-4514-B7CD-F8183EE3438A}"/>
              </a:ext>
            </a:extLst>
          </p:cNvPr>
          <p:cNvGrpSpPr/>
          <p:nvPr/>
        </p:nvGrpSpPr>
        <p:grpSpPr>
          <a:xfrm rot="10800000">
            <a:off x="2736278" y="1307429"/>
            <a:ext cx="70913" cy="48223"/>
            <a:chOff x="9017763" y="2551103"/>
            <a:chExt cx="116646" cy="79323"/>
          </a:xfrm>
        </p:grpSpPr>
        <p:sp>
          <p:nvSpPr>
            <p:cNvPr id="156" name="타원 155">
              <a:extLst>
                <a:ext uri="{FF2B5EF4-FFF2-40B4-BE49-F238E27FC236}">
                  <a16:creationId xmlns:a16="http://schemas.microsoft.com/office/drawing/2014/main" id="{08AC983D-103A-4235-A847-D75AFA2C0AAF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57" name="타원 156">
              <a:extLst>
                <a:ext uri="{FF2B5EF4-FFF2-40B4-BE49-F238E27FC236}">
                  <a16:creationId xmlns:a16="http://schemas.microsoft.com/office/drawing/2014/main" id="{E7943C88-199D-4943-87CE-25C56F89D5B5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69" name="그룹 68">
            <a:extLst>
              <a:ext uri="{FF2B5EF4-FFF2-40B4-BE49-F238E27FC236}">
                <a16:creationId xmlns:a16="http://schemas.microsoft.com/office/drawing/2014/main" id="{E172E425-69BD-4EBD-8000-836A150B8A60}"/>
              </a:ext>
            </a:extLst>
          </p:cNvPr>
          <p:cNvGrpSpPr/>
          <p:nvPr/>
        </p:nvGrpSpPr>
        <p:grpSpPr>
          <a:xfrm rot="10800000">
            <a:off x="3505064" y="1499452"/>
            <a:ext cx="70913" cy="48223"/>
            <a:chOff x="9017763" y="2551103"/>
            <a:chExt cx="116646" cy="79323"/>
          </a:xfrm>
        </p:grpSpPr>
        <p:sp>
          <p:nvSpPr>
            <p:cNvPr id="154" name="타원 153">
              <a:extLst>
                <a:ext uri="{FF2B5EF4-FFF2-40B4-BE49-F238E27FC236}">
                  <a16:creationId xmlns:a16="http://schemas.microsoft.com/office/drawing/2014/main" id="{D01B7532-EA92-4373-AFF0-C37DE288F8AB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55" name="타원 154">
              <a:extLst>
                <a:ext uri="{FF2B5EF4-FFF2-40B4-BE49-F238E27FC236}">
                  <a16:creationId xmlns:a16="http://schemas.microsoft.com/office/drawing/2014/main" id="{5FCE6123-09F9-42F2-8C09-E5DAE59FA966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70" name="그룹 69">
            <a:extLst>
              <a:ext uri="{FF2B5EF4-FFF2-40B4-BE49-F238E27FC236}">
                <a16:creationId xmlns:a16="http://schemas.microsoft.com/office/drawing/2014/main" id="{B7C1EBA4-0C0A-4A0C-B8EF-6477F02B1004}"/>
              </a:ext>
            </a:extLst>
          </p:cNvPr>
          <p:cNvGrpSpPr/>
          <p:nvPr/>
        </p:nvGrpSpPr>
        <p:grpSpPr>
          <a:xfrm rot="10800000">
            <a:off x="2610006" y="1501878"/>
            <a:ext cx="70913" cy="48223"/>
            <a:chOff x="9017763" y="2551103"/>
            <a:chExt cx="116646" cy="79323"/>
          </a:xfrm>
        </p:grpSpPr>
        <p:sp>
          <p:nvSpPr>
            <p:cNvPr id="152" name="타원 151">
              <a:extLst>
                <a:ext uri="{FF2B5EF4-FFF2-40B4-BE49-F238E27FC236}">
                  <a16:creationId xmlns:a16="http://schemas.microsoft.com/office/drawing/2014/main" id="{D63D3B14-D0A2-4FED-BA6A-412DA477912B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53" name="타원 152">
              <a:extLst>
                <a:ext uri="{FF2B5EF4-FFF2-40B4-BE49-F238E27FC236}">
                  <a16:creationId xmlns:a16="http://schemas.microsoft.com/office/drawing/2014/main" id="{9E4475D8-D1F0-4A92-8415-B46691C01D33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71" name="그룹 70">
            <a:extLst>
              <a:ext uri="{FF2B5EF4-FFF2-40B4-BE49-F238E27FC236}">
                <a16:creationId xmlns:a16="http://schemas.microsoft.com/office/drawing/2014/main" id="{1DB2A93B-FADD-49DA-9A4D-CC066F672EFE}"/>
              </a:ext>
            </a:extLst>
          </p:cNvPr>
          <p:cNvGrpSpPr/>
          <p:nvPr/>
        </p:nvGrpSpPr>
        <p:grpSpPr>
          <a:xfrm rot="10800000">
            <a:off x="3376073" y="1496995"/>
            <a:ext cx="70913" cy="48223"/>
            <a:chOff x="9017763" y="2551103"/>
            <a:chExt cx="116646" cy="79323"/>
          </a:xfrm>
        </p:grpSpPr>
        <p:sp>
          <p:nvSpPr>
            <p:cNvPr id="150" name="타원 149">
              <a:extLst>
                <a:ext uri="{FF2B5EF4-FFF2-40B4-BE49-F238E27FC236}">
                  <a16:creationId xmlns:a16="http://schemas.microsoft.com/office/drawing/2014/main" id="{4B82EC1E-5F4D-499F-A6B2-251EFE1ACE0E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51" name="타원 150">
              <a:extLst>
                <a:ext uri="{FF2B5EF4-FFF2-40B4-BE49-F238E27FC236}">
                  <a16:creationId xmlns:a16="http://schemas.microsoft.com/office/drawing/2014/main" id="{D6CFD984-A9A5-42A9-9A1C-2F0DE5F1AAD8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sp>
        <p:nvSpPr>
          <p:cNvPr id="72" name="직사각형 71">
            <a:extLst>
              <a:ext uri="{FF2B5EF4-FFF2-40B4-BE49-F238E27FC236}">
                <a16:creationId xmlns:a16="http://schemas.microsoft.com/office/drawing/2014/main" id="{660CD322-AEEC-436B-A173-884122D9E79C}"/>
              </a:ext>
            </a:extLst>
          </p:cNvPr>
          <p:cNvSpPr/>
          <p:nvPr/>
        </p:nvSpPr>
        <p:spPr>
          <a:xfrm>
            <a:off x="2253550" y="1017847"/>
            <a:ext cx="101033" cy="689650"/>
          </a:xfrm>
          <a:prstGeom prst="rect">
            <a:avLst/>
          </a:prstGeom>
          <a:solidFill>
            <a:srgbClr val="3A4858">
              <a:lumMod val="20000"/>
              <a:lumOff val="80000"/>
            </a:srgbClr>
          </a:soli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ko-KR" altLang="en-US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/>
              <a:ea typeface="맑은 고딕"/>
              <a:cs typeface="+mn-cs"/>
            </a:endParaRPr>
          </a:p>
        </p:txBody>
      </p:sp>
      <p:sp>
        <p:nvSpPr>
          <p:cNvPr id="73" name="직사각형 72">
            <a:extLst>
              <a:ext uri="{FF2B5EF4-FFF2-40B4-BE49-F238E27FC236}">
                <a16:creationId xmlns:a16="http://schemas.microsoft.com/office/drawing/2014/main" id="{BAD9E372-8DAA-42B7-A176-E96890DDD34C}"/>
              </a:ext>
            </a:extLst>
          </p:cNvPr>
          <p:cNvSpPr/>
          <p:nvPr/>
        </p:nvSpPr>
        <p:spPr>
          <a:xfrm>
            <a:off x="3837291" y="1017847"/>
            <a:ext cx="101033" cy="689650"/>
          </a:xfrm>
          <a:prstGeom prst="rect">
            <a:avLst/>
          </a:prstGeom>
          <a:solidFill>
            <a:srgbClr val="3A4858">
              <a:lumMod val="20000"/>
              <a:lumOff val="80000"/>
            </a:srgbClr>
          </a:soli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ko-KR" altLang="en-US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/>
              <a:ea typeface="맑은 고딕"/>
              <a:cs typeface="+mn-cs"/>
            </a:endParaRPr>
          </a:p>
        </p:txBody>
      </p:sp>
      <p:sp>
        <p:nvSpPr>
          <p:cNvPr id="74" name="자유형: 도형 474">
            <a:extLst>
              <a:ext uri="{FF2B5EF4-FFF2-40B4-BE49-F238E27FC236}">
                <a16:creationId xmlns:a16="http://schemas.microsoft.com/office/drawing/2014/main" id="{E4118F80-EDBF-4A58-856F-E342C71B0692}"/>
              </a:ext>
            </a:extLst>
          </p:cNvPr>
          <p:cNvSpPr/>
          <p:nvPr/>
        </p:nvSpPr>
        <p:spPr>
          <a:xfrm>
            <a:off x="2251654" y="1015484"/>
            <a:ext cx="1686633" cy="690522"/>
          </a:xfrm>
          <a:custGeom>
            <a:avLst/>
            <a:gdLst>
              <a:gd name="connsiteX0" fmla="*/ 12451 w 2788988"/>
              <a:gd name="connsiteY0" fmla="*/ 83088 h 1221325"/>
              <a:gd name="connsiteX1" fmla="*/ 188663 w 2788988"/>
              <a:gd name="connsiteY1" fmla="*/ 87850 h 1221325"/>
              <a:gd name="connsiteX2" fmla="*/ 186282 w 2788988"/>
              <a:gd name="connsiteY2" fmla="*/ 1052256 h 1221325"/>
              <a:gd name="connsiteX3" fmla="*/ 2627063 w 2788988"/>
              <a:gd name="connsiteY3" fmla="*/ 1047494 h 1221325"/>
              <a:gd name="connsiteX4" fmla="*/ 2627063 w 2788988"/>
              <a:gd name="connsiteY4" fmla="*/ 85469 h 1221325"/>
              <a:gd name="connsiteX5" fmla="*/ 2788988 w 2788988"/>
              <a:gd name="connsiteY5" fmla="*/ 80706 h 1221325"/>
              <a:gd name="connsiteX6" fmla="*/ 2788988 w 2788988"/>
              <a:gd name="connsiteY6" fmla="*/ 1221325 h 1221325"/>
              <a:gd name="connsiteX7" fmla="*/ 14832 w 2788988"/>
              <a:gd name="connsiteY7" fmla="*/ 1221325 h 1221325"/>
              <a:gd name="connsiteX8" fmla="*/ 12451 w 2788988"/>
              <a:gd name="connsiteY8" fmla="*/ 83088 h 1221325"/>
              <a:gd name="connsiteX0" fmla="*/ 12451 w 2788988"/>
              <a:gd name="connsiteY0" fmla="*/ 2382 h 1140619"/>
              <a:gd name="connsiteX1" fmla="*/ 188663 w 2788988"/>
              <a:gd name="connsiteY1" fmla="*/ 7144 h 1140619"/>
              <a:gd name="connsiteX2" fmla="*/ 186282 w 2788988"/>
              <a:gd name="connsiteY2" fmla="*/ 971550 h 1140619"/>
              <a:gd name="connsiteX3" fmla="*/ 2627063 w 2788988"/>
              <a:gd name="connsiteY3" fmla="*/ 966788 h 1140619"/>
              <a:gd name="connsiteX4" fmla="*/ 2627063 w 2788988"/>
              <a:gd name="connsiteY4" fmla="*/ 4763 h 1140619"/>
              <a:gd name="connsiteX5" fmla="*/ 2788988 w 2788988"/>
              <a:gd name="connsiteY5" fmla="*/ 0 h 1140619"/>
              <a:gd name="connsiteX6" fmla="*/ 2788988 w 2788988"/>
              <a:gd name="connsiteY6" fmla="*/ 1140619 h 1140619"/>
              <a:gd name="connsiteX7" fmla="*/ 14832 w 2788988"/>
              <a:gd name="connsiteY7" fmla="*/ 1140619 h 1140619"/>
              <a:gd name="connsiteX8" fmla="*/ 12451 w 2788988"/>
              <a:gd name="connsiteY8" fmla="*/ 2382 h 1140619"/>
              <a:gd name="connsiteX0" fmla="*/ 0 w 2776537"/>
              <a:gd name="connsiteY0" fmla="*/ 2382 h 1140619"/>
              <a:gd name="connsiteX1" fmla="*/ 176212 w 2776537"/>
              <a:gd name="connsiteY1" fmla="*/ 7144 h 1140619"/>
              <a:gd name="connsiteX2" fmla="*/ 173831 w 2776537"/>
              <a:gd name="connsiteY2" fmla="*/ 971550 h 1140619"/>
              <a:gd name="connsiteX3" fmla="*/ 2614612 w 2776537"/>
              <a:gd name="connsiteY3" fmla="*/ 966788 h 1140619"/>
              <a:gd name="connsiteX4" fmla="*/ 2614612 w 2776537"/>
              <a:gd name="connsiteY4" fmla="*/ 4763 h 1140619"/>
              <a:gd name="connsiteX5" fmla="*/ 2776537 w 2776537"/>
              <a:gd name="connsiteY5" fmla="*/ 0 h 1140619"/>
              <a:gd name="connsiteX6" fmla="*/ 2776537 w 2776537"/>
              <a:gd name="connsiteY6" fmla="*/ 1140619 h 1140619"/>
              <a:gd name="connsiteX7" fmla="*/ 2381 w 2776537"/>
              <a:gd name="connsiteY7" fmla="*/ 1140619 h 1140619"/>
              <a:gd name="connsiteX8" fmla="*/ 0 w 2776537"/>
              <a:gd name="connsiteY8" fmla="*/ 2382 h 1140619"/>
              <a:gd name="connsiteX0" fmla="*/ 231 w 2774386"/>
              <a:gd name="connsiteY0" fmla="*/ 7145 h 1140619"/>
              <a:gd name="connsiteX1" fmla="*/ 174061 w 2774386"/>
              <a:gd name="connsiteY1" fmla="*/ 7144 h 1140619"/>
              <a:gd name="connsiteX2" fmla="*/ 171680 w 2774386"/>
              <a:gd name="connsiteY2" fmla="*/ 971550 h 1140619"/>
              <a:gd name="connsiteX3" fmla="*/ 2612461 w 2774386"/>
              <a:gd name="connsiteY3" fmla="*/ 966788 h 1140619"/>
              <a:gd name="connsiteX4" fmla="*/ 2612461 w 2774386"/>
              <a:gd name="connsiteY4" fmla="*/ 4763 h 1140619"/>
              <a:gd name="connsiteX5" fmla="*/ 2774386 w 2774386"/>
              <a:gd name="connsiteY5" fmla="*/ 0 h 1140619"/>
              <a:gd name="connsiteX6" fmla="*/ 2774386 w 2774386"/>
              <a:gd name="connsiteY6" fmla="*/ 1140619 h 1140619"/>
              <a:gd name="connsiteX7" fmla="*/ 230 w 2774386"/>
              <a:gd name="connsiteY7" fmla="*/ 1140619 h 1140619"/>
              <a:gd name="connsiteX8" fmla="*/ 231 w 2774386"/>
              <a:gd name="connsiteY8" fmla="*/ 7145 h 1140619"/>
              <a:gd name="connsiteX0" fmla="*/ 231 w 2774386"/>
              <a:gd name="connsiteY0" fmla="*/ 7145 h 1140619"/>
              <a:gd name="connsiteX1" fmla="*/ 174061 w 2774386"/>
              <a:gd name="connsiteY1" fmla="*/ 7144 h 1140619"/>
              <a:gd name="connsiteX2" fmla="*/ 171680 w 2774386"/>
              <a:gd name="connsiteY2" fmla="*/ 971550 h 1140619"/>
              <a:gd name="connsiteX3" fmla="*/ 2614842 w 2774386"/>
              <a:gd name="connsiteY3" fmla="*/ 978694 h 1140619"/>
              <a:gd name="connsiteX4" fmla="*/ 2612461 w 2774386"/>
              <a:gd name="connsiteY4" fmla="*/ 4763 h 1140619"/>
              <a:gd name="connsiteX5" fmla="*/ 2774386 w 2774386"/>
              <a:gd name="connsiteY5" fmla="*/ 0 h 1140619"/>
              <a:gd name="connsiteX6" fmla="*/ 2774386 w 2774386"/>
              <a:gd name="connsiteY6" fmla="*/ 1140619 h 1140619"/>
              <a:gd name="connsiteX7" fmla="*/ 230 w 2774386"/>
              <a:gd name="connsiteY7" fmla="*/ 1140619 h 1140619"/>
              <a:gd name="connsiteX8" fmla="*/ 231 w 2774386"/>
              <a:gd name="connsiteY8" fmla="*/ 7145 h 1140619"/>
              <a:gd name="connsiteX0" fmla="*/ 231 w 2774386"/>
              <a:gd name="connsiteY0" fmla="*/ 7145 h 1140619"/>
              <a:gd name="connsiteX1" fmla="*/ 174061 w 2774386"/>
              <a:gd name="connsiteY1" fmla="*/ 7144 h 1140619"/>
              <a:gd name="connsiteX2" fmla="*/ 178824 w 2774386"/>
              <a:gd name="connsiteY2" fmla="*/ 976312 h 1140619"/>
              <a:gd name="connsiteX3" fmla="*/ 2614842 w 2774386"/>
              <a:gd name="connsiteY3" fmla="*/ 978694 h 1140619"/>
              <a:gd name="connsiteX4" fmla="*/ 2612461 w 2774386"/>
              <a:gd name="connsiteY4" fmla="*/ 4763 h 1140619"/>
              <a:gd name="connsiteX5" fmla="*/ 2774386 w 2774386"/>
              <a:gd name="connsiteY5" fmla="*/ 0 h 1140619"/>
              <a:gd name="connsiteX6" fmla="*/ 2774386 w 2774386"/>
              <a:gd name="connsiteY6" fmla="*/ 1140619 h 1140619"/>
              <a:gd name="connsiteX7" fmla="*/ 230 w 2774386"/>
              <a:gd name="connsiteY7" fmla="*/ 1140619 h 1140619"/>
              <a:gd name="connsiteX8" fmla="*/ 231 w 2774386"/>
              <a:gd name="connsiteY8" fmla="*/ 7145 h 1140619"/>
              <a:gd name="connsiteX0" fmla="*/ 231 w 2774386"/>
              <a:gd name="connsiteY0" fmla="*/ 2382 h 1135856"/>
              <a:gd name="connsiteX1" fmla="*/ 174061 w 2774386"/>
              <a:gd name="connsiteY1" fmla="*/ 2381 h 1135856"/>
              <a:gd name="connsiteX2" fmla="*/ 178824 w 2774386"/>
              <a:gd name="connsiteY2" fmla="*/ 971549 h 1135856"/>
              <a:gd name="connsiteX3" fmla="*/ 2614842 w 2774386"/>
              <a:gd name="connsiteY3" fmla="*/ 973931 h 1135856"/>
              <a:gd name="connsiteX4" fmla="*/ 2612461 w 2774386"/>
              <a:gd name="connsiteY4" fmla="*/ 0 h 1135856"/>
              <a:gd name="connsiteX5" fmla="*/ 2774386 w 2774386"/>
              <a:gd name="connsiteY5" fmla="*/ 2380 h 1135856"/>
              <a:gd name="connsiteX6" fmla="*/ 2774386 w 2774386"/>
              <a:gd name="connsiteY6" fmla="*/ 1135856 h 1135856"/>
              <a:gd name="connsiteX7" fmla="*/ 230 w 2774386"/>
              <a:gd name="connsiteY7" fmla="*/ 1135856 h 1135856"/>
              <a:gd name="connsiteX8" fmla="*/ 231 w 2774386"/>
              <a:gd name="connsiteY8" fmla="*/ 2382 h 1135856"/>
              <a:gd name="connsiteX0" fmla="*/ 231 w 2774386"/>
              <a:gd name="connsiteY0" fmla="*/ 2383 h 1135857"/>
              <a:gd name="connsiteX1" fmla="*/ 174061 w 2774386"/>
              <a:gd name="connsiteY1" fmla="*/ 2382 h 1135857"/>
              <a:gd name="connsiteX2" fmla="*/ 178824 w 2774386"/>
              <a:gd name="connsiteY2" fmla="*/ 971550 h 1135857"/>
              <a:gd name="connsiteX3" fmla="*/ 2614842 w 2774386"/>
              <a:gd name="connsiteY3" fmla="*/ 973932 h 1135857"/>
              <a:gd name="connsiteX4" fmla="*/ 2612461 w 2774386"/>
              <a:gd name="connsiteY4" fmla="*/ 1 h 1135857"/>
              <a:gd name="connsiteX5" fmla="*/ 2772004 w 2774386"/>
              <a:gd name="connsiteY5" fmla="*/ 0 h 1135857"/>
              <a:gd name="connsiteX6" fmla="*/ 2774386 w 2774386"/>
              <a:gd name="connsiteY6" fmla="*/ 1135857 h 1135857"/>
              <a:gd name="connsiteX7" fmla="*/ 230 w 2774386"/>
              <a:gd name="connsiteY7" fmla="*/ 1135857 h 1135857"/>
              <a:gd name="connsiteX8" fmla="*/ 231 w 2774386"/>
              <a:gd name="connsiteY8" fmla="*/ 2383 h 1135857"/>
              <a:gd name="connsiteX0" fmla="*/ 231 w 2774386"/>
              <a:gd name="connsiteY0" fmla="*/ 2383 h 1135857"/>
              <a:gd name="connsiteX1" fmla="*/ 174061 w 2774386"/>
              <a:gd name="connsiteY1" fmla="*/ 2382 h 1135857"/>
              <a:gd name="connsiteX2" fmla="*/ 178824 w 2774386"/>
              <a:gd name="connsiteY2" fmla="*/ 971550 h 1135857"/>
              <a:gd name="connsiteX3" fmla="*/ 2614842 w 2774386"/>
              <a:gd name="connsiteY3" fmla="*/ 973932 h 1135857"/>
              <a:gd name="connsiteX4" fmla="*/ 2612461 w 2774386"/>
              <a:gd name="connsiteY4" fmla="*/ 1 h 1135857"/>
              <a:gd name="connsiteX5" fmla="*/ 2774385 w 2774386"/>
              <a:gd name="connsiteY5" fmla="*/ 0 h 1135857"/>
              <a:gd name="connsiteX6" fmla="*/ 2774386 w 2774386"/>
              <a:gd name="connsiteY6" fmla="*/ 1135857 h 1135857"/>
              <a:gd name="connsiteX7" fmla="*/ 230 w 2774386"/>
              <a:gd name="connsiteY7" fmla="*/ 1135857 h 1135857"/>
              <a:gd name="connsiteX8" fmla="*/ 231 w 2774386"/>
              <a:gd name="connsiteY8" fmla="*/ 2383 h 1135857"/>
              <a:gd name="connsiteX0" fmla="*/ 231 w 2774386"/>
              <a:gd name="connsiteY0" fmla="*/ 2383 h 1135857"/>
              <a:gd name="connsiteX1" fmla="*/ 174061 w 2774386"/>
              <a:gd name="connsiteY1" fmla="*/ 2382 h 1135857"/>
              <a:gd name="connsiteX2" fmla="*/ 171681 w 2774386"/>
              <a:gd name="connsiteY2" fmla="*/ 971550 h 1135857"/>
              <a:gd name="connsiteX3" fmla="*/ 2614842 w 2774386"/>
              <a:gd name="connsiteY3" fmla="*/ 973932 h 1135857"/>
              <a:gd name="connsiteX4" fmla="*/ 2612461 w 2774386"/>
              <a:gd name="connsiteY4" fmla="*/ 1 h 1135857"/>
              <a:gd name="connsiteX5" fmla="*/ 2774385 w 2774386"/>
              <a:gd name="connsiteY5" fmla="*/ 0 h 1135857"/>
              <a:gd name="connsiteX6" fmla="*/ 2774386 w 2774386"/>
              <a:gd name="connsiteY6" fmla="*/ 1135857 h 1135857"/>
              <a:gd name="connsiteX7" fmla="*/ 230 w 2774386"/>
              <a:gd name="connsiteY7" fmla="*/ 1135857 h 1135857"/>
              <a:gd name="connsiteX8" fmla="*/ 231 w 2774386"/>
              <a:gd name="connsiteY8" fmla="*/ 2383 h 113585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2774386" h="1135857">
                <a:moveTo>
                  <a:pt x="231" y="2383"/>
                </a:moveTo>
                <a:lnTo>
                  <a:pt x="174061" y="2382"/>
                </a:lnTo>
                <a:cubicBezTo>
                  <a:pt x="173267" y="323851"/>
                  <a:pt x="172475" y="650081"/>
                  <a:pt x="171681" y="971550"/>
                </a:cubicBezTo>
                <a:lnTo>
                  <a:pt x="2614842" y="973932"/>
                </a:lnTo>
                <a:cubicBezTo>
                  <a:pt x="2614048" y="649288"/>
                  <a:pt x="2613255" y="324645"/>
                  <a:pt x="2612461" y="1"/>
                </a:cubicBezTo>
                <a:lnTo>
                  <a:pt x="2774385" y="0"/>
                </a:lnTo>
                <a:cubicBezTo>
                  <a:pt x="2774385" y="378619"/>
                  <a:pt x="2774386" y="757238"/>
                  <a:pt x="2774386" y="1135857"/>
                </a:cubicBezTo>
                <a:lnTo>
                  <a:pt x="230" y="1135857"/>
                </a:lnTo>
                <a:cubicBezTo>
                  <a:pt x="-564" y="756445"/>
                  <a:pt x="1025" y="381795"/>
                  <a:pt x="231" y="2383"/>
                </a:cubicBezTo>
                <a:close/>
              </a:path>
            </a:pathLst>
          </a:custGeom>
          <a:noFill/>
          <a:ln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75" name="자유형: 도형 475">
            <a:extLst>
              <a:ext uri="{FF2B5EF4-FFF2-40B4-BE49-F238E27FC236}">
                <a16:creationId xmlns:a16="http://schemas.microsoft.com/office/drawing/2014/main" id="{E798633E-16DF-4401-A700-1E2199959349}"/>
              </a:ext>
            </a:extLst>
          </p:cNvPr>
          <p:cNvSpPr/>
          <p:nvPr/>
        </p:nvSpPr>
        <p:spPr>
          <a:xfrm>
            <a:off x="3164475" y="2881672"/>
            <a:ext cx="572507" cy="343082"/>
          </a:xfrm>
          <a:custGeom>
            <a:avLst/>
            <a:gdLst>
              <a:gd name="connsiteX0" fmla="*/ 0 w 914400"/>
              <a:gd name="connsiteY0" fmla="*/ 590550 h 590550"/>
              <a:gd name="connsiteX1" fmla="*/ 44450 w 914400"/>
              <a:gd name="connsiteY1" fmla="*/ 330200 h 590550"/>
              <a:gd name="connsiteX2" fmla="*/ 209550 w 914400"/>
              <a:gd name="connsiteY2" fmla="*/ 120650 h 590550"/>
              <a:gd name="connsiteX3" fmla="*/ 361950 w 914400"/>
              <a:gd name="connsiteY3" fmla="*/ 0 h 590550"/>
              <a:gd name="connsiteX4" fmla="*/ 730250 w 914400"/>
              <a:gd name="connsiteY4" fmla="*/ 101600 h 590550"/>
              <a:gd name="connsiteX5" fmla="*/ 812800 w 914400"/>
              <a:gd name="connsiteY5" fmla="*/ 323850 h 590550"/>
              <a:gd name="connsiteX6" fmla="*/ 914400 w 914400"/>
              <a:gd name="connsiteY6" fmla="*/ 577850 h 590550"/>
              <a:gd name="connsiteX7" fmla="*/ 0 w 914400"/>
              <a:gd name="connsiteY7" fmla="*/ 590550 h 590550"/>
              <a:gd name="connsiteX0" fmla="*/ 0 w 914400"/>
              <a:gd name="connsiteY0" fmla="*/ 590691 h 590691"/>
              <a:gd name="connsiteX1" fmla="*/ 44450 w 914400"/>
              <a:gd name="connsiteY1" fmla="*/ 330341 h 590691"/>
              <a:gd name="connsiteX2" fmla="*/ 209550 w 914400"/>
              <a:gd name="connsiteY2" fmla="*/ 120791 h 590691"/>
              <a:gd name="connsiteX3" fmla="*/ 361950 w 914400"/>
              <a:gd name="connsiteY3" fmla="*/ 141 h 590691"/>
              <a:gd name="connsiteX4" fmla="*/ 730250 w 914400"/>
              <a:gd name="connsiteY4" fmla="*/ 101741 h 590691"/>
              <a:gd name="connsiteX5" fmla="*/ 812800 w 914400"/>
              <a:gd name="connsiteY5" fmla="*/ 323991 h 590691"/>
              <a:gd name="connsiteX6" fmla="*/ 914400 w 914400"/>
              <a:gd name="connsiteY6" fmla="*/ 577991 h 590691"/>
              <a:gd name="connsiteX7" fmla="*/ 0 w 914400"/>
              <a:gd name="connsiteY7" fmla="*/ 590691 h 590691"/>
              <a:gd name="connsiteX0" fmla="*/ 0 w 914400"/>
              <a:gd name="connsiteY0" fmla="*/ 590691 h 590691"/>
              <a:gd name="connsiteX1" fmla="*/ 44450 w 914400"/>
              <a:gd name="connsiteY1" fmla="*/ 330341 h 590691"/>
              <a:gd name="connsiteX2" fmla="*/ 209550 w 914400"/>
              <a:gd name="connsiteY2" fmla="*/ 120791 h 590691"/>
              <a:gd name="connsiteX3" fmla="*/ 361950 w 914400"/>
              <a:gd name="connsiteY3" fmla="*/ 141 h 590691"/>
              <a:gd name="connsiteX4" fmla="*/ 730250 w 914400"/>
              <a:gd name="connsiteY4" fmla="*/ 101741 h 590691"/>
              <a:gd name="connsiteX5" fmla="*/ 812800 w 914400"/>
              <a:gd name="connsiteY5" fmla="*/ 323991 h 590691"/>
              <a:gd name="connsiteX6" fmla="*/ 914400 w 914400"/>
              <a:gd name="connsiteY6" fmla="*/ 577991 h 590691"/>
              <a:gd name="connsiteX7" fmla="*/ 0 w 914400"/>
              <a:gd name="connsiteY7" fmla="*/ 590691 h 590691"/>
              <a:gd name="connsiteX0" fmla="*/ 0 w 914400"/>
              <a:gd name="connsiteY0" fmla="*/ 590694 h 590694"/>
              <a:gd name="connsiteX1" fmla="*/ 44450 w 914400"/>
              <a:gd name="connsiteY1" fmla="*/ 330344 h 590694"/>
              <a:gd name="connsiteX2" fmla="*/ 209550 w 914400"/>
              <a:gd name="connsiteY2" fmla="*/ 120794 h 590694"/>
              <a:gd name="connsiteX3" fmla="*/ 361950 w 914400"/>
              <a:gd name="connsiteY3" fmla="*/ 144 h 590694"/>
              <a:gd name="connsiteX4" fmla="*/ 730250 w 914400"/>
              <a:gd name="connsiteY4" fmla="*/ 101744 h 590694"/>
              <a:gd name="connsiteX5" fmla="*/ 850900 w 914400"/>
              <a:gd name="connsiteY5" fmla="*/ 330344 h 590694"/>
              <a:gd name="connsiteX6" fmla="*/ 914400 w 914400"/>
              <a:gd name="connsiteY6" fmla="*/ 577994 h 590694"/>
              <a:gd name="connsiteX7" fmla="*/ 0 w 914400"/>
              <a:gd name="connsiteY7" fmla="*/ 590694 h 590694"/>
              <a:gd name="connsiteX0" fmla="*/ 0 w 914400"/>
              <a:gd name="connsiteY0" fmla="*/ 590694 h 590694"/>
              <a:gd name="connsiteX1" fmla="*/ 44450 w 914400"/>
              <a:gd name="connsiteY1" fmla="*/ 330344 h 590694"/>
              <a:gd name="connsiteX2" fmla="*/ 209550 w 914400"/>
              <a:gd name="connsiteY2" fmla="*/ 120794 h 590694"/>
              <a:gd name="connsiteX3" fmla="*/ 361950 w 914400"/>
              <a:gd name="connsiteY3" fmla="*/ 144 h 590694"/>
              <a:gd name="connsiteX4" fmla="*/ 730250 w 914400"/>
              <a:gd name="connsiteY4" fmla="*/ 101744 h 590694"/>
              <a:gd name="connsiteX5" fmla="*/ 850900 w 914400"/>
              <a:gd name="connsiteY5" fmla="*/ 330344 h 590694"/>
              <a:gd name="connsiteX6" fmla="*/ 914400 w 914400"/>
              <a:gd name="connsiteY6" fmla="*/ 577994 h 590694"/>
              <a:gd name="connsiteX7" fmla="*/ 0 w 914400"/>
              <a:gd name="connsiteY7" fmla="*/ 590694 h 590694"/>
              <a:gd name="connsiteX0" fmla="*/ 0 w 914400"/>
              <a:gd name="connsiteY0" fmla="*/ 590694 h 590694"/>
              <a:gd name="connsiteX1" fmla="*/ 44450 w 914400"/>
              <a:gd name="connsiteY1" fmla="*/ 330344 h 590694"/>
              <a:gd name="connsiteX2" fmla="*/ 209550 w 914400"/>
              <a:gd name="connsiteY2" fmla="*/ 120794 h 590694"/>
              <a:gd name="connsiteX3" fmla="*/ 361950 w 914400"/>
              <a:gd name="connsiteY3" fmla="*/ 144 h 590694"/>
              <a:gd name="connsiteX4" fmla="*/ 730250 w 914400"/>
              <a:gd name="connsiteY4" fmla="*/ 101744 h 590694"/>
              <a:gd name="connsiteX5" fmla="*/ 850900 w 914400"/>
              <a:gd name="connsiteY5" fmla="*/ 330344 h 590694"/>
              <a:gd name="connsiteX6" fmla="*/ 914400 w 914400"/>
              <a:gd name="connsiteY6" fmla="*/ 577994 h 590694"/>
              <a:gd name="connsiteX7" fmla="*/ 0 w 914400"/>
              <a:gd name="connsiteY7" fmla="*/ 590694 h 590694"/>
              <a:gd name="connsiteX0" fmla="*/ 60980 w 975380"/>
              <a:gd name="connsiteY0" fmla="*/ 590694 h 590694"/>
              <a:gd name="connsiteX1" fmla="*/ 105430 w 975380"/>
              <a:gd name="connsiteY1" fmla="*/ 330344 h 590694"/>
              <a:gd name="connsiteX2" fmla="*/ 270530 w 975380"/>
              <a:gd name="connsiteY2" fmla="*/ 120794 h 590694"/>
              <a:gd name="connsiteX3" fmla="*/ 422930 w 975380"/>
              <a:gd name="connsiteY3" fmla="*/ 144 h 590694"/>
              <a:gd name="connsiteX4" fmla="*/ 791230 w 975380"/>
              <a:gd name="connsiteY4" fmla="*/ 101744 h 590694"/>
              <a:gd name="connsiteX5" fmla="*/ 911880 w 975380"/>
              <a:gd name="connsiteY5" fmla="*/ 330344 h 590694"/>
              <a:gd name="connsiteX6" fmla="*/ 975380 w 975380"/>
              <a:gd name="connsiteY6" fmla="*/ 577994 h 590694"/>
              <a:gd name="connsiteX7" fmla="*/ 60980 w 975380"/>
              <a:gd name="connsiteY7" fmla="*/ 590694 h 590694"/>
              <a:gd name="connsiteX0" fmla="*/ 60980 w 975380"/>
              <a:gd name="connsiteY0" fmla="*/ 590694 h 616688"/>
              <a:gd name="connsiteX1" fmla="*/ 105430 w 975380"/>
              <a:gd name="connsiteY1" fmla="*/ 330344 h 616688"/>
              <a:gd name="connsiteX2" fmla="*/ 270530 w 975380"/>
              <a:gd name="connsiteY2" fmla="*/ 120794 h 616688"/>
              <a:gd name="connsiteX3" fmla="*/ 422930 w 975380"/>
              <a:gd name="connsiteY3" fmla="*/ 144 h 616688"/>
              <a:gd name="connsiteX4" fmla="*/ 791230 w 975380"/>
              <a:gd name="connsiteY4" fmla="*/ 101744 h 616688"/>
              <a:gd name="connsiteX5" fmla="*/ 911880 w 975380"/>
              <a:gd name="connsiteY5" fmla="*/ 330344 h 616688"/>
              <a:gd name="connsiteX6" fmla="*/ 975380 w 975380"/>
              <a:gd name="connsiteY6" fmla="*/ 577994 h 616688"/>
              <a:gd name="connsiteX7" fmla="*/ 60980 w 975380"/>
              <a:gd name="connsiteY7" fmla="*/ 590694 h 616688"/>
              <a:gd name="connsiteX0" fmla="*/ 80378 w 918578"/>
              <a:gd name="connsiteY0" fmla="*/ 635144 h 649729"/>
              <a:gd name="connsiteX1" fmla="*/ 48628 w 918578"/>
              <a:gd name="connsiteY1" fmla="*/ 330344 h 649729"/>
              <a:gd name="connsiteX2" fmla="*/ 213728 w 918578"/>
              <a:gd name="connsiteY2" fmla="*/ 120794 h 649729"/>
              <a:gd name="connsiteX3" fmla="*/ 366128 w 918578"/>
              <a:gd name="connsiteY3" fmla="*/ 144 h 649729"/>
              <a:gd name="connsiteX4" fmla="*/ 734428 w 918578"/>
              <a:gd name="connsiteY4" fmla="*/ 101744 h 649729"/>
              <a:gd name="connsiteX5" fmla="*/ 855078 w 918578"/>
              <a:gd name="connsiteY5" fmla="*/ 330344 h 649729"/>
              <a:gd name="connsiteX6" fmla="*/ 918578 w 918578"/>
              <a:gd name="connsiteY6" fmla="*/ 577994 h 649729"/>
              <a:gd name="connsiteX7" fmla="*/ 80378 w 918578"/>
              <a:gd name="connsiteY7" fmla="*/ 635144 h 649729"/>
              <a:gd name="connsiteX0" fmla="*/ 80378 w 918578"/>
              <a:gd name="connsiteY0" fmla="*/ 584344 h 613042"/>
              <a:gd name="connsiteX1" fmla="*/ 48628 w 918578"/>
              <a:gd name="connsiteY1" fmla="*/ 330344 h 613042"/>
              <a:gd name="connsiteX2" fmla="*/ 213728 w 918578"/>
              <a:gd name="connsiteY2" fmla="*/ 120794 h 613042"/>
              <a:gd name="connsiteX3" fmla="*/ 366128 w 918578"/>
              <a:gd name="connsiteY3" fmla="*/ 144 h 613042"/>
              <a:gd name="connsiteX4" fmla="*/ 734428 w 918578"/>
              <a:gd name="connsiteY4" fmla="*/ 101744 h 613042"/>
              <a:gd name="connsiteX5" fmla="*/ 855078 w 918578"/>
              <a:gd name="connsiteY5" fmla="*/ 330344 h 613042"/>
              <a:gd name="connsiteX6" fmla="*/ 918578 w 918578"/>
              <a:gd name="connsiteY6" fmla="*/ 577994 h 613042"/>
              <a:gd name="connsiteX7" fmla="*/ 80378 w 918578"/>
              <a:gd name="connsiteY7" fmla="*/ 584344 h 613042"/>
              <a:gd name="connsiteX0" fmla="*/ 80378 w 919038"/>
              <a:gd name="connsiteY0" fmla="*/ 584344 h 628201"/>
              <a:gd name="connsiteX1" fmla="*/ 48628 w 919038"/>
              <a:gd name="connsiteY1" fmla="*/ 330344 h 628201"/>
              <a:gd name="connsiteX2" fmla="*/ 213728 w 919038"/>
              <a:gd name="connsiteY2" fmla="*/ 120794 h 628201"/>
              <a:gd name="connsiteX3" fmla="*/ 366128 w 919038"/>
              <a:gd name="connsiteY3" fmla="*/ 144 h 628201"/>
              <a:gd name="connsiteX4" fmla="*/ 734428 w 919038"/>
              <a:gd name="connsiteY4" fmla="*/ 101744 h 628201"/>
              <a:gd name="connsiteX5" fmla="*/ 855078 w 919038"/>
              <a:gd name="connsiteY5" fmla="*/ 330344 h 628201"/>
              <a:gd name="connsiteX6" fmla="*/ 918578 w 919038"/>
              <a:gd name="connsiteY6" fmla="*/ 577994 h 628201"/>
              <a:gd name="connsiteX7" fmla="*/ 80378 w 919038"/>
              <a:gd name="connsiteY7" fmla="*/ 584344 h 628201"/>
              <a:gd name="connsiteX0" fmla="*/ 76368 w 861839"/>
              <a:gd name="connsiteY0" fmla="*/ 584344 h 616919"/>
              <a:gd name="connsiteX1" fmla="*/ 44618 w 861839"/>
              <a:gd name="connsiteY1" fmla="*/ 330344 h 616919"/>
              <a:gd name="connsiteX2" fmla="*/ 209718 w 861839"/>
              <a:gd name="connsiteY2" fmla="*/ 120794 h 616919"/>
              <a:gd name="connsiteX3" fmla="*/ 362118 w 861839"/>
              <a:gd name="connsiteY3" fmla="*/ 144 h 616919"/>
              <a:gd name="connsiteX4" fmla="*/ 730418 w 861839"/>
              <a:gd name="connsiteY4" fmla="*/ 101744 h 616919"/>
              <a:gd name="connsiteX5" fmla="*/ 851068 w 861839"/>
              <a:gd name="connsiteY5" fmla="*/ 330344 h 616919"/>
              <a:gd name="connsiteX6" fmla="*/ 857418 w 861839"/>
              <a:gd name="connsiteY6" fmla="*/ 558944 h 616919"/>
              <a:gd name="connsiteX7" fmla="*/ 76368 w 861839"/>
              <a:gd name="connsiteY7" fmla="*/ 584344 h 616919"/>
              <a:gd name="connsiteX0" fmla="*/ 76368 w 861839"/>
              <a:gd name="connsiteY0" fmla="*/ 578011 h 610586"/>
              <a:gd name="connsiteX1" fmla="*/ 44618 w 861839"/>
              <a:gd name="connsiteY1" fmla="*/ 324011 h 610586"/>
              <a:gd name="connsiteX2" fmla="*/ 209718 w 861839"/>
              <a:gd name="connsiteY2" fmla="*/ 114461 h 610586"/>
              <a:gd name="connsiteX3" fmla="*/ 400218 w 861839"/>
              <a:gd name="connsiteY3" fmla="*/ 161 h 610586"/>
              <a:gd name="connsiteX4" fmla="*/ 730418 w 861839"/>
              <a:gd name="connsiteY4" fmla="*/ 95411 h 610586"/>
              <a:gd name="connsiteX5" fmla="*/ 851068 w 861839"/>
              <a:gd name="connsiteY5" fmla="*/ 324011 h 610586"/>
              <a:gd name="connsiteX6" fmla="*/ 857418 w 861839"/>
              <a:gd name="connsiteY6" fmla="*/ 552611 h 610586"/>
              <a:gd name="connsiteX7" fmla="*/ 76368 w 861839"/>
              <a:gd name="connsiteY7" fmla="*/ 578011 h 610586"/>
              <a:gd name="connsiteX0" fmla="*/ 72787 w 858258"/>
              <a:gd name="connsiteY0" fmla="*/ 577870 h 610445"/>
              <a:gd name="connsiteX1" fmla="*/ 41037 w 858258"/>
              <a:gd name="connsiteY1" fmla="*/ 323870 h 610445"/>
              <a:gd name="connsiteX2" fmla="*/ 136287 w 858258"/>
              <a:gd name="connsiteY2" fmla="*/ 101620 h 610445"/>
              <a:gd name="connsiteX3" fmla="*/ 396637 w 858258"/>
              <a:gd name="connsiteY3" fmla="*/ 20 h 610445"/>
              <a:gd name="connsiteX4" fmla="*/ 726837 w 858258"/>
              <a:gd name="connsiteY4" fmla="*/ 95270 h 610445"/>
              <a:gd name="connsiteX5" fmla="*/ 847487 w 858258"/>
              <a:gd name="connsiteY5" fmla="*/ 323870 h 610445"/>
              <a:gd name="connsiteX6" fmla="*/ 853837 w 858258"/>
              <a:gd name="connsiteY6" fmla="*/ 552470 h 610445"/>
              <a:gd name="connsiteX7" fmla="*/ 72787 w 858258"/>
              <a:gd name="connsiteY7" fmla="*/ 577870 h 610445"/>
              <a:gd name="connsiteX0" fmla="*/ 72787 w 860103"/>
              <a:gd name="connsiteY0" fmla="*/ 577991 h 610566"/>
              <a:gd name="connsiteX1" fmla="*/ 41037 w 860103"/>
              <a:gd name="connsiteY1" fmla="*/ 323991 h 610566"/>
              <a:gd name="connsiteX2" fmla="*/ 136287 w 860103"/>
              <a:gd name="connsiteY2" fmla="*/ 101741 h 610566"/>
              <a:gd name="connsiteX3" fmla="*/ 396637 w 860103"/>
              <a:gd name="connsiteY3" fmla="*/ 141 h 610566"/>
              <a:gd name="connsiteX4" fmla="*/ 701437 w 860103"/>
              <a:gd name="connsiteY4" fmla="*/ 120791 h 610566"/>
              <a:gd name="connsiteX5" fmla="*/ 847487 w 860103"/>
              <a:gd name="connsiteY5" fmla="*/ 323991 h 610566"/>
              <a:gd name="connsiteX6" fmla="*/ 853837 w 860103"/>
              <a:gd name="connsiteY6" fmla="*/ 552591 h 610566"/>
              <a:gd name="connsiteX7" fmla="*/ 72787 w 860103"/>
              <a:gd name="connsiteY7" fmla="*/ 577991 h 610566"/>
              <a:gd name="connsiteX0" fmla="*/ 72787 w 895070"/>
              <a:gd name="connsiteY0" fmla="*/ 577991 h 596838"/>
              <a:gd name="connsiteX1" fmla="*/ 41037 w 895070"/>
              <a:gd name="connsiteY1" fmla="*/ 323991 h 596838"/>
              <a:gd name="connsiteX2" fmla="*/ 136287 w 895070"/>
              <a:gd name="connsiteY2" fmla="*/ 101741 h 596838"/>
              <a:gd name="connsiteX3" fmla="*/ 396637 w 895070"/>
              <a:gd name="connsiteY3" fmla="*/ 141 h 596838"/>
              <a:gd name="connsiteX4" fmla="*/ 701437 w 895070"/>
              <a:gd name="connsiteY4" fmla="*/ 120791 h 596838"/>
              <a:gd name="connsiteX5" fmla="*/ 777637 w 895070"/>
              <a:gd name="connsiteY5" fmla="*/ 349391 h 596838"/>
              <a:gd name="connsiteX6" fmla="*/ 853837 w 895070"/>
              <a:gd name="connsiteY6" fmla="*/ 552591 h 596838"/>
              <a:gd name="connsiteX7" fmla="*/ 72787 w 895070"/>
              <a:gd name="connsiteY7" fmla="*/ 577991 h 596838"/>
              <a:gd name="connsiteX0" fmla="*/ 72787 w 917761"/>
              <a:gd name="connsiteY0" fmla="*/ 577991 h 596343"/>
              <a:gd name="connsiteX1" fmla="*/ 41037 w 917761"/>
              <a:gd name="connsiteY1" fmla="*/ 323991 h 596343"/>
              <a:gd name="connsiteX2" fmla="*/ 136287 w 917761"/>
              <a:gd name="connsiteY2" fmla="*/ 101741 h 596343"/>
              <a:gd name="connsiteX3" fmla="*/ 396637 w 917761"/>
              <a:gd name="connsiteY3" fmla="*/ 141 h 596343"/>
              <a:gd name="connsiteX4" fmla="*/ 701437 w 917761"/>
              <a:gd name="connsiteY4" fmla="*/ 120791 h 596343"/>
              <a:gd name="connsiteX5" fmla="*/ 853837 w 917761"/>
              <a:gd name="connsiteY5" fmla="*/ 362091 h 596343"/>
              <a:gd name="connsiteX6" fmla="*/ 853837 w 917761"/>
              <a:gd name="connsiteY6" fmla="*/ 552591 h 596343"/>
              <a:gd name="connsiteX7" fmla="*/ 72787 w 917761"/>
              <a:gd name="connsiteY7" fmla="*/ 577991 h 596343"/>
              <a:gd name="connsiteX0" fmla="*/ 75506 w 949897"/>
              <a:gd name="connsiteY0" fmla="*/ 577991 h 598659"/>
              <a:gd name="connsiteX1" fmla="*/ 43756 w 949897"/>
              <a:gd name="connsiteY1" fmla="*/ 323991 h 598659"/>
              <a:gd name="connsiteX2" fmla="*/ 139006 w 949897"/>
              <a:gd name="connsiteY2" fmla="*/ 101741 h 598659"/>
              <a:gd name="connsiteX3" fmla="*/ 399356 w 949897"/>
              <a:gd name="connsiteY3" fmla="*/ 141 h 598659"/>
              <a:gd name="connsiteX4" fmla="*/ 704156 w 949897"/>
              <a:gd name="connsiteY4" fmla="*/ 120791 h 598659"/>
              <a:gd name="connsiteX5" fmla="*/ 856556 w 949897"/>
              <a:gd name="connsiteY5" fmla="*/ 362091 h 598659"/>
              <a:gd name="connsiteX6" fmla="*/ 894656 w 949897"/>
              <a:gd name="connsiteY6" fmla="*/ 558941 h 598659"/>
              <a:gd name="connsiteX7" fmla="*/ 75506 w 949897"/>
              <a:gd name="connsiteY7" fmla="*/ 577991 h 598659"/>
              <a:gd name="connsiteX0" fmla="*/ 75506 w 958289"/>
              <a:gd name="connsiteY0" fmla="*/ 577991 h 598659"/>
              <a:gd name="connsiteX1" fmla="*/ 43756 w 958289"/>
              <a:gd name="connsiteY1" fmla="*/ 323991 h 598659"/>
              <a:gd name="connsiteX2" fmla="*/ 139006 w 958289"/>
              <a:gd name="connsiteY2" fmla="*/ 101741 h 598659"/>
              <a:gd name="connsiteX3" fmla="*/ 399356 w 958289"/>
              <a:gd name="connsiteY3" fmla="*/ 141 h 598659"/>
              <a:gd name="connsiteX4" fmla="*/ 704156 w 958289"/>
              <a:gd name="connsiteY4" fmla="*/ 120791 h 598659"/>
              <a:gd name="connsiteX5" fmla="*/ 881956 w 958289"/>
              <a:gd name="connsiteY5" fmla="*/ 362091 h 598659"/>
              <a:gd name="connsiteX6" fmla="*/ 894656 w 958289"/>
              <a:gd name="connsiteY6" fmla="*/ 558941 h 598659"/>
              <a:gd name="connsiteX7" fmla="*/ 75506 w 958289"/>
              <a:gd name="connsiteY7" fmla="*/ 577991 h 598659"/>
              <a:gd name="connsiteX0" fmla="*/ 75506 w 958289"/>
              <a:gd name="connsiteY0" fmla="*/ 571657 h 592325"/>
              <a:gd name="connsiteX1" fmla="*/ 43756 w 958289"/>
              <a:gd name="connsiteY1" fmla="*/ 317657 h 592325"/>
              <a:gd name="connsiteX2" fmla="*/ 139006 w 958289"/>
              <a:gd name="connsiteY2" fmla="*/ 95407 h 592325"/>
              <a:gd name="connsiteX3" fmla="*/ 462856 w 958289"/>
              <a:gd name="connsiteY3" fmla="*/ 157 h 592325"/>
              <a:gd name="connsiteX4" fmla="*/ 704156 w 958289"/>
              <a:gd name="connsiteY4" fmla="*/ 114457 h 592325"/>
              <a:gd name="connsiteX5" fmla="*/ 881956 w 958289"/>
              <a:gd name="connsiteY5" fmla="*/ 355757 h 592325"/>
              <a:gd name="connsiteX6" fmla="*/ 894656 w 958289"/>
              <a:gd name="connsiteY6" fmla="*/ 552607 h 592325"/>
              <a:gd name="connsiteX7" fmla="*/ 75506 w 958289"/>
              <a:gd name="connsiteY7" fmla="*/ 571657 h 592325"/>
              <a:gd name="connsiteX0" fmla="*/ 77088 w 959871"/>
              <a:gd name="connsiteY0" fmla="*/ 571564 h 592232"/>
              <a:gd name="connsiteX1" fmla="*/ 45338 w 959871"/>
              <a:gd name="connsiteY1" fmla="*/ 317564 h 592232"/>
              <a:gd name="connsiteX2" fmla="*/ 172338 w 959871"/>
              <a:gd name="connsiteY2" fmla="*/ 101664 h 592232"/>
              <a:gd name="connsiteX3" fmla="*/ 464438 w 959871"/>
              <a:gd name="connsiteY3" fmla="*/ 64 h 592232"/>
              <a:gd name="connsiteX4" fmla="*/ 705738 w 959871"/>
              <a:gd name="connsiteY4" fmla="*/ 114364 h 592232"/>
              <a:gd name="connsiteX5" fmla="*/ 883538 w 959871"/>
              <a:gd name="connsiteY5" fmla="*/ 355664 h 592232"/>
              <a:gd name="connsiteX6" fmla="*/ 896238 w 959871"/>
              <a:gd name="connsiteY6" fmla="*/ 552514 h 592232"/>
              <a:gd name="connsiteX7" fmla="*/ 77088 w 959871"/>
              <a:gd name="connsiteY7" fmla="*/ 571564 h 592232"/>
              <a:gd name="connsiteX0" fmla="*/ 31750 w 914533"/>
              <a:gd name="connsiteY0" fmla="*/ 571564 h 592232"/>
              <a:gd name="connsiteX1" fmla="*/ 0 w 914533"/>
              <a:gd name="connsiteY1" fmla="*/ 317564 h 592232"/>
              <a:gd name="connsiteX2" fmla="*/ 127000 w 914533"/>
              <a:gd name="connsiteY2" fmla="*/ 101664 h 592232"/>
              <a:gd name="connsiteX3" fmla="*/ 419100 w 914533"/>
              <a:gd name="connsiteY3" fmla="*/ 64 h 592232"/>
              <a:gd name="connsiteX4" fmla="*/ 660400 w 914533"/>
              <a:gd name="connsiteY4" fmla="*/ 114364 h 592232"/>
              <a:gd name="connsiteX5" fmla="*/ 838200 w 914533"/>
              <a:gd name="connsiteY5" fmla="*/ 355664 h 592232"/>
              <a:gd name="connsiteX6" fmla="*/ 850900 w 914533"/>
              <a:gd name="connsiteY6" fmla="*/ 552514 h 592232"/>
              <a:gd name="connsiteX7" fmla="*/ 31750 w 914533"/>
              <a:gd name="connsiteY7" fmla="*/ 571564 h 592232"/>
              <a:gd name="connsiteX0" fmla="*/ 77088 w 959871"/>
              <a:gd name="connsiteY0" fmla="*/ 571564 h 592232"/>
              <a:gd name="connsiteX1" fmla="*/ 45338 w 959871"/>
              <a:gd name="connsiteY1" fmla="*/ 317564 h 592232"/>
              <a:gd name="connsiteX2" fmla="*/ 172338 w 959871"/>
              <a:gd name="connsiteY2" fmla="*/ 101664 h 592232"/>
              <a:gd name="connsiteX3" fmla="*/ 464438 w 959871"/>
              <a:gd name="connsiteY3" fmla="*/ 64 h 592232"/>
              <a:gd name="connsiteX4" fmla="*/ 705738 w 959871"/>
              <a:gd name="connsiteY4" fmla="*/ 114364 h 592232"/>
              <a:gd name="connsiteX5" fmla="*/ 883538 w 959871"/>
              <a:gd name="connsiteY5" fmla="*/ 355664 h 592232"/>
              <a:gd name="connsiteX6" fmla="*/ 896238 w 959871"/>
              <a:gd name="connsiteY6" fmla="*/ 552514 h 592232"/>
              <a:gd name="connsiteX7" fmla="*/ 77088 w 959871"/>
              <a:gd name="connsiteY7" fmla="*/ 571564 h 592232"/>
              <a:gd name="connsiteX0" fmla="*/ 77088 w 959871"/>
              <a:gd name="connsiteY0" fmla="*/ 571564 h 571564"/>
              <a:gd name="connsiteX1" fmla="*/ 45338 w 959871"/>
              <a:gd name="connsiteY1" fmla="*/ 317564 h 571564"/>
              <a:gd name="connsiteX2" fmla="*/ 172338 w 959871"/>
              <a:gd name="connsiteY2" fmla="*/ 101664 h 571564"/>
              <a:gd name="connsiteX3" fmla="*/ 464438 w 959871"/>
              <a:gd name="connsiteY3" fmla="*/ 64 h 571564"/>
              <a:gd name="connsiteX4" fmla="*/ 705738 w 959871"/>
              <a:gd name="connsiteY4" fmla="*/ 114364 h 571564"/>
              <a:gd name="connsiteX5" fmla="*/ 883538 w 959871"/>
              <a:gd name="connsiteY5" fmla="*/ 355664 h 571564"/>
              <a:gd name="connsiteX6" fmla="*/ 896238 w 959871"/>
              <a:gd name="connsiteY6" fmla="*/ 552514 h 571564"/>
              <a:gd name="connsiteX7" fmla="*/ 77088 w 959871"/>
              <a:gd name="connsiteY7" fmla="*/ 571564 h 571564"/>
              <a:gd name="connsiteX0" fmla="*/ 76704 w 955639"/>
              <a:gd name="connsiteY0" fmla="*/ 571564 h 592606"/>
              <a:gd name="connsiteX1" fmla="*/ 44954 w 955639"/>
              <a:gd name="connsiteY1" fmla="*/ 317564 h 592606"/>
              <a:gd name="connsiteX2" fmla="*/ 171954 w 955639"/>
              <a:gd name="connsiteY2" fmla="*/ 101664 h 592606"/>
              <a:gd name="connsiteX3" fmla="*/ 464054 w 955639"/>
              <a:gd name="connsiteY3" fmla="*/ 64 h 592606"/>
              <a:gd name="connsiteX4" fmla="*/ 705354 w 955639"/>
              <a:gd name="connsiteY4" fmla="*/ 114364 h 592606"/>
              <a:gd name="connsiteX5" fmla="*/ 883154 w 955639"/>
              <a:gd name="connsiteY5" fmla="*/ 355664 h 592606"/>
              <a:gd name="connsiteX6" fmla="*/ 890431 w 955639"/>
              <a:gd name="connsiteY6" fmla="*/ 579629 h 592606"/>
              <a:gd name="connsiteX7" fmla="*/ 76704 w 955639"/>
              <a:gd name="connsiteY7" fmla="*/ 571564 h 592606"/>
              <a:gd name="connsiteX0" fmla="*/ 78243 w 972971"/>
              <a:gd name="connsiteY0" fmla="*/ 571564 h 597283"/>
              <a:gd name="connsiteX1" fmla="*/ 46493 w 972971"/>
              <a:gd name="connsiteY1" fmla="*/ 317564 h 597283"/>
              <a:gd name="connsiteX2" fmla="*/ 173493 w 972971"/>
              <a:gd name="connsiteY2" fmla="*/ 101664 h 597283"/>
              <a:gd name="connsiteX3" fmla="*/ 465593 w 972971"/>
              <a:gd name="connsiteY3" fmla="*/ 64 h 597283"/>
              <a:gd name="connsiteX4" fmla="*/ 706893 w 972971"/>
              <a:gd name="connsiteY4" fmla="*/ 114364 h 597283"/>
              <a:gd name="connsiteX5" fmla="*/ 884693 w 972971"/>
              <a:gd name="connsiteY5" fmla="*/ 355664 h 597283"/>
              <a:gd name="connsiteX6" fmla="*/ 913662 w 972971"/>
              <a:gd name="connsiteY6" fmla="*/ 590475 h 597283"/>
              <a:gd name="connsiteX7" fmla="*/ 78243 w 972971"/>
              <a:gd name="connsiteY7" fmla="*/ 571564 h 597283"/>
              <a:gd name="connsiteX0" fmla="*/ 78243 w 972971"/>
              <a:gd name="connsiteY0" fmla="*/ 571564 h 590475"/>
              <a:gd name="connsiteX1" fmla="*/ 46493 w 972971"/>
              <a:gd name="connsiteY1" fmla="*/ 317564 h 590475"/>
              <a:gd name="connsiteX2" fmla="*/ 173493 w 972971"/>
              <a:gd name="connsiteY2" fmla="*/ 101664 h 590475"/>
              <a:gd name="connsiteX3" fmla="*/ 465593 w 972971"/>
              <a:gd name="connsiteY3" fmla="*/ 64 h 590475"/>
              <a:gd name="connsiteX4" fmla="*/ 706893 w 972971"/>
              <a:gd name="connsiteY4" fmla="*/ 114364 h 590475"/>
              <a:gd name="connsiteX5" fmla="*/ 884693 w 972971"/>
              <a:gd name="connsiteY5" fmla="*/ 355664 h 590475"/>
              <a:gd name="connsiteX6" fmla="*/ 913662 w 972971"/>
              <a:gd name="connsiteY6" fmla="*/ 590475 h 590475"/>
              <a:gd name="connsiteX7" fmla="*/ 78243 w 972971"/>
              <a:gd name="connsiteY7" fmla="*/ 571564 h 590475"/>
              <a:gd name="connsiteX0" fmla="*/ 71834 w 989860"/>
              <a:gd name="connsiteY0" fmla="*/ 593256 h 608606"/>
              <a:gd name="connsiteX1" fmla="*/ 61776 w 989860"/>
              <a:gd name="connsiteY1" fmla="*/ 317564 h 608606"/>
              <a:gd name="connsiteX2" fmla="*/ 188776 w 989860"/>
              <a:gd name="connsiteY2" fmla="*/ 101664 h 608606"/>
              <a:gd name="connsiteX3" fmla="*/ 480876 w 989860"/>
              <a:gd name="connsiteY3" fmla="*/ 64 h 608606"/>
              <a:gd name="connsiteX4" fmla="*/ 722176 w 989860"/>
              <a:gd name="connsiteY4" fmla="*/ 114364 h 608606"/>
              <a:gd name="connsiteX5" fmla="*/ 899976 w 989860"/>
              <a:gd name="connsiteY5" fmla="*/ 355664 h 608606"/>
              <a:gd name="connsiteX6" fmla="*/ 928945 w 989860"/>
              <a:gd name="connsiteY6" fmla="*/ 590475 h 608606"/>
              <a:gd name="connsiteX7" fmla="*/ 71834 w 989860"/>
              <a:gd name="connsiteY7" fmla="*/ 593256 h 608606"/>
              <a:gd name="connsiteX0" fmla="*/ 71834 w 989860"/>
              <a:gd name="connsiteY0" fmla="*/ 593569 h 608919"/>
              <a:gd name="connsiteX1" fmla="*/ 61776 w 989860"/>
              <a:gd name="connsiteY1" fmla="*/ 317877 h 608919"/>
              <a:gd name="connsiteX2" fmla="*/ 188776 w 989860"/>
              <a:gd name="connsiteY2" fmla="*/ 101977 h 608919"/>
              <a:gd name="connsiteX3" fmla="*/ 480876 w 989860"/>
              <a:gd name="connsiteY3" fmla="*/ 377 h 608919"/>
              <a:gd name="connsiteX4" fmla="*/ 834782 w 989860"/>
              <a:gd name="connsiteY4" fmla="*/ 134549 h 608919"/>
              <a:gd name="connsiteX5" fmla="*/ 899976 w 989860"/>
              <a:gd name="connsiteY5" fmla="*/ 355977 h 608919"/>
              <a:gd name="connsiteX6" fmla="*/ 928945 w 989860"/>
              <a:gd name="connsiteY6" fmla="*/ 590788 h 608919"/>
              <a:gd name="connsiteX7" fmla="*/ 71834 w 989860"/>
              <a:gd name="connsiteY7" fmla="*/ 593569 h 608919"/>
              <a:gd name="connsiteX0" fmla="*/ 71834 w 989860"/>
              <a:gd name="connsiteY0" fmla="*/ 573844 h 589194"/>
              <a:gd name="connsiteX1" fmla="*/ 61776 w 989860"/>
              <a:gd name="connsiteY1" fmla="*/ 298152 h 589194"/>
              <a:gd name="connsiteX2" fmla="*/ 188776 w 989860"/>
              <a:gd name="connsiteY2" fmla="*/ 82252 h 589194"/>
              <a:gd name="connsiteX3" fmla="*/ 646473 w 989860"/>
              <a:gd name="connsiteY3" fmla="*/ 523 h 589194"/>
              <a:gd name="connsiteX4" fmla="*/ 834782 w 989860"/>
              <a:gd name="connsiteY4" fmla="*/ 114824 h 589194"/>
              <a:gd name="connsiteX5" fmla="*/ 899976 w 989860"/>
              <a:gd name="connsiteY5" fmla="*/ 336252 h 589194"/>
              <a:gd name="connsiteX6" fmla="*/ 928945 w 989860"/>
              <a:gd name="connsiteY6" fmla="*/ 571063 h 589194"/>
              <a:gd name="connsiteX7" fmla="*/ 71834 w 989860"/>
              <a:gd name="connsiteY7" fmla="*/ 573844 h 589194"/>
              <a:gd name="connsiteX0" fmla="*/ 78274 w 996300"/>
              <a:gd name="connsiteY0" fmla="*/ 573334 h 588684"/>
              <a:gd name="connsiteX1" fmla="*/ 68216 w 996300"/>
              <a:gd name="connsiteY1" fmla="*/ 297642 h 588684"/>
              <a:gd name="connsiteX2" fmla="*/ 334318 w 996300"/>
              <a:gd name="connsiteY2" fmla="*/ 108237 h 588684"/>
              <a:gd name="connsiteX3" fmla="*/ 652913 w 996300"/>
              <a:gd name="connsiteY3" fmla="*/ 13 h 588684"/>
              <a:gd name="connsiteX4" fmla="*/ 841222 w 996300"/>
              <a:gd name="connsiteY4" fmla="*/ 114314 h 588684"/>
              <a:gd name="connsiteX5" fmla="*/ 906416 w 996300"/>
              <a:gd name="connsiteY5" fmla="*/ 335742 h 588684"/>
              <a:gd name="connsiteX6" fmla="*/ 935385 w 996300"/>
              <a:gd name="connsiteY6" fmla="*/ 570553 h 588684"/>
              <a:gd name="connsiteX7" fmla="*/ 78274 w 996300"/>
              <a:gd name="connsiteY7" fmla="*/ 573334 h 588684"/>
              <a:gd name="connsiteX0" fmla="*/ 64322 w 982348"/>
              <a:gd name="connsiteY0" fmla="*/ 573334 h 588684"/>
              <a:gd name="connsiteX1" fmla="*/ 100632 w 982348"/>
              <a:gd name="connsiteY1" fmla="*/ 310890 h 588684"/>
              <a:gd name="connsiteX2" fmla="*/ 320366 w 982348"/>
              <a:gd name="connsiteY2" fmla="*/ 108237 h 588684"/>
              <a:gd name="connsiteX3" fmla="*/ 638961 w 982348"/>
              <a:gd name="connsiteY3" fmla="*/ 13 h 588684"/>
              <a:gd name="connsiteX4" fmla="*/ 827270 w 982348"/>
              <a:gd name="connsiteY4" fmla="*/ 114314 h 588684"/>
              <a:gd name="connsiteX5" fmla="*/ 892464 w 982348"/>
              <a:gd name="connsiteY5" fmla="*/ 335742 h 588684"/>
              <a:gd name="connsiteX6" fmla="*/ 921433 w 982348"/>
              <a:gd name="connsiteY6" fmla="*/ 570553 h 588684"/>
              <a:gd name="connsiteX7" fmla="*/ 64322 w 982348"/>
              <a:gd name="connsiteY7" fmla="*/ 573334 h 5886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982348" h="588684">
                <a:moveTo>
                  <a:pt x="64322" y="573334"/>
                </a:moveTo>
                <a:cubicBezTo>
                  <a:pt x="-80206" y="527849"/>
                  <a:pt x="57958" y="388406"/>
                  <a:pt x="100632" y="310890"/>
                </a:cubicBezTo>
                <a:cubicBezTo>
                  <a:pt x="143306" y="233374"/>
                  <a:pt x="230645" y="160050"/>
                  <a:pt x="320366" y="108237"/>
                </a:cubicBezTo>
                <a:cubicBezTo>
                  <a:pt x="410087" y="56424"/>
                  <a:pt x="554477" y="-1000"/>
                  <a:pt x="638961" y="13"/>
                </a:cubicBezTo>
                <a:cubicBezTo>
                  <a:pt x="723445" y="1026"/>
                  <a:pt x="785020" y="58359"/>
                  <a:pt x="827270" y="114314"/>
                </a:cubicBezTo>
                <a:cubicBezTo>
                  <a:pt x="869520" y="170269"/>
                  <a:pt x="860714" y="262717"/>
                  <a:pt x="892464" y="335742"/>
                </a:cubicBezTo>
                <a:cubicBezTo>
                  <a:pt x="924214" y="408767"/>
                  <a:pt x="1059457" y="530954"/>
                  <a:pt x="921433" y="570553"/>
                </a:cubicBezTo>
                <a:cubicBezTo>
                  <a:pt x="783409" y="610152"/>
                  <a:pt x="350026" y="572407"/>
                  <a:pt x="64322" y="573334"/>
                </a:cubicBezTo>
                <a:close/>
              </a:path>
            </a:pathLst>
          </a:custGeom>
          <a:solidFill>
            <a:srgbClr val="00CC00"/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ko-KR" altLang="en-US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/>
              <a:ea typeface="맑은 고딕"/>
              <a:cs typeface="+mn-cs"/>
            </a:endParaRPr>
          </a:p>
        </p:txBody>
      </p:sp>
      <p:sp>
        <p:nvSpPr>
          <p:cNvPr id="76" name="자유형: 도형 476">
            <a:extLst>
              <a:ext uri="{FF2B5EF4-FFF2-40B4-BE49-F238E27FC236}">
                <a16:creationId xmlns:a16="http://schemas.microsoft.com/office/drawing/2014/main" id="{D96F97BC-78B1-4E7D-A4B1-770ECAE66A04}"/>
              </a:ext>
            </a:extLst>
          </p:cNvPr>
          <p:cNvSpPr/>
          <p:nvPr/>
        </p:nvSpPr>
        <p:spPr>
          <a:xfrm>
            <a:off x="2437962" y="2878510"/>
            <a:ext cx="576885" cy="354693"/>
          </a:xfrm>
          <a:custGeom>
            <a:avLst/>
            <a:gdLst>
              <a:gd name="connsiteX0" fmla="*/ 0 w 914400"/>
              <a:gd name="connsiteY0" fmla="*/ 590550 h 590550"/>
              <a:gd name="connsiteX1" fmla="*/ 44450 w 914400"/>
              <a:gd name="connsiteY1" fmla="*/ 330200 h 590550"/>
              <a:gd name="connsiteX2" fmla="*/ 209550 w 914400"/>
              <a:gd name="connsiteY2" fmla="*/ 120650 h 590550"/>
              <a:gd name="connsiteX3" fmla="*/ 361950 w 914400"/>
              <a:gd name="connsiteY3" fmla="*/ 0 h 590550"/>
              <a:gd name="connsiteX4" fmla="*/ 730250 w 914400"/>
              <a:gd name="connsiteY4" fmla="*/ 101600 h 590550"/>
              <a:gd name="connsiteX5" fmla="*/ 812800 w 914400"/>
              <a:gd name="connsiteY5" fmla="*/ 323850 h 590550"/>
              <a:gd name="connsiteX6" fmla="*/ 914400 w 914400"/>
              <a:gd name="connsiteY6" fmla="*/ 577850 h 590550"/>
              <a:gd name="connsiteX7" fmla="*/ 0 w 914400"/>
              <a:gd name="connsiteY7" fmla="*/ 590550 h 590550"/>
              <a:gd name="connsiteX0" fmla="*/ 0 w 914400"/>
              <a:gd name="connsiteY0" fmla="*/ 590691 h 590691"/>
              <a:gd name="connsiteX1" fmla="*/ 44450 w 914400"/>
              <a:gd name="connsiteY1" fmla="*/ 330341 h 590691"/>
              <a:gd name="connsiteX2" fmla="*/ 209550 w 914400"/>
              <a:gd name="connsiteY2" fmla="*/ 120791 h 590691"/>
              <a:gd name="connsiteX3" fmla="*/ 361950 w 914400"/>
              <a:gd name="connsiteY3" fmla="*/ 141 h 590691"/>
              <a:gd name="connsiteX4" fmla="*/ 730250 w 914400"/>
              <a:gd name="connsiteY4" fmla="*/ 101741 h 590691"/>
              <a:gd name="connsiteX5" fmla="*/ 812800 w 914400"/>
              <a:gd name="connsiteY5" fmla="*/ 323991 h 590691"/>
              <a:gd name="connsiteX6" fmla="*/ 914400 w 914400"/>
              <a:gd name="connsiteY6" fmla="*/ 577991 h 590691"/>
              <a:gd name="connsiteX7" fmla="*/ 0 w 914400"/>
              <a:gd name="connsiteY7" fmla="*/ 590691 h 590691"/>
              <a:gd name="connsiteX0" fmla="*/ 0 w 914400"/>
              <a:gd name="connsiteY0" fmla="*/ 590691 h 590691"/>
              <a:gd name="connsiteX1" fmla="*/ 44450 w 914400"/>
              <a:gd name="connsiteY1" fmla="*/ 330341 h 590691"/>
              <a:gd name="connsiteX2" fmla="*/ 209550 w 914400"/>
              <a:gd name="connsiteY2" fmla="*/ 120791 h 590691"/>
              <a:gd name="connsiteX3" fmla="*/ 361950 w 914400"/>
              <a:gd name="connsiteY3" fmla="*/ 141 h 590691"/>
              <a:gd name="connsiteX4" fmla="*/ 730250 w 914400"/>
              <a:gd name="connsiteY4" fmla="*/ 101741 h 590691"/>
              <a:gd name="connsiteX5" fmla="*/ 812800 w 914400"/>
              <a:gd name="connsiteY5" fmla="*/ 323991 h 590691"/>
              <a:gd name="connsiteX6" fmla="*/ 914400 w 914400"/>
              <a:gd name="connsiteY6" fmla="*/ 577991 h 590691"/>
              <a:gd name="connsiteX7" fmla="*/ 0 w 914400"/>
              <a:gd name="connsiteY7" fmla="*/ 590691 h 590691"/>
              <a:gd name="connsiteX0" fmla="*/ 0 w 914400"/>
              <a:gd name="connsiteY0" fmla="*/ 590694 h 590694"/>
              <a:gd name="connsiteX1" fmla="*/ 44450 w 914400"/>
              <a:gd name="connsiteY1" fmla="*/ 330344 h 590694"/>
              <a:gd name="connsiteX2" fmla="*/ 209550 w 914400"/>
              <a:gd name="connsiteY2" fmla="*/ 120794 h 590694"/>
              <a:gd name="connsiteX3" fmla="*/ 361950 w 914400"/>
              <a:gd name="connsiteY3" fmla="*/ 144 h 590694"/>
              <a:gd name="connsiteX4" fmla="*/ 730250 w 914400"/>
              <a:gd name="connsiteY4" fmla="*/ 101744 h 590694"/>
              <a:gd name="connsiteX5" fmla="*/ 850900 w 914400"/>
              <a:gd name="connsiteY5" fmla="*/ 330344 h 590694"/>
              <a:gd name="connsiteX6" fmla="*/ 914400 w 914400"/>
              <a:gd name="connsiteY6" fmla="*/ 577994 h 590694"/>
              <a:gd name="connsiteX7" fmla="*/ 0 w 914400"/>
              <a:gd name="connsiteY7" fmla="*/ 590694 h 590694"/>
              <a:gd name="connsiteX0" fmla="*/ 0 w 914400"/>
              <a:gd name="connsiteY0" fmla="*/ 590694 h 590694"/>
              <a:gd name="connsiteX1" fmla="*/ 44450 w 914400"/>
              <a:gd name="connsiteY1" fmla="*/ 330344 h 590694"/>
              <a:gd name="connsiteX2" fmla="*/ 209550 w 914400"/>
              <a:gd name="connsiteY2" fmla="*/ 120794 h 590694"/>
              <a:gd name="connsiteX3" fmla="*/ 361950 w 914400"/>
              <a:gd name="connsiteY3" fmla="*/ 144 h 590694"/>
              <a:gd name="connsiteX4" fmla="*/ 730250 w 914400"/>
              <a:gd name="connsiteY4" fmla="*/ 101744 h 590694"/>
              <a:gd name="connsiteX5" fmla="*/ 850900 w 914400"/>
              <a:gd name="connsiteY5" fmla="*/ 330344 h 590694"/>
              <a:gd name="connsiteX6" fmla="*/ 914400 w 914400"/>
              <a:gd name="connsiteY6" fmla="*/ 577994 h 590694"/>
              <a:gd name="connsiteX7" fmla="*/ 0 w 914400"/>
              <a:gd name="connsiteY7" fmla="*/ 590694 h 590694"/>
              <a:gd name="connsiteX0" fmla="*/ 0 w 914400"/>
              <a:gd name="connsiteY0" fmla="*/ 590694 h 590694"/>
              <a:gd name="connsiteX1" fmla="*/ 44450 w 914400"/>
              <a:gd name="connsiteY1" fmla="*/ 330344 h 590694"/>
              <a:gd name="connsiteX2" fmla="*/ 209550 w 914400"/>
              <a:gd name="connsiteY2" fmla="*/ 120794 h 590694"/>
              <a:gd name="connsiteX3" fmla="*/ 361950 w 914400"/>
              <a:gd name="connsiteY3" fmla="*/ 144 h 590694"/>
              <a:gd name="connsiteX4" fmla="*/ 730250 w 914400"/>
              <a:gd name="connsiteY4" fmla="*/ 101744 h 590694"/>
              <a:gd name="connsiteX5" fmla="*/ 850900 w 914400"/>
              <a:gd name="connsiteY5" fmla="*/ 330344 h 590694"/>
              <a:gd name="connsiteX6" fmla="*/ 914400 w 914400"/>
              <a:gd name="connsiteY6" fmla="*/ 577994 h 590694"/>
              <a:gd name="connsiteX7" fmla="*/ 0 w 914400"/>
              <a:gd name="connsiteY7" fmla="*/ 590694 h 590694"/>
              <a:gd name="connsiteX0" fmla="*/ 60980 w 975380"/>
              <a:gd name="connsiteY0" fmla="*/ 590694 h 590694"/>
              <a:gd name="connsiteX1" fmla="*/ 105430 w 975380"/>
              <a:gd name="connsiteY1" fmla="*/ 330344 h 590694"/>
              <a:gd name="connsiteX2" fmla="*/ 270530 w 975380"/>
              <a:gd name="connsiteY2" fmla="*/ 120794 h 590694"/>
              <a:gd name="connsiteX3" fmla="*/ 422930 w 975380"/>
              <a:gd name="connsiteY3" fmla="*/ 144 h 590694"/>
              <a:gd name="connsiteX4" fmla="*/ 791230 w 975380"/>
              <a:gd name="connsiteY4" fmla="*/ 101744 h 590694"/>
              <a:gd name="connsiteX5" fmla="*/ 911880 w 975380"/>
              <a:gd name="connsiteY5" fmla="*/ 330344 h 590694"/>
              <a:gd name="connsiteX6" fmla="*/ 975380 w 975380"/>
              <a:gd name="connsiteY6" fmla="*/ 577994 h 590694"/>
              <a:gd name="connsiteX7" fmla="*/ 60980 w 975380"/>
              <a:gd name="connsiteY7" fmla="*/ 590694 h 590694"/>
              <a:gd name="connsiteX0" fmla="*/ 60980 w 975380"/>
              <a:gd name="connsiteY0" fmla="*/ 590694 h 616688"/>
              <a:gd name="connsiteX1" fmla="*/ 105430 w 975380"/>
              <a:gd name="connsiteY1" fmla="*/ 330344 h 616688"/>
              <a:gd name="connsiteX2" fmla="*/ 270530 w 975380"/>
              <a:gd name="connsiteY2" fmla="*/ 120794 h 616688"/>
              <a:gd name="connsiteX3" fmla="*/ 422930 w 975380"/>
              <a:gd name="connsiteY3" fmla="*/ 144 h 616688"/>
              <a:gd name="connsiteX4" fmla="*/ 791230 w 975380"/>
              <a:gd name="connsiteY4" fmla="*/ 101744 h 616688"/>
              <a:gd name="connsiteX5" fmla="*/ 911880 w 975380"/>
              <a:gd name="connsiteY5" fmla="*/ 330344 h 616688"/>
              <a:gd name="connsiteX6" fmla="*/ 975380 w 975380"/>
              <a:gd name="connsiteY6" fmla="*/ 577994 h 616688"/>
              <a:gd name="connsiteX7" fmla="*/ 60980 w 975380"/>
              <a:gd name="connsiteY7" fmla="*/ 590694 h 616688"/>
              <a:gd name="connsiteX0" fmla="*/ 80378 w 918578"/>
              <a:gd name="connsiteY0" fmla="*/ 635144 h 649729"/>
              <a:gd name="connsiteX1" fmla="*/ 48628 w 918578"/>
              <a:gd name="connsiteY1" fmla="*/ 330344 h 649729"/>
              <a:gd name="connsiteX2" fmla="*/ 213728 w 918578"/>
              <a:gd name="connsiteY2" fmla="*/ 120794 h 649729"/>
              <a:gd name="connsiteX3" fmla="*/ 366128 w 918578"/>
              <a:gd name="connsiteY3" fmla="*/ 144 h 649729"/>
              <a:gd name="connsiteX4" fmla="*/ 734428 w 918578"/>
              <a:gd name="connsiteY4" fmla="*/ 101744 h 649729"/>
              <a:gd name="connsiteX5" fmla="*/ 855078 w 918578"/>
              <a:gd name="connsiteY5" fmla="*/ 330344 h 649729"/>
              <a:gd name="connsiteX6" fmla="*/ 918578 w 918578"/>
              <a:gd name="connsiteY6" fmla="*/ 577994 h 649729"/>
              <a:gd name="connsiteX7" fmla="*/ 80378 w 918578"/>
              <a:gd name="connsiteY7" fmla="*/ 635144 h 649729"/>
              <a:gd name="connsiteX0" fmla="*/ 80378 w 918578"/>
              <a:gd name="connsiteY0" fmla="*/ 584344 h 613042"/>
              <a:gd name="connsiteX1" fmla="*/ 48628 w 918578"/>
              <a:gd name="connsiteY1" fmla="*/ 330344 h 613042"/>
              <a:gd name="connsiteX2" fmla="*/ 213728 w 918578"/>
              <a:gd name="connsiteY2" fmla="*/ 120794 h 613042"/>
              <a:gd name="connsiteX3" fmla="*/ 366128 w 918578"/>
              <a:gd name="connsiteY3" fmla="*/ 144 h 613042"/>
              <a:gd name="connsiteX4" fmla="*/ 734428 w 918578"/>
              <a:gd name="connsiteY4" fmla="*/ 101744 h 613042"/>
              <a:gd name="connsiteX5" fmla="*/ 855078 w 918578"/>
              <a:gd name="connsiteY5" fmla="*/ 330344 h 613042"/>
              <a:gd name="connsiteX6" fmla="*/ 918578 w 918578"/>
              <a:gd name="connsiteY6" fmla="*/ 577994 h 613042"/>
              <a:gd name="connsiteX7" fmla="*/ 80378 w 918578"/>
              <a:gd name="connsiteY7" fmla="*/ 584344 h 613042"/>
              <a:gd name="connsiteX0" fmla="*/ 80378 w 919038"/>
              <a:gd name="connsiteY0" fmla="*/ 584344 h 628201"/>
              <a:gd name="connsiteX1" fmla="*/ 48628 w 919038"/>
              <a:gd name="connsiteY1" fmla="*/ 330344 h 628201"/>
              <a:gd name="connsiteX2" fmla="*/ 213728 w 919038"/>
              <a:gd name="connsiteY2" fmla="*/ 120794 h 628201"/>
              <a:gd name="connsiteX3" fmla="*/ 366128 w 919038"/>
              <a:gd name="connsiteY3" fmla="*/ 144 h 628201"/>
              <a:gd name="connsiteX4" fmla="*/ 734428 w 919038"/>
              <a:gd name="connsiteY4" fmla="*/ 101744 h 628201"/>
              <a:gd name="connsiteX5" fmla="*/ 855078 w 919038"/>
              <a:gd name="connsiteY5" fmla="*/ 330344 h 628201"/>
              <a:gd name="connsiteX6" fmla="*/ 918578 w 919038"/>
              <a:gd name="connsiteY6" fmla="*/ 577994 h 628201"/>
              <a:gd name="connsiteX7" fmla="*/ 80378 w 919038"/>
              <a:gd name="connsiteY7" fmla="*/ 584344 h 628201"/>
              <a:gd name="connsiteX0" fmla="*/ 76368 w 861839"/>
              <a:gd name="connsiteY0" fmla="*/ 584344 h 616919"/>
              <a:gd name="connsiteX1" fmla="*/ 44618 w 861839"/>
              <a:gd name="connsiteY1" fmla="*/ 330344 h 616919"/>
              <a:gd name="connsiteX2" fmla="*/ 209718 w 861839"/>
              <a:gd name="connsiteY2" fmla="*/ 120794 h 616919"/>
              <a:gd name="connsiteX3" fmla="*/ 362118 w 861839"/>
              <a:gd name="connsiteY3" fmla="*/ 144 h 616919"/>
              <a:gd name="connsiteX4" fmla="*/ 730418 w 861839"/>
              <a:gd name="connsiteY4" fmla="*/ 101744 h 616919"/>
              <a:gd name="connsiteX5" fmla="*/ 851068 w 861839"/>
              <a:gd name="connsiteY5" fmla="*/ 330344 h 616919"/>
              <a:gd name="connsiteX6" fmla="*/ 857418 w 861839"/>
              <a:gd name="connsiteY6" fmla="*/ 558944 h 616919"/>
              <a:gd name="connsiteX7" fmla="*/ 76368 w 861839"/>
              <a:gd name="connsiteY7" fmla="*/ 584344 h 616919"/>
              <a:gd name="connsiteX0" fmla="*/ 76368 w 861839"/>
              <a:gd name="connsiteY0" fmla="*/ 578011 h 610586"/>
              <a:gd name="connsiteX1" fmla="*/ 44618 w 861839"/>
              <a:gd name="connsiteY1" fmla="*/ 324011 h 610586"/>
              <a:gd name="connsiteX2" fmla="*/ 209718 w 861839"/>
              <a:gd name="connsiteY2" fmla="*/ 114461 h 610586"/>
              <a:gd name="connsiteX3" fmla="*/ 400218 w 861839"/>
              <a:gd name="connsiteY3" fmla="*/ 161 h 610586"/>
              <a:gd name="connsiteX4" fmla="*/ 730418 w 861839"/>
              <a:gd name="connsiteY4" fmla="*/ 95411 h 610586"/>
              <a:gd name="connsiteX5" fmla="*/ 851068 w 861839"/>
              <a:gd name="connsiteY5" fmla="*/ 324011 h 610586"/>
              <a:gd name="connsiteX6" fmla="*/ 857418 w 861839"/>
              <a:gd name="connsiteY6" fmla="*/ 552611 h 610586"/>
              <a:gd name="connsiteX7" fmla="*/ 76368 w 861839"/>
              <a:gd name="connsiteY7" fmla="*/ 578011 h 610586"/>
              <a:gd name="connsiteX0" fmla="*/ 72787 w 858258"/>
              <a:gd name="connsiteY0" fmla="*/ 577870 h 610445"/>
              <a:gd name="connsiteX1" fmla="*/ 41037 w 858258"/>
              <a:gd name="connsiteY1" fmla="*/ 323870 h 610445"/>
              <a:gd name="connsiteX2" fmla="*/ 136287 w 858258"/>
              <a:gd name="connsiteY2" fmla="*/ 101620 h 610445"/>
              <a:gd name="connsiteX3" fmla="*/ 396637 w 858258"/>
              <a:gd name="connsiteY3" fmla="*/ 20 h 610445"/>
              <a:gd name="connsiteX4" fmla="*/ 726837 w 858258"/>
              <a:gd name="connsiteY4" fmla="*/ 95270 h 610445"/>
              <a:gd name="connsiteX5" fmla="*/ 847487 w 858258"/>
              <a:gd name="connsiteY5" fmla="*/ 323870 h 610445"/>
              <a:gd name="connsiteX6" fmla="*/ 853837 w 858258"/>
              <a:gd name="connsiteY6" fmla="*/ 552470 h 610445"/>
              <a:gd name="connsiteX7" fmla="*/ 72787 w 858258"/>
              <a:gd name="connsiteY7" fmla="*/ 577870 h 610445"/>
              <a:gd name="connsiteX0" fmla="*/ 72787 w 860103"/>
              <a:gd name="connsiteY0" fmla="*/ 577991 h 610566"/>
              <a:gd name="connsiteX1" fmla="*/ 41037 w 860103"/>
              <a:gd name="connsiteY1" fmla="*/ 323991 h 610566"/>
              <a:gd name="connsiteX2" fmla="*/ 136287 w 860103"/>
              <a:gd name="connsiteY2" fmla="*/ 101741 h 610566"/>
              <a:gd name="connsiteX3" fmla="*/ 396637 w 860103"/>
              <a:gd name="connsiteY3" fmla="*/ 141 h 610566"/>
              <a:gd name="connsiteX4" fmla="*/ 701437 w 860103"/>
              <a:gd name="connsiteY4" fmla="*/ 120791 h 610566"/>
              <a:gd name="connsiteX5" fmla="*/ 847487 w 860103"/>
              <a:gd name="connsiteY5" fmla="*/ 323991 h 610566"/>
              <a:gd name="connsiteX6" fmla="*/ 853837 w 860103"/>
              <a:gd name="connsiteY6" fmla="*/ 552591 h 610566"/>
              <a:gd name="connsiteX7" fmla="*/ 72787 w 860103"/>
              <a:gd name="connsiteY7" fmla="*/ 577991 h 610566"/>
              <a:gd name="connsiteX0" fmla="*/ 72787 w 895070"/>
              <a:gd name="connsiteY0" fmla="*/ 577991 h 596838"/>
              <a:gd name="connsiteX1" fmla="*/ 41037 w 895070"/>
              <a:gd name="connsiteY1" fmla="*/ 323991 h 596838"/>
              <a:gd name="connsiteX2" fmla="*/ 136287 w 895070"/>
              <a:gd name="connsiteY2" fmla="*/ 101741 h 596838"/>
              <a:gd name="connsiteX3" fmla="*/ 396637 w 895070"/>
              <a:gd name="connsiteY3" fmla="*/ 141 h 596838"/>
              <a:gd name="connsiteX4" fmla="*/ 701437 w 895070"/>
              <a:gd name="connsiteY4" fmla="*/ 120791 h 596838"/>
              <a:gd name="connsiteX5" fmla="*/ 777637 w 895070"/>
              <a:gd name="connsiteY5" fmla="*/ 349391 h 596838"/>
              <a:gd name="connsiteX6" fmla="*/ 853837 w 895070"/>
              <a:gd name="connsiteY6" fmla="*/ 552591 h 596838"/>
              <a:gd name="connsiteX7" fmla="*/ 72787 w 895070"/>
              <a:gd name="connsiteY7" fmla="*/ 577991 h 596838"/>
              <a:gd name="connsiteX0" fmla="*/ 72787 w 917761"/>
              <a:gd name="connsiteY0" fmla="*/ 577991 h 596343"/>
              <a:gd name="connsiteX1" fmla="*/ 41037 w 917761"/>
              <a:gd name="connsiteY1" fmla="*/ 323991 h 596343"/>
              <a:gd name="connsiteX2" fmla="*/ 136287 w 917761"/>
              <a:gd name="connsiteY2" fmla="*/ 101741 h 596343"/>
              <a:gd name="connsiteX3" fmla="*/ 396637 w 917761"/>
              <a:gd name="connsiteY3" fmla="*/ 141 h 596343"/>
              <a:gd name="connsiteX4" fmla="*/ 701437 w 917761"/>
              <a:gd name="connsiteY4" fmla="*/ 120791 h 596343"/>
              <a:gd name="connsiteX5" fmla="*/ 853837 w 917761"/>
              <a:gd name="connsiteY5" fmla="*/ 362091 h 596343"/>
              <a:gd name="connsiteX6" fmla="*/ 853837 w 917761"/>
              <a:gd name="connsiteY6" fmla="*/ 552591 h 596343"/>
              <a:gd name="connsiteX7" fmla="*/ 72787 w 917761"/>
              <a:gd name="connsiteY7" fmla="*/ 577991 h 596343"/>
              <a:gd name="connsiteX0" fmla="*/ 75506 w 949897"/>
              <a:gd name="connsiteY0" fmla="*/ 577991 h 598659"/>
              <a:gd name="connsiteX1" fmla="*/ 43756 w 949897"/>
              <a:gd name="connsiteY1" fmla="*/ 323991 h 598659"/>
              <a:gd name="connsiteX2" fmla="*/ 139006 w 949897"/>
              <a:gd name="connsiteY2" fmla="*/ 101741 h 598659"/>
              <a:gd name="connsiteX3" fmla="*/ 399356 w 949897"/>
              <a:gd name="connsiteY3" fmla="*/ 141 h 598659"/>
              <a:gd name="connsiteX4" fmla="*/ 704156 w 949897"/>
              <a:gd name="connsiteY4" fmla="*/ 120791 h 598659"/>
              <a:gd name="connsiteX5" fmla="*/ 856556 w 949897"/>
              <a:gd name="connsiteY5" fmla="*/ 362091 h 598659"/>
              <a:gd name="connsiteX6" fmla="*/ 894656 w 949897"/>
              <a:gd name="connsiteY6" fmla="*/ 558941 h 598659"/>
              <a:gd name="connsiteX7" fmla="*/ 75506 w 949897"/>
              <a:gd name="connsiteY7" fmla="*/ 577991 h 598659"/>
              <a:gd name="connsiteX0" fmla="*/ 75506 w 958289"/>
              <a:gd name="connsiteY0" fmla="*/ 577991 h 598659"/>
              <a:gd name="connsiteX1" fmla="*/ 43756 w 958289"/>
              <a:gd name="connsiteY1" fmla="*/ 323991 h 598659"/>
              <a:gd name="connsiteX2" fmla="*/ 139006 w 958289"/>
              <a:gd name="connsiteY2" fmla="*/ 101741 h 598659"/>
              <a:gd name="connsiteX3" fmla="*/ 399356 w 958289"/>
              <a:gd name="connsiteY3" fmla="*/ 141 h 598659"/>
              <a:gd name="connsiteX4" fmla="*/ 704156 w 958289"/>
              <a:gd name="connsiteY4" fmla="*/ 120791 h 598659"/>
              <a:gd name="connsiteX5" fmla="*/ 881956 w 958289"/>
              <a:gd name="connsiteY5" fmla="*/ 362091 h 598659"/>
              <a:gd name="connsiteX6" fmla="*/ 894656 w 958289"/>
              <a:gd name="connsiteY6" fmla="*/ 558941 h 598659"/>
              <a:gd name="connsiteX7" fmla="*/ 75506 w 958289"/>
              <a:gd name="connsiteY7" fmla="*/ 577991 h 598659"/>
              <a:gd name="connsiteX0" fmla="*/ 75506 w 958289"/>
              <a:gd name="connsiteY0" fmla="*/ 571657 h 592325"/>
              <a:gd name="connsiteX1" fmla="*/ 43756 w 958289"/>
              <a:gd name="connsiteY1" fmla="*/ 317657 h 592325"/>
              <a:gd name="connsiteX2" fmla="*/ 139006 w 958289"/>
              <a:gd name="connsiteY2" fmla="*/ 95407 h 592325"/>
              <a:gd name="connsiteX3" fmla="*/ 462856 w 958289"/>
              <a:gd name="connsiteY3" fmla="*/ 157 h 592325"/>
              <a:gd name="connsiteX4" fmla="*/ 704156 w 958289"/>
              <a:gd name="connsiteY4" fmla="*/ 114457 h 592325"/>
              <a:gd name="connsiteX5" fmla="*/ 881956 w 958289"/>
              <a:gd name="connsiteY5" fmla="*/ 355757 h 592325"/>
              <a:gd name="connsiteX6" fmla="*/ 894656 w 958289"/>
              <a:gd name="connsiteY6" fmla="*/ 552607 h 592325"/>
              <a:gd name="connsiteX7" fmla="*/ 75506 w 958289"/>
              <a:gd name="connsiteY7" fmla="*/ 571657 h 592325"/>
              <a:gd name="connsiteX0" fmla="*/ 77088 w 959871"/>
              <a:gd name="connsiteY0" fmla="*/ 571564 h 592232"/>
              <a:gd name="connsiteX1" fmla="*/ 45338 w 959871"/>
              <a:gd name="connsiteY1" fmla="*/ 317564 h 592232"/>
              <a:gd name="connsiteX2" fmla="*/ 172338 w 959871"/>
              <a:gd name="connsiteY2" fmla="*/ 101664 h 592232"/>
              <a:gd name="connsiteX3" fmla="*/ 464438 w 959871"/>
              <a:gd name="connsiteY3" fmla="*/ 64 h 592232"/>
              <a:gd name="connsiteX4" fmla="*/ 705738 w 959871"/>
              <a:gd name="connsiteY4" fmla="*/ 114364 h 592232"/>
              <a:gd name="connsiteX5" fmla="*/ 883538 w 959871"/>
              <a:gd name="connsiteY5" fmla="*/ 355664 h 592232"/>
              <a:gd name="connsiteX6" fmla="*/ 896238 w 959871"/>
              <a:gd name="connsiteY6" fmla="*/ 552514 h 592232"/>
              <a:gd name="connsiteX7" fmla="*/ 77088 w 959871"/>
              <a:gd name="connsiteY7" fmla="*/ 571564 h 592232"/>
              <a:gd name="connsiteX0" fmla="*/ 31750 w 914533"/>
              <a:gd name="connsiteY0" fmla="*/ 571564 h 592232"/>
              <a:gd name="connsiteX1" fmla="*/ 0 w 914533"/>
              <a:gd name="connsiteY1" fmla="*/ 317564 h 592232"/>
              <a:gd name="connsiteX2" fmla="*/ 127000 w 914533"/>
              <a:gd name="connsiteY2" fmla="*/ 101664 h 592232"/>
              <a:gd name="connsiteX3" fmla="*/ 419100 w 914533"/>
              <a:gd name="connsiteY3" fmla="*/ 64 h 592232"/>
              <a:gd name="connsiteX4" fmla="*/ 660400 w 914533"/>
              <a:gd name="connsiteY4" fmla="*/ 114364 h 592232"/>
              <a:gd name="connsiteX5" fmla="*/ 838200 w 914533"/>
              <a:gd name="connsiteY5" fmla="*/ 355664 h 592232"/>
              <a:gd name="connsiteX6" fmla="*/ 850900 w 914533"/>
              <a:gd name="connsiteY6" fmla="*/ 552514 h 592232"/>
              <a:gd name="connsiteX7" fmla="*/ 31750 w 914533"/>
              <a:gd name="connsiteY7" fmla="*/ 571564 h 592232"/>
              <a:gd name="connsiteX0" fmla="*/ 77088 w 959871"/>
              <a:gd name="connsiteY0" fmla="*/ 571564 h 592232"/>
              <a:gd name="connsiteX1" fmla="*/ 45338 w 959871"/>
              <a:gd name="connsiteY1" fmla="*/ 317564 h 592232"/>
              <a:gd name="connsiteX2" fmla="*/ 172338 w 959871"/>
              <a:gd name="connsiteY2" fmla="*/ 101664 h 592232"/>
              <a:gd name="connsiteX3" fmla="*/ 464438 w 959871"/>
              <a:gd name="connsiteY3" fmla="*/ 64 h 592232"/>
              <a:gd name="connsiteX4" fmla="*/ 705738 w 959871"/>
              <a:gd name="connsiteY4" fmla="*/ 114364 h 592232"/>
              <a:gd name="connsiteX5" fmla="*/ 883538 w 959871"/>
              <a:gd name="connsiteY5" fmla="*/ 355664 h 592232"/>
              <a:gd name="connsiteX6" fmla="*/ 896238 w 959871"/>
              <a:gd name="connsiteY6" fmla="*/ 552514 h 592232"/>
              <a:gd name="connsiteX7" fmla="*/ 77088 w 959871"/>
              <a:gd name="connsiteY7" fmla="*/ 571564 h 592232"/>
              <a:gd name="connsiteX0" fmla="*/ 77088 w 959871"/>
              <a:gd name="connsiteY0" fmla="*/ 571564 h 571564"/>
              <a:gd name="connsiteX1" fmla="*/ 45338 w 959871"/>
              <a:gd name="connsiteY1" fmla="*/ 317564 h 571564"/>
              <a:gd name="connsiteX2" fmla="*/ 172338 w 959871"/>
              <a:gd name="connsiteY2" fmla="*/ 101664 h 571564"/>
              <a:gd name="connsiteX3" fmla="*/ 464438 w 959871"/>
              <a:gd name="connsiteY3" fmla="*/ 64 h 571564"/>
              <a:gd name="connsiteX4" fmla="*/ 705738 w 959871"/>
              <a:gd name="connsiteY4" fmla="*/ 114364 h 571564"/>
              <a:gd name="connsiteX5" fmla="*/ 883538 w 959871"/>
              <a:gd name="connsiteY5" fmla="*/ 355664 h 571564"/>
              <a:gd name="connsiteX6" fmla="*/ 896238 w 959871"/>
              <a:gd name="connsiteY6" fmla="*/ 552514 h 571564"/>
              <a:gd name="connsiteX7" fmla="*/ 77088 w 959871"/>
              <a:gd name="connsiteY7" fmla="*/ 571564 h 571564"/>
              <a:gd name="connsiteX0" fmla="*/ 76704 w 955639"/>
              <a:gd name="connsiteY0" fmla="*/ 571564 h 592606"/>
              <a:gd name="connsiteX1" fmla="*/ 44954 w 955639"/>
              <a:gd name="connsiteY1" fmla="*/ 317564 h 592606"/>
              <a:gd name="connsiteX2" fmla="*/ 171954 w 955639"/>
              <a:gd name="connsiteY2" fmla="*/ 101664 h 592606"/>
              <a:gd name="connsiteX3" fmla="*/ 464054 w 955639"/>
              <a:gd name="connsiteY3" fmla="*/ 64 h 592606"/>
              <a:gd name="connsiteX4" fmla="*/ 705354 w 955639"/>
              <a:gd name="connsiteY4" fmla="*/ 114364 h 592606"/>
              <a:gd name="connsiteX5" fmla="*/ 883154 w 955639"/>
              <a:gd name="connsiteY5" fmla="*/ 355664 h 592606"/>
              <a:gd name="connsiteX6" fmla="*/ 890431 w 955639"/>
              <a:gd name="connsiteY6" fmla="*/ 579629 h 592606"/>
              <a:gd name="connsiteX7" fmla="*/ 76704 w 955639"/>
              <a:gd name="connsiteY7" fmla="*/ 571564 h 592606"/>
              <a:gd name="connsiteX0" fmla="*/ 78243 w 972971"/>
              <a:gd name="connsiteY0" fmla="*/ 571564 h 597283"/>
              <a:gd name="connsiteX1" fmla="*/ 46493 w 972971"/>
              <a:gd name="connsiteY1" fmla="*/ 317564 h 597283"/>
              <a:gd name="connsiteX2" fmla="*/ 173493 w 972971"/>
              <a:gd name="connsiteY2" fmla="*/ 101664 h 597283"/>
              <a:gd name="connsiteX3" fmla="*/ 465593 w 972971"/>
              <a:gd name="connsiteY3" fmla="*/ 64 h 597283"/>
              <a:gd name="connsiteX4" fmla="*/ 706893 w 972971"/>
              <a:gd name="connsiteY4" fmla="*/ 114364 h 597283"/>
              <a:gd name="connsiteX5" fmla="*/ 884693 w 972971"/>
              <a:gd name="connsiteY5" fmla="*/ 355664 h 597283"/>
              <a:gd name="connsiteX6" fmla="*/ 913662 w 972971"/>
              <a:gd name="connsiteY6" fmla="*/ 590475 h 597283"/>
              <a:gd name="connsiteX7" fmla="*/ 78243 w 972971"/>
              <a:gd name="connsiteY7" fmla="*/ 571564 h 597283"/>
              <a:gd name="connsiteX0" fmla="*/ 78243 w 972971"/>
              <a:gd name="connsiteY0" fmla="*/ 571564 h 590475"/>
              <a:gd name="connsiteX1" fmla="*/ 46493 w 972971"/>
              <a:gd name="connsiteY1" fmla="*/ 317564 h 590475"/>
              <a:gd name="connsiteX2" fmla="*/ 173493 w 972971"/>
              <a:gd name="connsiteY2" fmla="*/ 101664 h 590475"/>
              <a:gd name="connsiteX3" fmla="*/ 465593 w 972971"/>
              <a:gd name="connsiteY3" fmla="*/ 64 h 590475"/>
              <a:gd name="connsiteX4" fmla="*/ 706893 w 972971"/>
              <a:gd name="connsiteY4" fmla="*/ 114364 h 590475"/>
              <a:gd name="connsiteX5" fmla="*/ 884693 w 972971"/>
              <a:gd name="connsiteY5" fmla="*/ 355664 h 590475"/>
              <a:gd name="connsiteX6" fmla="*/ 913662 w 972971"/>
              <a:gd name="connsiteY6" fmla="*/ 590475 h 590475"/>
              <a:gd name="connsiteX7" fmla="*/ 78243 w 972971"/>
              <a:gd name="connsiteY7" fmla="*/ 571564 h 590475"/>
              <a:gd name="connsiteX0" fmla="*/ 71834 w 989860"/>
              <a:gd name="connsiteY0" fmla="*/ 593256 h 608606"/>
              <a:gd name="connsiteX1" fmla="*/ 61776 w 989860"/>
              <a:gd name="connsiteY1" fmla="*/ 317564 h 608606"/>
              <a:gd name="connsiteX2" fmla="*/ 188776 w 989860"/>
              <a:gd name="connsiteY2" fmla="*/ 101664 h 608606"/>
              <a:gd name="connsiteX3" fmla="*/ 480876 w 989860"/>
              <a:gd name="connsiteY3" fmla="*/ 64 h 608606"/>
              <a:gd name="connsiteX4" fmla="*/ 722176 w 989860"/>
              <a:gd name="connsiteY4" fmla="*/ 114364 h 608606"/>
              <a:gd name="connsiteX5" fmla="*/ 899976 w 989860"/>
              <a:gd name="connsiteY5" fmla="*/ 355664 h 608606"/>
              <a:gd name="connsiteX6" fmla="*/ 928945 w 989860"/>
              <a:gd name="connsiteY6" fmla="*/ 590475 h 608606"/>
              <a:gd name="connsiteX7" fmla="*/ 71834 w 989860"/>
              <a:gd name="connsiteY7" fmla="*/ 593256 h 60860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989860" h="608606">
                <a:moveTo>
                  <a:pt x="71834" y="593256"/>
                </a:moveTo>
                <a:cubicBezTo>
                  <a:pt x="-72694" y="547771"/>
                  <a:pt x="42286" y="399496"/>
                  <a:pt x="61776" y="317564"/>
                </a:cubicBezTo>
                <a:cubicBezTo>
                  <a:pt x="81266" y="235632"/>
                  <a:pt x="118926" y="154581"/>
                  <a:pt x="188776" y="101664"/>
                </a:cubicBezTo>
                <a:cubicBezTo>
                  <a:pt x="258626" y="48747"/>
                  <a:pt x="391976" y="-2053"/>
                  <a:pt x="480876" y="64"/>
                </a:cubicBezTo>
                <a:cubicBezTo>
                  <a:pt x="569776" y="2181"/>
                  <a:pt x="652326" y="55097"/>
                  <a:pt x="722176" y="114364"/>
                </a:cubicBezTo>
                <a:cubicBezTo>
                  <a:pt x="792026" y="173631"/>
                  <a:pt x="868226" y="282639"/>
                  <a:pt x="899976" y="355664"/>
                </a:cubicBezTo>
                <a:cubicBezTo>
                  <a:pt x="931726" y="428689"/>
                  <a:pt x="1066969" y="550876"/>
                  <a:pt x="928945" y="590475"/>
                </a:cubicBezTo>
                <a:cubicBezTo>
                  <a:pt x="790921" y="630074"/>
                  <a:pt x="357538" y="592329"/>
                  <a:pt x="71834" y="593256"/>
                </a:cubicBezTo>
                <a:close/>
              </a:path>
            </a:pathLst>
          </a:custGeom>
          <a:solidFill>
            <a:srgbClr val="00CC00"/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ko-KR" altLang="en-US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/>
              <a:ea typeface="맑은 고딕"/>
              <a:cs typeface="+mn-cs"/>
            </a:endParaRPr>
          </a:p>
        </p:txBody>
      </p:sp>
      <p:sp>
        <p:nvSpPr>
          <p:cNvPr id="77" name="직사각형 76">
            <a:extLst>
              <a:ext uri="{FF2B5EF4-FFF2-40B4-BE49-F238E27FC236}">
                <a16:creationId xmlns:a16="http://schemas.microsoft.com/office/drawing/2014/main" id="{5CBB9C3F-772A-41BD-BC0C-32880253E47B}"/>
              </a:ext>
            </a:extLst>
          </p:cNvPr>
          <p:cNvSpPr/>
          <p:nvPr/>
        </p:nvSpPr>
        <p:spPr>
          <a:xfrm>
            <a:off x="2347948" y="3225399"/>
            <a:ext cx="1493471" cy="98848"/>
          </a:xfrm>
          <a:prstGeom prst="rect">
            <a:avLst/>
          </a:prstGeom>
          <a:solidFill>
            <a:srgbClr val="3A4858">
              <a:lumMod val="20000"/>
              <a:lumOff val="80000"/>
            </a:srgbClr>
          </a:soli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ko-KR" altLang="en-US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/>
              <a:ea typeface="맑은 고딕"/>
              <a:cs typeface="+mn-cs"/>
            </a:endParaRPr>
          </a:p>
        </p:txBody>
      </p:sp>
      <p:grpSp>
        <p:nvGrpSpPr>
          <p:cNvPr id="78" name="그룹 77">
            <a:extLst>
              <a:ext uri="{FF2B5EF4-FFF2-40B4-BE49-F238E27FC236}">
                <a16:creationId xmlns:a16="http://schemas.microsoft.com/office/drawing/2014/main" id="{ED6AAE8B-0E1A-453B-B241-924653EF75D2}"/>
              </a:ext>
            </a:extLst>
          </p:cNvPr>
          <p:cNvGrpSpPr/>
          <p:nvPr/>
        </p:nvGrpSpPr>
        <p:grpSpPr>
          <a:xfrm rot="10800000">
            <a:off x="2730967" y="2933686"/>
            <a:ext cx="70913" cy="48223"/>
            <a:chOff x="9017763" y="2551103"/>
            <a:chExt cx="116646" cy="79323"/>
          </a:xfrm>
        </p:grpSpPr>
        <p:sp>
          <p:nvSpPr>
            <p:cNvPr id="148" name="타원 147">
              <a:extLst>
                <a:ext uri="{FF2B5EF4-FFF2-40B4-BE49-F238E27FC236}">
                  <a16:creationId xmlns:a16="http://schemas.microsoft.com/office/drawing/2014/main" id="{CEE5B36C-8A17-4648-A694-7F9794695848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49" name="타원 148">
              <a:extLst>
                <a:ext uri="{FF2B5EF4-FFF2-40B4-BE49-F238E27FC236}">
                  <a16:creationId xmlns:a16="http://schemas.microsoft.com/office/drawing/2014/main" id="{B7489099-1DF4-4E5F-8FC5-2E85EF807520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79" name="그룹 78">
            <a:extLst>
              <a:ext uri="{FF2B5EF4-FFF2-40B4-BE49-F238E27FC236}">
                <a16:creationId xmlns:a16="http://schemas.microsoft.com/office/drawing/2014/main" id="{A133AF26-7E76-4DE4-BE77-A86DF03AD3CB}"/>
              </a:ext>
            </a:extLst>
          </p:cNvPr>
          <p:cNvGrpSpPr/>
          <p:nvPr/>
        </p:nvGrpSpPr>
        <p:grpSpPr>
          <a:xfrm rot="10800000">
            <a:off x="3498915" y="2960140"/>
            <a:ext cx="70913" cy="48223"/>
            <a:chOff x="9017763" y="2551103"/>
            <a:chExt cx="116646" cy="79323"/>
          </a:xfrm>
        </p:grpSpPr>
        <p:sp>
          <p:nvSpPr>
            <p:cNvPr id="146" name="타원 145">
              <a:extLst>
                <a:ext uri="{FF2B5EF4-FFF2-40B4-BE49-F238E27FC236}">
                  <a16:creationId xmlns:a16="http://schemas.microsoft.com/office/drawing/2014/main" id="{C774B20D-B766-47DA-A336-98893DE45FEA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47" name="타원 146">
              <a:extLst>
                <a:ext uri="{FF2B5EF4-FFF2-40B4-BE49-F238E27FC236}">
                  <a16:creationId xmlns:a16="http://schemas.microsoft.com/office/drawing/2014/main" id="{654D9749-1EBA-493B-9778-C6D6542E4AC3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80" name="그룹 79">
            <a:extLst>
              <a:ext uri="{FF2B5EF4-FFF2-40B4-BE49-F238E27FC236}">
                <a16:creationId xmlns:a16="http://schemas.microsoft.com/office/drawing/2014/main" id="{0DAE4866-6839-4C0F-A04A-34658ACEA1A1}"/>
              </a:ext>
            </a:extLst>
          </p:cNvPr>
          <p:cNvGrpSpPr/>
          <p:nvPr/>
        </p:nvGrpSpPr>
        <p:grpSpPr>
          <a:xfrm rot="10800000">
            <a:off x="2562240" y="2926659"/>
            <a:ext cx="70913" cy="48223"/>
            <a:chOff x="9017763" y="2551103"/>
            <a:chExt cx="116646" cy="79323"/>
          </a:xfrm>
        </p:grpSpPr>
        <p:sp>
          <p:nvSpPr>
            <p:cNvPr id="144" name="타원 143">
              <a:extLst>
                <a:ext uri="{FF2B5EF4-FFF2-40B4-BE49-F238E27FC236}">
                  <a16:creationId xmlns:a16="http://schemas.microsoft.com/office/drawing/2014/main" id="{5D3D7D68-242A-476D-904D-6CBA666ADB9F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45" name="타원 144">
              <a:extLst>
                <a:ext uri="{FF2B5EF4-FFF2-40B4-BE49-F238E27FC236}">
                  <a16:creationId xmlns:a16="http://schemas.microsoft.com/office/drawing/2014/main" id="{352EFFC8-F515-4954-AC9B-58EE33FEF6CD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81" name="그룹 80">
            <a:extLst>
              <a:ext uri="{FF2B5EF4-FFF2-40B4-BE49-F238E27FC236}">
                <a16:creationId xmlns:a16="http://schemas.microsoft.com/office/drawing/2014/main" id="{CCEF48EB-A3CC-42B7-ABFE-734EC30A30BF}"/>
              </a:ext>
            </a:extLst>
          </p:cNvPr>
          <p:cNvGrpSpPr/>
          <p:nvPr/>
        </p:nvGrpSpPr>
        <p:grpSpPr>
          <a:xfrm rot="10800000">
            <a:off x="3574282" y="3112221"/>
            <a:ext cx="70913" cy="48223"/>
            <a:chOff x="9017763" y="2551103"/>
            <a:chExt cx="116646" cy="79323"/>
          </a:xfrm>
        </p:grpSpPr>
        <p:sp>
          <p:nvSpPr>
            <p:cNvPr id="142" name="타원 141">
              <a:extLst>
                <a:ext uri="{FF2B5EF4-FFF2-40B4-BE49-F238E27FC236}">
                  <a16:creationId xmlns:a16="http://schemas.microsoft.com/office/drawing/2014/main" id="{1E5ED1C4-D447-4313-A690-B2724AD2DD61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43" name="타원 142">
              <a:extLst>
                <a:ext uri="{FF2B5EF4-FFF2-40B4-BE49-F238E27FC236}">
                  <a16:creationId xmlns:a16="http://schemas.microsoft.com/office/drawing/2014/main" id="{5690BADE-E844-48E4-ABF3-8028E3EE80D2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82" name="그룹 81">
            <a:extLst>
              <a:ext uri="{FF2B5EF4-FFF2-40B4-BE49-F238E27FC236}">
                <a16:creationId xmlns:a16="http://schemas.microsoft.com/office/drawing/2014/main" id="{870C9408-801B-40E9-8F39-CBEB8EF0A7F6}"/>
              </a:ext>
            </a:extLst>
          </p:cNvPr>
          <p:cNvGrpSpPr/>
          <p:nvPr/>
        </p:nvGrpSpPr>
        <p:grpSpPr>
          <a:xfrm rot="10800000">
            <a:off x="3516643" y="2968991"/>
            <a:ext cx="70913" cy="48223"/>
            <a:chOff x="9017763" y="2551103"/>
            <a:chExt cx="116646" cy="79323"/>
          </a:xfrm>
        </p:grpSpPr>
        <p:sp>
          <p:nvSpPr>
            <p:cNvPr id="140" name="타원 139">
              <a:extLst>
                <a:ext uri="{FF2B5EF4-FFF2-40B4-BE49-F238E27FC236}">
                  <a16:creationId xmlns:a16="http://schemas.microsoft.com/office/drawing/2014/main" id="{3F45B384-41E7-45A2-BE74-572E2051B3B1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41" name="타원 140">
              <a:extLst>
                <a:ext uri="{FF2B5EF4-FFF2-40B4-BE49-F238E27FC236}">
                  <a16:creationId xmlns:a16="http://schemas.microsoft.com/office/drawing/2014/main" id="{AC7CD951-1A89-4F33-AB69-E50E9145197A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83" name="그룹 82">
            <a:extLst>
              <a:ext uri="{FF2B5EF4-FFF2-40B4-BE49-F238E27FC236}">
                <a16:creationId xmlns:a16="http://schemas.microsoft.com/office/drawing/2014/main" id="{3F4283F6-A545-43C5-BA87-4DE736A3523A}"/>
              </a:ext>
            </a:extLst>
          </p:cNvPr>
          <p:cNvGrpSpPr/>
          <p:nvPr/>
        </p:nvGrpSpPr>
        <p:grpSpPr>
          <a:xfrm rot="10800000">
            <a:off x="3388034" y="3003513"/>
            <a:ext cx="70913" cy="48223"/>
            <a:chOff x="9017763" y="2551103"/>
            <a:chExt cx="116646" cy="79323"/>
          </a:xfrm>
        </p:grpSpPr>
        <p:sp>
          <p:nvSpPr>
            <p:cNvPr id="138" name="타원 137">
              <a:extLst>
                <a:ext uri="{FF2B5EF4-FFF2-40B4-BE49-F238E27FC236}">
                  <a16:creationId xmlns:a16="http://schemas.microsoft.com/office/drawing/2014/main" id="{3E8472E6-E09D-4D40-9776-26940EF500D0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39" name="타원 138">
              <a:extLst>
                <a:ext uri="{FF2B5EF4-FFF2-40B4-BE49-F238E27FC236}">
                  <a16:creationId xmlns:a16="http://schemas.microsoft.com/office/drawing/2014/main" id="{2EE49E82-883A-4A6D-813C-33C40F43BF8A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84" name="그룹 83">
            <a:extLst>
              <a:ext uri="{FF2B5EF4-FFF2-40B4-BE49-F238E27FC236}">
                <a16:creationId xmlns:a16="http://schemas.microsoft.com/office/drawing/2014/main" id="{4EA5D301-2D6B-4720-BE4B-A3707CB8B6CE}"/>
              </a:ext>
            </a:extLst>
          </p:cNvPr>
          <p:cNvGrpSpPr/>
          <p:nvPr/>
        </p:nvGrpSpPr>
        <p:grpSpPr>
          <a:xfrm rot="10800000">
            <a:off x="2908695" y="3140313"/>
            <a:ext cx="70913" cy="48223"/>
            <a:chOff x="9017763" y="2551103"/>
            <a:chExt cx="116646" cy="79323"/>
          </a:xfrm>
        </p:grpSpPr>
        <p:sp>
          <p:nvSpPr>
            <p:cNvPr id="136" name="타원 135">
              <a:extLst>
                <a:ext uri="{FF2B5EF4-FFF2-40B4-BE49-F238E27FC236}">
                  <a16:creationId xmlns:a16="http://schemas.microsoft.com/office/drawing/2014/main" id="{764B5BF4-D8A3-4503-AB56-2510B699876E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37" name="타원 136">
              <a:extLst>
                <a:ext uri="{FF2B5EF4-FFF2-40B4-BE49-F238E27FC236}">
                  <a16:creationId xmlns:a16="http://schemas.microsoft.com/office/drawing/2014/main" id="{4480E8FE-CDEB-4DCE-A560-C912D41776BD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85" name="그룹 84">
            <a:extLst>
              <a:ext uri="{FF2B5EF4-FFF2-40B4-BE49-F238E27FC236}">
                <a16:creationId xmlns:a16="http://schemas.microsoft.com/office/drawing/2014/main" id="{1CF710D8-19A4-496B-AB1E-2FABAF1CAAB4}"/>
              </a:ext>
            </a:extLst>
          </p:cNvPr>
          <p:cNvGrpSpPr/>
          <p:nvPr/>
        </p:nvGrpSpPr>
        <p:grpSpPr>
          <a:xfrm rot="10800000">
            <a:off x="2751302" y="3121734"/>
            <a:ext cx="70913" cy="48223"/>
            <a:chOff x="9017763" y="2551103"/>
            <a:chExt cx="116646" cy="79323"/>
          </a:xfrm>
        </p:grpSpPr>
        <p:sp>
          <p:nvSpPr>
            <p:cNvPr id="134" name="타원 133">
              <a:extLst>
                <a:ext uri="{FF2B5EF4-FFF2-40B4-BE49-F238E27FC236}">
                  <a16:creationId xmlns:a16="http://schemas.microsoft.com/office/drawing/2014/main" id="{ED544A1D-0713-4E48-8910-308DCCBB0A2E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35" name="타원 134">
              <a:extLst>
                <a:ext uri="{FF2B5EF4-FFF2-40B4-BE49-F238E27FC236}">
                  <a16:creationId xmlns:a16="http://schemas.microsoft.com/office/drawing/2014/main" id="{D487A5BB-1BAB-440F-B137-761652847E03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86" name="그룹 85">
            <a:extLst>
              <a:ext uri="{FF2B5EF4-FFF2-40B4-BE49-F238E27FC236}">
                <a16:creationId xmlns:a16="http://schemas.microsoft.com/office/drawing/2014/main" id="{90CBC906-5672-4717-AD23-95FC01B0B133}"/>
              </a:ext>
            </a:extLst>
          </p:cNvPr>
          <p:cNvGrpSpPr/>
          <p:nvPr/>
        </p:nvGrpSpPr>
        <p:grpSpPr>
          <a:xfrm rot="10800000">
            <a:off x="2763114" y="2937932"/>
            <a:ext cx="70913" cy="48223"/>
            <a:chOff x="9017763" y="2551103"/>
            <a:chExt cx="116646" cy="79323"/>
          </a:xfrm>
        </p:grpSpPr>
        <p:sp>
          <p:nvSpPr>
            <p:cNvPr id="132" name="타원 131">
              <a:extLst>
                <a:ext uri="{FF2B5EF4-FFF2-40B4-BE49-F238E27FC236}">
                  <a16:creationId xmlns:a16="http://schemas.microsoft.com/office/drawing/2014/main" id="{A4590CA7-5737-4747-BF1E-2396F786BCB7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33" name="타원 132">
              <a:extLst>
                <a:ext uri="{FF2B5EF4-FFF2-40B4-BE49-F238E27FC236}">
                  <a16:creationId xmlns:a16="http://schemas.microsoft.com/office/drawing/2014/main" id="{354D6274-BA57-4190-A6FA-A940EC92A5DD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87" name="그룹 86">
            <a:extLst>
              <a:ext uri="{FF2B5EF4-FFF2-40B4-BE49-F238E27FC236}">
                <a16:creationId xmlns:a16="http://schemas.microsoft.com/office/drawing/2014/main" id="{DF4037CD-944B-42A0-AB0D-2CC0D7DA6210}"/>
              </a:ext>
            </a:extLst>
          </p:cNvPr>
          <p:cNvGrpSpPr/>
          <p:nvPr/>
        </p:nvGrpSpPr>
        <p:grpSpPr>
          <a:xfrm rot="10800000">
            <a:off x="3558960" y="3127843"/>
            <a:ext cx="70913" cy="48223"/>
            <a:chOff x="9017763" y="2551103"/>
            <a:chExt cx="116646" cy="79323"/>
          </a:xfrm>
        </p:grpSpPr>
        <p:sp>
          <p:nvSpPr>
            <p:cNvPr id="130" name="타원 129">
              <a:extLst>
                <a:ext uri="{FF2B5EF4-FFF2-40B4-BE49-F238E27FC236}">
                  <a16:creationId xmlns:a16="http://schemas.microsoft.com/office/drawing/2014/main" id="{8EFE6A52-183A-4841-AB7A-4C048B9E6BC5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31" name="타원 130">
              <a:extLst>
                <a:ext uri="{FF2B5EF4-FFF2-40B4-BE49-F238E27FC236}">
                  <a16:creationId xmlns:a16="http://schemas.microsoft.com/office/drawing/2014/main" id="{2D0CBADA-61A8-41B8-981F-F807FDE4674E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88" name="그룹 87">
            <a:extLst>
              <a:ext uri="{FF2B5EF4-FFF2-40B4-BE49-F238E27FC236}">
                <a16:creationId xmlns:a16="http://schemas.microsoft.com/office/drawing/2014/main" id="{C8C4F533-C348-496C-8CD7-B9E8656927BD}"/>
              </a:ext>
            </a:extLst>
          </p:cNvPr>
          <p:cNvGrpSpPr/>
          <p:nvPr/>
        </p:nvGrpSpPr>
        <p:grpSpPr>
          <a:xfrm rot="10800000">
            <a:off x="2606300" y="3118627"/>
            <a:ext cx="70913" cy="48223"/>
            <a:chOff x="9017763" y="2551103"/>
            <a:chExt cx="116646" cy="79323"/>
          </a:xfrm>
        </p:grpSpPr>
        <p:sp>
          <p:nvSpPr>
            <p:cNvPr id="128" name="타원 127">
              <a:extLst>
                <a:ext uri="{FF2B5EF4-FFF2-40B4-BE49-F238E27FC236}">
                  <a16:creationId xmlns:a16="http://schemas.microsoft.com/office/drawing/2014/main" id="{AE48CD32-491C-46D0-8151-031CD7BC6B6B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29" name="타원 128">
              <a:extLst>
                <a:ext uri="{FF2B5EF4-FFF2-40B4-BE49-F238E27FC236}">
                  <a16:creationId xmlns:a16="http://schemas.microsoft.com/office/drawing/2014/main" id="{D0A590D4-BAEC-4095-A231-9AC3BCC4BEA0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89" name="그룹 88">
            <a:extLst>
              <a:ext uri="{FF2B5EF4-FFF2-40B4-BE49-F238E27FC236}">
                <a16:creationId xmlns:a16="http://schemas.microsoft.com/office/drawing/2014/main" id="{E3F145B3-00B3-442F-844E-E752E105D670}"/>
              </a:ext>
            </a:extLst>
          </p:cNvPr>
          <p:cNvGrpSpPr/>
          <p:nvPr/>
        </p:nvGrpSpPr>
        <p:grpSpPr>
          <a:xfrm rot="10800000">
            <a:off x="3372367" y="3113745"/>
            <a:ext cx="70913" cy="48223"/>
            <a:chOff x="9017763" y="2551103"/>
            <a:chExt cx="116646" cy="79323"/>
          </a:xfrm>
        </p:grpSpPr>
        <p:sp>
          <p:nvSpPr>
            <p:cNvPr id="126" name="타원 125">
              <a:extLst>
                <a:ext uri="{FF2B5EF4-FFF2-40B4-BE49-F238E27FC236}">
                  <a16:creationId xmlns:a16="http://schemas.microsoft.com/office/drawing/2014/main" id="{B6F4A3B8-1D71-4FD9-8E5B-E27A6396AA3C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27" name="타원 126">
              <a:extLst>
                <a:ext uri="{FF2B5EF4-FFF2-40B4-BE49-F238E27FC236}">
                  <a16:creationId xmlns:a16="http://schemas.microsoft.com/office/drawing/2014/main" id="{59CF6C07-B213-4FAB-A585-24C2ACA35921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sp>
        <p:nvSpPr>
          <p:cNvPr id="90" name="직사각형 89">
            <a:extLst>
              <a:ext uri="{FF2B5EF4-FFF2-40B4-BE49-F238E27FC236}">
                <a16:creationId xmlns:a16="http://schemas.microsoft.com/office/drawing/2014/main" id="{1AB8F2F3-6555-4049-8FD6-DC3C0E5926E5}"/>
              </a:ext>
            </a:extLst>
          </p:cNvPr>
          <p:cNvSpPr/>
          <p:nvPr/>
        </p:nvSpPr>
        <p:spPr>
          <a:xfrm>
            <a:off x="2249844" y="2634596"/>
            <a:ext cx="101033" cy="689650"/>
          </a:xfrm>
          <a:prstGeom prst="rect">
            <a:avLst/>
          </a:prstGeom>
          <a:solidFill>
            <a:srgbClr val="3A4858">
              <a:lumMod val="20000"/>
              <a:lumOff val="80000"/>
            </a:srgbClr>
          </a:soli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ko-KR" altLang="en-US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/>
              <a:ea typeface="맑은 고딕"/>
              <a:cs typeface="+mn-cs"/>
            </a:endParaRPr>
          </a:p>
        </p:txBody>
      </p:sp>
      <p:sp>
        <p:nvSpPr>
          <p:cNvPr id="91" name="직사각형 90">
            <a:extLst>
              <a:ext uri="{FF2B5EF4-FFF2-40B4-BE49-F238E27FC236}">
                <a16:creationId xmlns:a16="http://schemas.microsoft.com/office/drawing/2014/main" id="{A94A7BE5-D13F-429E-82AA-B7B0D34FCAB7}"/>
              </a:ext>
            </a:extLst>
          </p:cNvPr>
          <p:cNvSpPr/>
          <p:nvPr/>
        </p:nvSpPr>
        <p:spPr>
          <a:xfrm>
            <a:off x="3833585" y="2634596"/>
            <a:ext cx="101033" cy="689650"/>
          </a:xfrm>
          <a:prstGeom prst="rect">
            <a:avLst/>
          </a:prstGeom>
          <a:solidFill>
            <a:srgbClr val="3A4858">
              <a:lumMod val="20000"/>
              <a:lumOff val="80000"/>
            </a:srgbClr>
          </a:soli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ko-KR" altLang="en-US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/>
              <a:ea typeface="맑은 고딕"/>
              <a:cs typeface="+mn-cs"/>
            </a:endParaRPr>
          </a:p>
        </p:txBody>
      </p:sp>
      <p:sp>
        <p:nvSpPr>
          <p:cNvPr id="92" name="자유형: 도형 516">
            <a:extLst>
              <a:ext uri="{FF2B5EF4-FFF2-40B4-BE49-F238E27FC236}">
                <a16:creationId xmlns:a16="http://schemas.microsoft.com/office/drawing/2014/main" id="{EA9ACE8B-AB95-414B-B992-3FA013F557BE}"/>
              </a:ext>
            </a:extLst>
          </p:cNvPr>
          <p:cNvSpPr/>
          <p:nvPr/>
        </p:nvSpPr>
        <p:spPr>
          <a:xfrm>
            <a:off x="2247948" y="2632234"/>
            <a:ext cx="1686633" cy="690522"/>
          </a:xfrm>
          <a:custGeom>
            <a:avLst/>
            <a:gdLst>
              <a:gd name="connsiteX0" fmla="*/ 12451 w 2788988"/>
              <a:gd name="connsiteY0" fmla="*/ 83088 h 1221325"/>
              <a:gd name="connsiteX1" fmla="*/ 188663 w 2788988"/>
              <a:gd name="connsiteY1" fmla="*/ 87850 h 1221325"/>
              <a:gd name="connsiteX2" fmla="*/ 186282 w 2788988"/>
              <a:gd name="connsiteY2" fmla="*/ 1052256 h 1221325"/>
              <a:gd name="connsiteX3" fmla="*/ 2627063 w 2788988"/>
              <a:gd name="connsiteY3" fmla="*/ 1047494 h 1221325"/>
              <a:gd name="connsiteX4" fmla="*/ 2627063 w 2788988"/>
              <a:gd name="connsiteY4" fmla="*/ 85469 h 1221325"/>
              <a:gd name="connsiteX5" fmla="*/ 2788988 w 2788988"/>
              <a:gd name="connsiteY5" fmla="*/ 80706 h 1221325"/>
              <a:gd name="connsiteX6" fmla="*/ 2788988 w 2788988"/>
              <a:gd name="connsiteY6" fmla="*/ 1221325 h 1221325"/>
              <a:gd name="connsiteX7" fmla="*/ 14832 w 2788988"/>
              <a:gd name="connsiteY7" fmla="*/ 1221325 h 1221325"/>
              <a:gd name="connsiteX8" fmla="*/ 12451 w 2788988"/>
              <a:gd name="connsiteY8" fmla="*/ 83088 h 1221325"/>
              <a:gd name="connsiteX0" fmla="*/ 12451 w 2788988"/>
              <a:gd name="connsiteY0" fmla="*/ 2382 h 1140619"/>
              <a:gd name="connsiteX1" fmla="*/ 188663 w 2788988"/>
              <a:gd name="connsiteY1" fmla="*/ 7144 h 1140619"/>
              <a:gd name="connsiteX2" fmla="*/ 186282 w 2788988"/>
              <a:gd name="connsiteY2" fmla="*/ 971550 h 1140619"/>
              <a:gd name="connsiteX3" fmla="*/ 2627063 w 2788988"/>
              <a:gd name="connsiteY3" fmla="*/ 966788 h 1140619"/>
              <a:gd name="connsiteX4" fmla="*/ 2627063 w 2788988"/>
              <a:gd name="connsiteY4" fmla="*/ 4763 h 1140619"/>
              <a:gd name="connsiteX5" fmla="*/ 2788988 w 2788988"/>
              <a:gd name="connsiteY5" fmla="*/ 0 h 1140619"/>
              <a:gd name="connsiteX6" fmla="*/ 2788988 w 2788988"/>
              <a:gd name="connsiteY6" fmla="*/ 1140619 h 1140619"/>
              <a:gd name="connsiteX7" fmla="*/ 14832 w 2788988"/>
              <a:gd name="connsiteY7" fmla="*/ 1140619 h 1140619"/>
              <a:gd name="connsiteX8" fmla="*/ 12451 w 2788988"/>
              <a:gd name="connsiteY8" fmla="*/ 2382 h 1140619"/>
              <a:gd name="connsiteX0" fmla="*/ 0 w 2776537"/>
              <a:gd name="connsiteY0" fmla="*/ 2382 h 1140619"/>
              <a:gd name="connsiteX1" fmla="*/ 176212 w 2776537"/>
              <a:gd name="connsiteY1" fmla="*/ 7144 h 1140619"/>
              <a:gd name="connsiteX2" fmla="*/ 173831 w 2776537"/>
              <a:gd name="connsiteY2" fmla="*/ 971550 h 1140619"/>
              <a:gd name="connsiteX3" fmla="*/ 2614612 w 2776537"/>
              <a:gd name="connsiteY3" fmla="*/ 966788 h 1140619"/>
              <a:gd name="connsiteX4" fmla="*/ 2614612 w 2776537"/>
              <a:gd name="connsiteY4" fmla="*/ 4763 h 1140619"/>
              <a:gd name="connsiteX5" fmla="*/ 2776537 w 2776537"/>
              <a:gd name="connsiteY5" fmla="*/ 0 h 1140619"/>
              <a:gd name="connsiteX6" fmla="*/ 2776537 w 2776537"/>
              <a:gd name="connsiteY6" fmla="*/ 1140619 h 1140619"/>
              <a:gd name="connsiteX7" fmla="*/ 2381 w 2776537"/>
              <a:gd name="connsiteY7" fmla="*/ 1140619 h 1140619"/>
              <a:gd name="connsiteX8" fmla="*/ 0 w 2776537"/>
              <a:gd name="connsiteY8" fmla="*/ 2382 h 1140619"/>
              <a:gd name="connsiteX0" fmla="*/ 231 w 2774386"/>
              <a:gd name="connsiteY0" fmla="*/ 7145 h 1140619"/>
              <a:gd name="connsiteX1" fmla="*/ 174061 w 2774386"/>
              <a:gd name="connsiteY1" fmla="*/ 7144 h 1140619"/>
              <a:gd name="connsiteX2" fmla="*/ 171680 w 2774386"/>
              <a:gd name="connsiteY2" fmla="*/ 971550 h 1140619"/>
              <a:gd name="connsiteX3" fmla="*/ 2612461 w 2774386"/>
              <a:gd name="connsiteY3" fmla="*/ 966788 h 1140619"/>
              <a:gd name="connsiteX4" fmla="*/ 2612461 w 2774386"/>
              <a:gd name="connsiteY4" fmla="*/ 4763 h 1140619"/>
              <a:gd name="connsiteX5" fmla="*/ 2774386 w 2774386"/>
              <a:gd name="connsiteY5" fmla="*/ 0 h 1140619"/>
              <a:gd name="connsiteX6" fmla="*/ 2774386 w 2774386"/>
              <a:gd name="connsiteY6" fmla="*/ 1140619 h 1140619"/>
              <a:gd name="connsiteX7" fmla="*/ 230 w 2774386"/>
              <a:gd name="connsiteY7" fmla="*/ 1140619 h 1140619"/>
              <a:gd name="connsiteX8" fmla="*/ 231 w 2774386"/>
              <a:gd name="connsiteY8" fmla="*/ 7145 h 1140619"/>
              <a:gd name="connsiteX0" fmla="*/ 231 w 2774386"/>
              <a:gd name="connsiteY0" fmla="*/ 7145 h 1140619"/>
              <a:gd name="connsiteX1" fmla="*/ 174061 w 2774386"/>
              <a:gd name="connsiteY1" fmla="*/ 7144 h 1140619"/>
              <a:gd name="connsiteX2" fmla="*/ 171680 w 2774386"/>
              <a:gd name="connsiteY2" fmla="*/ 971550 h 1140619"/>
              <a:gd name="connsiteX3" fmla="*/ 2614842 w 2774386"/>
              <a:gd name="connsiteY3" fmla="*/ 978694 h 1140619"/>
              <a:gd name="connsiteX4" fmla="*/ 2612461 w 2774386"/>
              <a:gd name="connsiteY4" fmla="*/ 4763 h 1140619"/>
              <a:gd name="connsiteX5" fmla="*/ 2774386 w 2774386"/>
              <a:gd name="connsiteY5" fmla="*/ 0 h 1140619"/>
              <a:gd name="connsiteX6" fmla="*/ 2774386 w 2774386"/>
              <a:gd name="connsiteY6" fmla="*/ 1140619 h 1140619"/>
              <a:gd name="connsiteX7" fmla="*/ 230 w 2774386"/>
              <a:gd name="connsiteY7" fmla="*/ 1140619 h 1140619"/>
              <a:gd name="connsiteX8" fmla="*/ 231 w 2774386"/>
              <a:gd name="connsiteY8" fmla="*/ 7145 h 1140619"/>
              <a:gd name="connsiteX0" fmla="*/ 231 w 2774386"/>
              <a:gd name="connsiteY0" fmla="*/ 7145 h 1140619"/>
              <a:gd name="connsiteX1" fmla="*/ 174061 w 2774386"/>
              <a:gd name="connsiteY1" fmla="*/ 7144 h 1140619"/>
              <a:gd name="connsiteX2" fmla="*/ 178824 w 2774386"/>
              <a:gd name="connsiteY2" fmla="*/ 976312 h 1140619"/>
              <a:gd name="connsiteX3" fmla="*/ 2614842 w 2774386"/>
              <a:gd name="connsiteY3" fmla="*/ 978694 h 1140619"/>
              <a:gd name="connsiteX4" fmla="*/ 2612461 w 2774386"/>
              <a:gd name="connsiteY4" fmla="*/ 4763 h 1140619"/>
              <a:gd name="connsiteX5" fmla="*/ 2774386 w 2774386"/>
              <a:gd name="connsiteY5" fmla="*/ 0 h 1140619"/>
              <a:gd name="connsiteX6" fmla="*/ 2774386 w 2774386"/>
              <a:gd name="connsiteY6" fmla="*/ 1140619 h 1140619"/>
              <a:gd name="connsiteX7" fmla="*/ 230 w 2774386"/>
              <a:gd name="connsiteY7" fmla="*/ 1140619 h 1140619"/>
              <a:gd name="connsiteX8" fmla="*/ 231 w 2774386"/>
              <a:gd name="connsiteY8" fmla="*/ 7145 h 1140619"/>
              <a:gd name="connsiteX0" fmla="*/ 231 w 2774386"/>
              <a:gd name="connsiteY0" fmla="*/ 2382 h 1135856"/>
              <a:gd name="connsiteX1" fmla="*/ 174061 w 2774386"/>
              <a:gd name="connsiteY1" fmla="*/ 2381 h 1135856"/>
              <a:gd name="connsiteX2" fmla="*/ 178824 w 2774386"/>
              <a:gd name="connsiteY2" fmla="*/ 971549 h 1135856"/>
              <a:gd name="connsiteX3" fmla="*/ 2614842 w 2774386"/>
              <a:gd name="connsiteY3" fmla="*/ 973931 h 1135856"/>
              <a:gd name="connsiteX4" fmla="*/ 2612461 w 2774386"/>
              <a:gd name="connsiteY4" fmla="*/ 0 h 1135856"/>
              <a:gd name="connsiteX5" fmla="*/ 2774386 w 2774386"/>
              <a:gd name="connsiteY5" fmla="*/ 2380 h 1135856"/>
              <a:gd name="connsiteX6" fmla="*/ 2774386 w 2774386"/>
              <a:gd name="connsiteY6" fmla="*/ 1135856 h 1135856"/>
              <a:gd name="connsiteX7" fmla="*/ 230 w 2774386"/>
              <a:gd name="connsiteY7" fmla="*/ 1135856 h 1135856"/>
              <a:gd name="connsiteX8" fmla="*/ 231 w 2774386"/>
              <a:gd name="connsiteY8" fmla="*/ 2382 h 1135856"/>
              <a:gd name="connsiteX0" fmla="*/ 231 w 2774386"/>
              <a:gd name="connsiteY0" fmla="*/ 2383 h 1135857"/>
              <a:gd name="connsiteX1" fmla="*/ 174061 w 2774386"/>
              <a:gd name="connsiteY1" fmla="*/ 2382 h 1135857"/>
              <a:gd name="connsiteX2" fmla="*/ 178824 w 2774386"/>
              <a:gd name="connsiteY2" fmla="*/ 971550 h 1135857"/>
              <a:gd name="connsiteX3" fmla="*/ 2614842 w 2774386"/>
              <a:gd name="connsiteY3" fmla="*/ 973932 h 1135857"/>
              <a:gd name="connsiteX4" fmla="*/ 2612461 w 2774386"/>
              <a:gd name="connsiteY4" fmla="*/ 1 h 1135857"/>
              <a:gd name="connsiteX5" fmla="*/ 2772004 w 2774386"/>
              <a:gd name="connsiteY5" fmla="*/ 0 h 1135857"/>
              <a:gd name="connsiteX6" fmla="*/ 2774386 w 2774386"/>
              <a:gd name="connsiteY6" fmla="*/ 1135857 h 1135857"/>
              <a:gd name="connsiteX7" fmla="*/ 230 w 2774386"/>
              <a:gd name="connsiteY7" fmla="*/ 1135857 h 1135857"/>
              <a:gd name="connsiteX8" fmla="*/ 231 w 2774386"/>
              <a:gd name="connsiteY8" fmla="*/ 2383 h 1135857"/>
              <a:gd name="connsiteX0" fmla="*/ 231 w 2774386"/>
              <a:gd name="connsiteY0" fmla="*/ 2383 h 1135857"/>
              <a:gd name="connsiteX1" fmla="*/ 174061 w 2774386"/>
              <a:gd name="connsiteY1" fmla="*/ 2382 h 1135857"/>
              <a:gd name="connsiteX2" fmla="*/ 178824 w 2774386"/>
              <a:gd name="connsiteY2" fmla="*/ 971550 h 1135857"/>
              <a:gd name="connsiteX3" fmla="*/ 2614842 w 2774386"/>
              <a:gd name="connsiteY3" fmla="*/ 973932 h 1135857"/>
              <a:gd name="connsiteX4" fmla="*/ 2612461 w 2774386"/>
              <a:gd name="connsiteY4" fmla="*/ 1 h 1135857"/>
              <a:gd name="connsiteX5" fmla="*/ 2774385 w 2774386"/>
              <a:gd name="connsiteY5" fmla="*/ 0 h 1135857"/>
              <a:gd name="connsiteX6" fmla="*/ 2774386 w 2774386"/>
              <a:gd name="connsiteY6" fmla="*/ 1135857 h 1135857"/>
              <a:gd name="connsiteX7" fmla="*/ 230 w 2774386"/>
              <a:gd name="connsiteY7" fmla="*/ 1135857 h 1135857"/>
              <a:gd name="connsiteX8" fmla="*/ 231 w 2774386"/>
              <a:gd name="connsiteY8" fmla="*/ 2383 h 1135857"/>
              <a:gd name="connsiteX0" fmla="*/ 231 w 2774386"/>
              <a:gd name="connsiteY0" fmla="*/ 2383 h 1135857"/>
              <a:gd name="connsiteX1" fmla="*/ 174061 w 2774386"/>
              <a:gd name="connsiteY1" fmla="*/ 2382 h 1135857"/>
              <a:gd name="connsiteX2" fmla="*/ 171681 w 2774386"/>
              <a:gd name="connsiteY2" fmla="*/ 971550 h 1135857"/>
              <a:gd name="connsiteX3" fmla="*/ 2614842 w 2774386"/>
              <a:gd name="connsiteY3" fmla="*/ 973932 h 1135857"/>
              <a:gd name="connsiteX4" fmla="*/ 2612461 w 2774386"/>
              <a:gd name="connsiteY4" fmla="*/ 1 h 1135857"/>
              <a:gd name="connsiteX5" fmla="*/ 2774385 w 2774386"/>
              <a:gd name="connsiteY5" fmla="*/ 0 h 1135857"/>
              <a:gd name="connsiteX6" fmla="*/ 2774386 w 2774386"/>
              <a:gd name="connsiteY6" fmla="*/ 1135857 h 1135857"/>
              <a:gd name="connsiteX7" fmla="*/ 230 w 2774386"/>
              <a:gd name="connsiteY7" fmla="*/ 1135857 h 1135857"/>
              <a:gd name="connsiteX8" fmla="*/ 231 w 2774386"/>
              <a:gd name="connsiteY8" fmla="*/ 2383 h 113585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2774386" h="1135857">
                <a:moveTo>
                  <a:pt x="231" y="2383"/>
                </a:moveTo>
                <a:lnTo>
                  <a:pt x="174061" y="2382"/>
                </a:lnTo>
                <a:cubicBezTo>
                  <a:pt x="173267" y="323851"/>
                  <a:pt x="172475" y="650081"/>
                  <a:pt x="171681" y="971550"/>
                </a:cubicBezTo>
                <a:lnTo>
                  <a:pt x="2614842" y="973932"/>
                </a:lnTo>
                <a:cubicBezTo>
                  <a:pt x="2614048" y="649288"/>
                  <a:pt x="2613255" y="324645"/>
                  <a:pt x="2612461" y="1"/>
                </a:cubicBezTo>
                <a:lnTo>
                  <a:pt x="2774385" y="0"/>
                </a:lnTo>
                <a:cubicBezTo>
                  <a:pt x="2774385" y="378619"/>
                  <a:pt x="2774386" y="757238"/>
                  <a:pt x="2774386" y="1135857"/>
                </a:cubicBezTo>
                <a:lnTo>
                  <a:pt x="230" y="1135857"/>
                </a:lnTo>
                <a:cubicBezTo>
                  <a:pt x="-564" y="756445"/>
                  <a:pt x="1025" y="381795"/>
                  <a:pt x="231" y="2383"/>
                </a:cubicBezTo>
                <a:close/>
              </a:path>
            </a:pathLst>
          </a:custGeom>
          <a:noFill/>
          <a:ln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grpSp>
        <p:nvGrpSpPr>
          <p:cNvPr id="93" name="그룹 92">
            <a:extLst>
              <a:ext uri="{FF2B5EF4-FFF2-40B4-BE49-F238E27FC236}">
                <a16:creationId xmlns:a16="http://schemas.microsoft.com/office/drawing/2014/main" id="{7FA268AC-65ED-410B-9BA6-85F27F8D6297}"/>
              </a:ext>
            </a:extLst>
          </p:cNvPr>
          <p:cNvGrpSpPr/>
          <p:nvPr/>
        </p:nvGrpSpPr>
        <p:grpSpPr>
          <a:xfrm rot="10800000">
            <a:off x="3351630" y="3011323"/>
            <a:ext cx="70913" cy="48223"/>
            <a:chOff x="9017763" y="2551103"/>
            <a:chExt cx="116646" cy="79323"/>
          </a:xfrm>
        </p:grpSpPr>
        <p:sp>
          <p:nvSpPr>
            <p:cNvPr id="124" name="타원 123">
              <a:extLst>
                <a:ext uri="{FF2B5EF4-FFF2-40B4-BE49-F238E27FC236}">
                  <a16:creationId xmlns:a16="http://schemas.microsoft.com/office/drawing/2014/main" id="{5D3A1E53-B581-4185-B642-43CD72F45B3B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25" name="타원 124">
              <a:extLst>
                <a:ext uri="{FF2B5EF4-FFF2-40B4-BE49-F238E27FC236}">
                  <a16:creationId xmlns:a16="http://schemas.microsoft.com/office/drawing/2014/main" id="{BE329C36-340B-4915-B7C1-E9E1FF51E6E2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94" name="그룹 93">
            <a:extLst>
              <a:ext uri="{FF2B5EF4-FFF2-40B4-BE49-F238E27FC236}">
                <a16:creationId xmlns:a16="http://schemas.microsoft.com/office/drawing/2014/main" id="{89C31043-5FD7-4E80-A07B-A4F70785A715}"/>
              </a:ext>
            </a:extLst>
          </p:cNvPr>
          <p:cNvGrpSpPr/>
          <p:nvPr/>
        </p:nvGrpSpPr>
        <p:grpSpPr>
          <a:xfrm rot="10800000">
            <a:off x="3398760" y="3132803"/>
            <a:ext cx="70913" cy="48223"/>
            <a:chOff x="9017763" y="2551103"/>
            <a:chExt cx="116646" cy="79323"/>
          </a:xfrm>
        </p:grpSpPr>
        <p:sp>
          <p:nvSpPr>
            <p:cNvPr id="122" name="타원 121">
              <a:extLst>
                <a:ext uri="{FF2B5EF4-FFF2-40B4-BE49-F238E27FC236}">
                  <a16:creationId xmlns:a16="http://schemas.microsoft.com/office/drawing/2014/main" id="{79DD0082-0003-43F6-9A22-EA9F563BA66A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23" name="타원 122">
              <a:extLst>
                <a:ext uri="{FF2B5EF4-FFF2-40B4-BE49-F238E27FC236}">
                  <a16:creationId xmlns:a16="http://schemas.microsoft.com/office/drawing/2014/main" id="{64B5D431-AEED-40E2-B1A2-287BE7CD52FE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95" name="그룹 94">
            <a:extLst>
              <a:ext uri="{FF2B5EF4-FFF2-40B4-BE49-F238E27FC236}">
                <a16:creationId xmlns:a16="http://schemas.microsoft.com/office/drawing/2014/main" id="{36347B2E-2958-4DD8-BBB3-3FAA5BF2BEA8}"/>
              </a:ext>
            </a:extLst>
          </p:cNvPr>
          <p:cNvGrpSpPr/>
          <p:nvPr/>
        </p:nvGrpSpPr>
        <p:grpSpPr>
          <a:xfrm rot="10800000">
            <a:off x="3339201" y="3142316"/>
            <a:ext cx="70913" cy="48223"/>
            <a:chOff x="9017763" y="2551103"/>
            <a:chExt cx="116646" cy="79323"/>
          </a:xfrm>
        </p:grpSpPr>
        <p:sp>
          <p:nvSpPr>
            <p:cNvPr id="120" name="타원 119">
              <a:extLst>
                <a:ext uri="{FF2B5EF4-FFF2-40B4-BE49-F238E27FC236}">
                  <a16:creationId xmlns:a16="http://schemas.microsoft.com/office/drawing/2014/main" id="{75792EE0-1CBB-41A4-B02A-B79338F144B9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21" name="타원 120">
              <a:extLst>
                <a:ext uri="{FF2B5EF4-FFF2-40B4-BE49-F238E27FC236}">
                  <a16:creationId xmlns:a16="http://schemas.microsoft.com/office/drawing/2014/main" id="{33E0ED8C-AF41-409A-BB12-C21606A1B98E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96" name="그룹 95">
            <a:extLst>
              <a:ext uri="{FF2B5EF4-FFF2-40B4-BE49-F238E27FC236}">
                <a16:creationId xmlns:a16="http://schemas.microsoft.com/office/drawing/2014/main" id="{7142BC6A-21F5-4355-ABC8-0EDABA503708}"/>
              </a:ext>
            </a:extLst>
          </p:cNvPr>
          <p:cNvGrpSpPr/>
          <p:nvPr/>
        </p:nvGrpSpPr>
        <p:grpSpPr>
          <a:xfrm rot="10800000">
            <a:off x="2732783" y="3126829"/>
            <a:ext cx="70913" cy="48223"/>
            <a:chOff x="9017763" y="2551103"/>
            <a:chExt cx="116646" cy="79323"/>
          </a:xfrm>
        </p:grpSpPr>
        <p:sp>
          <p:nvSpPr>
            <p:cNvPr id="118" name="타원 117">
              <a:extLst>
                <a:ext uri="{FF2B5EF4-FFF2-40B4-BE49-F238E27FC236}">
                  <a16:creationId xmlns:a16="http://schemas.microsoft.com/office/drawing/2014/main" id="{A68E0A50-3ABD-4FDC-92F4-4A3AAB930243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19" name="타원 118">
              <a:extLst>
                <a:ext uri="{FF2B5EF4-FFF2-40B4-BE49-F238E27FC236}">
                  <a16:creationId xmlns:a16="http://schemas.microsoft.com/office/drawing/2014/main" id="{B46058C2-711B-4A19-8E85-384F3F986E69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97" name="그룹 96">
            <a:extLst>
              <a:ext uri="{FF2B5EF4-FFF2-40B4-BE49-F238E27FC236}">
                <a16:creationId xmlns:a16="http://schemas.microsoft.com/office/drawing/2014/main" id="{7D7CEE84-6E95-4E4A-80A5-90733916F1D7}"/>
              </a:ext>
            </a:extLst>
          </p:cNvPr>
          <p:cNvGrpSpPr/>
          <p:nvPr/>
        </p:nvGrpSpPr>
        <p:grpSpPr>
          <a:xfrm rot="10800000">
            <a:off x="2773212" y="3145845"/>
            <a:ext cx="70913" cy="48223"/>
            <a:chOff x="9017763" y="2551103"/>
            <a:chExt cx="116646" cy="79323"/>
          </a:xfrm>
        </p:grpSpPr>
        <p:sp>
          <p:nvSpPr>
            <p:cNvPr id="116" name="타원 115">
              <a:extLst>
                <a:ext uri="{FF2B5EF4-FFF2-40B4-BE49-F238E27FC236}">
                  <a16:creationId xmlns:a16="http://schemas.microsoft.com/office/drawing/2014/main" id="{A6478D24-EF7C-4711-BCC7-FC11849945D5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17" name="타원 116">
              <a:extLst>
                <a:ext uri="{FF2B5EF4-FFF2-40B4-BE49-F238E27FC236}">
                  <a16:creationId xmlns:a16="http://schemas.microsoft.com/office/drawing/2014/main" id="{2464C536-CBAA-4BD5-BDB2-12D5B84E51B6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98" name="그룹 97">
            <a:extLst>
              <a:ext uri="{FF2B5EF4-FFF2-40B4-BE49-F238E27FC236}">
                <a16:creationId xmlns:a16="http://schemas.microsoft.com/office/drawing/2014/main" id="{6C82F7E4-93B5-4A36-B65A-13269C9A069E}"/>
              </a:ext>
            </a:extLst>
          </p:cNvPr>
          <p:cNvGrpSpPr/>
          <p:nvPr/>
        </p:nvGrpSpPr>
        <p:grpSpPr>
          <a:xfrm rot="10800000">
            <a:off x="2597940" y="2945886"/>
            <a:ext cx="70913" cy="48223"/>
            <a:chOff x="9017763" y="2551103"/>
            <a:chExt cx="116646" cy="79323"/>
          </a:xfrm>
        </p:grpSpPr>
        <p:sp>
          <p:nvSpPr>
            <p:cNvPr id="114" name="타원 113">
              <a:extLst>
                <a:ext uri="{FF2B5EF4-FFF2-40B4-BE49-F238E27FC236}">
                  <a16:creationId xmlns:a16="http://schemas.microsoft.com/office/drawing/2014/main" id="{35166F62-5D18-4766-80C7-DD3E737ECFDC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15" name="타원 114">
              <a:extLst>
                <a:ext uri="{FF2B5EF4-FFF2-40B4-BE49-F238E27FC236}">
                  <a16:creationId xmlns:a16="http://schemas.microsoft.com/office/drawing/2014/main" id="{956D69C8-E6EF-461B-B9F6-223CDD8AA8EE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99" name="그룹 98">
            <a:extLst>
              <a:ext uri="{FF2B5EF4-FFF2-40B4-BE49-F238E27FC236}">
                <a16:creationId xmlns:a16="http://schemas.microsoft.com/office/drawing/2014/main" id="{9140B4EF-DFBD-43B5-99A0-1F5CBB89D68E}"/>
              </a:ext>
            </a:extLst>
          </p:cNvPr>
          <p:cNvGrpSpPr/>
          <p:nvPr/>
        </p:nvGrpSpPr>
        <p:grpSpPr>
          <a:xfrm rot="10800000">
            <a:off x="2566511" y="2964141"/>
            <a:ext cx="70913" cy="48223"/>
            <a:chOff x="9017763" y="2551103"/>
            <a:chExt cx="116646" cy="79323"/>
          </a:xfrm>
        </p:grpSpPr>
        <p:sp>
          <p:nvSpPr>
            <p:cNvPr id="112" name="타원 111">
              <a:extLst>
                <a:ext uri="{FF2B5EF4-FFF2-40B4-BE49-F238E27FC236}">
                  <a16:creationId xmlns:a16="http://schemas.microsoft.com/office/drawing/2014/main" id="{7C861DA3-9F7E-40A2-B30B-74ECAD9F19E0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13" name="타원 112">
              <a:extLst>
                <a:ext uri="{FF2B5EF4-FFF2-40B4-BE49-F238E27FC236}">
                  <a16:creationId xmlns:a16="http://schemas.microsoft.com/office/drawing/2014/main" id="{505A16EE-6ED6-41BD-9D6B-B9FFDFF9F232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grpSp>
        <p:nvGrpSpPr>
          <p:cNvPr id="100" name="그룹 99">
            <a:extLst>
              <a:ext uri="{FF2B5EF4-FFF2-40B4-BE49-F238E27FC236}">
                <a16:creationId xmlns:a16="http://schemas.microsoft.com/office/drawing/2014/main" id="{C8908CB4-D891-4684-8F87-DFEE281AA367}"/>
              </a:ext>
            </a:extLst>
          </p:cNvPr>
          <p:cNvGrpSpPr/>
          <p:nvPr/>
        </p:nvGrpSpPr>
        <p:grpSpPr>
          <a:xfrm rot="10800000">
            <a:off x="2551929" y="3140593"/>
            <a:ext cx="70913" cy="48223"/>
            <a:chOff x="9017763" y="2551103"/>
            <a:chExt cx="116646" cy="79323"/>
          </a:xfrm>
        </p:grpSpPr>
        <p:sp>
          <p:nvSpPr>
            <p:cNvPr id="110" name="타원 109">
              <a:extLst>
                <a:ext uri="{FF2B5EF4-FFF2-40B4-BE49-F238E27FC236}">
                  <a16:creationId xmlns:a16="http://schemas.microsoft.com/office/drawing/2014/main" id="{89336C90-60AA-416A-A9F2-B37AB63406FF}"/>
                </a:ext>
              </a:extLst>
            </p:cNvPr>
            <p:cNvSpPr/>
            <p:nvPr/>
          </p:nvSpPr>
          <p:spPr>
            <a:xfrm rot="10800000" flipH="1" flipV="1">
              <a:off x="9017763" y="2551103"/>
              <a:ext cx="116646" cy="79323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60">
                <a:latin typeface="HY강M" pitchFamily="18" charset="-127"/>
                <a:ea typeface="HY강M" pitchFamily="18" charset="-127"/>
              </a:endParaRPr>
            </a:p>
          </p:txBody>
        </p:sp>
        <p:sp>
          <p:nvSpPr>
            <p:cNvPr id="111" name="타원 110">
              <a:extLst>
                <a:ext uri="{FF2B5EF4-FFF2-40B4-BE49-F238E27FC236}">
                  <a16:creationId xmlns:a16="http://schemas.microsoft.com/office/drawing/2014/main" id="{767BCCAF-B81D-48C1-A393-AE929C84FE04}"/>
                </a:ext>
              </a:extLst>
            </p:cNvPr>
            <p:cNvSpPr/>
            <p:nvPr/>
          </p:nvSpPr>
          <p:spPr>
            <a:xfrm flipH="1" flipV="1">
              <a:off x="9076086" y="2577273"/>
              <a:ext cx="30809" cy="3859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1260"/>
            </a:p>
          </p:txBody>
        </p:sp>
      </p:grpSp>
      <p:pic>
        <p:nvPicPr>
          <p:cNvPr id="101" name="Picture 7" descr="화살표_목표3">
            <a:extLst>
              <a:ext uri="{FF2B5EF4-FFF2-40B4-BE49-F238E27FC236}">
                <a16:creationId xmlns:a16="http://schemas.microsoft.com/office/drawing/2014/main" id="{66891DB0-FEEB-4E35-92DF-9410A9E6CB1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6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 flipH="1">
            <a:off x="2435581" y="2106212"/>
            <a:ext cx="1303783" cy="4569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3" name="직사각형 686">
            <a:extLst>
              <a:ext uri="{FF2B5EF4-FFF2-40B4-BE49-F238E27FC236}">
                <a16:creationId xmlns:a16="http://schemas.microsoft.com/office/drawing/2014/main" id="{21CF46F8-E5FB-43FD-AEF4-1317D90FFD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38199" y="2011050"/>
            <a:ext cx="1448441" cy="205457"/>
          </a:xfrm>
          <a:prstGeom prst="rect">
            <a:avLst/>
          </a:prstGeom>
          <a:noFill/>
          <a:ln w="9525" algn="ctr">
            <a:noFill/>
            <a:round/>
            <a:headEnd/>
            <a:tailEnd/>
          </a:ln>
        </p:spPr>
        <p:txBody>
          <a:bodyPr anchor="ctr"/>
          <a:lstStyle/>
          <a:p>
            <a:pPr algn="ctr">
              <a:defRPr/>
            </a:pPr>
            <a:r>
              <a:rPr kumimoji="1" lang="en-US" altLang="ko-KR" sz="1400" kern="0" dirty="0">
                <a:solidFill>
                  <a:sysClr val="windowText" lastClr="000000"/>
                </a:solidFill>
                <a:latin typeface="Arial" pitchFamily="34" charset="0"/>
                <a:ea typeface="굴림" charset="-127"/>
                <a:cs typeface="Arial" pitchFamily="34" charset="0"/>
              </a:rPr>
              <a:t>3D cell Culture</a:t>
            </a:r>
            <a:endParaRPr kumimoji="1" lang="ko-KR" altLang="en-US" sz="1400" b="0" i="0" u="none" strike="noStrike" kern="0" cap="none" spc="0" normalizeH="0" baseline="0" noProof="0" dirty="0">
              <a:ln>
                <a:noFill/>
              </a:ln>
              <a:solidFill>
                <a:srgbClr val="080808"/>
              </a:solidFill>
              <a:effectLst/>
              <a:uLnTx/>
              <a:uFillTx/>
              <a:latin typeface="Arial" pitchFamily="34" charset="0"/>
              <a:ea typeface="굴림" charset="-127"/>
              <a:cs typeface="Arial" pitchFamily="34" charset="0"/>
            </a:endParaRPr>
          </a:p>
        </p:txBody>
      </p:sp>
      <p:sp>
        <p:nvSpPr>
          <p:cNvPr id="106" name="사각형: 둥근 모서리 549">
            <a:extLst>
              <a:ext uri="{FF2B5EF4-FFF2-40B4-BE49-F238E27FC236}">
                <a16:creationId xmlns:a16="http://schemas.microsoft.com/office/drawing/2014/main" id="{367014A1-A5CD-4374-9AB4-67B56CAF3172}"/>
              </a:ext>
            </a:extLst>
          </p:cNvPr>
          <p:cNvSpPr/>
          <p:nvPr/>
        </p:nvSpPr>
        <p:spPr>
          <a:xfrm>
            <a:off x="3127556" y="1217410"/>
            <a:ext cx="653032" cy="435153"/>
          </a:xfrm>
          <a:prstGeom prst="round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7" name="사각형: 둥근 모서리 550">
            <a:extLst>
              <a:ext uri="{FF2B5EF4-FFF2-40B4-BE49-F238E27FC236}">
                <a16:creationId xmlns:a16="http://schemas.microsoft.com/office/drawing/2014/main" id="{9DE1603A-AA2B-43B1-BCBA-AC1483D4E7D2}"/>
              </a:ext>
            </a:extLst>
          </p:cNvPr>
          <p:cNvSpPr/>
          <p:nvPr/>
        </p:nvSpPr>
        <p:spPr>
          <a:xfrm>
            <a:off x="3973824" y="966917"/>
            <a:ext cx="892627" cy="765540"/>
          </a:xfrm>
          <a:prstGeom prst="round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8" name="사각형: 둥근 모서리 551">
            <a:extLst>
              <a:ext uri="{FF2B5EF4-FFF2-40B4-BE49-F238E27FC236}">
                <a16:creationId xmlns:a16="http://schemas.microsoft.com/office/drawing/2014/main" id="{B796D94D-723B-441C-BEEE-74DDA3B1EE0E}"/>
              </a:ext>
            </a:extLst>
          </p:cNvPr>
          <p:cNvSpPr/>
          <p:nvPr/>
        </p:nvSpPr>
        <p:spPr>
          <a:xfrm>
            <a:off x="4487855" y="5599316"/>
            <a:ext cx="892627" cy="765540"/>
          </a:xfrm>
          <a:prstGeom prst="round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74" name="TextBox 373"/>
          <p:cNvSpPr txBox="1"/>
          <p:nvPr/>
        </p:nvSpPr>
        <p:spPr>
          <a:xfrm>
            <a:off x="4827234" y="-45004"/>
            <a:ext cx="24780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5" name="Rectangle 142">
            <a:extLst>
              <a:ext uri="{FF2B5EF4-FFF2-40B4-BE49-F238E27FC236}">
                <a16:creationId xmlns:a16="http://schemas.microsoft.com/office/drawing/2014/main" id="{7EC680F0-8D35-4499-9608-0C77C9959D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4351" y="439931"/>
            <a:ext cx="5721882" cy="4253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 marL="0" marR="0" lvl="0" indent="0" algn="ct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ko-KR" sz="1400" kern="0" dirty="0">
                <a:solidFill>
                  <a:sysClr val="windowText" lastClr="000000"/>
                </a:solidFill>
                <a:latin typeface="Arial" pitchFamily="34" charset="0"/>
                <a:ea typeface="굴림" charset="-127"/>
                <a:cs typeface="Arial" pitchFamily="34" charset="0"/>
              </a:rPr>
              <a:t>Conventional ECM-embedded 3D Cell Culture</a:t>
            </a:r>
            <a:endParaRPr kumimoji="1" lang="en-US" altLang="ko-KR" sz="1400" b="0" i="0" u="none" strike="noStrike" kern="0" cap="none" spc="0" normalizeH="0" baseline="-2500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Arial" pitchFamily="34" charset="0"/>
              <a:ea typeface="굴림" charset="-127"/>
              <a:cs typeface="Arial" pitchFamily="34" charset="0"/>
            </a:endParaRPr>
          </a:p>
        </p:txBody>
      </p:sp>
      <p:sp>
        <p:nvSpPr>
          <p:cNvPr id="376" name="TextBox 375"/>
          <p:cNvSpPr txBox="1"/>
          <p:nvPr/>
        </p:nvSpPr>
        <p:spPr>
          <a:xfrm>
            <a:off x="1054903" y="439931"/>
            <a:ext cx="330928" cy="3064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itchFamily="34" charset="0"/>
                <a:cs typeface="Arial" pitchFamily="34" charset="0"/>
              </a:rPr>
              <a:t>a</a:t>
            </a:r>
            <a:endParaRPr lang="ko-KR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7" name="TextBox 376"/>
          <p:cNvSpPr txBox="1"/>
          <p:nvPr/>
        </p:nvSpPr>
        <p:spPr>
          <a:xfrm>
            <a:off x="1580726" y="4774593"/>
            <a:ext cx="330928" cy="3064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itchFamily="34" charset="0"/>
                <a:cs typeface="Arial" pitchFamily="34" charset="0"/>
              </a:rPr>
              <a:t>b</a:t>
            </a:r>
            <a:endParaRPr lang="ko-KR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49665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그림 42">
            <a:extLst>
              <a:ext uri="{FF2B5EF4-FFF2-40B4-BE49-F238E27FC236}">
                <a16:creationId xmlns:a16="http://schemas.microsoft.com/office/drawing/2014/main" id="{02B59D2D-19E9-4CB6-90A6-CC8158F1304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64000"/>
                    </a14:imgEffect>
                    <a14:imgEffect>
                      <a14:brightnessContrast bright="54000" contrast="61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0" y="2133600"/>
            <a:ext cx="6858000" cy="5638800"/>
          </a:xfrm>
          <a:prstGeom prst="rect">
            <a:avLst/>
          </a:prstGeom>
        </p:spPr>
      </p:pic>
      <p:sp>
        <p:nvSpPr>
          <p:cNvPr id="44" name="직사각형 43">
            <a:extLst>
              <a:ext uri="{FF2B5EF4-FFF2-40B4-BE49-F238E27FC236}">
                <a16:creationId xmlns:a16="http://schemas.microsoft.com/office/drawing/2014/main" id="{5431261D-B545-455E-86C7-41C1D25BBBEF}"/>
              </a:ext>
            </a:extLst>
          </p:cNvPr>
          <p:cNvSpPr/>
          <p:nvPr/>
        </p:nvSpPr>
        <p:spPr>
          <a:xfrm>
            <a:off x="671572" y="2244215"/>
            <a:ext cx="152462" cy="101498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1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83" name="직사각형 82">
            <a:extLst>
              <a:ext uri="{FF2B5EF4-FFF2-40B4-BE49-F238E27FC236}">
                <a16:creationId xmlns:a16="http://schemas.microsoft.com/office/drawing/2014/main" id="{9B313F24-9E31-4CE6-B11C-D2A255AFB1CF}"/>
              </a:ext>
            </a:extLst>
          </p:cNvPr>
          <p:cNvSpPr/>
          <p:nvPr/>
        </p:nvSpPr>
        <p:spPr>
          <a:xfrm>
            <a:off x="1800530" y="2244215"/>
            <a:ext cx="152462" cy="101498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2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84" name="직사각형 83">
            <a:extLst>
              <a:ext uri="{FF2B5EF4-FFF2-40B4-BE49-F238E27FC236}">
                <a16:creationId xmlns:a16="http://schemas.microsoft.com/office/drawing/2014/main" id="{2FA49EDB-7197-4A53-AC2B-FEA71F807C27}"/>
              </a:ext>
            </a:extLst>
          </p:cNvPr>
          <p:cNvSpPr/>
          <p:nvPr/>
        </p:nvSpPr>
        <p:spPr>
          <a:xfrm>
            <a:off x="2930305" y="2244215"/>
            <a:ext cx="152462" cy="101498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3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85" name="직사각형 84">
            <a:extLst>
              <a:ext uri="{FF2B5EF4-FFF2-40B4-BE49-F238E27FC236}">
                <a16:creationId xmlns:a16="http://schemas.microsoft.com/office/drawing/2014/main" id="{4D465924-E469-424C-AB60-0A0D97ED3163}"/>
              </a:ext>
            </a:extLst>
          </p:cNvPr>
          <p:cNvSpPr/>
          <p:nvPr/>
        </p:nvSpPr>
        <p:spPr>
          <a:xfrm>
            <a:off x="4059263" y="2244215"/>
            <a:ext cx="152462" cy="101498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4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86" name="직사각형 85">
            <a:extLst>
              <a:ext uri="{FF2B5EF4-FFF2-40B4-BE49-F238E27FC236}">
                <a16:creationId xmlns:a16="http://schemas.microsoft.com/office/drawing/2014/main" id="{D1CCA1A8-1C28-4D76-830B-0FB1E1146DAA}"/>
              </a:ext>
            </a:extLst>
          </p:cNvPr>
          <p:cNvSpPr/>
          <p:nvPr/>
        </p:nvSpPr>
        <p:spPr>
          <a:xfrm>
            <a:off x="5092796" y="2244215"/>
            <a:ext cx="152462" cy="101498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5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87" name="직사각형 86">
            <a:extLst>
              <a:ext uri="{FF2B5EF4-FFF2-40B4-BE49-F238E27FC236}">
                <a16:creationId xmlns:a16="http://schemas.microsoft.com/office/drawing/2014/main" id="{64CD8C86-3624-4AA9-9438-0B5F95F76EED}"/>
              </a:ext>
            </a:extLst>
          </p:cNvPr>
          <p:cNvSpPr/>
          <p:nvPr/>
        </p:nvSpPr>
        <p:spPr>
          <a:xfrm>
            <a:off x="6221754" y="2244215"/>
            <a:ext cx="152462" cy="101498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6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88" name="직사각형 87">
            <a:extLst>
              <a:ext uri="{FF2B5EF4-FFF2-40B4-BE49-F238E27FC236}">
                <a16:creationId xmlns:a16="http://schemas.microsoft.com/office/drawing/2014/main" id="{A1A7C609-BC91-47AF-8827-7FDB98333D1A}"/>
              </a:ext>
            </a:extLst>
          </p:cNvPr>
          <p:cNvSpPr/>
          <p:nvPr/>
        </p:nvSpPr>
        <p:spPr>
          <a:xfrm>
            <a:off x="671572" y="3037509"/>
            <a:ext cx="152462" cy="101498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7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89" name="직사각형 88">
            <a:extLst>
              <a:ext uri="{FF2B5EF4-FFF2-40B4-BE49-F238E27FC236}">
                <a16:creationId xmlns:a16="http://schemas.microsoft.com/office/drawing/2014/main" id="{E164DF97-4164-4846-B1F4-ADA23E641199}"/>
              </a:ext>
            </a:extLst>
          </p:cNvPr>
          <p:cNvSpPr/>
          <p:nvPr/>
        </p:nvSpPr>
        <p:spPr>
          <a:xfrm>
            <a:off x="1800530" y="3037509"/>
            <a:ext cx="152462" cy="101498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8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90" name="직사각형 89">
            <a:extLst>
              <a:ext uri="{FF2B5EF4-FFF2-40B4-BE49-F238E27FC236}">
                <a16:creationId xmlns:a16="http://schemas.microsoft.com/office/drawing/2014/main" id="{8FDFF601-EE88-477E-B0B9-4665AFF9B552}"/>
              </a:ext>
            </a:extLst>
          </p:cNvPr>
          <p:cNvSpPr/>
          <p:nvPr/>
        </p:nvSpPr>
        <p:spPr>
          <a:xfrm>
            <a:off x="2930305" y="3037509"/>
            <a:ext cx="152462" cy="101498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9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91" name="직사각형 90">
            <a:extLst>
              <a:ext uri="{FF2B5EF4-FFF2-40B4-BE49-F238E27FC236}">
                <a16:creationId xmlns:a16="http://schemas.microsoft.com/office/drawing/2014/main" id="{76AE3AAA-17AF-4E29-A60A-89E25ECB9F85}"/>
              </a:ext>
            </a:extLst>
          </p:cNvPr>
          <p:cNvSpPr/>
          <p:nvPr/>
        </p:nvSpPr>
        <p:spPr>
          <a:xfrm>
            <a:off x="4059263" y="3037508"/>
            <a:ext cx="193438" cy="128777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10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92" name="직사각형 91">
            <a:extLst>
              <a:ext uri="{FF2B5EF4-FFF2-40B4-BE49-F238E27FC236}">
                <a16:creationId xmlns:a16="http://schemas.microsoft.com/office/drawing/2014/main" id="{2FCAD368-9E5E-4794-890A-E865BC579ECD}"/>
              </a:ext>
            </a:extLst>
          </p:cNvPr>
          <p:cNvSpPr/>
          <p:nvPr/>
        </p:nvSpPr>
        <p:spPr>
          <a:xfrm>
            <a:off x="5092796" y="3037508"/>
            <a:ext cx="193438" cy="128777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11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93" name="직사각형 92">
            <a:extLst>
              <a:ext uri="{FF2B5EF4-FFF2-40B4-BE49-F238E27FC236}">
                <a16:creationId xmlns:a16="http://schemas.microsoft.com/office/drawing/2014/main" id="{B308C77D-5A28-497B-8690-E35EABAEE8EF}"/>
              </a:ext>
            </a:extLst>
          </p:cNvPr>
          <p:cNvSpPr/>
          <p:nvPr/>
        </p:nvSpPr>
        <p:spPr>
          <a:xfrm>
            <a:off x="6221754" y="3037508"/>
            <a:ext cx="193438" cy="128777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12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94" name="직사각형 93">
            <a:extLst>
              <a:ext uri="{FF2B5EF4-FFF2-40B4-BE49-F238E27FC236}">
                <a16:creationId xmlns:a16="http://schemas.microsoft.com/office/drawing/2014/main" id="{3F074458-23D8-4D33-B31B-BFBF051B7511}"/>
              </a:ext>
            </a:extLst>
          </p:cNvPr>
          <p:cNvSpPr/>
          <p:nvPr/>
        </p:nvSpPr>
        <p:spPr>
          <a:xfrm>
            <a:off x="637912" y="3836154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13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95" name="직사각형 94">
            <a:extLst>
              <a:ext uri="{FF2B5EF4-FFF2-40B4-BE49-F238E27FC236}">
                <a16:creationId xmlns:a16="http://schemas.microsoft.com/office/drawing/2014/main" id="{8122252A-5C88-4E86-91E8-5075588F9AA6}"/>
              </a:ext>
            </a:extLst>
          </p:cNvPr>
          <p:cNvSpPr/>
          <p:nvPr/>
        </p:nvSpPr>
        <p:spPr>
          <a:xfrm>
            <a:off x="1766870" y="3836154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14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96" name="직사각형 95">
            <a:extLst>
              <a:ext uri="{FF2B5EF4-FFF2-40B4-BE49-F238E27FC236}">
                <a16:creationId xmlns:a16="http://schemas.microsoft.com/office/drawing/2014/main" id="{066F3F90-0FAE-46F1-B816-74043887B172}"/>
              </a:ext>
            </a:extLst>
          </p:cNvPr>
          <p:cNvSpPr/>
          <p:nvPr/>
        </p:nvSpPr>
        <p:spPr>
          <a:xfrm>
            <a:off x="2896645" y="3836154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15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97" name="직사각형 96">
            <a:extLst>
              <a:ext uri="{FF2B5EF4-FFF2-40B4-BE49-F238E27FC236}">
                <a16:creationId xmlns:a16="http://schemas.microsoft.com/office/drawing/2014/main" id="{4CD471D8-C09C-491C-9B72-4FE7B17CFCED}"/>
              </a:ext>
            </a:extLst>
          </p:cNvPr>
          <p:cNvSpPr/>
          <p:nvPr/>
        </p:nvSpPr>
        <p:spPr>
          <a:xfrm>
            <a:off x="4025603" y="3836154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16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98" name="직사각형 97">
            <a:extLst>
              <a:ext uri="{FF2B5EF4-FFF2-40B4-BE49-F238E27FC236}">
                <a16:creationId xmlns:a16="http://schemas.microsoft.com/office/drawing/2014/main" id="{45FD2170-CEA3-484A-BAA7-CA8FD1FD1365}"/>
              </a:ext>
            </a:extLst>
          </p:cNvPr>
          <p:cNvSpPr/>
          <p:nvPr/>
        </p:nvSpPr>
        <p:spPr>
          <a:xfrm>
            <a:off x="5059136" y="3836154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17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99" name="직사각형 98">
            <a:extLst>
              <a:ext uri="{FF2B5EF4-FFF2-40B4-BE49-F238E27FC236}">
                <a16:creationId xmlns:a16="http://schemas.microsoft.com/office/drawing/2014/main" id="{1BD2CB07-E7C4-4FCC-B49F-17033C988647}"/>
              </a:ext>
            </a:extLst>
          </p:cNvPr>
          <p:cNvSpPr/>
          <p:nvPr/>
        </p:nvSpPr>
        <p:spPr>
          <a:xfrm>
            <a:off x="6188094" y="3836154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18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106" name="직사각형 105">
            <a:extLst>
              <a:ext uri="{FF2B5EF4-FFF2-40B4-BE49-F238E27FC236}">
                <a16:creationId xmlns:a16="http://schemas.microsoft.com/office/drawing/2014/main" id="{A81E6647-23B1-4572-85D7-624FCFE24989}"/>
              </a:ext>
            </a:extLst>
          </p:cNvPr>
          <p:cNvSpPr/>
          <p:nvPr/>
        </p:nvSpPr>
        <p:spPr>
          <a:xfrm>
            <a:off x="637912" y="4584050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19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107" name="직사각형 106">
            <a:extLst>
              <a:ext uri="{FF2B5EF4-FFF2-40B4-BE49-F238E27FC236}">
                <a16:creationId xmlns:a16="http://schemas.microsoft.com/office/drawing/2014/main" id="{3239E80F-CBD0-4D85-8F94-A8C2074BC3C9}"/>
              </a:ext>
            </a:extLst>
          </p:cNvPr>
          <p:cNvSpPr/>
          <p:nvPr/>
        </p:nvSpPr>
        <p:spPr>
          <a:xfrm>
            <a:off x="1766870" y="4584050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20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108" name="직사각형 107">
            <a:extLst>
              <a:ext uri="{FF2B5EF4-FFF2-40B4-BE49-F238E27FC236}">
                <a16:creationId xmlns:a16="http://schemas.microsoft.com/office/drawing/2014/main" id="{C8832954-13CF-4449-AFA3-CFD711A544B2}"/>
              </a:ext>
            </a:extLst>
          </p:cNvPr>
          <p:cNvSpPr/>
          <p:nvPr/>
        </p:nvSpPr>
        <p:spPr>
          <a:xfrm>
            <a:off x="2896645" y="4584050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21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109" name="직사각형 108">
            <a:extLst>
              <a:ext uri="{FF2B5EF4-FFF2-40B4-BE49-F238E27FC236}">
                <a16:creationId xmlns:a16="http://schemas.microsoft.com/office/drawing/2014/main" id="{FFC250BE-3B9E-42B2-BF1B-B45D3826C516}"/>
              </a:ext>
            </a:extLst>
          </p:cNvPr>
          <p:cNvSpPr/>
          <p:nvPr/>
        </p:nvSpPr>
        <p:spPr>
          <a:xfrm>
            <a:off x="4025603" y="4584050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22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110" name="직사각형 109">
            <a:extLst>
              <a:ext uri="{FF2B5EF4-FFF2-40B4-BE49-F238E27FC236}">
                <a16:creationId xmlns:a16="http://schemas.microsoft.com/office/drawing/2014/main" id="{3534FB1D-069E-446B-8853-DD11EAE7D762}"/>
              </a:ext>
            </a:extLst>
          </p:cNvPr>
          <p:cNvSpPr/>
          <p:nvPr/>
        </p:nvSpPr>
        <p:spPr>
          <a:xfrm>
            <a:off x="5059136" y="4584050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23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111" name="직사각형 110">
            <a:extLst>
              <a:ext uri="{FF2B5EF4-FFF2-40B4-BE49-F238E27FC236}">
                <a16:creationId xmlns:a16="http://schemas.microsoft.com/office/drawing/2014/main" id="{8F2353CD-B294-4581-9A18-6285103B20E9}"/>
              </a:ext>
            </a:extLst>
          </p:cNvPr>
          <p:cNvSpPr/>
          <p:nvPr/>
        </p:nvSpPr>
        <p:spPr>
          <a:xfrm>
            <a:off x="6188094" y="4584050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24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112" name="직사각형 111">
            <a:extLst>
              <a:ext uri="{FF2B5EF4-FFF2-40B4-BE49-F238E27FC236}">
                <a16:creationId xmlns:a16="http://schemas.microsoft.com/office/drawing/2014/main" id="{E24CE7D4-B151-43B2-BB07-4B8293D06886}"/>
              </a:ext>
            </a:extLst>
          </p:cNvPr>
          <p:cNvSpPr/>
          <p:nvPr/>
        </p:nvSpPr>
        <p:spPr>
          <a:xfrm>
            <a:off x="637912" y="5379580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25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113" name="직사각형 112">
            <a:extLst>
              <a:ext uri="{FF2B5EF4-FFF2-40B4-BE49-F238E27FC236}">
                <a16:creationId xmlns:a16="http://schemas.microsoft.com/office/drawing/2014/main" id="{8EE8FC53-AAA7-4AE9-8B3C-80C2EAB8C602}"/>
              </a:ext>
            </a:extLst>
          </p:cNvPr>
          <p:cNvSpPr/>
          <p:nvPr/>
        </p:nvSpPr>
        <p:spPr>
          <a:xfrm>
            <a:off x="1766870" y="5379580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26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114" name="직사각형 113">
            <a:extLst>
              <a:ext uri="{FF2B5EF4-FFF2-40B4-BE49-F238E27FC236}">
                <a16:creationId xmlns:a16="http://schemas.microsoft.com/office/drawing/2014/main" id="{5C96FFE0-D9FE-4ABC-942A-4D2F3B854FCD}"/>
              </a:ext>
            </a:extLst>
          </p:cNvPr>
          <p:cNvSpPr/>
          <p:nvPr/>
        </p:nvSpPr>
        <p:spPr>
          <a:xfrm>
            <a:off x="2896645" y="5379580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27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115" name="직사각형 114">
            <a:extLst>
              <a:ext uri="{FF2B5EF4-FFF2-40B4-BE49-F238E27FC236}">
                <a16:creationId xmlns:a16="http://schemas.microsoft.com/office/drawing/2014/main" id="{9016D071-72A0-45AD-B8D5-DDF7AE614139}"/>
              </a:ext>
            </a:extLst>
          </p:cNvPr>
          <p:cNvSpPr/>
          <p:nvPr/>
        </p:nvSpPr>
        <p:spPr>
          <a:xfrm>
            <a:off x="4025603" y="5379580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28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116" name="직사각형 115">
            <a:extLst>
              <a:ext uri="{FF2B5EF4-FFF2-40B4-BE49-F238E27FC236}">
                <a16:creationId xmlns:a16="http://schemas.microsoft.com/office/drawing/2014/main" id="{977D65C7-8C34-4F79-A75B-E875AA5A9541}"/>
              </a:ext>
            </a:extLst>
          </p:cNvPr>
          <p:cNvSpPr/>
          <p:nvPr/>
        </p:nvSpPr>
        <p:spPr>
          <a:xfrm>
            <a:off x="5059136" y="5379580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29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117" name="직사각형 116">
            <a:extLst>
              <a:ext uri="{FF2B5EF4-FFF2-40B4-BE49-F238E27FC236}">
                <a16:creationId xmlns:a16="http://schemas.microsoft.com/office/drawing/2014/main" id="{D959334B-82C9-4A7A-86FF-5658093BC1D0}"/>
              </a:ext>
            </a:extLst>
          </p:cNvPr>
          <p:cNvSpPr/>
          <p:nvPr/>
        </p:nvSpPr>
        <p:spPr>
          <a:xfrm>
            <a:off x="6188094" y="5379580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30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118" name="직사각형 117">
            <a:extLst>
              <a:ext uri="{FF2B5EF4-FFF2-40B4-BE49-F238E27FC236}">
                <a16:creationId xmlns:a16="http://schemas.microsoft.com/office/drawing/2014/main" id="{44334B5A-BEC2-470E-AB22-9F0FBB118971}"/>
              </a:ext>
            </a:extLst>
          </p:cNvPr>
          <p:cNvSpPr/>
          <p:nvPr/>
        </p:nvSpPr>
        <p:spPr>
          <a:xfrm>
            <a:off x="637912" y="6175110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31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119" name="직사각형 118">
            <a:extLst>
              <a:ext uri="{FF2B5EF4-FFF2-40B4-BE49-F238E27FC236}">
                <a16:creationId xmlns:a16="http://schemas.microsoft.com/office/drawing/2014/main" id="{30848E2C-DCA4-4431-ACB0-6C44C0CFD3C4}"/>
              </a:ext>
            </a:extLst>
          </p:cNvPr>
          <p:cNvSpPr/>
          <p:nvPr/>
        </p:nvSpPr>
        <p:spPr>
          <a:xfrm>
            <a:off x="1766870" y="6175110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32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120" name="직사각형 119">
            <a:extLst>
              <a:ext uri="{FF2B5EF4-FFF2-40B4-BE49-F238E27FC236}">
                <a16:creationId xmlns:a16="http://schemas.microsoft.com/office/drawing/2014/main" id="{2DEF2C1B-2F41-4F64-A6D3-B595BC096AB4}"/>
              </a:ext>
            </a:extLst>
          </p:cNvPr>
          <p:cNvSpPr/>
          <p:nvPr/>
        </p:nvSpPr>
        <p:spPr>
          <a:xfrm>
            <a:off x="2896645" y="6175110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33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121" name="직사각형 120">
            <a:extLst>
              <a:ext uri="{FF2B5EF4-FFF2-40B4-BE49-F238E27FC236}">
                <a16:creationId xmlns:a16="http://schemas.microsoft.com/office/drawing/2014/main" id="{106DB86B-1CDC-4D89-97FE-934820E935A4}"/>
              </a:ext>
            </a:extLst>
          </p:cNvPr>
          <p:cNvSpPr/>
          <p:nvPr/>
        </p:nvSpPr>
        <p:spPr>
          <a:xfrm>
            <a:off x="4025603" y="6175110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34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122" name="직사각형 121">
            <a:extLst>
              <a:ext uri="{FF2B5EF4-FFF2-40B4-BE49-F238E27FC236}">
                <a16:creationId xmlns:a16="http://schemas.microsoft.com/office/drawing/2014/main" id="{4F4D0626-83A2-432D-A43D-7389E7A3022C}"/>
              </a:ext>
            </a:extLst>
          </p:cNvPr>
          <p:cNvSpPr/>
          <p:nvPr/>
        </p:nvSpPr>
        <p:spPr>
          <a:xfrm>
            <a:off x="5059136" y="6175110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35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123" name="직사각형 122">
            <a:extLst>
              <a:ext uri="{FF2B5EF4-FFF2-40B4-BE49-F238E27FC236}">
                <a16:creationId xmlns:a16="http://schemas.microsoft.com/office/drawing/2014/main" id="{0811806B-6FD6-4FD2-A5FD-0CED746FD5EA}"/>
              </a:ext>
            </a:extLst>
          </p:cNvPr>
          <p:cNvSpPr/>
          <p:nvPr/>
        </p:nvSpPr>
        <p:spPr>
          <a:xfrm>
            <a:off x="6188094" y="6175110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36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124" name="직사각형 123">
            <a:extLst>
              <a:ext uri="{FF2B5EF4-FFF2-40B4-BE49-F238E27FC236}">
                <a16:creationId xmlns:a16="http://schemas.microsoft.com/office/drawing/2014/main" id="{A49CD58E-AF6E-440A-9AA7-19DBF16959ED}"/>
              </a:ext>
            </a:extLst>
          </p:cNvPr>
          <p:cNvSpPr/>
          <p:nvPr/>
        </p:nvSpPr>
        <p:spPr>
          <a:xfrm>
            <a:off x="637912" y="6970640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37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125" name="직사각형 124">
            <a:extLst>
              <a:ext uri="{FF2B5EF4-FFF2-40B4-BE49-F238E27FC236}">
                <a16:creationId xmlns:a16="http://schemas.microsoft.com/office/drawing/2014/main" id="{30E700E1-40FB-4DD6-B1D9-BBB4247E3455}"/>
              </a:ext>
            </a:extLst>
          </p:cNvPr>
          <p:cNvSpPr/>
          <p:nvPr/>
        </p:nvSpPr>
        <p:spPr>
          <a:xfrm>
            <a:off x="1766870" y="6970640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38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126" name="직사각형 125">
            <a:extLst>
              <a:ext uri="{FF2B5EF4-FFF2-40B4-BE49-F238E27FC236}">
                <a16:creationId xmlns:a16="http://schemas.microsoft.com/office/drawing/2014/main" id="{ACA65EAB-0D94-423D-9F0F-837AFD3D89A4}"/>
              </a:ext>
            </a:extLst>
          </p:cNvPr>
          <p:cNvSpPr/>
          <p:nvPr/>
        </p:nvSpPr>
        <p:spPr>
          <a:xfrm>
            <a:off x="2896645" y="6970640"/>
            <a:ext cx="296852" cy="197622"/>
          </a:xfrm>
          <a:prstGeom prst="rect">
            <a:avLst/>
          </a:prstGeom>
          <a:noFill/>
          <a:ln w="6350" cap="flat" cmpd="sng" algn="ctr">
            <a:solidFill>
              <a:sysClr val="window" lastClr="FFFFFF"/>
            </a:solidFill>
            <a:prstDash val="dash"/>
          </a:ln>
          <a:effectLst/>
        </p:spPr>
        <p:txBody>
          <a:bodyPr lIns="0" tIns="0" rIns="0" bIns="0" rtlCol="0" anchor="ctr"/>
          <a:lstStyle/>
          <a:p>
            <a:pPr algn="ctr" defTabSz="914400" latinLnBrk="1"/>
            <a:r>
              <a:rPr lang="en-US" altLang="ko-KR" sz="900" b="1" kern="0" dirty="0">
                <a:cs typeface="Arial" panose="020B0604020202020204" pitchFamily="34" charset="0"/>
              </a:rPr>
              <a:t>#39</a:t>
            </a:r>
            <a:endParaRPr lang="ko-KR" altLang="en-US" sz="900" b="1" kern="0" dirty="0">
              <a:cs typeface="Arial" panose="020B0604020202020204" pitchFamily="34" charset="0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BC7D2E65-7D8F-47DB-AA31-9767F2557F71}"/>
              </a:ext>
            </a:extLst>
          </p:cNvPr>
          <p:cNvSpPr txBox="1"/>
          <p:nvPr/>
        </p:nvSpPr>
        <p:spPr>
          <a:xfrm>
            <a:off x="4827234" y="-45004"/>
            <a:ext cx="24780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2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70136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TextBox 373"/>
          <p:cNvSpPr txBox="1"/>
          <p:nvPr/>
        </p:nvSpPr>
        <p:spPr>
          <a:xfrm>
            <a:off x="4827234" y="-45004"/>
            <a:ext cx="24780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3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그룹 1"/>
          <p:cNvGrpSpPr/>
          <p:nvPr/>
        </p:nvGrpSpPr>
        <p:grpSpPr>
          <a:xfrm>
            <a:off x="830474" y="3959294"/>
            <a:ext cx="5229194" cy="3010344"/>
            <a:chOff x="866806" y="3939601"/>
            <a:chExt cx="5229194" cy="3010344"/>
          </a:xfrm>
        </p:grpSpPr>
        <p:grpSp>
          <p:nvGrpSpPr>
            <p:cNvPr id="384" name="그룹 383">
              <a:extLst>
                <a:ext uri="{FF2B5EF4-FFF2-40B4-BE49-F238E27FC236}">
                  <a16:creationId xmlns:a16="http://schemas.microsoft.com/office/drawing/2014/main" id="{D049FA5D-BEC9-4AE7-A543-7A67573697CE}"/>
                </a:ext>
              </a:extLst>
            </p:cNvPr>
            <p:cNvGrpSpPr/>
            <p:nvPr/>
          </p:nvGrpSpPr>
          <p:grpSpPr>
            <a:xfrm>
              <a:off x="866806" y="4117373"/>
              <a:ext cx="5229194" cy="2832572"/>
              <a:chOff x="1840910" y="4281192"/>
              <a:chExt cx="4086225" cy="2213444"/>
            </a:xfrm>
          </p:grpSpPr>
          <p:pic>
            <p:nvPicPr>
              <p:cNvPr id="385" name="그림 384">
                <a:extLst>
                  <a:ext uri="{FF2B5EF4-FFF2-40B4-BE49-F238E27FC236}">
                    <a16:creationId xmlns:a16="http://schemas.microsoft.com/office/drawing/2014/main" id="{6FD36BE4-8A4F-440D-9363-0D313FD874F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840910" y="4281192"/>
                <a:ext cx="4086225" cy="2085975"/>
              </a:xfrm>
              <a:prstGeom prst="rect">
                <a:avLst/>
              </a:prstGeom>
            </p:spPr>
          </p:pic>
          <p:grpSp>
            <p:nvGrpSpPr>
              <p:cNvPr id="386" name="그룹 385">
                <a:extLst>
                  <a:ext uri="{FF2B5EF4-FFF2-40B4-BE49-F238E27FC236}">
                    <a16:creationId xmlns:a16="http://schemas.microsoft.com/office/drawing/2014/main" id="{76CCCF54-4CC7-44AD-8DE3-CEDF86549E4E}"/>
                  </a:ext>
                </a:extLst>
              </p:cNvPr>
              <p:cNvGrpSpPr/>
              <p:nvPr/>
            </p:nvGrpSpPr>
            <p:grpSpPr>
              <a:xfrm>
                <a:off x="2272937" y="4545874"/>
                <a:ext cx="3232316" cy="1948762"/>
                <a:chOff x="2272937" y="4545874"/>
                <a:chExt cx="3232316" cy="1948762"/>
              </a:xfrm>
            </p:grpSpPr>
            <p:sp>
              <p:nvSpPr>
                <p:cNvPr id="387" name="직사각형 386">
                  <a:extLst>
                    <a:ext uri="{FF2B5EF4-FFF2-40B4-BE49-F238E27FC236}">
                      <a16:creationId xmlns:a16="http://schemas.microsoft.com/office/drawing/2014/main" id="{6661C030-0498-46F4-8CC9-6F9655C16276}"/>
                    </a:ext>
                  </a:extLst>
                </p:cNvPr>
                <p:cNvSpPr/>
                <p:nvPr/>
              </p:nvSpPr>
              <p:spPr>
                <a:xfrm>
                  <a:off x="2272937" y="4545874"/>
                  <a:ext cx="1163533" cy="1419497"/>
                </a:xfrm>
                <a:prstGeom prst="rect">
                  <a:avLst/>
                </a:prstGeom>
                <a:solidFill>
                  <a:schemeClr val="accent5">
                    <a:lumMod val="60000"/>
                    <a:lumOff val="40000"/>
                    <a:alpha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dirty="0"/>
                </a:p>
              </p:txBody>
            </p:sp>
            <p:sp>
              <p:nvSpPr>
                <p:cNvPr id="388" name="직사각형 387">
                  <a:extLst>
                    <a:ext uri="{FF2B5EF4-FFF2-40B4-BE49-F238E27FC236}">
                      <a16:creationId xmlns:a16="http://schemas.microsoft.com/office/drawing/2014/main" id="{F5AA9152-76D9-4AE6-B563-54C8F1AF23AE}"/>
                    </a:ext>
                  </a:extLst>
                </p:cNvPr>
                <p:cNvSpPr/>
                <p:nvPr/>
              </p:nvSpPr>
              <p:spPr>
                <a:xfrm>
                  <a:off x="3429664" y="4545874"/>
                  <a:ext cx="2075589" cy="1419497"/>
                </a:xfrm>
                <a:prstGeom prst="rect">
                  <a:avLst/>
                </a:prstGeom>
                <a:solidFill>
                  <a:srgbClr val="00B050">
                    <a:alpha val="50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dirty="0"/>
                </a:p>
              </p:txBody>
            </p:sp>
            <p:sp>
              <p:nvSpPr>
                <p:cNvPr id="389" name="TextBox 388">
                  <a:extLst>
                    <a:ext uri="{FF2B5EF4-FFF2-40B4-BE49-F238E27FC236}">
                      <a16:creationId xmlns:a16="http://schemas.microsoft.com/office/drawing/2014/main" id="{32361817-7346-46A9-853C-B883C5711F37}"/>
                    </a:ext>
                  </a:extLst>
                </p:cNvPr>
                <p:cNvSpPr txBox="1"/>
                <p:nvPr/>
              </p:nvSpPr>
              <p:spPr>
                <a:xfrm>
                  <a:off x="2731920" y="6206031"/>
                  <a:ext cx="2194560" cy="2886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b="1" dirty="0"/>
                    <a:t>Z-score</a:t>
                  </a:r>
                  <a:r>
                    <a:rPr lang="ko-KR" altLang="en-US" b="1" dirty="0"/>
                    <a:t> </a:t>
                  </a:r>
                  <a:r>
                    <a:rPr lang="en-US" altLang="ko-KR" b="1" dirty="0"/>
                    <a:t>(</a:t>
                  </a:r>
                  <a:r>
                    <a:rPr lang="en-US" altLang="ko-KR" b="1" dirty="0" err="1"/>
                    <a:t>RT</a:t>
                  </a:r>
                  <a:r>
                    <a:rPr lang="en-US" altLang="ko-KR" b="1" baseline="-25000" dirty="0" err="1"/>
                    <a:t>auc</a:t>
                  </a:r>
                  <a:r>
                    <a:rPr lang="en-US" altLang="ko-KR" b="1" dirty="0"/>
                    <a:t>)</a:t>
                  </a:r>
                  <a:endParaRPr lang="ko-KR" altLang="en-US" b="1" dirty="0"/>
                </a:p>
              </p:txBody>
            </p:sp>
          </p:grpSp>
        </p:grpSp>
        <p:sp>
          <p:nvSpPr>
            <p:cNvPr id="390" name="TextBox 389">
              <a:extLst>
                <a:ext uri="{FF2B5EF4-FFF2-40B4-BE49-F238E27FC236}">
                  <a16:creationId xmlns:a16="http://schemas.microsoft.com/office/drawing/2014/main" id="{8825B20F-6772-437F-9670-32E029030D01}"/>
                </a:ext>
              </a:extLst>
            </p:cNvPr>
            <p:cNvSpPr txBox="1"/>
            <p:nvPr/>
          </p:nvSpPr>
          <p:spPr>
            <a:xfrm>
              <a:off x="1047573" y="4130728"/>
              <a:ext cx="2194560" cy="3657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dirty="0">
                  <a:solidFill>
                    <a:schemeClr val="accent1">
                      <a:lumMod val="75000"/>
                    </a:schemeClr>
                  </a:solidFill>
                </a:rPr>
                <a:t>RT-sensitive</a:t>
              </a:r>
              <a:endParaRPr lang="ko-KR" altLang="en-US" b="1" dirty="0">
                <a:solidFill>
                  <a:schemeClr val="accent1">
                    <a:lumMod val="75000"/>
                  </a:schemeClr>
                </a:solidFill>
              </a:endParaRPr>
            </a:p>
          </p:txBody>
        </p:sp>
        <p:sp>
          <p:nvSpPr>
            <p:cNvPr id="391" name="TextBox 390">
              <a:extLst>
                <a:ext uri="{FF2B5EF4-FFF2-40B4-BE49-F238E27FC236}">
                  <a16:creationId xmlns:a16="http://schemas.microsoft.com/office/drawing/2014/main" id="{2568CCD1-B909-448E-97C9-66BE6E90732F}"/>
                </a:ext>
              </a:extLst>
            </p:cNvPr>
            <p:cNvSpPr txBox="1"/>
            <p:nvPr/>
          </p:nvSpPr>
          <p:spPr>
            <a:xfrm>
              <a:off x="1035105" y="4443016"/>
              <a:ext cx="2194560" cy="469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 err="1"/>
                <a:t>Rt</a:t>
              </a:r>
              <a:r>
                <a:rPr lang="en-US" altLang="ko-KR" sz="1400" b="1" baseline="-25000" dirty="0" err="1"/>
                <a:t>auc</a:t>
              </a:r>
              <a:r>
                <a:rPr lang="en-US" altLang="ko-KR" sz="1400" b="1" baseline="-25000" dirty="0"/>
                <a:t>  </a:t>
              </a:r>
              <a:r>
                <a:rPr lang="en-US" altLang="ko-KR" sz="1400" b="1" dirty="0"/>
                <a:t>= 4.6</a:t>
              </a:r>
            </a:p>
            <a:p>
              <a:pPr algn="ctr"/>
              <a:r>
                <a:rPr lang="en-US" altLang="ko-KR" sz="1000" b="1" dirty="0"/>
                <a:t>lower 40% distribution</a:t>
              </a:r>
            </a:p>
          </p:txBody>
        </p:sp>
        <p:sp>
          <p:nvSpPr>
            <p:cNvPr id="392" name="TextBox 391">
              <a:extLst>
                <a:ext uri="{FF2B5EF4-FFF2-40B4-BE49-F238E27FC236}">
                  <a16:creationId xmlns:a16="http://schemas.microsoft.com/office/drawing/2014/main" id="{6FD8A12F-B746-4D19-BDE7-D1948483C3BC}"/>
                </a:ext>
              </a:extLst>
            </p:cNvPr>
            <p:cNvSpPr txBox="1"/>
            <p:nvPr/>
          </p:nvSpPr>
          <p:spPr>
            <a:xfrm>
              <a:off x="3054507" y="4124665"/>
              <a:ext cx="2194560" cy="3657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dirty="0">
                  <a:solidFill>
                    <a:srgbClr val="00B050"/>
                  </a:solidFill>
                </a:rPr>
                <a:t>RT-Resistant</a:t>
              </a:r>
              <a:endParaRPr lang="ko-KR" altLang="en-US" b="1" dirty="0">
                <a:solidFill>
                  <a:srgbClr val="00B050"/>
                </a:solidFill>
              </a:endParaRPr>
            </a:p>
          </p:txBody>
        </p:sp>
        <p:sp>
          <p:nvSpPr>
            <p:cNvPr id="393" name="TextBox 392">
              <a:extLst>
                <a:ext uri="{FF2B5EF4-FFF2-40B4-BE49-F238E27FC236}">
                  <a16:creationId xmlns:a16="http://schemas.microsoft.com/office/drawing/2014/main" id="{C886DBCB-2A68-4620-9D01-0B1BBD58A797}"/>
                </a:ext>
              </a:extLst>
            </p:cNvPr>
            <p:cNvSpPr txBox="1"/>
            <p:nvPr/>
          </p:nvSpPr>
          <p:spPr>
            <a:xfrm rot="16200000">
              <a:off x="-265590" y="5159138"/>
              <a:ext cx="2808406" cy="369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dirty="0"/>
                <a:t>Cases</a:t>
              </a:r>
              <a:endParaRPr lang="ko-KR" altLang="en-US" b="1" dirty="0"/>
            </a:p>
          </p:txBody>
        </p:sp>
      </p:grpSp>
      <p:pic>
        <p:nvPicPr>
          <p:cNvPr id="15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2003" y="827966"/>
            <a:ext cx="3064505" cy="20959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257483" y="591572"/>
            <a:ext cx="2827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itchFamily="34" charset="0"/>
                <a:cs typeface="Arial" pitchFamily="34" charset="0"/>
              </a:rPr>
              <a:t>a</a:t>
            </a:r>
            <a:endParaRPr lang="ko-KR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265872" y="2805521"/>
            <a:ext cx="1174107" cy="236706"/>
          </a:xfrm>
          <a:prstGeom prst="rect">
            <a:avLst/>
          </a:prstGeom>
          <a:noFill/>
          <a:ln w="635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r>
              <a:rPr lang="en-US" altLang="ko-KR" sz="1200" b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auc</a:t>
            </a:r>
            <a:endParaRPr lang="ko-KR" altLang="en-US" sz="12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386129" y="2828875"/>
            <a:ext cx="1724460" cy="276999"/>
          </a:xfrm>
          <a:prstGeom prst="rect">
            <a:avLst/>
          </a:prstGeom>
          <a:noFill/>
          <a:ln w="635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Z-score of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r>
              <a:rPr lang="en-US" altLang="ko-KR" sz="1200" b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auc</a:t>
            </a:r>
            <a:endParaRPr lang="ko-KR" altLang="en-US" sz="12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-352923" y="1725721"/>
            <a:ext cx="1174107" cy="236706"/>
          </a:xfrm>
          <a:prstGeom prst="rect">
            <a:avLst/>
          </a:prstGeom>
          <a:noFill/>
          <a:ln w="635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6200000">
            <a:off x="3264644" y="1725721"/>
            <a:ext cx="1174107" cy="236706"/>
          </a:xfrm>
          <a:prstGeom prst="rect">
            <a:avLst/>
          </a:prstGeom>
          <a:noFill/>
          <a:ln w="635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오른쪽 화살표 20"/>
          <p:cNvSpPr/>
          <p:nvPr/>
        </p:nvSpPr>
        <p:spPr>
          <a:xfrm>
            <a:off x="3063983" y="1618534"/>
            <a:ext cx="621861" cy="812594"/>
          </a:xfrm>
          <a:prstGeom prst="rightArrow">
            <a:avLst/>
          </a:prstGeom>
          <a:noFill/>
          <a:ln w="6350" cap="flat" cmpd="sng" algn="ctr">
            <a:solidFill>
              <a:schemeClr val="tx1"/>
            </a:solidFill>
            <a:prstDash val="dash"/>
          </a:ln>
          <a:effectLst/>
        </p:spPr>
        <p:txBody>
          <a:bodyPr rtlCol="0" anchor="ctr"/>
          <a:lstStyle/>
          <a:p>
            <a:pPr algn="ctr" defTabSz="914400" latinLnBrk="1"/>
            <a:endParaRPr lang="ko-KR" altLang="en-US" sz="800" kern="0">
              <a:solidFill>
                <a:prstClr val="white"/>
              </a:solidFill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821285" y="819750"/>
            <a:ext cx="1174107" cy="646331"/>
          </a:xfrm>
          <a:prstGeom prst="rect">
            <a:avLst/>
          </a:prstGeom>
          <a:noFill/>
          <a:ln w="635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tandard Normal Distribution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직선 연결선 22"/>
          <p:cNvCxnSpPr/>
          <p:nvPr/>
        </p:nvCxnSpPr>
        <p:spPr>
          <a:xfrm>
            <a:off x="5200860" y="805936"/>
            <a:ext cx="0" cy="1774839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2568CCD1-B909-448E-97C9-66BE6E90732F}"/>
              </a:ext>
            </a:extLst>
          </p:cNvPr>
          <p:cNvSpPr txBox="1"/>
          <p:nvPr/>
        </p:nvSpPr>
        <p:spPr>
          <a:xfrm>
            <a:off x="3569030" y="379102"/>
            <a:ext cx="27779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err="1"/>
              <a:t>RT</a:t>
            </a:r>
            <a:r>
              <a:rPr lang="en-US" altLang="ko-KR" sz="1400" b="1" baseline="-25000" dirty="0" err="1"/>
              <a:t>auc</a:t>
            </a:r>
            <a:r>
              <a:rPr lang="en-US" altLang="ko-KR" sz="1400" b="1" dirty="0"/>
              <a:t> = 4.6 </a:t>
            </a:r>
            <a:r>
              <a:rPr lang="en-US" altLang="ko-KR" sz="1100" b="1" dirty="0"/>
              <a:t>(lower 40% distribution)</a:t>
            </a:r>
            <a:endParaRPr lang="en-US" altLang="ko-KR" sz="1400" b="1" dirty="0"/>
          </a:p>
        </p:txBody>
      </p:sp>
      <p:sp>
        <p:nvSpPr>
          <p:cNvPr id="25" name="오른쪽 화살표 24"/>
          <p:cNvSpPr/>
          <p:nvPr/>
        </p:nvSpPr>
        <p:spPr>
          <a:xfrm rot="10800000">
            <a:off x="4065955" y="634948"/>
            <a:ext cx="1146780" cy="386033"/>
          </a:xfrm>
          <a:prstGeom prst="rightArrow">
            <a:avLst/>
          </a:prstGeom>
          <a:solidFill>
            <a:srgbClr val="FF0000"/>
          </a:solidFill>
          <a:ln w="6350" cap="flat" cmpd="sng" algn="ctr">
            <a:noFill/>
            <a:prstDash val="dash"/>
          </a:ln>
          <a:effectLst/>
        </p:spPr>
        <p:txBody>
          <a:bodyPr rtlCol="0" anchor="ctr"/>
          <a:lstStyle/>
          <a:p>
            <a:pPr algn="ctr" defTabSz="914400" latinLnBrk="1"/>
            <a:endParaRPr lang="ko-KR" altLang="en-US" sz="800" kern="0">
              <a:solidFill>
                <a:prstClr val="white"/>
              </a:solidFill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795452" y="705000"/>
            <a:ext cx="1724460" cy="261610"/>
          </a:xfrm>
          <a:prstGeom prst="rect">
            <a:avLst/>
          </a:prstGeom>
          <a:noFill/>
          <a:ln w="635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spc="-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-score = - 0.26</a:t>
            </a:r>
            <a:endParaRPr lang="ko-KR" altLang="en-US" sz="1100" b="1" spc="-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41865" y="816091"/>
            <a:ext cx="3094429" cy="2116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8" name="TextBox 27"/>
          <p:cNvSpPr txBox="1"/>
          <p:nvPr/>
        </p:nvSpPr>
        <p:spPr>
          <a:xfrm>
            <a:off x="310549" y="3689216"/>
            <a:ext cx="2827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itchFamily="34" charset="0"/>
                <a:cs typeface="Arial" pitchFamily="34" charset="0"/>
              </a:rPr>
              <a:t>b</a:t>
            </a:r>
            <a:endParaRPr lang="ko-KR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직사각형 2">
            <a:extLst>
              <a:ext uri="{FF2B5EF4-FFF2-40B4-BE49-F238E27FC236}">
                <a16:creationId xmlns:a16="http://schemas.microsoft.com/office/drawing/2014/main" id="{C942E132-46F8-4D5F-A1F5-D5DC953AD16E}"/>
              </a:ext>
            </a:extLst>
          </p:cNvPr>
          <p:cNvSpPr/>
          <p:nvPr/>
        </p:nvSpPr>
        <p:spPr>
          <a:xfrm>
            <a:off x="3795453" y="5861444"/>
            <a:ext cx="1740920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0" kern="0" dirty="0">
                <a:solidFill>
                  <a:srgbClr val="FF0000"/>
                </a:solidFill>
                <a:ea typeface="Times New Roman" panose="02020603050405020304" pitchFamily="18" charset="0"/>
              </a:rPr>
              <a:t>T</a:t>
            </a:r>
            <a:r>
              <a:rPr lang="ko-KR" altLang="ko-KR" sz="1100" kern="0" dirty="0" err="1">
                <a:solidFill>
                  <a:srgbClr val="FF0000"/>
                </a:solidFill>
                <a:ea typeface="Times New Roman" panose="02020603050405020304" pitchFamily="18" charset="0"/>
              </a:rPr>
              <a:t>rue</a:t>
            </a:r>
            <a:r>
              <a:rPr lang="ko-KR" altLang="ko-KR" sz="1100" kern="0" dirty="0">
                <a:solidFill>
                  <a:srgbClr val="FF0000"/>
                </a:solidFill>
                <a:ea typeface="Times New Roman" panose="02020603050405020304" pitchFamily="18" charset="0"/>
              </a:rPr>
              <a:t> </a:t>
            </a:r>
            <a:r>
              <a:rPr lang="en-US" altLang="ko-KR" sz="1100" kern="0" dirty="0">
                <a:solidFill>
                  <a:srgbClr val="FF0000"/>
                </a:solidFill>
                <a:ea typeface="Times New Roman" panose="02020603050405020304" pitchFamily="18" charset="0"/>
              </a:rPr>
              <a:t>P</a:t>
            </a:r>
            <a:r>
              <a:rPr lang="ko-KR" altLang="ko-KR" sz="1100" kern="0" dirty="0" err="1">
                <a:solidFill>
                  <a:srgbClr val="FF0000"/>
                </a:solidFill>
                <a:ea typeface="Times New Roman" panose="02020603050405020304" pitchFamily="18" charset="0"/>
              </a:rPr>
              <a:t>ositive</a:t>
            </a:r>
            <a:r>
              <a:rPr lang="en-US" altLang="ko-KR" sz="1100" kern="0" dirty="0">
                <a:solidFill>
                  <a:srgbClr val="FF0000"/>
                </a:solidFill>
                <a:ea typeface="Times New Roman" panose="02020603050405020304" pitchFamily="18" charset="0"/>
              </a:rPr>
              <a:t> R</a:t>
            </a:r>
            <a:r>
              <a:rPr lang="ko-KR" altLang="ko-KR" sz="1100" kern="0" dirty="0" err="1">
                <a:solidFill>
                  <a:srgbClr val="FF0000"/>
                </a:solidFill>
                <a:ea typeface="Times New Roman" panose="02020603050405020304" pitchFamily="18" charset="0"/>
              </a:rPr>
              <a:t>ate</a:t>
            </a:r>
            <a:r>
              <a:rPr lang="en-US" altLang="ko-KR" sz="1100" kern="0" dirty="0">
                <a:solidFill>
                  <a:srgbClr val="FF0000"/>
                </a:solidFill>
                <a:ea typeface="Times New Roman" panose="02020603050405020304" pitchFamily="18" charset="0"/>
              </a:rPr>
              <a:t> </a:t>
            </a:r>
          </a:p>
          <a:p>
            <a:r>
              <a:rPr lang="en-US" altLang="ko-KR" sz="1100" kern="0" dirty="0">
                <a:solidFill>
                  <a:srgbClr val="FF0000"/>
                </a:solidFill>
                <a:ea typeface="Times New Roman" panose="02020603050405020304" pitchFamily="18" charset="0"/>
              </a:rPr>
              <a:t>(Recurrence):</a:t>
            </a:r>
            <a:r>
              <a:rPr lang="ko-KR" altLang="ko-KR" sz="1100" kern="0" dirty="0">
                <a:solidFill>
                  <a:srgbClr val="FF0000"/>
                </a:solidFill>
                <a:ea typeface="Times New Roman" panose="02020603050405020304" pitchFamily="18" charset="0"/>
              </a:rPr>
              <a:t> 84.61% </a:t>
            </a:r>
            <a:endParaRPr lang="ko-KR" altLang="en-US" sz="1100" dirty="0"/>
          </a:p>
        </p:txBody>
      </p:sp>
      <p:sp>
        <p:nvSpPr>
          <p:cNvPr id="4" name="타원 3">
            <a:extLst>
              <a:ext uri="{FF2B5EF4-FFF2-40B4-BE49-F238E27FC236}">
                <a16:creationId xmlns:a16="http://schemas.microsoft.com/office/drawing/2014/main" id="{45AD3CE3-A18E-4BF3-ADE4-7A476FD9EB26}"/>
              </a:ext>
            </a:extLst>
          </p:cNvPr>
          <p:cNvSpPr/>
          <p:nvPr/>
        </p:nvSpPr>
        <p:spPr>
          <a:xfrm>
            <a:off x="2596514" y="5275403"/>
            <a:ext cx="90000" cy="90000"/>
          </a:xfrm>
          <a:prstGeom prst="ellipse">
            <a:avLst/>
          </a:prstGeom>
          <a:solidFill>
            <a:srgbClr val="FF0000"/>
          </a:solidFill>
          <a:ln w="6350" cap="flat" cmpd="sng" algn="ctr">
            <a:noFill/>
            <a:prstDash val="dash"/>
          </a:ln>
          <a:effectLst/>
        </p:spPr>
        <p:txBody>
          <a:bodyPr rtlCol="0" anchor="ctr"/>
          <a:lstStyle/>
          <a:p>
            <a:pPr algn="ctr" defTabSz="914400" latinLnBrk="1"/>
            <a:endParaRPr lang="ko-KR" altLang="en-US" sz="800" kern="0">
              <a:solidFill>
                <a:prstClr val="white"/>
              </a:solidFill>
              <a:cs typeface="Arial" panose="020B0604020202020204" pitchFamily="34" charset="0"/>
            </a:endParaRPr>
          </a:p>
        </p:txBody>
      </p:sp>
      <p:sp>
        <p:nvSpPr>
          <p:cNvPr id="32" name="타원 31">
            <a:extLst>
              <a:ext uri="{FF2B5EF4-FFF2-40B4-BE49-F238E27FC236}">
                <a16:creationId xmlns:a16="http://schemas.microsoft.com/office/drawing/2014/main" id="{CF041796-1D05-4337-8CB7-AE2AD962D282}"/>
              </a:ext>
            </a:extLst>
          </p:cNvPr>
          <p:cNvSpPr/>
          <p:nvPr/>
        </p:nvSpPr>
        <p:spPr>
          <a:xfrm>
            <a:off x="2485153" y="5276685"/>
            <a:ext cx="90000" cy="90000"/>
          </a:xfrm>
          <a:prstGeom prst="ellipse">
            <a:avLst/>
          </a:prstGeom>
          <a:solidFill>
            <a:srgbClr val="FF0000"/>
          </a:solidFill>
          <a:ln w="6350" cap="flat" cmpd="sng" algn="ctr">
            <a:noFill/>
            <a:prstDash val="dash"/>
          </a:ln>
          <a:effectLst/>
        </p:spPr>
        <p:txBody>
          <a:bodyPr rtlCol="0" anchor="ctr"/>
          <a:lstStyle/>
          <a:p>
            <a:pPr algn="ctr" defTabSz="914400" latinLnBrk="1"/>
            <a:endParaRPr lang="ko-KR" altLang="en-US" sz="800" kern="0">
              <a:solidFill>
                <a:prstClr val="white"/>
              </a:solidFill>
              <a:cs typeface="Arial" panose="020B0604020202020204" pitchFamily="34" charset="0"/>
            </a:endParaRPr>
          </a:p>
        </p:txBody>
      </p:sp>
      <p:sp>
        <p:nvSpPr>
          <p:cNvPr id="33" name="타원 32">
            <a:extLst>
              <a:ext uri="{FF2B5EF4-FFF2-40B4-BE49-F238E27FC236}">
                <a16:creationId xmlns:a16="http://schemas.microsoft.com/office/drawing/2014/main" id="{DA1ACFB1-930F-47A2-B946-A130784C96D1}"/>
              </a:ext>
            </a:extLst>
          </p:cNvPr>
          <p:cNvSpPr/>
          <p:nvPr/>
        </p:nvSpPr>
        <p:spPr>
          <a:xfrm>
            <a:off x="2917895" y="5135847"/>
            <a:ext cx="90000" cy="90000"/>
          </a:xfrm>
          <a:prstGeom prst="ellipse">
            <a:avLst/>
          </a:prstGeom>
          <a:solidFill>
            <a:srgbClr val="FF0000"/>
          </a:solidFill>
          <a:ln w="6350" cap="flat" cmpd="sng" algn="ctr">
            <a:noFill/>
            <a:prstDash val="dash"/>
          </a:ln>
          <a:effectLst/>
        </p:spPr>
        <p:txBody>
          <a:bodyPr rtlCol="0" anchor="ctr"/>
          <a:lstStyle/>
          <a:p>
            <a:pPr algn="ctr" defTabSz="914400" latinLnBrk="1"/>
            <a:endParaRPr lang="ko-KR" altLang="en-US" sz="800" kern="0">
              <a:solidFill>
                <a:prstClr val="white"/>
              </a:solidFill>
              <a:cs typeface="Arial" panose="020B0604020202020204" pitchFamily="34" charset="0"/>
            </a:endParaRPr>
          </a:p>
        </p:txBody>
      </p:sp>
      <p:sp>
        <p:nvSpPr>
          <p:cNvPr id="34" name="타원 33">
            <a:extLst>
              <a:ext uri="{FF2B5EF4-FFF2-40B4-BE49-F238E27FC236}">
                <a16:creationId xmlns:a16="http://schemas.microsoft.com/office/drawing/2014/main" id="{53455D0A-F86F-4344-B4CD-B751FC461145}"/>
              </a:ext>
            </a:extLst>
          </p:cNvPr>
          <p:cNvSpPr/>
          <p:nvPr/>
        </p:nvSpPr>
        <p:spPr>
          <a:xfrm>
            <a:off x="2922177" y="5552096"/>
            <a:ext cx="90000" cy="90000"/>
          </a:xfrm>
          <a:prstGeom prst="ellipse">
            <a:avLst/>
          </a:prstGeom>
          <a:solidFill>
            <a:srgbClr val="FF0000"/>
          </a:solidFill>
          <a:ln w="6350" cap="flat" cmpd="sng" algn="ctr">
            <a:noFill/>
            <a:prstDash val="dash"/>
          </a:ln>
          <a:effectLst/>
        </p:spPr>
        <p:txBody>
          <a:bodyPr rtlCol="0" anchor="ctr"/>
          <a:lstStyle/>
          <a:p>
            <a:pPr algn="ctr" defTabSz="914400" latinLnBrk="1"/>
            <a:endParaRPr lang="ko-KR" altLang="en-US" sz="800" kern="0">
              <a:solidFill>
                <a:prstClr val="white"/>
              </a:solidFill>
              <a:cs typeface="Arial" panose="020B0604020202020204" pitchFamily="34" charset="0"/>
            </a:endParaRPr>
          </a:p>
        </p:txBody>
      </p:sp>
      <p:sp>
        <p:nvSpPr>
          <p:cNvPr id="35" name="타원 34">
            <a:extLst>
              <a:ext uri="{FF2B5EF4-FFF2-40B4-BE49-F238E27FC236}">
                <a16:creationId xmlns:a16="http://schemas.microsoft.com/office/drawing/2014/main" id="{F6E8EE27-D2B7-4799-A142-750858396777}"/>
              </a:ext>
            </a:extLst>
          </p:cNvPr>
          <p:cNvSpPr/>
          <p:nvPr/>
        </p:nvSpPr>
        <p:spPr>
          <a:xfrm>
            <a:off x="2971566" y="5268351"/>
            <a:ext cx="90000" cy="90000"/>
          </a:xfrm>
          <a:prstGeom prst="ellipse">
            <a:avLst/>
          </a:prstGeom>
          <a:solidFill>
            <a:srgbClr val="FF0000"/>
          </a:solidFill>
          <a:ln w="6350" cap="flat" cmpd="sng" algn="ctr">
            <a:noFill/>
            <a:prstDash val="dash"/>
          </a:ln>
          <a:effectLst/>
        </p:spPr>
        <p:txBody>
          <a:bodyPr rtlCol="0" anchor="ctr"/>
          <a:lstStyle/>
          <a:p>
            <a:pPr algn="ctr" defTabSz="914400" latinLnBrk="1"/>
            <a:endParaRPr lang="ko-KR" altLang="en-US" sz="800" kern="0">
              <a:solidFill>
                <a:prstClr val="white"/>
              </a:solidFill>
              <a:cs typeface="Arial" panose="020B0604020202020204" pitchFamily="34" charset="0"/>
            </a:endParaRPr>
          </a:p>
        </p:txBody>
      </p:sp>
      <p:sp>
        <p:nvSpPr>
          <p:cNvPr id="36" name="타원 35">
            <a:extLst>
              <a:ext uri="{FF2B5EF4-FFF2-40B4-BE49-F238E27FC236}">
                <a16:creationId xmlns:a16="http://schemas.microsoft.com/office/drawing/2014/main" id="{060CE614-E768-486E-811D-880F7BD20424}"/>
              </a:ext>
            </a:extLst>
          </p:cNvPr>
          <p:cNvSpPr/>
          <p:nvPr/>
        </p:nvSpPr>
        <p:spPr>
          <a:xfrm>
            <a:off x="3022220" y="5131691"/>
            <a:ext cx="90000" cy="90000"/>
          </a:xfrm>
          <a:prstGeom prst="ellipse">
            <a:avLst/>
          </a:prstGeom>
          <a:solidFill>
            <a:srgbClr val="FF0000"/>
          </a:solidFill>
          <a:ln w="6350" cap="flat" cmpd="sng" algn="ctr">
            <a:noFill/>
            <a:prstDash val="dash"/>
          </a:ln>
          <a:effectLst/>
        </p:spPr>
        <p:txBody>
          <a:bodyPr rtlCol="0" anchor="ctr"/>
          <a:lstStyle/>
          <a:p>
            <a:pPr algn="ctr" defTabSz="914400" latinLnBrk="1"/>
            <a:endParaRPr lang="ko-KR" altLang="en-US" sz="800" kern="0">
              <a:solidFill>
                <a:prstClr val="white"/>
              </a:solidFill>
              <a:cs typeface="Arial" panose="020B0604020202020204" pitchFamily="34" charset="0"/>
            </a:endParaRPr>
          </a:p>
        </p:txBody>
      </p:sp>
      <p:sp>
        <p:nvSpPr>
          <p:cNvPr id="37" name="타원 36">
            <a:extLst>
              <a:ext uri="{FF2B5EF4-FFF2-40B4-BE49-F238E27FC236}">
                <a16:creationId xmlns:a16="http://schemas.microsoft.com/office/drawing/2014/main" id="{4677BD74-E250-4F89-A29F-2F8347B18402}"/>
              </a:ext>
            </a:extLst>
          </p:cNvPr>
          <p:cNvSpPr/>
          <p:nvPr/>
        </p:nvSpPr>
        <p:spPr>
          <a:xfrm>
            <a:off x="3065546" y="5557482"/>
            <a:ext cx="90000" cy="90000"/>
          </a:xfrm>
          <a:prstGeom prst="ellipse">
            <a:avLst/>
          </a:prstGeom>
          <a:solidFill>
            <a:srgbClr val="FF0000"/>
          </a:solidFill>
          <a:ln w="6350" cap="flat" cmpd="sng" algn="ctr">
            <a:noFill/>
            <a:prstDash val="dash"/>
          </a:ln>
          <a:effectLst/>
        </p:spPr>
        <p:txBody>
          <a:bodyPr rtlCol="0" anchor="ctr"/>
          <a:lstStyle/>
          <a:p>
            <a:pPr algn="ctr" defTabSz="914400" latinLnBrk="1"/>
            <a:endParaRPr lang="ko-KR" altLang="en-US" sz="800" kern="0">
              <a:solidFill>
                <a:prstClr val="white"/>
              </a:solidFill>
              <a:cs typeface="Arial" panose="020B0604020202020204" pitchFamily="34" charset="0"/>
            </a:endParaRPr>
          </a:p>
        </p:txBody>
      </p:sp>
      <p:sp>
        <p:nvSpPr>
          <p:cNvPr id="38" name="타원 37">
            <a:extLst>
              <a:ext uri="{FF2B5EF4-FFF2-40B4-BE49-F238E27FC236}">
                <a16:creationId xmlns:a16="http://schemas.microsoft.com/office/drawing/2014/main" id="{0954946B-22A2-4F32-BD95-D7DBFFA26C15}"/>
              </a:ext>
            </a:extLst>
          </p:cNvPr>
          <p:cNvSpPr/>
          <p:nvPr/>
        </p:nvSpPr>
        <p:spPr>
          <a:xfrm>
            <a:off x="3165297" y="5270328"/>
            <a:ext cx="90000" cy="90000"/>
          </a:xfrm>
          <a:prstGeom prst="ellipse">
            <a:avLst/>
          </a:prstGeom>
          <a:solidFill>
            <a:srgbClr val="FF0000"/>
          </a:solidFill>
          <a:ln w="6350" cap="flat" cmpd="sng" algn="ctr">
            <a:noFill/>
            <a:prstDash val="dash"/>
          </a:ln>
          <a:effectLst/>
        </p:spPr>
        <p:txBody>
          <a:bodyPr rtlCol="0" anchor="ctr"/>
          <a:lstStyle/>
          <a:p>
            <a:pPr algn="ctr" defTabSz="914400" latinLnBrk="1"/>
            <a:endParaRPr lang="ko-KR" altLang="en-US" sz="800" kern="0">
              <a:solidFill>
                <a:prstClr val="white"/>
              </a:solidFill>
              <a:cs typeface="Arial" panose="020B0604020202020204" pitchFamily="34" charset="0"/>
            </a:endParaRPr>
          </a:p>
        </p:txBody>
      </p:sp>
      <p:sp>
        <p:nvSpPr>
          <p:cNvPr id="39" name="타원 38">
            <a:extLst>
              <a:ext uri="{FF2B5EF4-FFF2-40B4-BE49-F238E27FC236}">
                <a16:creationId xmlns:a16="http://schemas.microsoft.com/office/drawing/2014/main" id="{E90AB81B-72C6-4A6F-A7A6-CAC8868168F4}"/>
              </a:ext>
            </a:extLst>
          </p:cNvPr>
          <p:cNvSpPr/>
          <p:nvPr/>
        </p:nvSpPr>
        <p:spPr>
          <a:xfrm>
            <a:off x="3206364" y="5128791"/>
            <a:ext cx="90000" cy="90000"/>
          </a:xfrm>
          <a:prstGeom prst="ellipse">
            <a:avLst/>
          </a:prstGeom>
          <a:solidFill>
            <a:srgbClr val="FF0000"/>
          </a:solidFill>
          <a:ln w="6350" cap="flat" cmpd="sng" algn="ctr">
            <a:noFill/>
            <a:prstDash val="dash"/>
          </a:ln>
          <a:effectLst/>
        </p:spPr>
        <p:txBody>
          <a:bodyPr rtlCol="0" anchor="ctr"/>
          <a:lstStyle/>
          <a:p>
            <a:pPr algn="ctr" defTabSz="914400" latinLnBrk="1"/>
            <a:endParaRPr lang="ko-KR" altLang="en-US" sz="800" kern="0">
              <a:solidFill>
                <a:prstClr val="white"/>
              </a:solidFill>
              <a:cs typeface="Arial" panose="020B0604020202020204" pitchFamily="34" charset="0"/>
            </a:endParaRPr>
          </a:p>
        </p:txBody>
      </p:sp>
      <p:sp>
        <p:nvSpPr>
          <p:cNvPr id="40" name="타원 39">
            <a:extLst>
              <a:ext uri="{FF2B5EF4-FFF2-40B4-BE49-F238E27FC236}">
                <a16:creationId xmlns:a16="http://schemas.microsoft.com/office/drawing/2014/main" id="{BC9E7730-CF2A-41CB-BF31-D36C0F360E80}"/>
              </a:ext>
            </a:extLst>
          </p:cNvPr>
          <p:cNvSpPr/>
          <p:nvPr/>
        </p:nvSpPr>
        <p:spPr>
          <a:xfrm>
            <a:off x="3260541" y="5278862"/>
            <a:ext cx="90000" cy="90000"/>
          </a:xfrm>
          <a:prstGeom prst="ellipse">
            <a:avLst/>
          </a:prstGeom>
          <a:solidFill>
            <a:srgbClr val="FF0000"/>
          </a:solidFill>
          <a:ln w="6350" cap="flat" cmpd="sng" algn="ctr">
            <a:noFill/>
            <a:prstDash val="dash"/>
          </a:ln>
          <a:effectLst/>
        </p:spPr>
        <p:txBody>
          <a:bodyPr rtlCol="0" anchor="ctr"/>
          <a:lstStyle/>
          <a:p>
            <a:pPr algn="ctr" defTabSz="914400" latinLnBrk="1"/>
            <a:endParaRPr lang="ko-KR" altLang="en-US" sz="800" kern="0">
              <a:solidFill>
                <a:prstClr val="white"/>
              </a:solidFill>
              <a:cs typeface="Arial" panose="020B0604020202020204" pitchFamily="34" charset="0"/>
            </a:endParaRPr>
          </a:p>
        </p:txBody>
      </p:sp>
      <p:sp>
        <p:nvSpPr>
          <p:cNvPr id="41" name="타원 40">
            <a:extLst>
              <a:ext uri="{FF2B5EF4-FFF2-40B4-BE49-F238E27FC236}">
                <a16:creationId xmlns:a16="http://schemas.microsoft.com/office/drawing/2014/main" id="{1104CBF1-6336-44CE-AD32-FBCC46911D31}"/>
              </a:ext>
            </a:extLst>
          </p:cNvPr>
          <p:cNvSpPr/>
          <p:nvPr/>
        </p:nvSpPr>
        <p:spPr>
          <a:xfrm>
            <a:off x="3355239" y="5275403"/>
            <a:ext cx="90000" cy="90000"/>
          </a:xfrm>
          <a:prstGeom prst="ellipse">
            <a:avLst/>
          </a:prstGeom>
          <a:solidFill>
            <a:srgbClr val="FF0000"/>
          </a:solidFill>
          <a:ln w="6350" cap="flat" cmpd="sng" algn="ctr">
            <a:noFill/>
            <a:prstDash val="dash"/>
          </a:ln>
          <a:effectLst/>
        </p:spPr>
        <p:txBody>
          <a:bodyPr rtlCol="0" anchor="ctr"/>
          <a:lstStyle/>
          <a:p>
            <a:pPr algn="ctr" defTabSz="914400" latinLnBrk="1"/>
            <a:endParaRPr lang="ko-KR" altLang="en-US" sz="800" kern="0">
              <a:solidFill>
                <a:prstClr val="white"/>
              </a:solidFill>
              <a:cs typeface="Arial" panose="020B0604020202020204" pitchFamily="34" charset="0"/>
            </a:endParaRPr>
          </a:p>
        </p:txBody>
      </p:sp>
      <p:sp>
        <p:nvSpPr>
          <p:cNvPr id="42" name="타원 41">
            <a:extLst>
              <a:ext uri="{FF2B5EF4-FFF2-40B4-BE49-F238E27FC236}">
                <a16:creationId xmlns:a16="http://schemas.microsoft.com/office/drawing/2014/main" id="{3540DFC3-EF4D-4B9B-956C-C0E1195406E2}"/>
              </a:ext>
            </a:extLst>
          </p:cNvPr>
          <p:cNvSpPr/>
          <p:nvPr/>
        </p:nvSpPr>
        <p:spPr>
          <a:xfrm>
            <a:off x="3550578" y="5491212"/>
            <a:ext cx="90000" cy="90000"/>
          </a:xfrm>
          <a:prstGeom prst="ellipse">
            <a:avLst/>
          </a:prstGeom>
          <a:solidFill>
            <a:srgbClr val="FF0000"/>
          </a:solidFill>
          <a:ln w="6350" cap="flat" cmpd="sng" algn="ctr">
            <a:noFill/>
            <a:prstDash val="dash"/>
          </a:ln>
          <a:effectLst/>
        </p:spPr>
        <p:txBody>
          <a:bodyPr rtlCol="0" anchor="ctr"/>
          <a:lstStyle/>
          <a:p>
            <a:pPr algn="ctr" defTabSz="914400" latinLnBrk="1"/>
            <a:endParaRPr lang="ko-KR" altLang="en-US" sz="800" kern="0">
              <a:solidFill>
                <a:prstClr val="white"/>
              </a:solidFill>
              <a:cs typeface="Arial" panose="020B0604020202020204" pitchFamily="34" charset="0"/>
            </a:endParaRPr>
          </a:p>
        </p:txBody>
      </p:sp>
      <p:sp>
        <p:nvSpPr>
          <p:cNvPr id="43" name="타원 42">
            <a:extLst>
              <a:ext uri="{FF2B5EF4-FFF2-40B4-BE49-F238E27FC236}">
                <a16:creationId xmlns:a16="http://schemas.microsoft.com/office/drawing/2014/main" id="{B71F699D-A9F1-4E6C-BC49-2C4F45634E97}"/>
              </a:ext>
            </a:extLst>
          </p:cNvPr>
          <p:cNvSpPr/>
          <p:nvPr/>
        </p:nvSpPr>
        <p:spPr>
          <a:xfrm>
            <a:off x="3547896" y="5347369"/>
            <a:ext cx="90000" cy="90000"/>
          </a:xfrm>
          <a:prstGeom prst="ellipse">
            <a:avLst/>
          </a:prstGeom>
          <a:solidFill>
            <a:srgbClr val="FF0000"/>
          </a:solidFill>
          <a:ln w="6350" cap="flat" cmpd="sng" algn="ctr">
            <a:noFill/>
            <a:prstDash val="dash"/>
          </a:ln>
          <a:effectLst/>
        </p:spPr>
        <p:txBody>
          <a:bodyPr rtlCol="0" anchor="ctr"/>
          <a:lstStyle/>
          <a:p>
            <a:pPr algn="ctr" defTabSz="914400" latinLnBrk="1"/>
            <a:endParaRPr lang="ko-KR" altLang="en-US" sz="800" kern="0">
              <a:solidFill>
                <a:prstClr val="white"/>
              </a:solidFill>
              <a:cs typeface="Arial" panose="020B0604020202020204" pitchFamily="34" charset="0"/>
            </a:endParaRPr>
          </a:p>
        </p:txBody>
      </p:sp>
      <p:sp>
        <p:nvSpPr>
          <p:cNvPr id="45" name="타원 44">
            <a:extLst>
              <a:ext uri="{FF2B5EF4-FFF2-40B4-BE49-F238E27FC236}">
                <a16:creationId xmlns:a16="http://schemas.microsoft.com/office/drawing/2014/main" id="{5E2C40D7-A254-4A51-A931-4B9554F9C2A8}"/>
              </a:ext>
            </a:extLst>
          </p:cNvPr>
          <p:cNvSpPr/>
          <p:nvPr/>
        </p:nvSpPr>
        <p:spPr>
          <a:xfrm>
            <a:off x="5506763" y="4238792"/>
            <a:ext cx="90000" cy="90000"/>
          </a:xfrm>
          <a:prstGeom prst="ellipse">
            <a:avLst/>
          </a:prstGeom>
          <a:solidFill>
            <a:srgbClr val="FF0000"/>
          </a:solidFill>
          <a:ln w="6350" cap="flat" cmpd="sng" algn="ctr">
            <a:noFill/>
            <a:prstDash val="dash"/>
          </a:ln>
          <a:effectLst/>
        </p:spPr>
        <p:txBody>
          <a:bodyPr rtlCol="0" anchor="ctr"/>
          <a:lstStyle/>
          <a:p>
            <a:pPr algn="ctr" defTabSz="914400" latinLnBrk="1"/>
            <a:endParaRPr lang="ko-KR" altLang="en-US" sz="800" kern="0">
              <a:solidFill>
                <a:prstClr val="white"/>
              </a:solidFill>
              <a:cs typeface="Arial" panose="020B0604020202020204" pitchFamily="34" charset="0"/>
            </a:endParaRPr>
          </a:p>
        </p:txBody>
      </p:sp>
      <p:sp>
        <p:nvSpPr>
          <p:cNvPr id="46" name="직사각형 45">
            <a:extLst>
              <a:ext uri="{FF2B5EF4-FFF2-40B4-BE49-F238E27FC236}">
                <a16:creationId xmlns:a16="http://schemas.microsoft.com/office/drawing/2014/main" id="{5D02A26A-5428-41A8-AB40-60523A8F252C}"/>
              </a:ext>
            </a:extLst>
          </p:cNvPr>
          <p:cNvSpPr/>
          <p:nvPr/>
        </p:nvSpPr>
        <p:spPr>
          <a:xfrm>
            <a:off x="5583746" y="4147993"/>
            <a:ext cx="1179040" cy="32496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ts val="900"/>
              </a:lnSpc>
            </a:pPr>
            <a:r>
              <a:rPr lang="en-US" altLang="ko-KR" sz="1050" dirty="0">
                <a:solidFill>
                  <a:srgbClr val="FF0000"/>
                </a:solidFill>
              </a:rPr>
              <a:t>Recurrent</a:t>
            </a:r>
          </a:p>
          <a:p>
            <a:pPr>
              <a:lnSpc>
                <a:spcPts val="900"/>
              </a:lnSpc>
            </a:pPr>
            <a:r>
              <a:rPr lang="en-US" altLang="ko-KR" sz="1050" dirty="0">
                <a:solidFill>
                  <a:srgbClr val="FF0000"/>
                </a:solidFill>
              </a:rPr>
              <a:t>Patient</a:t>
            </a:r>
            <a:endParaRPr lang="ko-KR" altLang="en-US" sz="105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86526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사용자 지정 2">
      <a:majorFont>
        <a:latin typeface="Arial"/>
        <a:ea typeface="맑은 고딕"/>
        <a:cs typeface=""/>
      </a:majorFont>
      <a:minorFont>
        <a:latin typeface="Arial"/>
        <a:ea typeface="맑은 고딕"/>
        <a:cs typeface="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noFill/>
        <a:ln w="6350" cap="flat" cmpd="sng" algn="ctr">
          <a:solidFill>
            <a:sysClr val="window" lastClr="FFFFFF"/>
          </a:solidFill>
          <a:prstDash val="dash"/>
        </a:ln>
        <a:effectLst/>
      </a:spPr>
      <a:bodyPr rtlCol="0" anchor="ctr"/>
      <a:lstStyle>
        <a:defPPr algn="ctr" defTabSz="914400" latinLnBrk="1">
          <a:defRPr sz="800" kern="0">
            <a:solidFill>
              <a:prstClr val="white"/>
            </a:solidFill>
            <a:cs typeface="Arial" panose="020B0604020202020204" pitchFamily="34" charset="0"/>
          </a:defRPr>
        </a:defPPr>
      </a:lst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991</TotalTime>
  <Words>160</Words>
  <Application>Microsoft Office PowerPoint</Application>
  <PresentationFormat>A4 용지(210x297mm)</PresentationFormat>
  <Paragraphs>69</Paragraphs>
  <Slides>3</Slides>
  <Notes>2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7" baseType="lpstr">
      <vt:lpstr>HY강M</vt:lpstr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Dae-Young Park</dc:creator>
  <cp:lastModifiedBy>만기 정</cp:lastModifiedBy>
  <cp:revision>1717</cp:revision>
  <cp:lastPrinted>2018-05-29T11:57:18Z</cp:lastPrinted>
  <dcterms:created xsi:type="dcterms:W3CDTF">2016-01-11T06:15:13Z</dcterms:created>
  <dcterms:modified xsi:type="dcterms:W3CDTF">2022-06-24T03:52:03Z</dcterms:modified>
</cp:coreProperties>
</file>